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  <p:sldId id="264" r:id="rId3"/>
    <p:sldId id="263" r:id="rId4"/>
  </p:sldIdLst>
  <p:sldSz cx="9601200" cy="12801600" type="A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0F8F8"/>
    <a:srgbClr val="0000FF"/>
    <a:srgbClr val="F810F8"/>
    <a:srgbClr val="00FF00"/>
    <a:srgbClr val="C5F3F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30" autoAdjust="0"/>
    <p:restoredTop sz="94660"/>
  </p:normalViewPr>
  <p:slideViewPr>
    <p:cSldViewPr snapToGrid="0">
      <p:cViewPr>
        <p:scale>
          <a:sx n="80" d="100"/>
          <a:sy n="80" d="100"/>
        </p:scale>
        <p:origin x="1133" y="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Sporulation\02.07.2023\Li1497\IR64_Li_02.07.2023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F:\Manuskripte_2022\AWMaina_MAGNOR\MAGNOR_Sporulation\20231211_Correlation_AUDS_x_conidia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F:\Manuskripte_2022\AWMaina_MAGNOR\MAGNOR_Sporulation\20231211_Correlation_AUDS_x_conidia.xlsx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F:\Manuskripte_2022\AWMaina_MAGNOR\MAGNOR_Sporulation\20231211_Correlation_AUDS_x_conidia.xlsx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file:///F:\Manuskripte_2022\AWMaina_MAGNOR\MAGNOR_Sporulation\20231211_Correlation_AUDS_x_conidia.xlsx" TargetMode="External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oleObject" Target="file:///F:\Manuskripte_2022\AWMaina_MAGNOR\MAGNOR_Sporulation\20231211_Correlation_AUDS_x_conidia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E:\Sporulation\02.07.2023\Li1497\IR64_Li_02.07.2023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E:\Sporulation\02.07.2023\IR64_guy11_02072023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E:\Sporulation\02.07.2023\IR64_guy11_02072023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F:\Manuskripte_2022\AWMaina_MAGNOR\MAGNOR_Sporulation\20231211_Correlation_AUDS_x_conidia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F:\Manuskripte_2022\AWMaina_MAGNOR\MAGNOR_Sporulation\20231211_Correlation_AUDS_x_conidia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F:\Manuskripte_2022\AWMaina_MAGNOR\MAGNOR_Sporulation\20231211_Correlation_AUDS_x_conidia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strRef>
              <c:f>Sheet1!$AG$4</c:f>
              <c:strCache>
                <c:ptCount val="1"/>
                <c:pt idx="0">
                  <c:v>Healthy tissue</c:v>
                </c:pt>
              </c:strCache>
            </c:strRef>
          </c:tx>
          <c:spPr>
            <a:ln w="19050" cap="rnd">
              <a:solidFill>
                <a:srgbClr val="06C60B"/>
              </a:solidFill>
              <a:round/>
            </a:ln>
            <a:effectLst/>
          </c:spPr>
          <c:marker>
            <c:symbol val="none"/>
          </c:marker>
          <c:xVal>
            <c:numRef>
              <c:f>Sheet1!$AF$5:$AF$144</c:f>
              <c:numCache>
                <c:formatCode>General</c:formatCode>
                <c:ptCount val="140"/>
                <c:pt idx="0">
                  <c:v>451.25</c:v>
                </c:pt>
                <c:pt idx="1">
                  <c:v>454.040009</c:v>
                </c:pt>
                <c:pt idx="2">
                  <c:v>456.82000699999998</c:v>
                </c:pt>
                <c:pt idx="3">
                  <c:v>459.60998499999999</c:v>
                </c:pt>
                <c:pt idx="4">
                  <c:v>462.39999399999999</c:v>
                </c:pt>
                <c:pt idx="5">
                  <c:v>465.19000199999999</c:v>
                </c:pt>
                <c:pt idx="6">
                  <c:v>467.98001099999999</c:v>
                </c:pt>
                <c:pt idx="7">
                  <c:v>470.77999899999998</c:v>
                </c:pt>
                <c:pt idx="8">
                  <c:v>473.57000699999998</c:v>
                </c:pt>
                <c:pt idx="9">
                  <c:v>476.36999500000002</c:v>
                </c:pt>
                <c:pt idx="10">
                  <c:v>479.16000400000001</c:v>
                </c:pt>
                <c:pt idx="11">
                  <c:v>481.959991</c:v>
                </c:pt>
                <c:pt idx="12">
                  <c:v>484.76001000000002</c:v>
                </c:pt>
                <c:pt idx="13">
                  <c:v>487.55999800000001</c:v>
                </c:pt>
                <c:pt idx="14">
                  <c:v>490.35998499999999</c:v>
                </c:pt>
                <c:pt idx="15">
                  <c:v>493.16000400000001</c:v>
                </c:pt>
                <c:pt idx="16">
                  <c:v>495.97000100000002</c:v>
                </c:pt>
                <c:pt idx="17">
                  <c:v>498.76998900000001</c:v>
                </c:pt>
                <c:pt idx="18">
                  <c:v>501.57998700000002</c:v>
                </c:pt>
                <c:pt idx="19">
                  <c:v>504.39001500000001</c:v>
                </c:pt>
                <c:pt idx="20">
                  <c:v>507.19000199999999</c:v>
                </c:pt>
                <c:pt idx="21">
                  <c:v>510</c:v>
                </c:pt>
                <c:pt idx="22">
                  <c:v>512.80999799999995</c:v>
                </c:pt>
                <c:pt idx="23">
                  <c:v>515.63000499999998</c:v>
                </c:pt>
                <c:pt idx="24">
                  <c:v>518.44000200000005</c:v>
                </c:pt>
                <c:pt idx="25">
                  <c:v>521.25</c:v>
                </c:pt>
                <c:pt idx="26">
                  <c:v>524.07000700000003</c:v>
                </c:pt>
                <c:pt idx="27">
                  <c:v>526.88000499999998</c:v>
                </c:pt>
                <c:pt idx="28">
                  <c:v>529.70001200000002</c:v>
                </c:pt>
                <c:pt idx="29">
                  <c:v>532.52002000000005</c:v>
                </c:pt>
                <c:pt idx="30">
                  <c:v>535.34002699999996</c:v>
                </c:pt>
                <c:pt idx="31">
                  <c:v>538.15997300000004</c:v>
                </c:pt>
                <c:pt idx="32">
                  <c:v>540.98999000000003</c:v>
                </c:pt>
                <c:pt idx="33">
                  <c:v>543.80999799999995</c:v>
                </c:pt>
                <c:pt idx="34">
                  <c:v>546.63000499999998</c:v>
                </c:pt>
                <c:pt idx="35">
                  <c:v>549.46002199999998</c:v>
                </c:pt>
                <c:pt idx="36">
                  <c:v>552.28997800000002</c:v>
                </c:pt>
                <c:pt idx="37">
                  <c:v>555.11999500000002</c:v>
                </c:pt>
                <c:pt idx="38">
                  <c:v>557.94000200000005</c:v>
                </c:pt>
                <c:pt idx="39">
                  <c:v>560.78002900000001</c:v>
                </c:pt>
                <c:pt idx="40">
                  <c:v>563.60998500000005</c:v>
                </c:pt>
                <c:pt idx="41">
                  <c:v>566.44000200000005</c:v>
                </c:pt>
                <c:pt idx="42">
                  <c:v>569.27002000000005</c:v>
                </c:pt>
                <c:pt idx="43">
                  <c:v>572.10998500000005</c:v>
                </c:pt>
                <c:pt idx="44">
                  <c:v>574.95001200000002</c:v>
                </c:pt>
                <c:pt idx="45">
                  <c:v>577.78002900000001</c:v>
                </c:pt>
                <c:pt idx="46">
                  <c:v>580.61999500000002</c:v>
                </c:pt>
                <c:pt idx="47">
                  <c:v>583.46002199999998</c:v>
                </c:pt>
                <c:pt idx="48">
                  <c:v>586.29998799999998</c:v>
                </c:pt>
                <c:pt idx="49">
                  <c:v>589.15002400000003</c:v>
                </c:pt>
                <c:pt idx="50">
                  <c:v>591.98999000000003</c:v>
                </c:pt>
                <c:pt idx="51">
                  <c:v>594.84002699999996</c:v>
                </c:pt>
                <c:pt idx="52">
                  <c:v>597.67999299999997</c:v>
                </c:pt>
                <c:pt idx="53">
                  <c:v>600.53002900000001</c:v>
                </c:pt>
                <c:pt idx="54">
                  <c:v>603.38000499999998</c:v>
                </c:pt>
                <c:pt idx="55">
                  <c:v>606.22997999999995</c:v>
                </c:pt>
                <c:pt idx="56">
                  <c:v>609.080017</c:v>
                </c:pt>
                <c:pt idx="57">
                  <c:v>611.92999299999997</c:v>
                </c:pt>
                <c:pt idx="58">
                  <c:v>614.78002900000001</c:v>
                </c:pt>
                <c:pt idx="59">
                  <c:v>617.64001499999995</c:v>
                </c:pt>
                <c:pt idx="60">
                  <c:v>620.48999000000003</c:v>
                </c:pt>
                <c:pt idx="61">
                  <c:v>623.34997599999997</c:v>
                </c:pt>
                <c:pt idx="62">
                  <c:v>626.21002199999998</c:v>
                </c:pt>
                <c:pt idx="63">
                  <c:v>629.07000700000003</c:v>
                </c:pt>
                <c:pt idx="64">
                  <c:v>631.92999299999997</c:v>
                </c:pt>
                <c:pt idx="65">
                  <c:v>634.78997800000002</c:v>
                </c:pt>
                <c:pt idx="66">
                  <c:v>637.65002400000003</c:v>
                </c:pt>
                <c:pt idx="67">
                  <c:v>640.51000999999997</c:v>
                </c:pt>
                <c:pt idx="68">
                  <c:v>643.38000499999998</c:v>
                </c:pt>
                <c:pt idx="69">
                  <c:v>646.23999000000003</c:v>
                </c:pt>
                <c:pt idx="70">
                  <c:v>649.10998500000005</c:v>
                </c:pt>
                <c:pt idx="71">
                  <c:v>651.97997999999995</c:v>
                </c:pt>
                <c:pt idx="72">
                  <c:v>654.84997599999997</c:v>
                </c:pt>
                <c:pt idx="73">
                  <c:v>657.71997099999999</c:v>
                </c:pt>
                <c:pt idx="74">
                  <c:v>660.59002699999996</c:v>
                </c:pt>
                <c:pt idx="75">
                  <c:v>663.46997099999999</c:v>
                </c:pt>
                <c:pt idx="76">
                  <c:v>666.34002699999996</c:v>
                </c:pt>
                <c:pt idx="77">
                  <c:v>669.21997099999999</c:v>
                </c:pt>
                <c:pt idx="78">
                  <c:v>672.09002699999996</c:v>
                </c:pt>
                <c:pt idx="79">
                  <c:v>674.96997099999999</c:v>
                </c:pt>
                <c:pt idx="80">
                  <c:v>677.84997599999997</c:v>
                </c:pt>
                <c:pt idx="81">
                  <c:v>680.72997999999995</c:v>
                </c:pt>
                <c:pt idx="82">
                  <c:v>683.60998500000005</c:v>
                </c:pt>
                <c:pt idx="83">
                  <c:v>686.48999000000003</c:v>
                </c:pt>
                <c:pt idx="84">
                  <c:v>689.38000499999998</c:v>
                </c:pt>
                <c:pt idx="85">
                  <c:v>692.26000999999997</c:v>
                </c:pt>
                <c:pt idx="86">
                  <c:v>695.15002400000003</c:v>
                </c:pt>
                <c:pt idx="87">
                  <c:v>698.03002900000001</c:v>
                </c:pt>
                <c:pt idx="88">
                  <c:v>700.919983</c:v>
                </c:pt>
                <c:pt idx="89">
                  <c:v>703.80999799999995</c:v>
                </c:pt>
                <c:pt idx="90">
                  <c:v>706.70001200000002</c:v>
                </c:pt>
                <c:pt idx="91">
                  <c:v>709.59997599999997</c:v>
                </c:pt>
                <c:pt idx="92">
                  <c:v>712.48999000000003</c:v>
                </c:pt>
                <c:pt idx="93">
                  <c:v>715.38000499999998</c:v>
                </c:pt>
                <c:pt idx="94">
                  <c:v>718.28002900000001</c:v>
                </c:pt>
                <c:pt idx="95">
                  <c:v>721.17999299999997</c:v>
                </c:pt>
                <c:pt idx="96">
                  <c:v>724.07000700000003</c:v>
                </c:pt>
                <c:pt idx="97">
                  <c:v>726.96997099999999</c:v>
                </c:pt>
                <c:pt idx="98">
                  <c:v>729.86999500000002</c:v>
                </c:pt>
                <c:pt idx="99">
                  <c:v>732.77002000000005</c:v>
                </c:pt>
                <c:pt idx="100">
                  <c:v>735.67999299999997</c:v>
                </c:pt>
                <c:pt idx="101">
                  <c:v>738.580017</c:v>
                </c:pt>
                <c:pt idx="102">
                  <c:v>741.48999000000003</c:v>
                </c:pt>
                <c:pt idx="103">
                  <c:v>744.39001499999995</c:v>
                </c:pt>
                <c:pt idx="104">
                  <c:v>747.29998799999998</c:v>
                </c:pt>
                <c:pt idx="105">
                  <c:v>750.21002199999998</c:v>
                </c:pt>
                <c:pt idx="106">
                  <c:v>753.11999500000002</c:v>
                </c:pt>
                <c:pt idx="107">
                  <c:v>756.03002900000001</c:v>
                </c:pt>
                <c:pt idx="108">
                  <c:v>758.94000200000005</c:v>
                </c:pt>
                <c:pt idx="109">
                  <c:v>761.84997599999997</c:v>
                </c:pt>
                <c:pt idx="110">
                  <c:v>764.77002000000005</c:v>
                </c:pt>
                <c:pt idx="111">
                  <c:v>767.67999299999997</c:v>
                </c:pt>
                <c:pt idx="112">
                  <c:v>770.59997599999997</c:v>
                </c:pt>
                <c:pt idx="113">
                  <c:v>773.52002000000005</c:v>
                </c:pt>
                <c:pt idx="114">
                  <c:v>776.44000200000005</c:v>
                </c:pt>
                <c:pt idx="115">
                  <c:v>779.35998500000005</c:v>
                </c:pt>
                <c:pt idx="116">
                  <c:v>782.28002900000001</c:v>
                </c:pt>
                <c:pt idx="117">
                  <c:v>785.20001200000002</c:v>
                </c:pt>
                <c:pt idx="118">
                  <c:v>788.11999500000002</c:v>
                </c:pt>
                <c:pt idx="119">
                  <c:v>791.04998799999998</c:v>
                </c:pt>
                <c:pt idx="120">
                  <c:v>793.97997999999995</c:v>
                </c:pt>
                <c:pt idx="121">
                  <c:v>796.90002400000003</c:v>
                </c:pt>
                <c:pt idx="122">
                  <c:v>799.830017</c:v>
                </c:pt>
                <c:pt idx="123">
                  <c:v>802.76000999999997</c:v>
                </c:pt>
                <c:pt idx="124">
                  <c:v>805.69000200000005</c:v>
                </c:pt>
                <c:pt idx="125">
                  <c:v>808.61999500000002</c:v>
                </c:pt>
                <c:pt idx="126">
                  <c:v>811.55999799999995</c:v>
                </c:pt>
                <c:pt idx="127">
                  <c:v>814.48999000000003</c:v>
                </c:pt>
                <c:pt idx="128">
                  <c:v>817.42999299999997</c:v>
                </c:pt>
                <c:pt idx="129">
                  <c:v>820.35998500000005</c:v>
                </c:pt>
                <c:pt idx="130">
                  <c:v>823.29998799999998</c:v>
                </c:pt>
                <c:pt idx="131">
                  <c:v>826.23999000000003</c:v>
                </c:pt>
                <c:pt idx="132">
                  <c:v>829.17999299999997</c:v>
                </c:pt>
                <c:pt idx="133">
                  <c:v>832.11999500000002</c:v>
                </c:pt>
                <c:pt idx="134">
                  <c:v>835.07000700000003</c:v>
                </c:pt>
                <c:pt idx="135">
                  <c:v>838.01000999999997</c:v>
                </c:pt>
                <c:pt idx="136">
                  <c:v>840.95001200000002</c:v>
                </c:pt>
                <c:pt idx="137">
                  <c:v>843.90002400000003</c:v>
                </c:pt>
                <c:pt idx="138">
                  <c:v>846.84997599999997</c:v>
                </c:pt>
                <c:pt idx="139">
                  <c:v>849.79998799999998</c:v>
                </c:pt>
              </c:numCache>
            </c:numRef>
          </c:xVal>
          <c:yVal>
            <c:numRef>
              <c:f>Sheet1!$AG$5:$AG$144</c:f>
              <c:numCache>
                <c:formatCode>General</c:formatCode>
                <c:ptCount val="140"/>
                <c:pt idx="0">
                  <c:v>4.4800000000000006E-2</c:v>
                </c:pt>
                <c:pt idx="1">
                  <c:v>4.4692249999999996E-2</c:v>
                </c:pt>
                <c:pt idx="2">
                  <c:v>4.4428250000000002E-2</c:v>
                </c:pt>
                <c:pt idx="3">
                  <c:v>4.4021749999999998E-2</c:v>
                </c:pt>
                <c:pt idx="4">
                  <c:v>4.3443999999999997E-2</c:v>
                </c:pt>
                <c:pt idx="5">
                  <c:v>4.2809750000000001E-2</c:v>
                </c:pt>
                <c:pt idx="6">
                  <c:v>4.2251249999999997E-2</c:v>
                </c:pt>
                <c:pt idx="7">
                  <c:v>4.1861250000000003E-2</c:v>
                </c:pt>
                <c:pt idx="8">
                  <c:v>4.1599749999999998E-2</c:v>
                </c:pt>
                <c:pt idx="9">
                  <c:v>4.1402500000000002E-2</c:v>
                </c:pt>
                <c:pt idx="10">
                  <c:v>4.1183500000000005E-2</c:v>
                </c:pt>
                <c:pt idx="11">
                  <c:v>4.0957250000000001E-2</c:v>
                </c:pt>
                <c:pt idx="12">
                  <c:v>4.0708000000000001E-2</c:v>
                </c:pt>
                <c:pt idx="13">
                  <c:v>4.0661500000000003E-2</c:v>
                </c:pt>
                <c:pt idx="14">
                  <c:v>4.0781249999999998E-2</c:v>
                </c:pt>
                <c:pt idx="15">
                  <c:v>4.117125E-2</c:v>
                </c:pt>
                <c:pt idx="16">
                  <c:v>4.1846999999999995E-2</c:v>
                </c:pt>
                <c:pt idx="17">
                  <c:v>4.3021249999999997E-2</c:v>
                </c:pt>
                <c:pt idx="18">
                  <c:v>4.4851000000000002E-2</c:v>
                </c:pt>
                <c:pt idx="19">
                  <c:v>4.749225E-2</c:v>
                </c:pt>
                <c:pt idx="20">
                  <c:v>5.1139999999999998E-2</c:v>
                </c:pt>
                <c:pt idx="21">
                  <c:v>5.5883250000000002E-2</c:v>
                </c:pt>
                <c:pt idx="22">
                  <c:v>6.1829749999999996E-2</c:v>
                </c:pt>
                <c:pt idx="23">
                  <c:v>6.9015749999999987E-2</c:v>
                </c:pt>
                <c:pt idx="24">
                  <c:v>7.7450000000000005E-2</c:v>
                </c:pt>
                <c:pt idx="25">
                  <c:v>8.6790499999999993E-2</c:v>
                </c:pt>
                <c:pt idx="26">
                  <c:v>9.6279749999999997E-2</c:v>
                </c:pt>
                <c:pt idx="27">
                  <c:v>0.10511075</c:v>
                </c:pt>
                <c:pt idx="28">
                  <c:v>0.11260325</c:v>
                </c:pt>
                <c:pt idx="29">
                  <c:v>0.11844099999999999</c:v>
                </c:pt>
                <c:pt idx="30">
                  <c:v>0.12263999999999999</c:v>
                </c:pt>
                <c:pt idx="31">
                  <c:v>0.1254895</c:v>
                </c:pt>
                <c:pt idx="32">
                  <c:v>0.12736624999999999</c:v>
                </c:pt>
                <c:pt idx="33">
                  <c:v>0.12877675</c:v>
                </c:pt>
                <c:pt idx="34">
                  <c:v>0.13009900000000002</c:v>
                </c:pt>
                <c:pt idx="35">
                  <c:v>0.13133025000000001</c:v>
                </c:pt>
                <c:pt idx="36">
                  <c:v>0.13206675000000001</c:v>
                </c:pt>
                <c:pt idx="37">
                  <c:v>0.13172475</c:v>
                </c:pt>
                <c:pt idx="38">
                  <c:v>0.12995875000000001</c:v>
                </c:pt>
                <c:pt idx="39">
                  <c:v>0.12688050000000001</c:v>
                </c:pt>
                <c:pt idx="40">
                  <c:v>0.1227965</c:v>
                </c:pt>
                <c:pt idx="41">
                  <c:v>0.11776325</c:v>
                </c:pt>
                <c:pt idx="42">
                  <c:v>0.11185225</c:v>
                </c:pt>
                <c:pt idx="43">
                  <c:v>0.10548575</c:v>
                </c:pt>
                <c:pt idx="44">
                  <c:v>9.9431999999999993E-2</c:v>
                </c:pt>
                <c:pt idx="45">
                  <c:v>9.4170500000000004E-2</c:v>
                </c:pt>
                <c:pt idx="46">
                  <c:v>8.9787249999999999E-2</c:v>
                </c:pt>
                <c:pt idx="47">
                  <c:v>8.6116750000000006E-2</c:v>
                </c:pt>
                <c:pt idx="48">
                  <c:v>8.3060499999999995E-2</c:v>
                </c:pt>
                <c:pt idx="49">
                  <c:v>8.0574750000000001E-2</c:v>
                </c:pt>
                <c:pt idx="50">
                  <c:v>7.8643999999999992E-2</c:v>
                </c:pt>
                <c:pt idx="51">
                  <c:v>7.719825000000001E-2</c:v>
                </c:pt>
                <c:pt idx="52">
                  <c:v>7.6049000000000005E-2</c:v>
                </c:pt>
                <c:pt idx="53">
                  <c:v>7.4903749999999991E-2</c:v>
                </c:pt>
                <c:pt idx="54">
                  <c:v>7.3407250000000007E-2</c:v>
                </c:pt>
                <c:pt idx="55">
                  <c:v>7.1317000000000005E-2</c:v>
                </c:pt>
                <c:pt idx="56">
                  <c:v>6.8644750000000004E-2</c:v>
                </c:pt>
                <c:pt idx="57">
                  <c:v>6.5668499999999991E-2</c:v>
                </c:pt>
                <c:pt idx="58">
                  <c:v>6.273274999999999E-2</c:v>
                </c:pt>
                <c:pt idx="59">
                  <c:v>6.0143749999999996E-2</c:v>
                </c:pt>
                <c:pt idx="60">
                  <c:v>5.8085999999999999E-2</c:v>
                </c:pt>
                <c:pt idx="61">
                  <c:v>5.6658750000000001E-2</c:v>
                </c:pt>
                <c:pt idx="62">
                  <c:v>5.5830749999999998E-2</c:v>
                </c:pt>
                <c:pt idx="63">
                  <c:v>5.540925E-2</c:v>
                </c:pt>
                <c:pt idx="64">
                  <c:v>5.4975249999999996E-2</c:v>
                </c:pt>
                <c:pt idx="65">
                  <c:v>5.4058500000000009E-2</c:v>
                </c:pt>
                <c:pt idx="66">
                  <c:v>5.2456749999999996E-2</c:v>
                </c:pt>
                <c:pt idx="67">
                  <c:v>5.0313499999999997E-2</c:v>
                </c:pt>
                <c:pt idx="68">
                  <c:v>4.7918500000000003E-2</c:v>
                </c:pt>
                <c:pt idx="69">
                  <c:v>4.5573749999999996E-2</c:v>
                </c:pt>
                <c:pt idx="70">
                  <c:v>4.3564499999999999E-2</c:v>
                </c:pt>
                <c:pt idx="71">
                  <c:v>4.1952749999999997E-2</c:v>
                </c:pt>
                <c:pt idx="72">
                  <c:v>4.0431999999999996E-2</c:v>
                </c:pt>
                <c:pt idx="73">
                  <c:v>3.8726749999999997E-2</c:v>
                </c:pt>
                <c:pt idx="74">
                  <c:v>3.6873500000000003E-2</c:v>
                </c:pt>
                <c:pt idx="75">
                  <c:v>3.5114499999999993E-2</c:v>
                </c:pt>
                <c:pt idx="76">
                  <c:v>3.3598749999999997E-2</c:v>
                </c:pt>
                <c:pt idx="77">
                  <c:v>3.2472000000000001E-2</c:v>
                </c:pt>
                <c:pt idx="78">
                  <c:v>3.1834000000000001E-2</c:v>
                </c:pt>
                <c:pt idx="79">
                  <c:v>3.1684749999999998E-2</c:v>
                </c:pt>
                <c:pt idx="80">
                  <c:v>3.1984249999999999E-2</c:v>
                </c:pt>
                <c:pt idx="81">
                  <c:v>3.2741499999999993E-2</c:v>
                </c:pt>
                <c:pt idx="82">
                  <c:v>3.4110000000000001E-2</c:v>
                </c:pt>
                <c:pt idx="83">
                  <c:v>3.6722749999999998E-2</c:v>
                </c:pt>
                <c:pt idx="84">
                  <c:v>4.2050749999999998E-2</c:v>
                </c:pt>
                <c:pt idx="85">
                  <c:v>5.1950999999999997E-2</c:v>
                </c:pt>
                <c:pt idx="86">
                  <c:v>6.7694500000000005E-2</c:v>
                </c:pt>
                <c:pt idx="87">
                  <c:v>8.9031750000000007E-2</c:v>
                </c:pt>
                <c:pt idx="88">
                  <c:v>0.11393400000000001</c:v>
                </c:pt>
                <c:pt idx="89">
                  <c:v>0.13964675000000001</c:v>
                </c:pt>
                <c:pt idx="90">
                  <c:v>0.16429550000000001</c:v>
                </c:pt>
                <c:pt idx="91">
                  <c:v>0.18749825000000001</c:v>
                </c:pt>
                <c:pt idx="92">
                  <c:v>0.209615</c:v>
                </c:pt>
                <c:pt idx="93">
                  <c:v>0.23080000000000001</c:v>
                </c:pt>
                <c:pt idx="94">
                  <c:v>0.25098025000000002</c:v>
                </c:pt>
                <c:pt idx="95">
                  <c:v>0.26996724999999999</c:v>
                </c:pt>
                <c:pt idx="96">
                  <c:v>0.2875355</c:v>
                </c:pt>
                <c:pt idx="97">
                  <c:v>0.30359975</c:v>
                </c:pt>
                <c:pt idx="98">
                  <c:v>0.31791425000000001</c:v>
                </c:pt>
                <c:pt idx="99">
                  <c:v>0.33030199999999998</c:v>
                </c:pt>
                <c:pt idx="100">
                  <c:v>0.34079999999999999</c:v>
                </c:pt>
                <c:pt idx="101">
                  <c:v>0.34952050000000001</c:v>
                </c:pt>
                <c:pt idx="102">
                  <c:v>0.35641600000000001</c:v>
                </c:pt>
                <c:pt idx="103">
                  <c:v>0.3615585</c:v>
                </c:pt>
                <c:pt idx="104">
                  <c:v>0.36542825000000001</c:v>
                </c:pt>
                <c:pt idx="105">
                  <c:v>0.36832299999999996</c:v>
                </c:pt>
                <c:pt idx="106">
                  <c:v>0.37048700000000001</c:v>
                </c:pt>
                <c:pt idx="107">
                  <c:v>0.37225575</c:v>
                </c:pt>
                <c:pt idx="108">
                  <c:v>0.37364799999999998</c:v>
                </c:pt>
                <c:pt idx="109">
                  <c:v>0.37458150000000001</c:v>
                </c:pt>
                <c:pt idx="110">
                  <c:v>0.37540699999999999</c:v>
                </c:pt>
                <c:pt idx="111">
                  <c:v>0.37621974999999996</c:v>
                </c:pt>
                <c:pt idx="112">
                  <c:v>0.37679249999999997</c:v>
                </c:pt>
                <c:pt idx="113">
                  <c:v>0.37714175</c:v>
                </c:pt>
                <c:pt idx="114">
                  <c:v>0.37741550000000001</c:v>
                </c:pt>
                <c:pt idx="115">
                  <c:v>0.37732750000000004</c:v>
                </c:pt>
                <c:pt idx="116">
                  <c:v>0.37686699999999995</c:v>
                </c:pt>
                <c:pt idx="117">
                  <c:v>0.37621550000000004</c:v>
                </c:pt>
                <c:pt idx="118">
                  <c:v>0.37552075000000001</c:v>
                </c:pt>
                <c:pt idx="119">
                  <c:v>0.37476799999999999</c:v>
                </c:pt>
                <c:pt idx="120">
                  <c:v>0.37394574999999997</c:v>
                </c:pt>
                <c:pt idx="121">
                  <c:v>0.37286074999999996</c:v>
                </c:pt>
                <c:pt idx="122">
                  <c:v>0.37161224999999998</c:v>
                </c:pt>
                <c:pt idx="123">
                  <c:v>0.37049325</c:v>
                </c:pt>
                <c:pt idx="124">
                  <c:v>0.36977325</c:v>
                </c:pt>
                <c:pt idx="125">
                  <c:v>0.36936025</c:v>
                </c:pt>
                <c:pt idx="126">
                  <c:v>0.368641</c:v>
                </c:pt>
                <c:pt idx="127">
                  <c:v>0.36778374999999996</c:v>
                </c:pt>
                <c:pt idx="128">
                  <c:v>0.36711500000000002</c:v>
                </c:pt>
                <c:pt idx="129">
                  <c:v>0.36673549999999999</c:v>
                </c:pt>
                <c:pt idx="130">
                  <c:v>0.36622075000000004</c:v>
                </c:pt>
                <c:pt idx="131">
                  <c:v>0.36570899999999995</c:v>
                </c:pt>
                <c:pt idx="132">
                  <c:v>0.3653805</c:v>
                </c:pt>
                <c:pt idx="133">
                  <c:v>0.36534274999999994</c:v>
                </c:pt>
                <c:pt idx="134">
                  <c:v>0.36537825000000002</c:v>
                </c:pt>
                <c:pt idx="135">
                  <c:v>0.36558699999999994</c:v>
                </c:pt>
                <c:pt idx="136">
                  <c:v>0.36594075000000004</c:v>
                </c:pt>
                <c:pt idx="137">
                  <c:v>0.36655374999999996</c:v>
                </c:pt>
                <c:pt idx="138">
                  <c:v>0.36736274999999996</c:v>
                </c:pt>
                <c:pt idx="139">
                  <c:v>0.3680594999999999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8AE6-43D8-A424-CF1383F2B8E9}"/>
            </c:ext>
          </c:extLst>
        </c:ser>
        <c:ser>
          <c:idx val="1"/>
          <c:order val="1"/>
          <c:tx>
            <c:strRef>
              <c:f>Sheet1!$AH$4</c:f>
              <c:strCache>
                <c:ptCount val="1"/>
                <c:pt idx="0">
                  <c:v>Dark brown tissue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xVal>
            <c:numRef>
              <c:f>Sheet1!$AF$5:$AF$144</c:f>
              <c:numCache>
                <c:formatCode>General</c:formatCode>
                <c:ptCount val="140"/>
                <c:pt idx="0">
                  <c:v>451.25</c:v>
                </c:pt>
                <c:pt idx="1">
                  <c:v>454.040009</c:v>
                </c:pt>
                <c:pt idx="2">
                  <c:v>456.82000699999998</c:v>
                </c:pt>
                <c:pt idx="3">
                  <c:v>459.60998499999999</c:v>
                </c:pt>
                <c:pt idx="4">
                  <c:v>462.39999399999999</c:v>
                </c:pt>
                <c:pt idx="5">
                  <c:v>465.19000199999999</c:v>
                </c:pt>
                <c:pt idx="6">
                  <c:v>467.98001099999999</c:v>
                </c:pt>
                <c:pt idx="7">
                  <c:v>470.77999899999998</c:v>
                </c:pt>
                <c:pt idx="8">
                  <c:v>473.57000699999998</c:v>
                </c:pt>
                <c:pt idx="9">
                  <c:v>476.36999500000002</c:v>
                </c:pt>
                <c:pt idx="10">
                  <c:v>479.16000400000001</c:v>
                </c:pt>
                <c:pt idx="11">
                  <c:v>481.959991</c:v>
                </c:pt>
                <c:pt idx="12">
                  <c:v>484.76001000000002</c:v>
                </c:pt>
                <c:pt idx="13">
                  <c:v>487.55999800000001</c:v>
                </c:pt>
                <c:pt idx="14">
                  <c:v>490.35998499999999</c:v>
                </c:pt>
                <c:pt idx="15">
                  <c:v>493.16000400000001</c:v>
                </c:pt>
                <c:pt idx="16">
                  <c:v>495.97000100000002</c:v>
                </c:pt>
                <c:pt idx="17">
                  <c:v>498.76998900000001</c:v>
                </c:pt>
                <c:pt idx="18">
                  <c:v>501.57998700000002</c:v>
                </c:pt>
                <c:pt idx="19">
                  <c:v>504.39001500000001</c:v>
                </c:pt>
                <c:pt idx="20">
                  <c:v>507.19000199999999</c:v>
                </c:pt>
                <c:pt idx="21">
                  <c:v>510</c:v>
                </c:pt>
                <c:pt idx="22">
                  <c:v>512.80999799999995</c:v>
                </c:pt>
                <c:pt idx="23">
                  <c:v>515.63000499999998</c:v>
                </c:pt>
                <c:pt idx="24">
                  <c:v>518.44000200000005</c:v>
                </c:pt>
                <c:pt idx="25">
                  <c:v>521.25</c:v>
                </c:pt>
                <c:pt idx="26">
                  <c:v>524.07000700000003</c:v>
                </c:pt>
                <c:pt idx="27">
                  <c:v>526.88000499999998</c:v>
                </c:pt>
                <c:pt idx="28">
                  <c:v>529.70001200000002</c:v>
                </c:pt>
                <c:pt idx="29">
                  <c:v>532.52002000000005</c:v>
                </c:pt>
                <c:pt idx="30">
                  <c:v>535.34002699999996</c:v>
                </c:pt>
                <c:pt idx="31">
                  <c:v>538.15997300000004</c:v>
                </c:pt>
                <c:pt idx="32">
                  <c:v>540.98999000000003</c:v>
                </c:pt>
                <c:pt idx="33">
                  <c:v>543.80999799999995</c:v>
                </c:pt>
                <c:pt idx="34">
                  <c:v>546.63000499999998</c:v>
                </c:pt>
                <c:pt idx="35">
                  <c:v>549.46002199999998</c:v>
                </c:pt>
                <c:pt idx="36">
                  <c:v>552.28997800000002</c:v>
                </c:pt>
                <c:pt idx="37">
                  <c:v>555.11999500000002</c:v>
                </c:pt>
                <c:pt idx="38">
                  <c:v>557.94000200000005</c:v>
                </c:pt>
                <c:pt idx="39">
                  <c:v>560.78002900000001</c:v>
                </c:pt>
                <c:pt idx="40">
                  <c:v>563.60998500000005</c:v>
                </c:pt>
                <c:pt idx="41">
                  <c:v>566.44000200000005</c:v>
                </c:pt>
                <c:pt idx="42">
                  <c:v>569.27002000000005</c:v>
                </c:pt>
                <c:pt idx="43">
                  <c:v>572.10998500000005</c:v>
                </c:pt>
                <c:pt idx="44">
                  <c:v>574.95001200000002</c:v>
                </c:pt>
                <c:pt idx="45">
                  <c:v>577.78002900000001</c:v>
                </c:pt>
                <c:pt idx="46">
                  <c:v>580.61999500000002</c:v>
                </c:pt>
                <c:pt idx="47">
                  <c:v>583.46002199999998</c:v>
                </c:pt>
                <c:pt idx="48">
                  <c:v>586.29998799999998</c:v>
                </c:pt>
                <c:pt idx="49">
                  <c:v>589.15002400000003</c:v>
                </c:pt>
                <c:pt idx="50">
                  <c:v>591.98999000000003</c:v>
                </c:pt>
                <c:pt idx="51">
                  <c:v>594.84002699999996</c:v>
                </c:pt>
                <c:pt idx="52">
                  <c:v>597.67999299999997</c:v>
                </c:pt>
                <c:pt idx="53">
                  <c:v>600.53002900000001</c:v>
                </c:pt>
                <c:pt idx="54">
                  <c:v>603.38000499999998</c:v>
                </c:pt>
                <c:pt idx="55">
                  <c:v>606.22997999999995</c:v>
                </c:pt>
                <c:pt idx="56">
                  <c:v>609.080017</c:v>
                </c:pt>
                <c:pt idx="57">
                  <c:v>611.92999299999997</c:v>
                </c:pt>
                <c:pt idx="58">
                  <c:v>614.78002900000001</c:v>
                </c:pt>
                <c:pt idx="59">
                  <c:v>617.64001499999995</c:v>
                </c:pt>
                <c:pt idx="60">
                  <c:v>620.48999000000003</c:v>
                </c:pt>
                <c:pt idx="61">
                  <c:v>623.34997599999997</c:v>
                </c:pt>
                <c:pt idx="62">
                  <c:v>626.21002199999998</c:v>
                </c:pt>
                <c:pt idx="63">
                  <c:v>629.07000700000003</c:v>
                </c:pt>
                <c:pt idx="64">
                  <c:v>631.92999299999997</c:v>
                </c:pt>
                <c:pt idx="65">
                  <c:v>634.78997800000002</c:v>
                </c:pt>
                <c:pt idx="66">
                  <c:v>637.65002400000003</c:v>
                </c:pt>
                <c:pt idx="67">
                  <c:v>640.51000999999997</c:v>
                </c:pt>
                <c:pt idx="68">
                  <c:v>643.38000499999998</c:v>
                </c:pt>
                <c:pt idx="69">
                  <c:v>646.23999000000003</c:v>
                </c:pt>
                <c:pt idx="70">
                  <c:v>649.10998500000005</c:v>
                </c:pt>
                <c:pt idx="71">
                  <c:v>651.97997999999995</c:v>
                </c:pt>
                <c:pt idx="72">
                  <c:v>654.84997599999997</c:v>
                </c:pt>
                <c:pt idx="73">
                  <c:v>657.71997099999999</c:v>
                </c:pt>
                <c:pt idx="74">
                  <c:v>660.59002699999996</c:v>
                </c:pt>
                <c:pt idx="75">
                  <c:v>663.46997099999999</c:v>
                </c:pt>
                <c:pt idx="76">
                  <c:v>666.34002699999996</c:v>
                </c:pt>
                <c:pt idx="77">
                  <c:v>669.21997099999999</c:v>
                </c:pt>
                <c:pt idx="78">
                  <c:v>672.09002699999996</c:v>
                </c:pt>
                <c:pt idx="79">
                  <c:v>674.96997099999999</c:v>
                </c:pt>
                <c:pt idx="80">
                  <c:v>677.84997599999997</c:v>
                </c:pt>
                <c:pt idx="81">
                  <c:v>680.72997999999995</c:v>
                </c:pt>
                <c:pt idx="82">
                  <c:v>683.60998500000005</c:v>
                </c:pt>
                <c:pt idx="83">
                  <c:v>686.48999000000003</c:v>
                </c:pt>
                <c:pt idx="84">
                  <c:v>689.38000499999998</c:v>
                </c:pt>
                <c:pt idx="85">
                  <c:v>692.26000999999997</c:v>
                </c:pt>
                <c:pt idx="86">
                  <c:v>695.15002400000003</c:v>
                </c:pt>
                <c:pt idx="87">
                  <c:v>698.03002900000001</c:v>
                </c:pt>
                <c:pt idx="88">
                  <c:v>700.919983</c:v>
                </c:pt>
                <c:pt idx="89">
                  <c:v>703.80999799999995</c:v>
                </c:pt>
                <c:pt idx="90">
                  <c:v>706.70001200000002</c:v>
                </c:pt>
                <c:pt idx="91">
                  <c:v>709.59997599999997</c:v>
                </c:pt>
                <c:pt idx="92">
                  <c:v>712.48999000000003</c:v>
                </c:pt>
                <c:pt idx="93">
                  <c:v>715.38000499999998</c:v>
                </c:pt>
                <c:pt idx="94">
                  <c:v>718.28002900000001</c:v>
                </c:pt>
                <c:pt idx="95">
                  <c:v>721.17999299999997</c:v>
                </c:pt>
                <c:pt idx="96">
                  <c:v>724.07000700000003</c:v>
                </c:pt>
                <c:pt idx="97">
                  <c:v>726.96997099999999</c:v>
                </c:pt>
                <c:pt idx="98">
                  <c:v>729.86999500000002</c:v>
                </c:pt>
                <c:pt idx="99">
                  <c:v>732.77002000000005</c:v>
                </c:pt>
                <c:pt idx="100">
                  <c:v>735.67999299999997</c:v>
                </c:pt>
                <c:pt idx="101">
                  <c:v>738.580017</c:v>
                </c:pt>
                <c:pt idx="102">
                  <c:v>741.48999000000003</c:v>
                </c:pt>
                <c:pt idx="103">
                  <c:v>744.39001499999995</c:v>
                </c:pt>
                <c:pt idx="104">
                  <c:v>747.29998799999998</c:v>
                </c:pt>
                <c:pt idx="105">
                  <c:v>750.21002199999998</c:v>
                </c:pt>
                <c:pt idx="106">
                  <c:v>753.11999500000002</c:v>
                </c:pt>
                <c:pt idx="107">
                  <c:v>756.03002900000001</c:v>
                </c:pt>
                <c:pt idx="108">
                  <c:v>758.94000200000005</c:v>
                </c:pt>
                <c:pt idx="109">
                  <c:v>761.84997599999997</c:v>
                </c:pt>
                <c:pt idx="110">
                  <c:v>764.77002000000005</c:v>
                </c:pt>
                <c:pt idx="111">
                  <c:v>767.67999299999997</c:v>
                </c:pt>
                <c:pt idx="112">
                  <c:v>770.59997599999997</c:v>
                </c:pt>
                <c:pt idx="113">
                  <c:v>773.52002000000005</c:v>
                </c:pt>
                <c:pt idx="114">
                  <c:v>776.44000200000005</c:v>
                </c:pt>
                <c:pt idx="115">
                  <c:v>779.35998500000005</c:v>
                </c:pt>
                <c:pt idx="116">
                  <c:v>782.28002900000001</c:v>
                </c:pt>
                <c:pt idx="117">
                  <c:v>785.20001200000002</c:v>
                </c:pt>
                <c:pt idx="118">
                  <c:v>788.11999500000002</c:v>
                </c:pt>
                <c:pt idx="119">
                  <c:v>791.04998799999998</c:v>
                </c:pt>
                <c:pt idx="120">
                  <c:v>793.97997999999995</c:v>
                </c:pt>
                <c:pt idx="121">
                  <c:v>796.90002400000003</c:v>
                </c:pt>
                <c:pt idx="122">
                  <c:v>799.830017</c:v>
                </c:pt>
                <c:pt idx="123">
                  <c:v>802.76000999999997</c:v>
                </c:pt>
                <c:pt idx="124">
                  <c:v>805.69000200000005</c:v>
                </c:pt>
                <c:pt idx="125">
                  <c:v>808.61999500000002</c:v>
                </c:pt>
                <c:pt idx="126">
                  <c:v>811.55999799999995</c:v>
                </c:pt>
                <c:pt idx="127">
                  <c:v>814.48999000000003</c:v>
                </c:pt>
                <c:pt idx="128">
                  <c:v>817.42999299999997</c:v>
                </c:pt>
                <c:pt idx="129">
                  <c:v>820.35998500000005</c:v>
                </c:pt>
                <c:pt idx="130">
                  <c:v>823.29998799999998</c:v>
                </c:pt>
                <c:pt idx="131">
                  <c:v>826.23999000000003</c:v>
                </c:pt>
                <c:pt idx="132">
                  <c:v>829.17999299999997</c:v>
                </c:pt>
                <c:pt idx="133">
                  <c:v>832.11999500000002</c:v>
                </c:pt>
                <c:pt idx="134">
                  <c:v>835.07000700000003</c:v>
                </c:pt>
                <c:pt idx="135">
                  <c:v>838.01000999999997</c:v>
                </c:pt>
                <c:pt idx="136">
                  <c:v>840.95001200000002</c:v>
                </c:pt>
                <c:pt idx="137">
                  <c:v>843.90002400000003</c:v>
                </c:pt>
                <c:pt idx="138">
                  <c:v>846.84997599999997</c:v>
                </c:pt>
                <c:pt idx="139">
                  <c:v>849.79998799999998</c:v>
                </c:pt>
              </c:numCache>
            </c:numRef>
          </c:xVal>
          <c:yVal>
            <c:numRef>
              <c:f>Sheet1!$AH$5:$AH$144</c:f>
              <c:numCache>
                <c:formatCode>General</c:formatCode>
                <c:ptCount val="140"/>
                <c:pt idx="0">
                  <c:v>4.2515249999999997E-2</c:v>
                </c:pt>
                <c:pt idx="1">
                  <c:v>4.1992250000000002E-2</c:v>
                </c:pt>
                <c:pt idx="2">
                  <c:v>4.1758999999999998E-2</c:v>
                </c:pt>
                <c:pt idx="3">
                  <c:v>4.1854749999999996E-2</c:v>
                </c:pt>
                <c:pt idx="4">
                  <c:v>4.2109250000000001E-2</c:v>
                </c:pt>
                <c:pt idx="5">
                  <c:v>4.1496249999999998E-2</c:v>
                </c:pt>
                <c:pt idx="6">
                  <c:v>4.1348499999999996E-2</c:v>
                </c:pt>
                <c:pt idx="7">
                  <c:v>4.1286500000000004E-2</c:v>
                </c:pt>
                <c:pt idx="8">
                  <c:v>4.1707250000000001E-2</c:v>
                </c:pt>
                <c:pt idx="9">
                  <c:v>4.1550249999999997E-2</c:v>
                </c:pt>
                <c:pt idx="10">
                  <c:v>4.1558249999999998E-2</c:v>
                </c:pt>
                <c:pt idx="11">
                  <c:v>4.1600499999999999E-2</c:v>
                </c:pt>
                <c:pt idx="12">
                  <c:v>4.2064749999999998E-2</c:v>
                </c:pt>
                <c:pt idx="13">
                  <c:v>4.2297500000000002E-2</c:v>
                </c:pt>
                <c:pt idx="14">
                  <c:v>4.2539E-2</c:v>
                </c:pt>
                <c:pt idx="15">
                  <c:v>4.32115E-2</c:v>
                </c:pt>
                <c:pt idx="16">
                  <c:v>4.4238E-2</c:v>
                </c:pt>
                <c:pt idx="17">
                  <c:v>4.5165250000000004E-2</c:v>
                </c:pt>
                <c:pt idx="18">
                  <c:v>4.6442249999999997E-2</c:v>
                </c:pt>
                <c:pt idx="19">
                  <c:v>4.8352249999999999E-2</c:v>
                </c:pt>
                <c:pt idx="20">
                  <c:v>5.0893000000000001E-2</c:v>
                </c:pt>
                <c:pt idx="21">
                  <c:v>5.3554999999999998E-2</c:v>
                </c:pt>
                <c:pt idx="22">
                  <c:v>5.6783249999999993E-2</c:v>
                </c:pt>
                <c:pt idx="23">
                  <c:v>6.0568000000000004E-2</c:v>
                </c:pt>
                <c:pt idx="24">
                  <c:v>6.4827499999999996E-2</c:v>
                </c:pt>
                <c:pt idx="25">
                  <c:v>6.9245749999999995E-2</c:v>
                </c:pt>
                <c:pt idx="26">
                  <c:v>7.3620750000000013E-2</c:v>
                </c:pt>
                <c:pt idx="27">
                  <c:v>7.752400000000001E-2</c:v>
                </c:pt>
                <c:pt idx="28">
                  <c:v>8.1137749999999995E-2</c:v>
                </c:pt>
                <c:pt idx="29">
                  <c:v>8.4009249999999994E-2</c:v>
                </c:pt>
                <c:pt idx="30">
                  <c:v>8.6354249999999994E-2</c:v>
                </c:pt>
                <c:pt idx="31">
                  <c:v>8.8086499999999998E-2</c:v>
                </c:pt>
                <c:pt idx="32">
                  <c:v>8.9766750000000006E-2</c:v>
                </c:pt>
                <c:pt idx="33">
                  <c:v>9.103725E-2</c:v>
                </c:pt>
                <c:pt idx="34">
                  <c:v>9.2412999999999995E-2</c:v>
                </c:pt>
                <c:pt idx="35">
                  <c:v>9.3762249999999991E-2</c:v>
                </c:pt>
                <c:pt idx="36">
                  <c:v>9.5038249999999991E-2</c:v>
                </c:pt>
                <c:pt idx="37">
                  <c:v>9.5647499999999996E-2</c:v>
                </c:pt>
                <c:pt idx="38">
                  <c:v>9.5811999999999994E-2</c:v>
                </c:pt>
                <c:pt idx="39">
                  <c:v>9.5543500000000003E-2</c:v>
                </c:pt>
                <c:pt idx="40">
                  <c:v>9.4834749999999995E-2</c:v>
                </c:pt>
                <c:pt idx="41">
                  <c:v>9.3301750000000003E-2</c:v>
                </c:pt>
                <c:pt idx="42">
                  <c:v>9.14045E-2</c:v>
                </c:pt>
                <c:pt idx="43">
                  <c:v>8.93375E-2</c:v>
                </c:pt>
                <c:pt idx="44">
                  <c:v>8.7358249999999998E-2</c:v>
                </c:pt>
                <c:pt idx="45">
                  <c:v>8.5508749999999994E-2</c:v>
                </c:pt>
                <c:pt idx="46">
                  <c:v>8.3978499999999998E-2</c:v>
                </c:pt>
                <c:pt idx="47">
                  <c:v>8.3032250000000002E-2</c:v>
                </c:pt>
                <c:pt idx="48">
                  <c:v>8.2196999999999992E-2</c:v>
                </c:pt>
                <c:pt idx="49">
                  <c:v>8.1542249999999997E-2</c:v>
                </c:pt>
                <c:pt idx="50">
                  <c:v>8.1104999999999997E-2</c:v>
                </c:pt>
                <c:pt idx="51">
                  <c:v>8.1086500000000006E-2</c:v>
                </c:pt>
                <c:pt idx="52">
                  <c:v>8.1102000000000007E-2</c:v>
                </c:pt>
                <c:pt idx="53">
                  <c:v>8.1089999999999995E-2</c:v>
                </c:pt>
                <c:pt idx="54">
                  <c:v>8.0985000000000001E-2</c:v>
                </c:pt>
                <c:pt idx="55">
                  <c:v>8.0415500000000001E-2</c:v>
                </c:pt>
                <c:pt idx="56">
                  <c:v>7.9452750000000003E-2</c:v>
                </c:pt>
                <c:pt idx="57">
                  <c:v>7.8357249999999989E-2</c:v>
                </c:pt>
                <c:pt idx="58">
                  <c:v>7.7116749999999998E-2</c:v>
                </c:pt>
                <c:pt idx="59">
                  <c:v>7.6058750000000008E-2</c:v>
                </c:pt>
                <c:pt idx="60">
                  <c:v>7.5208250000000004E-2</c:v>
                </c:pt>
                <c:pt idx="61">
                  <c:v>7.4844250000000001E-2</c:v>
                </c:pt>
                <c:pt idx="62">
                  <c:v>7.4914750000000002E-2</c:v>
                </c:pt>
                <c:pt idx="63">
                  <c:v>7.5366749999999996E-2</c:v>
                </c:pt>
                <c:pt idx="64">
                  <c:v>7.5818500000000011E-2</c:v>
                </c:pt>
                <c:pt idx="65">
                  <c:v>7.5718499999999994E-2</c:v>
                </c:pt>
                <c:pt idx="66">
                  <c:v>7.4980749999999999E-2</c:v>
                </c:pt>
                <c:pt idx="67">
                  <c:v>7.3527750000000003E-2</c:v>
                </c:pt>
                <c:pt idx="68">
                  <c:v>7.1748499999999993E-2</c:v>
                </c:pt>
                <c:pt idx="69">
                  <c:v>6.9842750000000009E-2</c:v>
                </c:pt>
                <c:pt idx="70">
                  <c:v>6.8092749999999994E-2</c:v>
                </c:pt>
                <c:pt idx="71">
                  <c:v>6.6696000000000005E-2</c:v>
                </c:pt>
                <c:pt idx="72">
                  <c:v>6.5428249999999993E-2</c:v>
                </c:pt>
                <c:pt idx="73">
                  <c:v>6.3890000000000002E-2</c:v>
                </c:pt>
                <c:pt idx="74">
                  <c:v>6.1906749999999997E-2</c:v>
                </c:pt>
                <c:pt idx="75">
                  <c:v>5.97875E-2</c:v>
                </c:pt>
                <c:pt idx="76">
                  <c:v>5.7710750000000005E-2</c:v>
                </c:pt>
                <c:pt idx="77">
                  <c:v>5.603375E-2</c:v>
                </c:pt>
                <c:pt idx="78">
                  <c:v>5.4939000000000002E-2</c:v>
                </c:pt>
                <c:pt idx="79">
                  <c:v>5.4551250000000003E-2</c:v>
                </c:pt>
                <c:pt idx="80">
                  <c:v>5.4674249999999994E-2</c:v>
                </c:pt>
                <c:pt idx="81">
                  <c:v>5.5664749999999999E-2</c:v>
                </c:pt>
                <c:pt idx="82">
                  <c:v>5.7898499999999999E-2</c:v>
                </c:pt>
                <c:pt idx="83">
                  <c:v>6.2427999999999997E-2</c:v>
                </c:pt>
                <c:pt idx="84">
                  <c:v>7.0466249999999994E-2</c:v>
                </c:pt>
                <c:pt idx="85">
                  <c:v>8.2476499999999994E-2</c:v>
                </c:pt>
                <c:pt idx="86">
                  <c:v>9.8300749999999992E-2</c:v>
                </c:pt>
                <c:pt idx="87">
                  <c:v>0.11687525000000001</c:v>
                </c:pt>
                <c:pt idx="88">
                  <c:v>0.136768</c:v>
                </c:pt>
                <c:pt idx="89">
                  <c:v>0.15580250000000001</c:v>
                </c:pt>
                <c:pt idx="90">
                  <c:v>0.1731705</c:v>
                </c:pt>
                <c:pt idx="91">
                  <c:v>0.1888715</c:v>
                </c:pt>
                <c:pt idx="92">
                  <c:v>0.20352225000000002</c:v>
                </c:pt>
                <c:pt idx="93">
                  <c:v>0.21727724999999998</c:v>
                </c:pt>
                <c:pt idx="94">
                  <c:v>0.23021775</c:v>
                </c:pt>
                <c:pt idx="95">
                  <c:v>0.24231750000000002</c:v>
                </c:pt>
                <c:pt idx="96">
                  <c:v>0.25373449999999997</c:v>
                </c:pt>
                <c:pt idx="97">
                  <c:v>0.26431150000000003</c:v>
                </c:pt>
                <c:pt idx="98">
                  <c:v>0.27379399999999998</c:v>
                </c:pt>
                <c:pt idx="99">
                  <c:v>0.2819275</c:v>
                </c:pt>
                <c:pt idx="100">
                  <c:v>0.28887425</c:v>
                </c:pt>
                <c:pt idx="101">
                  <c:v>0.2952515</c:v>
                </c:pt>
                <c:pt idx="102">
                  <c:v>0.30070150000000001</c:v>
                </c:pt>
                <c:pt idx="103">
                  <c:v>0.3050735</c:v>
                </c:pt>
                <c:pt idx="104">
                  <c:v>0.30825524999999998</c:v>
                </c:pt>
                <c:pt idx="105">
                  <c:v>0.31177949999999999</c:v>
                </c:pt>
                <c:pt idx="106">
                  <c:v>0.31478525000000002</c:v>
                </c:pt>
                <c:pt idx="107">
                  <c:v>0.31735950000000002</c:v>
                </c:pt>
                <c:pt idx="108">
                  <c:v>0.31944050000000002</c:v>
                </c:pt>
                <c:pt idx="109">
                  <c:v>0.32190950000000002</c:v>
                </c:pt>
                <c:pt idx="110">
                  <c:v>0.32380100000000001</c:v>
                </c:pt>
                <c:pt idx="111">
                  <c:v>0.32480825000000002</c:v>
                </c:pt>
                <c:pt idx="112">
                  <c:v>0.32628950000000001</c:v>
                </c:pt>
                <c:pt idx="113">
                  <c:v>0.32885300000000001</c:v>
                </c:pt>
                <c:pt idx="114">
                  <c:v>0.33053374999999996</c:v>
                </c:pt>
                <c:pt idx="115">
                  <c:v>0.33131349999999998</c:v>
                </c:pt>
                <c:pt idx="116">
                  <c:v>0.33174075000000003</c:v>
                </c:pt>
                <c:pt idx="117">
                  <c:v>0.33315824999999999</c:v>
                </c:pt>
                <c:pt idx="118">
                  <c:v>0.33350550000000001</c:v>
                </c:pt>
                <c:pt idx="119">
                  <c:v>0.33393600000000001</c:v>
                </c:pt>
                <c:pt idx="120">
                  <c:v>0.3335475</c:v>
                </c:pt>
                <c:pt idx="121">
                  <c:v>0.33378025</c:v>
                </c:pt>
                <c:pt idx="122">
                  <c:v>0.33442899999999998</c:v>
                </c:pt>
                <c:pt idx="123">
                  <c:v>0.33453549999999999</c:v>
                </c:pt>
                <c:pt idx="124">
                  <c:v>0.33479575</c:v>
                </c:pt>
                <c:pt idx="125">
                  <c:v>0.33517025</c:v>
                </c:pt>
                <c:pt idx="126">
                  <c:v>0.33609900000000004</c:v>
                </c:pt>
                <c:pt idx="127">
                  <c:v>0.33643475</c:v>
                </c:pt>
                <c:pt idx="128">
                  <c:v>0.33707424999999996</c:v>
                </c:pt>
                <c:pt idx="129">
                  <c:v>0.33804725000000002</c:v>
                </c:pt>
                <c:pt idx="130">
                  <c:v>0.33750100000000005</c:v>
                </c:pt>
                <c:pt idx="131">
                  <c:v>0.33680525000000006</c:v>
                </c:pt>
                <c:pt idx="132">
                  <c:v>0.33819375000000002</c:v>
                </c:pt>
                <c:pt idx="133">
                  <c:v>0.34023550000000002</c:v>
                </c:pt>
                <c:pt idx="134">
                  <c:v>0.34088600000000002</c:v>
                </c:pt>
                <c:pt idx="135">
                  <c:v>0.34166325000000003</c:v>
                </c:pt>
                <c:pt idx="136">
                  <c:v>0.34369675</c:v>
                </c:pt>
                <c:pt idx="137">
                  <c:v>0.34536600000000001</c:v>
                </c:pt>
                <c:pt idx="138">
                  <c:v>0.34753724999999996</c:v>
                </c:pt>
                <c:pt idx="139">
                  <c:v>0.3498909999999999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8AE6-43D8-A424-CF1383F2B8E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84320368"/>
        <c:axId val="1682741776"/>
      </c:scatterChart>
      <c:valAx>
        <c:axId val="484320368"/>
        <c:scaling>
          <c:orientation val="minMax"/>
          <c:max val="850"/>
          <c:min val="45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Wavelength [nm]</a:t>
                </a:r>
              </a:p>
            </c:rich>
          </c:tx>
          <c:layout>
            <c:manualLayout>
              <c:xMode val="edge"/>
              <c:yMode val="edge"/>
              <c:x val="0.41624912510936141"/>
              <c:y val="0.9144917908883436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2741776"/>
        <c:crosses val="autoZero"/>
        <c:crossBetween val="midCat"/>
      </c:valAx>
      <c:valAx>
        <c:axId val="168274177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Reflectance [%/100]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84320368"/>
        <c:crosses val="autoZero"/>
        <c:crossBetween val="midCat"/>
        <c:majorUnit val="0.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757442481851931"/>
          <c:y val="5.2681992337164751E-2"/>
          <c:w val="0.7102634130193185"/>
          <c:h val="0.75952235496425013"/>
        </c:manualLayout>
      </c:layout>
      <c:scatterChart>
        <c:scatterStyle val="lineMarker"/>
        <c:varyColors val="0"/>
        <c:ser>
          <c:idx val="0"/>
          <c:order val="0"/>
          <c:tx>
            <c:strRef>
              <c:f>'Correlation per genotype'!$F$56</c:f>
              <c:strCache>
                <c:ptCount val="1"/>
                <c:pt idx="0">
                  <c:v>No. of conidia per lesion area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square"/>
            <c:size val="5"/>
            <c:spPr>
              <a:noFill/>
              <a:ln w="12700">
                <a:solidFill>
                  <a:schemeClr val="tx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9050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4.1817407959140246E-3"/>
                  <c:y val="-0.18539498295471687"/>
                </c:manualLayout>
              </c:layout>
              <c:numFmt formatCode="#,##0.000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200" b="0" i="0" u="none" strike="noStrike" kern="1200" baseline="0">
                      <a:solidFill>
                        <a:sysClr val="windowText" lastClr="000000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</c:trendlineLbl>
          </c:trendline>
          <c:xVal>
            <c:numRef>
              <c:f>'Correlation per genotype'!$D$57:$D$64</c:f>
              <c:numCache>
                <c:formatCode>General</c:formatCode>
                <c:ptCount val="8"/>
                <c:pt idx="0">
                  <c:v>8.8053399999999904</c:v>
                </c:pt>
                <c:pt idx="1">
                  <c:v>9.163365000000006</c:v>
                </c:pt>
                <c:pt idx="2">
                  <c:v>12.044175999999979</c:v>
                </c:pt>
                <c:pt idx="3">
                  <c:v>11.557476999999988</c:v>
                </c:pt>
                <c:pt idx="4">
                  <c:v>12.509151999999993</c:v>
                </c:pt>
                <c:pt idx="5">
                  <c:v>10.723353000000003</c:v>
                </c:pt>
                <c:pt idx="6">
                  <c:v>15.357332999999993</c:v>
                </c:pt>
                <c:pt idx="7">
                  <c:v>15.466359999999998</c:v>
                </c:pt>
              </c:numCache>
            </c:numRef>
          </c:xVal>
          <c:yVal>
            <c:numRef>
              <c:f>'Correlation per genotype'!$F$57:$F$64</c:f>
              <c:numCache>
                <c:formatCode>General</c:formatCode>
                <c:ptCount val="8"/>
                <c:pt idx="0">
                  <c:v>714.28571428571433</c:v>
                </c:pt>
                <c:pt idx="1">
                  <c:v>1022.7272727272727</c:v>
                </c:pt>
                <c:pt idx="2">
                  <c:v>1111.1111111111111</c:v>
                </c:pt>
                <c:pt idx="3">
                  <c:v>1015.625</c:v>
                </c:pt>
                <c:pt idx="4">
                  <c:v>989.58333333333337</c:v>
                </c:pt>
                <c:pt idx="5">
                  <c:v>1250</c:v>
                </c:pt>
                <c:pt idx="6">
                  <c:v>1944.4444444444443</c:v>
                </c:pt>
                <c:pt idx="7">
                  <c:v>15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D695-4EEA-BA50-F84DED71916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61514752"/>
        <c:axId val="261516672"/>
      </c:scatterChart>
      <c:valAx>
        <c:axId val="261514752"/>
        <c:scaling>
          <c:orientation val="minMax"/>
          <c:max val="25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/>
                  <a:t>Area under difference spectrum  [%/100 . nm]</a:t>
                </a:r>
                <a:endParaRPr lang="en-US"/>
              </a:p>
            </c:rich>
          </c:tx>
          <c:layout>
            <c:manualLayout>
              <c:xMode val="edge"/>
              <c:yMode val="edge"/>
              <c:x val="0.18252937977347425"/>
              <c:y val="0.8970306513409963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61516672"/>
        <c:crosses val="autoZero"/>
        <c:crossBetween val="midCat"/>
        <c:majorUnit val="5"/>
      </c:valAx>
      <c:valAx>
        <c:axId val="261516672"/>
        <c:scaling>
          <c:orientation val="minMax"/>
          <c:max val="400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 dirty="0" err="1"/>
                  <a:t>No</a:t>
                </a:r>
                <a:r>
                  <a:rPr lang="de-DE" dirty="0"/>
                  <a:t>. </a:t>
                </a:r>
                <a:r>
                  <a:rPr lang="de-DE" dirty="0" err="1"/>
                  <a:t>conidia</a:t>
                </a:r>
                <a:r>
                  <a:rPr lang="de-DE" dirty="0"/>
                  <a:t> per </a:t>
                </a:r>
                <a:r>
                  <a:rPr lang="de-DE" dirty="0" err="1"/>
                  <a:t>lesion</a:t>
                </a:r>
                <a:r>
                  <a:rPr lang="de-DE" dirty="0"/>
                  <a:t> </a:t>
                </a:r>
                <a:r>
                  <a:rPr lang="de-DE" dirty="0" err="1"/>
                  <a:t>area</a:t>
                </a:r>
                <a:r>
                  <a:rPr lang="de-DE" dirty="0"/>
                  <a:t>  [mm-</a:t>
                </a:r>
                <a:r>
                  <a:rPr lang="de-DE" baseline="30000" dirty="0"/>
                  <a:t>2</a:t>
                </a:r>
                <a:r>
                  <a:rPr lang="de-DE" dirty="0"/>
                  <a:t>]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#,##0" sourceLinked="0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6151475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3175">
      <a:solidFill>
        <a:schemeClr val="tx1"/>
      </a:solidFill>
    </a:ln>
    <a:effectLst/>
  </c:spPr>
  <c:txPr>
    <a:bodyPr/>
    <a:lstStyle/>
    <a:p>
      <a:pPr>
        <a:defRPr sz="12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071425925925926"/>
          <c:y val="4.535714285714286E-2"/>
          <c:w val="0.74754506172839508"/>
          <c:h val="0.75954801587301601"/>
        </c:manualLayout>
      </c:layout>
      <c:scatterChart>
        <c:scatterStyle val="lineMarker"/>
        <c:varyColors val="0"/>
        <c:ser>
          <c:idx val="1"/>
          <c:order val="0"/>
          <c:spPr>
            <a:ln w="19050">
              <a:noFill/>
            </a:ln>
          </c:spPr>
          <c:marker>
            <c:symbol val="circle"/>
            <c:size val="6"/>
            <c:spPr>
              <a:noFill/>
              <a:ln w="12700">
                <a:solidFill>
                  <a:schemeClr val="tx1"/>
                </a:solidFill>
              </a:ln>
            </c:spPr>
          </c:marker>
          <c:trendline>
            <c:trendlineType val="linear"/>
            <c:dispRSqr val="1"/>
            <c:dispEq val="1"/>
            <c:trendlineLbl>
              <c:layout>
                <c:manualLayout>
                  <c:x val="-0.27550690454233762"/>
                  <c:y val="0.13032929073520982"/>
                </c:manualLayout>
              </c:layout>
              <c:numFmt formatCode="#,##0.000" sourceLinked="0"/>
            </c:trendlineLbl>
          </c:trendline>
          <c:xVal>
            <c:numRef>
              <c:f>AUDS_condia!$D$41:$D$56</c:f>
              <c:numCache>
                <c:formatCode>General</c:formatCode>
                <c:ptCount val="16"/>
                <c:pt idx="0">
                  <c:v>9.9876570000000271</c:v>
                </c:pt>
                <c:pt idx="1">
                  <c:v>12.53045999999998</c:v>
                </c:pt>
                <c:pt idx="2">
                  <c:v>9.7414430000000003</c:v>
                </c:pt>
                <c:pt idx="3">
                  <c:v>11.620011000000005</c:v>
                </c:pt>
                <c:pt idx="4">
                  <c:v>12.457256999999998</c:v>
                </c:pt>
                <c:pt idx="5">
                  <c:v>13.585542</c:v>
                </c:pt>
                <c:pt idx="6">
                  <c:v>14.259430999999974</c:v>
                </c:pt>
                <c:pt idx="7">
                  <c:v>9.0177570000000102</c:v>
                </c:pt>
                <c:pt idx="8">
                  <c:v>16.779368000000009</c:v>
                </c:pt>
                <c:pt idx="9">
                  <c:v>17.790261000000005</c:v>
                </c:pt>
                <c:pt idx="10">
                  <c:v>15.15408099999998</c:v>
                </c:pt>
                <c:pt idx="11">
                  <c:v>23.190562000000014</c:v>
                </c:pt>
                <c:pt idx="12">
                  <c:v>15.799911000000005</c:v>
                </c:pt>
                <c:pt idx="13">
                  <c:v>11.743462000000015</c:v>
                </c:pt>
                <c:pt idx="14">
                  <c:v>8.8528110000000133</c:v>
                </c:pt>
                <c:pt idx="15">
                  <c:v>19.803377000000001</c:v>
                </c:pt>
              </c:numCache>
            </c:numRef>
          </c:xVal>
          <c:yVal>
            <c:numRef>
              <c:f>AUDS_condia!$F$41:$F$56</c:f>
              <c:numCache>
                <c:formatCode>General</c:formatCode>
                <c:ptCount val="16"/>
                <c:pt idx="0">
                  <c:v>2031.25</c:v>
                </c:pt>
                <c:pt idx="1">
                  <c:v>1875</c:v>
                </c:pt>
                <c:pt idx="2">
                  <c:v>1093.75</c:v>
                </c:pt>
                <c:pt idx="3">
                  <c:v>1750</c:v>
                </c:pt>
                <c:pt idx="4">
                  <c:v>1944.4444444444443</c:v>
                </c:pt>
                <c:pt idx="5">
                  <c:v>3035.7142857142858</c:v>
                </c:pt>
                <c:pt idx="6">
                  <c:v>1964.2857142857142</c:v>
                </c:pt>
                <c:pt idx="7">
                  <c:v>833.33333333333337</c:v>
                </c:pt>
                <c:pt idx="8">
                  <c:v>2968.75</c:v>
                </c:pt>
                <c:pt idx="9">
                  <c:v>2500</c:v>
                </c:pt>
                <c:pt idx="10">
                  <c:v>2750</c:v>
                </c:pt>
                <c:pt idx="11">
                  <c:v>3541.6666666666665</c:v>
                </c:pt>
                <c:pt idx="12">
                  <c:v>1916.6666666666667</c:v>
                </c:pt>
                <c:pt idx="13">
                  <c:v>1130.952380952381</c:v>
                </c:pt>
                <c:pt idx="14">
                  <c:v>1562.5</c:v>
                </c:pt>
                <c:pt idx="15">
                  <c:v>2187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34E5-4DBC-A56F-2FEFB2EAE07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5590784"/>
        <c:axId val="176305664"/>
      </c:scatterChart>
      <c:valAx>
        <c:axId val="175590784"/>
        <c:scaling>
          <c:orientation val="minMax"/>
          <c:max val="25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GB"/>
                  <a:t>Area under difference spectrum  [%/100 . nm]</a:t>
                </a:r>
              </a:p>
            </c:rich>
          </c:tx>
          <c:layout>
            <c:manualLayout>
              <c:xMode val="edge"/>
              <c:yMode val="edge"/>
              <c:x val="0.19930308641975308"/>
              <c:y val="0.89416666666666644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crossAx val="176305664"/>
        <c:crosses val="autoZero"/>
        <c:crossBetween val="midCat"/>
        <c:majorUnit val="5"/>
      </c:valAx>
      <c:valAx>
        <c:axId val="176305664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GB" dirty="0"/>
                  <a:t>No. conidia per lesion area [mm</a:t>
                </a:r>
                <a:r>
                  <a:rPr lang="en-GB" baseline="30000" dirty="0"/>
                  <a:t>-2</a:t>
                </a:r>
                <a:r>
                  <a:rPr lang="en-GB" dirty="0"/>
                  <a:t>]</a:t>
                </a:r>
              </a:p>
            </c:rich>
          </c:tx>
          <c:layout>
            <c:manualLayout>
              <c:xMode val="edge"/>
              <c:yMode val="edge"/>
              <c:x val="1.5679012345679012E-2"/>
              <c:y val="7.559523809523809E-2"/>
            </c:manualLayout>
          </c:layout>
          <c:overlay val="0"/>
        </c:title>
        <c:numFmt formatCode="#,##0" sourceLinked="0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crossAx val="175590784"/>
        <c:crosses val="autoZero"/>
        <c:crossBetween val="midCat"/>
      </c:valAx>
    </c:plotArea>
    <c:plotVisOnly val="1"/>
    <c:dispBlanksAs val="gap"/>
    <c:showDLblsOverMax val="0"/>
  </c:chart>
  <c:spPr>
    <a:ln>
      <a:solidFill>
        <a:schemeClr val="tx1"/>
      </a:solidFill>
    </a:ln>
  </c:spPr>
  <c:txPr>
    <a:bodyPr/>
    <a:lstStyle/>
    <a:p>
      <a:pPr>
        <a:defRPr sz="1200" b="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071425925925926"/>
          <c:y val="5.5436507936507937E-2"/>
          <c:w val="0.72986697530864197"/>
          <c:h val="0.74672222222222218"/>
        </c:manualLayout>
      </c:layout>
      <c:scatterChart>
        <c:scatterStyle val="lineMarker"/>
        <c:varyColors val="0"/>
        <c:ser>
          <c:idx val="1"/>
          <c:order val="0"/>
          <c:spPr>
            <a:ln w="19050">
              <a:noFill/>
            </a:ln>
          </c:spPr>
          <c:marker>
            <c:symbol val="circle"/>
            <c:size val="6"/>
            <c:spPr>
              <a:noFill/>
              <a:ln>
                <a:solidFill>
                  <a:schemeClr val="tx1"/>
                </a:solidFill>
              </a:ln>
            </c:spPr>
          </c:marker>
          <c:trendline>
            <c:spPr>
              <a:ln w="12700"/>
            </c:spPr>
            <c:trendlineType val="linear"/>
            <c:dispRSqr val="1"/>
            <c:dispEq val="1"/>
            <c:trendlineLbl>
              <c:layout>
                <c:manualLayout>
                  <c:x val="-2.9849140479061738E-2"/>
                  <c:y val="-0.23435906718556732"/>
                </c:manualLayout>
              </c:layout>
              <c:numFmt formatCode="#,##0.000" sourceLinked="0"/>
            </c:trendlineLbl>
          </c:trendline>
          <c:trendline>
            <c:trendlineType val="exp"/>
            <c:dispRSqr val="1"/>
            <c:dispEq val="1"/>
            <c:trendlineLbl>
              <c:layout>
                <c:manualLayout>
                  <c:x val="0.30643074176538743"/>
                  <c:y val="0.12928093040094127"/>
                </c:manualLayout>
              </c:layout>
              <c:numFmt formatCode="#,##0.000" sourceLinked="0"/>
            </c:trendlineLbl>
          </c:trendline>
          <c:xVal>
            <c:numRef>
              <c:f>AUDS_condia!$D$59:$D$74</c:f>
              <c:numCache>
                <c:formatCode>General</c:formatCode>
                <c:ptCount val="16"/>
                <c:pt idx="0">
                  <c:v>4.5667830000000151</c:v>
                </c:pt>
                <c:pt idx="1">
                  <c:v>6.1891310000000068</c:v>
                </c:pt>
                <c:pt idx="2">
                  <c:v>6.2370510000000046</c:v>
                </c:pt>
                <c:pt idx="3">
                  <c:v>14.777808000000014</c:v>
                </c:pt>
                <c:pt idx="4">
                  <c:v>12.467093000000002</c:v>
                </c:pt>
                <c:pt idx="5">
                  <c:v>2.1453170000000092</c:v>
                </c:pt>
                <c:pt idx="6">
                  <c:v>8.9180520000000136</c:v>
                </c:pt>
                <c:pt idx="7">
                  <c:v>8.8514039999999987</c:v>
                </c:pt>
                <c:pt idx="8">
                  <c:v>8.8053399999999904</c:v>
                </c:pt>
                <c:pt idx="9">
                  <c:v>9.163365000000006</c:v>
                </c:pt>
                <c:pt idx="10">
                  <c:v>12.044175999999979</c:v>
                </c:pt>
                <c:pt idx="11">
                  <c:v>11.557476999999988</c:v>
                </c:pt>
                <c:pt idx="12">
                  <c:v>12.509151999999993</c:v>
                </c:pt>
                <c:pt idx="13">
                  <c:v>10.723353000000003</c:v>
                </c:pt>
                <c:pt idx="14">
                  <c:v>15.357332999999993</c:v>
                </c:pt>
                <c:pt idx="15">
                  <c:v>15.466359999999998</c:v>
                </c:pt>
              </c:numCache>
            </c:numRef>
          </c:xVal>
          <c:yVal>
            <c:numRef>
              <c:f>AUDS_condia!$F$59:$F$74</c:f>
              <c:numCache>
                <c:formatCode>General</c:formatCode>
                <c:ptCount val="16"/>
                <c:pt idx="0">
                  <c:v>625</c:v>
                </c:pt>
                <c:pt idx="1">
                  <c:v>1250</c:v>
                </c:pt>
                <c:pt idx="2">
                  <c:v>833.33333333333337</c:v>
                </c:pt>
                <c:pt idx="3">
                  <c:v>1406.25</c:v>
                </c:pt>
                <c:pt idx="4">
                  <c:v>1145.8333333333333</c:v>
                </c:pt>
                <c:pt idx="5">
                  <c:v>625</c:v>
                </c:pt>
                <c:pt idx="6">
                  <c:v>1041.6666666666667</c:v>
                </c:pt>
                <c:pt idx="7">
                  <c:v>1250</c:v>
                </c:pt>
                <c:pt idx="8">
                  <c:v>714.28571428571433</c:v>
                </c:pt>
                <c:pt idx="9">
                  <c:v>1022.7272727272727</c:v>
                </c:pt>
                <c:pt idx="10">
                  <c:v>1111.1111111111111</c:v>
                </c:pt>
                <c:pt idx="11">
                  <c:v>1015.625</c:v>
                </c:pt>
                <c:pt idx="12">
                  <c:v>989.58333333333337</c:v>
                </c:pt>
                <c:pt idx="13">
                  <c:v>1250</c:v>
                </c:pt>
                <c:pt idx="14">
                  <c:v>1944.4444444444443</c:v>
                </c:pt>
                <c:pt idx="15">
                  <c:v>15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6E57-4E22-906E-971177CC29F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35551360"/>
        <c:axId val="235604608"/>
      </c:scatterChart>
      <c:valAx>
        <c:axId val="235551360"/>
        <c:scaling>
          <c:orientation val="minMax"/>
          <c:max val="25"/>
          <c:min val="0"/>
        </c:scaling>
        <c:delete val="0"/>
        <c:axPos val="b"/>
        <c:title>
          <c:tx>
            <c:rich>
              <a:bodyPr/>
              <a:lstStyle/>
              <a:p>
                <a:pPr algn="ctr" rtl="0">
                  <a:defRPr/>
                </a:pPr>
                <a:r>
                  <a:rPr lang="en-GB"/>
                  <a:t>Area under difference spectrum  [%/100 . nm]</a:t>
                </a:r>
              </a:p>
            </c:rich>
          </c:tx>
          <c:layout>
            <c:manualLayout>
              <c:xMode val="edge"/>
              <c:yMode val="edge"/>
              <c:x val="0.19946915419356365"/>
              <c:y val="0.89288284007602503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crossAx val="235604608"/>
        <c:crosses val="autoZero"/>
        <c:crossBetween val="midCat"/>
        <c:majorUnit val="5"/>
      </c:valAx>
      <c:valAx>
        <c:axId val="235604608"/>
        <c:scaling>
          <c:orientation val="minMax"/>
          <c:max val="4000"/>
          <c:min val="0"/>
        </c:scaling>
        <c:delete val="0"/>
        <c:axPos val="l"/>
        <c:title>
          <c:tx>
            <c:rich>
              <a:bodyPr/>
              <a:lstStyle/>
              <a:p>
                <a:pPr algn="ctr" rtl="0">
                  <a:defRPr/>
                </a:pPr>
                <a:r>
                  <a:rPr lang="en-GB" dirty="0"/>
                  <a:t>No. conidia per lesion area [mm</a:t>
                </a:r>
                <a:r>
                  <a:rPr lang="en-GB" baseline="30000" dirty="0"/>
                  <a:t>-2</a:t>
                </a:r>
                <a:r>
                  <a:rPr lang="en-GB" dirty="0"/>
                  <a:t>]</a:t>
                </a:r>
              </a:p>
            </c:rich>
          </c:tx>
          <c:layout>
            <c:manualLayout>
              <c:xMode val="edge"/>
              <c:yMode val="edge"/>
              <c:x val="1.5679012345679012E-2"/>
              <c:y val="6.5515873015873013E-2"/>
            </c:manualLayout>
          </c:layout>
          <c:overlay val="0"/>
        </c:title>
        <c:numFmt formatCode="#,##0" sourceLinked="0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crossAx val="235551360"/>
        <c:crosses val="autoZero"/>
        <c:crossBetween val="midCat"/>
      </c:valAx>
    </c:plotArea>
    <c:plotVisOnly val="1"/>
    <c:dispBlanksAs val="gap"/>
    <c:showDLblsOverMax val="0"/>
  </c:chart>
  <c:spPr>
    <a:ln>
      <a:solidFill>
        <a:schemeClr val="tx1"/>
      </a:solidFill>
    </a:ln>
  </c:spPr>
  <c:txPr>
    <a:bodyPr/>
    <a:lstStyle/>
    <a:p>
      <a:pPr>
        <a:defRPr sz="1200" b="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9538333333333333"/>
          <c:y val="7.0555555555555552E-2"/>
          <c:w val="0.75930432098765432"/>
          <c:h val="0.72729093130600042"/>
        </c:manualLayout>
      </c:layout>
      <c:scatterChart>
        <c:scatterStyle val="lineMarker"/>
        <c:varyColors val="0"/>
        <c:ser>
          <c:idx val="1"/>
          <c:order val="0"/>
          <c:spPr>
            <a:ln w="19050">
              <a:noFill/>
            </a:ln>
          </c:spPr>
          <c:marker>
            <c:symbol val="circle"/>
            <c:size val="6"/>
            <c:spPr>
              <a:noFill/>
              <a:ln w="12700">
                <a:solidFill>
                  <a:schemeClr val="tx1"/>
                </a:solidFill>
              </a:ln>
            </c:spPr>
          </c:marker>
          <c:trendline>
            <c:spPr>
              <a:ln w="12700"/>
            </c:spPr>
            <c:trendlineType val="linear"/>
            <c:dispRSqr val="1"/>
            <c:dispEq val="1"/>
            <c:trendlineLbl>
              <c:layout>
                <c:manualLayout>
                  <c:x val="1.7285001536970041E-3"/>
                  <c:y val="-0.10056717048299997"/>
                </c:manualLayout>
              </c:layout>
              <c:numFmt formatCode="#,##0.000" sourceLinked="0"/>
            </c:trendlineLbl>
          </c:trendline>
          <c:xVal>
            <c:numRef>
              <c:f>AUDS_condia!$D$81:$D$96</c:f>
              <c:numCache>
                <c:formatCode>General</c:formatCode>
                <c:ptCount val="16"/>
                <c:pt idx="0">
                  <c:v>9.9876570000000271</c:v>
                </c:pt>
                <c:pt idx="1">
                  <c:v>12.53045999999998</c:v>
                </c:pt>
                <c:pt idx="2">
                  <c:v>9.7414430000000003</c:v>
                </c:pt>
                <c:pt idx="3">
                  <c:v>11.620011000000005</c:v>
                </c:pt>
                <c:pt idx="4">
                  <c:v>12.457256999999998</c:v>
                </c:pt>
                <c:pt idx="5">
                  <c:v>13.585542</c:v>
                </c:pt>
                <c:pt idx="6">
                  <c:v>14.259430999999974</c:v>
                </c:pt>
                <c:pt idx="7">
                  <c:v>9.0177570000000102</c:v>
                </c:pt>
                <c:pt idx="8">
                  <c:v>4.5667830000000151</c:v>
                </c:pt>
                <c:pt idx="9">
                  <c:v>6.1891310000000068</c:v>
                </c:pt>
                <c:pt idx="10">
                  <c:v>6.2370510000000046</c:v>
                </c:pt>
                <c:pt idx="11">
                  <c:v>14.777808000000014</c:v>
                </c:pt>
                <c:pt idx="12">
                  <c:v>12.467093000000002</c:v>
                </c:pt>
                <c:pt idx="13">
                  <c:v>2.1453170000000092</c:v>
                </c:pt>
                <c:pt idx="14">
                  <c:v>8.9180520000000136</c:v>
                </c:pt>
                <c:pt idx="15">
                  <c:v>8.8514039999999987</c:v>
                </c:pt>
              </c:numCache>
            </c:numRef>
          </c:xVal>
          <c:yVal>
            <c:numRef>
              <c:f>AUDS_condia!$F$81:$F$96</c:f>
              <c:numCache>
                <c:formatCode>General</c:formatCode>
                <c:ptCount val="16"/>
                <c:pt idx="0">
                  <c:v>2031.25</c:v>
                </c:pt>
                <c:pt idx="1">
                  <c:v>1875</c:v>
                </c:pt>
                <c:pt idx="2">
                  <c:v>1093.75</c:v>
                </c:pt>
                <c:pt idx="3">
                  <c:v>1750</c:v>
                </c:pt>
                <c:pt idx="4">
                  <c:v>1944.4444444444443</c:v>
                </c:pt>
                <c:pt idx="5">
                  <c:v>3035.7142857142858</c:v>
                </c:pt>
                <c:pt idx="6">
                  <c:v>1964.2857142857142</c:v>
                </c:pt>
                <c:pt idx="7">
                  <c:v>833.33333333333337</c:v>
                </c:pt>
                <c:pt idx="8">
                  <c:v>625</c:v>
                </c:pt>
                <c:pt idx="9">
                  <c:v>1250</c:v>
                </c:pt>
                <c:pt idx="10">
                  <c:v>833.33333333333337</c:v>
                </c:pt>
                <c:pt idx="11">
                  <c:v>1406.25</c:v>
                </c:pt>
                <c:pt idx="12">
                  <c:v>1145.8333333333333</c:v>
                </c:pt>
                <c:pt idx="13">
                  <c:v>625</c:v>
                </c:pt>
                <c:pt idx="14">
                  <c:v>1041.6666666666667</c:v>
                </c:pt>
                <c:pt idx="15">
                  <c:v>125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B9FA-4CEE-BF75-2A12E13C2E6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22836224"/>
        <c:axId val="235559552"/>
      </c:scatterChart>
      <c:valAx>
        <c:axId val="222836224"/>
        <c:scaling>
          <c:orientation val="minMax"/>
          <c:max val="25"/>
          <c:min val="0"/>
        </c:scaling>
        <c:delete val="0"/>
        <c:axPos val="b"/>
        <c:title>
          <c:tx>
            <c:rich>
              <a:bodyPr/>
              <a:lstStyle/>
              <a:p>
                <a:pPr algn="ctr" rtl="0">
                  <a:defRPr/>
                </a:pPr>
                <a:r>
                  <a:rPr lang="en-GB"/>
                  <a:t>Area under difference spectrum  [%/100 . nm]</a:t>
                </a:r>
              </a:p>
            </c:rich>
          </c:tx>
          <c:layout>
            <c:manualLayout>
              <c:xMode val="edge"/>
              <c:yMode val="edge"/>
              <c:x val="0.19830696838570855"/>
              <c:y val="0.8959351525024889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crossAx val="235559552"/>
        <c:crosses val="autoZero"/>
        <c:crossBetween val="midCat"/>
        <c:majorUnit val="5"/>
      </c:valAx>
      <c:valAx>
        <c:axId val="235559552"/>
        <c:scaling>
          <c:orientation val="minMax"/>
          <c:max val="4000"/>
          <c:min val="0"/>
        </c:scaling>
        <c:delete val="0"/>
        <c:axPos val="l"/>
        <c:title>
          <c:tx>
            <c:rich>
              <a:bodyPr/>
              <a:lstStyle/>
              <a:p>
                <a:pPr algn="ctr" rtl="0">
                  <a:defRPr/>
                </a:pPr>
                <a:r>
                  <a:rPr lang="en-GB" dirty="0"/>
                  <a:t>No. conidia per lesion area [mm</a:t>
                </a:r>
                <a:r>
                  <a:rPr lang="en-GB" baseline="30000" dirty="0"/>
                  <a:t>-2</a:t>
                </a:r>
                <a:r>
                  <a:rPr lang="en-GB" dirty="0"/>
                  <a:t>]</a:t>
                </a:r>
              </a:p>
            </c:rich>
          </c:tx>
          <c:layout>
            <c:manualLayout>
              <c:xMode val="edge"/>
              <c:yMode val="edge"/>
              <c:x val="1.5679012345679012E-2"/>
              <c:y val="7.0555555555555552E-2"/>
            </c:manualLayout>
          </c:layout>
          <c:overlay val="0"/>
        </c:title>
        <c:numFmt formatCode="#,##0" sourceLinked="0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crossAx val="222836224"/>
        <c:crosses val="autoZero"/>
        <c:crossBetween val="midCat"/>
      </c:valAx>
    </c:plotArea>
    <c:plotVisOnly val="1"/>
    <c:dispBlanksAs val="gap"/>
    <c:showDLblsOverMax val="0"/>
  </c:chart>
  <c:spPr>
    <a:ln>
      <a:solidFill>
        <a:schemeClr val="tx1"/>
      </a:solidFill>
    </a:ln>
  </c:spPr>
  <c:txPr>
    <a:bodyPr/>
    <a:lstStyle/>
    <a:p>
      <a:pPr>
        <a:defRPr sz="1200" b="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071425925925926"/>
          <c:y val="5.5436507936507937E-2"/>
          <c:w val="0.72794629629629626"/>
          <c:h val="0.75123729145925722"/>
        </c:manualLayout>
      </c:layout>
      <c:scatterChart>
        <c:scatterStyle val="lineMarker"/>
        <c:varyColors val="0"/>
        <c:ser>
          <c:idx val="1"/>
          <c:order val="0"/>
          <c:spPr>
            <a:ln w="19050">
              <a:noFill/>
            </a:ln>
          </c:spPr>
          <c:marker>
            <c:symbol val="circle"/>
            <c:size val="6"/>
            <c:spPr>
              <a:noFill/>
              <a:ln>
                <a:solidFill>
                  <a:schemeClr val="tx1"/>
                </a:solidFill>
              </a:ln>
            </c:spPr>
          </c:marker>
          <c:trendline>
            <c:spPr>
              <a:ln w="12700"/>
            </c:spPr>
            <c:trendlineType val="linear"/>
            <c:dispRSqr val="1"/>
            <c:dispEq val="1"/>
            <c:trendlineLbl>
              <c:layout>
                <c:manualLayout>
                  <c:x val="-0.23837016150008275"/>
                  <c:y val="0.12553398497601592"/>
                </c:manualLayout>
              </c:layout>
              <c:numFmt formatCode="#,##0.000" sourceLinked="0"/>
            </c:trendlineLbl>
          </c:trendline>
          <c:xVal>
            <c:numRef>
              <c:f>AUDS_condia!$D$100:$D$115</c:f>
              <c:numCache>
                <c:formatCode>General</c:formatCode>
                <c:ptCount val="16"/>
                <c:pt idx="0">
                  <c:v>16.779368000000009</c:v>
                </c:pt>
                <c:pt idx="1">
                  <c:v>17.790261000000005</c:v>
                </c:pt>
                <c:pt idx="2">
                  <c:v>15.15408099999998</c:v>
                </c:pt>
                <c:pt idx="3">
                  <c:v>23.190562000000014</c:v>
                </c:pt>
                <c:pt idx="4">
                  <c:v>15.799911000000005</c:v>
                </c:pt>
                <c:pt idx="5">
                  <c:v>11.743462000000015</c:v>
                </c:pt>
                <c:pt idx="6">
                  <c:v>8.8528110000000133</c:v>
                </c:pt>
                <c:pt idx="7">
                  <c:v>19.803377000000001</c:v>
                </c:pt>
                <c:pt idx="8">
                  <c:v>8.8053399999999904</c:v>
                </c:pt>
                <c:pt idx="9">
                  <c:v>9.163365000000006</c:v>
                </c:pt>
                <c:pt idx="10">
                  <c:v>12.044175999999979</c:v>
                </c:pt>
                <c:pt idx="11">
                  <c:v>11.557476999999988</c:v>
                </c:pt>
                <c:pt idx="12">
                  <c:v>12.509151999999993</c:v>
                </c:pt>
                <c:pt idx="13">
                  <c:v>10.723353000000003</c:v>
                </c:pt>
                <c:pt idx="14">
                  <c:v>15.357332999999993</c:v>
                </c:pt>
                <c:pt idx="15">
                  <c:v>15.466359999999998</c:v>
                </c:pt>
              </c:numCache>
            </c:numRef>
          </c:xVal>
          <c:yVal>
            <c:numRef>
              <c:f>AUDS_condia!$F$100:$F$115</c:f>
              <c:numCache>
                <c:formatCode>General</c:formatCode>
                <c:ptCount val="16"/>
                <c:pt idx="0">
                  <c:v>2968.75</c:v>
                </c:pt>
                <c:pt idx="1">
                  <c:v>2500</c:v>
                </c:pt>
                <c:pt idx="2">
                  <c:v>2750</c:v>
                </c:pt>
                <c:pt idx="3">
                  <c:v>3541.6666666666665</c:v>
                </c:pt>
                <c:pt idx="4">
                  <c:v>1916.6666666666667</c:v>
                </c:pt>
                <c:pt idx="5">
                  <c:v>1130.952380952381</c:v>
                </c:pt>
                <c:pt idx="6">
                  <c:v>1562.5</c:v>
                </c:pt>
                <c:pt idx="7">
                  <c:v>2187.5</c:v>
                </c:pt>
                <c:pt idx="8">
                  <c:v>714.28571428571433</c:v>
                </c:pt>
                <c:pt idx="9">
                  <c:v>1022.7272727272727</c:v>
                </c:pt>
                <c:pt idx="10">
                  <c:v>1111.1111111111111</c:v>
                </c:pt>
                <c:pt idx="11">
                  <c:v>1015.625</c:v>
                </c:pt>
                <c:pt idx="12">
                  <c:v>989.58333333333337</c:v>
                </c:pt>
                <c:pt idx="13">
                  <c:v>1250</c:v>
                </c:pt>
                <c:pt idx="14">
                  <c:v>1944.4444444444443</c:v>
                </c:pt>
                <c:pt idx="15">
                  <c:v>15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B956-43C5-B4AC-F2E0BA0AA04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8608384"/>
        <c:axId val="182685696"/>
      </c:scatterChart>
      <c:valAx>
        <c:axId val="178608384"/>
        <c:scaling>
          <c:orientation val="minMax"/>
          <c:max val="25"/>
          <c:min val="0"/>
        </c:scaling>
        <c:delete val="0"/>
        <c:axPos val="b"/>
        <c:title>
          <c:tx>
            <c:rich>
              <a:bodyPr/>
              <a:lstStyle/>
              <a:p>
                <a:pPr algn="ctr" rtl="0">
                  <a:defRPr/>
                </a:pPr>
                <a:r>
                  <a:rPr lang="en-GB"/>
                  <a:t>Area under difference spectrum  [%/100 . nm]</a:t>
                </a:r>
              </a:p>
            </c:rich>
          </c:tx>
          <c:layout>
            <c:manualLayout>
              <c:xMode val="edge"/>
              <c:yMode val="edge"/>
              <c:x val="0.17711244709276205"/>
              <c:y val="0.90107852897698137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crossAx val="182685696"/>
        <c:crosses val="autoZero"/>
        <c:crossBetween val="midCat"/>
        <c:majorUnit val="5"/>
      </c:valAx>
      <c:valAx>
        <c:axId val="182685696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 algn="ctr" rtl="0">
                  <a:defRPr/>
                </a:pPr>
                <a:r>
                  <a:rPr lang="en-GB" dirty="0"/>
                  <a:t>No. conidia per lesion area [mm</a:t>
                </a:r>
                <a:r>
                  <a:rPr lang="en-GB" baseline="30000" dirty="0"/>
                  <a:t>-2</a:t>
                </a:r>
                <a:r>
                  <a:rPr lang="en-GB" dirty="0"/>
                  <a:t>]</a:t>
                </a:r>
              </a:p>
            </c:rich>
          </c:tx>
          <c:layout>
            <c:manualLayout>
              <c:xMode val="edge"/>
              <c:yMode val="edge"/>
              <c:x val="1.5679012345679012E-2"/>
              <c:y val="6.5515873015873013E-2"/>
            </c:manualLayout>
          </c:layout>
          <c:overlay val="0"/>
        </c:title>
        <c:numFmt formatCode="#,##0" sourceLinked="0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crossAx val="178608384"/>
        <c:crosses val="autoZero"/>
        <c:crossBetween val="midCat"/>
      </c:valAx>
    </c:plotArea>
    <c:plotVisOnly val="1"/>
    <c:dispBlanksAs val="gap"/>
    <c:showDLblsOverMax val="0"/>
  </c:chart>
  <c:spPr>
    <a:ln>
      <a:solidFill>
        <a:schemeClr val="tx1"/>
      </a:solidFill>
    </a:ln>
  </c:spPr>
  <c:txPr>
    <a:bodyPr/>
    <a:lstStyle/>
    <a:p>
      <a:pPr>
        <a:defRPr sz="1200" b="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strRef>
              <c:f>Sheet1!$AO$4</c:f>
              <c:strCache>
                <c:ptCount val="1"/>
                <c:pt idx="0">
                  <c:v>Healthy tissue</c:v>
                </c:pt>
              </c:strCache>
            </c:strRef>
          </c:tx>
          <c:spPr>
            <a:ln w="19050" cap="rnd">
              <a:solidFill>
                <a:srgbClr val="06C60B"/>
              </a:solidFill>
              <a:round/>
            </a:ln>
            <a:effectLst/>
          </c:spPr>
          <c:marker>
            <c:symbol val="none"/>
          </c:marker>
          <c:xVal>
            <c:numRef>
              <c:f>Sheet1!$AN$5:$AN$144</c:f>
              <c:numCache>
                <c:formatCode>General</c:formatCode>
                <c:ptCount val="140"/>
                <c:pt idx="0">
                  <c:v>451.25</c:v>
                </c:pt>
                <c:pt idx="1">
                  <c:v>454.040009</c:v>
                </c:pt>
                <c:pt idx="2">
                  <c:v>456.82000699999998</c:v>
                </c:pt>
                <c:pt idx="3">
                  <c:v>459.60998499999999</c:v>
                </c:pt>
                <c:pt idx="4">
                  <c:v>462.39999399999999</c:v>
                </c:pt>
                <c:pt idx="5">
                  <c:v>465.19000199999999</c:v>
                </c:pt>
                <c:pt idx="6">
                  <c:v>467.98001099999999</c:v>
                </c:pt>
                <c:pt idx="7">
                  <c:v>470.77999899999998</c:v>
                </c:pt>
                <c:pt idx="8">
                  <c:v>473.57000699999998</c:v>
                </c:pt>
                <c:pt idx="9">
                  <c:v>476.36999500000002</c:v>
                </c:pt>
                <c:pt idx="10">
                  <c:v>479.16000400000001</c:v>
                </c:pt>
                <c:pt idx="11">
                  <c:v>481.959991</c:v>
                </c:pt>
                <c:pt idx="12">
                  <c:v>484.76001000000002</c:v>
                </c:pt>
                <c:pt idx="13">
                  <c:v>487.55999800000001</c:v>
                </c:pt>
                <c:pt idx="14">
                  <c:v>490.35998499999999</c:v>
                </c:pt>
                <c:pt idx="15">
                  <c:v>493.16000400000001</c:v>
                </c:pt>
                <c:pt idx="16">
                  <c:v>495.97000100000002</c:v>
                </c:pt>
                <c:pt idx="17">
                  <c:v>498.76998900000001</c:v>
                </c:pt>
                <c:pt idx="18">
                  <c:v>501.57998700000002</c:v>
                </c:pt>
                <c:pt idx="19">
                  <c:v>504.39001500000001</c:v>
                </c:pt>
                <c:pt idx="20">
                  <c:v>507.19000199999999</c:v>
                </c:pt>
                <c:pt idx="21">
                  <c:v>510</c:v>
                </c:pt>
                <c:pt idx="22">
                  <c:v>512.80999799999995</c:v>
                </c:pt>
                <c:pt idx="23">
                  <c:v>515.63000499999998</c:v>
                </c:pt>
                <c:pt idx="24">
                  <c:v>518.44000200000005</c:v>
                </c:pt>
                <c:pt idx="25">
                  <c:v>521.25</c:v>
                </c:pt>
                <c:pt idx="26">
                  <c:v>524.07000700000003</c:v>
                </c:pt>
                <c:pt idx="27">
                  <c:v>526.88000499999998</c:v>
                </c:pt>
                <c:pt idx="28">
                  <c:v>529.70001200000002</c:v>
                </c:pt>
                <c:pt idx="29">
                  <c:v>532.52002000000005</c:v>
                </c:pt>
                <c:pt idx="30">
                  <c:v>535.34002699999996</c:v>
                </c:pt>
                <c:pt idx="31">
                  <c:v>538.15997300000004</c:v>
                </c:pt>
                <c:pt idx="32">
                  <c:v>540.98999000000003</c:v>
                </c:pt>
                <c:pt idx="33">
                  <c:v>543.80999799999995</c:v>
                </c:pt>
                <c:pt idx="34">
                  <c:v>546.63000499999998</c:v>
                </c:pt>
                <c:pt idx="35">
                  <c:v>549.46002199999998</c:v>
                </c:pt>
                <c:pt idx="36">
                  <c:v>552.28997800000002</c:v>
                </c:pt>
                <c:pt idx="37">
                  <c:v>555.11999500000002</c:v>
                </c:pt>
                <c:pt idx="38">
                  <c:v>557.94000200000005</c:v>
                </c:pt>
                <c:pt idx="39">
                  <c:v>560.78002900000001</c:v>
                </c:pt>
                <c:pt idx="40">
                  <c:v>563.60998500000005</c:v>
                </c:pt>
                <c:pt idx="41">
                  <c:v>566.44000200000005</c:v>
                </c:pt>
                <c:pt idx="42">
                  <c:v>569.27002000000005</c:v>
                </c:pt>
                <c:pt idx="43">
                  <c:v>572.10998500000005</c:v>
                </c:pt>
                <c:pt idx="44">
                  <c:v>574.95001200000002</c:v>
                </c:pt>
                <c:pt idx="45">
                  <c:v>577.78002900000001</c:v>
                </c:pt>
                <c:pt idx="46">
                  <c:v>580.61999500000002</c:v>
                </c:pt>
                <c:pt idx="47">
                  <c:v>583.46002199999998</c:v>
                </c:pt>
                <c:pt idx="48">
                  <c:v>586.29998799999998</c:v>
                </c:pt>
                <c:pt idx="49">
                  <c:v>589.15002400000003</c:v>
                </c:pt>
                <c:pt idx="50">
                  <c:v>591.98999000000003</c:v>
                </c:pt>
                <c:pt idx="51">
                  <c:v>594.84002699999996</c:v>
                </c:pt>
                <c:pt idx="52">
                  <c:v>597.67999299999997</c:v>
                </c:pt>
                <c:pt idx="53">
                  <c:v>600.53002900000001</c:v>
                </c:pt>
                <c:pt idx="54">
                  <c:v>603.38000499999998</c:v>
                </c:pt>
                <c:pt idx="55">
                  <c:v>606.22997999999995</c:v>
                </c:pt>
                <c:pt idx="56">
                  <c:v>609.080017</c:v>
                </c:pt>
                <c:pt idx="57">
                  <c:v>611.92999299999997</c:v>
                </c:pt>
                <c:pt idx="58">
                  <c:v>614.78002900000001</c:v>
                </c:pt>
                <c:pt idx="59">
                  <c:v>617.64001499999995</c:v>
                </c:pt>
                <c:pt idx="60">
                  <c:v>620.48999000000003</c:v>
                </c:pt>
                <c:pt idx="61">
                  <c:v>623.34997599999997</c:v>
                </c:pt>
                <c:pt idx="62">
                  <c:v>626.21002199999998</c:v>
                </c:pt>
                <c:pt idx="63">
                  <c:v>629.07000700000003</c:v>
                </c:pt>
                <c:pt idx="64">
                  <c:v>631.92999299999997</c:v>
                </c:pt>
                <c:pt idx="65">
                  <c:v>634.78997800000002</c:v>
                </c:pt>
                <c:pt idx="66">
                  <c:v>637.65002400000003</c:v>
                </c:pt>
                <c:pt idx="67">
                  <c:v>640.51000999999997</c:v>
                </c:pt>
                <c:pt idx="68">
                  <c:v>643.38000499999998</c:v>
                </c:pt>
                <c:pt idx="69">
                  <c:v>646.23999000000003</c:v>
                </c:pt>
                <c:pt idx="70">
                  <c:v>649.10998500000005</c:v>
                </c:pt>
                <c:pt idx="71">
                  <c:v>651.97997999999995</c:v>
                </c:pt>
                <c:pt idx="72">
                  <c:v>654.84997599999997</c:v>
                </c:pt>
                <c:pt idx="73">
                  <c:v>657.71997099999999</c:v>
                </c:pt>
                <c:pt idx="74">
                  <c:v>660.59002699999996</c:v>
                </c:pt>
                <c:pt idx="75">
                  <c:v>663.46997099999999</c:v>
                </c:pt>
                <c:pt idx="76">
                  <c:v>666.34002699999996</c:v>
                </c:pt>
                <c:pt idx="77">
                  <c:v>669.21997099999999</c:v>
                </c:pt>
                <c:pt idx="78">
                  <c:v>672.09002699999996</c:v>
                </c:pt>
                <c:pt idx="79">
                  <c:v>674.96997099999999</c:v>
                </c:pt>
                <c:pt idx="80">
                  <c:v>677.84997599999997</c:v>
                </c:pt>
                <c:pt idx="81">
                  <c:v>680.72997999999995</c:v>
                </c:pt>
                <c:pt idx="82">
                  <c:v>683.60998500000005</c:v>
                </c:pt>
                <c:pt idx="83">
                  <c:v>686.48999000000003</c:v>
                </c:pt>
                <c:pt idx="84">
                  <c:v>689.38000499999998</c:v>
                </c:pt>
                <c:pt idx="85">
                  <c:v>692.26000999999997</c:v>
                </c:pt>
                <c:pt idx="86">
                  <c:v>695.15002400000003</c:v>
                </c:pt>
                <c:pt idx="87">
                  <c:v>698.03002900000001</c:v>
                </c:pt>
                <c:pt idx="88">
                  <c:v>700.919983</c:v>
                </c:pt>
                <c:pt idx="89">
                  <c:v>703.80999799999995</c:v>
                </c:pt>
                <c:pt idx="90">
                  <c:v>706.70001200000002</c:v>
                </c:pt>
                <c:pt idx="91">
                  <c:v>709.59997599999997</c:v>
                </c:pt>
                <c:pt idx="92">
                  <c:v>712.48999000000003</c:v>
                </c:pt>
                <c:pt idx="93">
                  <c:v>715.38000499999998</c:v>
                </c:pt>
                <c:pt idx="94">
                  <c:v>718.28002900000001</c:v>
                </c:pt>
                <c:pt idx="95">
                  <c:v>721.17999299999997</c:v>
                </c:pt>
                <c:pt idx="96">
                  <c:v>724.07000700000003</c:v>
                </c:pt>
                <c:pt idx="97">
                  <c:v>726.96997099999999</c:v>
                </c:pt>
                <c:pt idx="98">
                  <c:v>729.86999500000002</c:v>
                </c:pt>
                <c:pt idx="99">
                  <c:v>732.77002000000005</c:v>
                </c:pt>
                <c:pt idx="100">
                  <c:v>735.67999299999997</c:v>
                </c:pt>
                <c:pt idx="101">
                  <c:v>738.580017</c:v>
                </c:pt>
                <c:pt idx="102">
                  <c:v>741.48999000000003</c:v>
                </c:pt>
                <c:pt idx="103">
                  <c:v>744.39001499999995</c:v>
                </c:pt>
                <c:pt idx="104">
                  <c:v>747.29998799999998</c:v>
                </c:pt>
                <c:pt idx="105">
                  <c:v>750.21002199999998</c:v>
                </c:pt>
                <c:pt idx="106">
                  <c:v>753.11999500000002</c:v>
                </c:pt>
                <c:pt idx="107">
                  <c:v>756.03002900000001</c:v>
                </c:pt>
                <c:pt idx="108">
                  <c:v>758.94000200000005</c:v>
                </c:pt>
                <c:pt idx="109">
                  <c:v>761.84997599999997</c:v>
                </c:pt>
                <c:pt idx="110">
                  <c:v>764.77002000000005</c:v>
                </c:pt>
                <c:pt idx="111">
                  <c:v>767.67999299999997</c:v>
                </c:pt>
                <c:pt idx="112">
                  <c:v>770.59997599999997</c:v>
                </c:pt>
                <c:pt idx="113">
                  <c:v>773.52002000000005</c:v>
                </c:pt>
                <c:pt idx="114">
                  <c:v>776.44000200000005</c:v>
                </c:pt>
                <c:pt idx="115">
                  <c:v>779.35998500000005</c:v>
                </c:pt>
                <c:pt idx="116">
                  <c:v>782.28002900000001</c:v>
                </c:pt>
                <c:pt idx="117">
                  <c:v>785.20001200000002</c:v>
                </c:pt>
                <c:pt idx="118">
                  <c:v>788.11999500000002</c:v>
                </c:pt>
                <c:pt idx="119">
                  <c:v>791.04998799999998</c:v>
                </c:pt>
                <c:pt idx="120">
                  <c:v>793.97997999999995</c:v>
                </c:pt>
                <c:pt idx="121">
                  <c:v>796.90002400000003</c:v>
                </c:pt>
                <c:pt idx="122">
                  <c:v>799.830017</c:v>
                </c:pt>
                <c:pt idx="123">
                  <c:v>802.76000999999997</c:v>
                </c:pt>
                <c:pt idx="124">
                  <c:v>805.69000200000005</c:v>
                </c:pt>
                <c:pt idx="125">
                  <c:v>808.61999500000002</c:v>
                </c:pt>
                <c:pt idx="126">
                  <c:v>811.55999799999995</c:v>
                </c:pt>
                <c:pt idx="127">
                  <c:v>814.48999000000003</c:v>
                </c:pt>
                <c:pt idx="128">
                  <c:v>817.42999299999997</c:v>
                </c:pt>
                <c:pt idx="129">
                  <c:v>820.35998500000005</c:v>
                </c:pt>
                <c:pt idx="130">
                  <c:v>823.29998799999998</c:v>
                </c:pt>
                <c:pt idx="131">
                  <c:v>826.23999000000003</c:v>
                </c:pt>
                <c:pt idx="132">
                  <c:v>829.17999299999997</c:v>
                </c:pt>
                <c:pt idx="133">
                  <c:v>832.11999500000002</c:v>
                </c:pt>
                <c:pt idx="134">
                  <c:v>835.07000700000003</c:v>
                </c:pt>
                <c:pt idx="135">
                  <c:v>838.01000999999997</c:v>
                </c:pt>
                <c:pt idx="136">
                  <c:v>840.95001200000002</c:v>
                </c:pt>
                <c:pt idx="137">
                  <c:v>843.90002400000003</c:v>
                </c:pt>
                <c:pt idx="138">
                  <c:v>846.84997599999997</c:v>
                </c:pt>
                <c:pt idx="139">
                  <c:v>849.79998799999998</c:v>
                </c:pt>
              </c:numCache>
            </c:numRef>
          </c:xVal>
          <c:yVal>
            <c:numRef>
              <c:f>Sheet1!$AO$5:$AO$144</c:f>
              <c:numCache>
                <c:formatCode>General</c:formatCode>
                <c:ptCount val="140"/>
                <c:pt idx="0">
                  <c:v>4.5289000000000003E-2</c:v>
                </c:pt>
                <c:pt idx="1">
                  <c:v>4.5249999999999999E-2</c:v>
                </c:pt>
                <c:pt idx="2">
                  <c:v>4.5005500000000004E-2</c:v>
                </c:pt>
                <c:pt idx="3">
                  <c:v>4.4602000000000003E-2</c:v>
                </c:pt>
                <c:pt idx="4">
                  <c:v>4.4192999999999996E-2</c:v>
                </c:pt>
                <c:pt idx="5">
                  <c:v>4.3787E-2</c:v>
                </c:pt>
                <c:pt idx="6">
                  <c:v>4.3352000000000002E-2</c:v>
                </c:pt>
                <c:pt idx="7">
                  <c:v>4.3032000000000001E-2</c:v>
                </c:pt>
                <c:pt idx="8">
                  <c:v>4.2779499999999998E-2</c:v>
                </c:pt>
                <c:pt idx="9">
                  <c:v>4.2699000000000001E-2</c:v>
                </c:pt>
                <c:pt idx="10">
                  <c:v>4.2647999999999998E-2</c:v>
                </c:pt>
                <c:pt idx="11">
                  <c:v>4.2624499999999996E-2</c:v>
                </c:pt>
                <c:pt idx="12">
                  <c:v>4.2583999999999997E-2</c:v>
                </c:pt>
                <c:pt idx="13">
                  <c:v>4.2709499999999997E-2</c:v>
                </c:pt>
                <c:pt idx="14">
                  <c:v>4.3102500000000002E-2</c:v>
                </c:pt>
                <c:pt idx="15">
                  <c:v>4.3749499999999997E-2</c:v>
                </c:pt>
                <c:pt idx="16">
                  <c:v>4.4719000000000002E-2</c:v>
                </c:pt>
                <c:pt idx="17">
                  <c:v>4.6114500000000003E-2</c:v>
                </c:pt>
                <c:pt idx="18">
                  <c:v>4.8103999999999994E-2</c:v>
                </c:pt>
                <c:pt idx="19">
                  <c:v>5.0860500000000003E-2</c:v>
                </c:pt>
                <c:pt idx="20">
                  <c:v>5.4572999999999997E-2</c:v>
                </c:pt>
                <c:pt idx="21">
                  <c:v>5.9415499999999996E-2</c:v>
                </c:pt>
                <c:pt idx="22">
                  <c:v>6.5411500000000011E-2</c:v>
                </c:pt>
                <c:pt idx="23">
                  <c:v>7.271749999999999E-2</c:v>
                </c:pt>
                <c:pt idx="24">
                  <c:v>8.1249500000000002E-2</c:v>
                </c:pt>
                <c:pt idx="25">
                  <c:v>9.0550500000000006E-2</c:v>
                </c:pt>
                <c:pt idx="26">
                  <c:v>9.9872500000000003E-2</c:v>
                </c:pt>
                <c:pt idx="27">
                  <c:v>0.10852149999999999</c:v>
                </c:pt>
                <c:pt idx="28">
                  <c:v>0.115859</c:v>
                </c:pt>
                <c:pt idx="29">
                  <c:v>0.12149</c:v>
                </c:pt>
                <c:pt idx="30">
                  <c:v>0.12546199999999999</c:v>
                </c:pt>
                <c:pt idx="31">
                  <c:v>0.12814249999999999</c:v>
                </c:pt>
                <c:pt idx="32">
                  <c:v>0.1298995</c:v>
                </c:pt>
                <c:pt idx="33">
                  <c:v>0.13120900000000002</c:v>
                </c:pt>
                <c:pt idx="34">
                  <c:v>0.13243099999999999</c:v>
                </c:pt>
                <c:pt idx="35">
                  <c:v>0.13354450000000001</c:v>
                </c:pt>
                <c:pt idx="36">
                  <c:v>0.134188</c:v>
                </c:pt>
                <c:pt idx="37">
                  <c:v>0.13381499999999999</c:v>
                </c:pt>
                <c:pt idx="38">
                  <c:v>0.132156</c:v>
                </c:pt>
                <c:pt idx="39">
                  <c:v>0.12921850000000001</c:v>
                </c:pt>
                <c:pt idx="40">
                  <c:v>0.125226</c:v>
                </c:pt>
                <c:pt idx="41">
                  <c:v>0.120212</c:v>
                </c:pt>
                <c:pt idx="42">
                  <c:v>0.1143435</c:v>
                </c:pt>
                <c:pt idx="43">
                  <c:v>0.108094</c:v>
                </c:pt>
                <c:pt idx="44">
                  <c:v>0.102201</c:v>
                </c:pt>
                <c:pt idx="45">
                  <c:v>9.7091499999999997E-2</c:v>
                </c:pt>
                <c:pt idx="46">
                  <c:v>9.2822500000000002E-2</c:v>
                </c:pt>
                <c:pt idx="47">
                  <c:v>8.9196999999999999E-2</c:v>
                </c:pt>
                <c:pt idx="48">
                  <c:v>8.6161500000000002E-2</c:v>
                </c:pt>
                <c:pt idx="49">
                  <c:v>8.3648E-2</c:v>
                </c:pt>
                <c:pt idx="50">
                  <c:v>8.1679000000000002E-2</c:v>
                </c:pt>
                <c:pt idx="51">
                  <c:v>8.0187000000000008E-2</c:v>
                </c:pt>
                <c:pt idx="52">
                  <c:v>7.9003000000000004E-2</c:v>
                </c:pt>
                <c:pt idx="53">
                  <c:v>7.7835500000000002E-2</c:v>
                </c:pt>
                <c:pt idx="54">
                  <c:v>7.6369999999999993E-2</c:v>
                </c:pt>
                <c:pt idx="55">
                  <c:v>7.4362999999999999E-2</c:v>
                </c:pt>
                <c:pt idx="56">
                  <c:v>7.1800000000000003E-2</c:v>
                </c:pt>
                <c:pt idx="57">
                  <c:v>6.8948499999999996E-2</c:v>
                </c:pt>
                <c:pt idx="58">
                  <c:v>6.6115499999999994E-2</c:v>
                </c:pt>
                <c:pt idx="59">
                  <c:v>6.3563499999999995E-2</c:v>
                </c:pt>
                <c:pt idx="60">
                  <c:v>6.1498999999999998E-2</c:v>
                </c:pt>
                <c:pt idx="61">
                  <c:v>6.0061000000000003E-2</c:v>
                </c:pt>
                <c:pt idx="62">
                  <c:v>5.9219500000000001E-2</c:v>
                </c:pt>
                <c:pt idx="63">
                  <c:v>5.8776499999999995E-2</c:v>
                </c:pt>
                <c:pt idx="64">
                  <c:v>5.8265499999999998E-2</c:v>
                </c:pt>
                <c:pt idx="65">
                  <c:v>5.7184499999999999E-2</c:v>
                </c:pt>
                <c:pt idx="66">
                  <c:v>5.5321000000000002E-2</c:v>
                </c:pt>
                <c:pt idx="67">
                  <c:v>5.2914500000000003E-2</c:v>
                </c:pt>
                <c:pt idx="68">
                  <c:v>5.0307500000000005E-2</c:v>
                </c:pt>
                <c:pt idx="69">
                  <c:v>4.7839999999999994E-2</c:v>
                </c:pt>
                <c:pt idx="70">
                  <c:v>4.5777999999999999E-2</c:v>
                </c:pt>
                <c:pt idx="71">
                  <c:v>4.4190500000000001E-2</c:v>
                </c:pt>
                <c:pt idx="72">
                  <c:v>4.2765499999999998E-2</c:v>
                </c:pt>
                <c:pt idx="73">
                  <c:v>4.1152499999999995E-2</c:v>
                </c:pt>
                <c:pt idx="74">
                  <c:v>3.9375500000000001E-2</c:v>
                </c:pt>
                <c:pt idx="75">
                  <c:v>3.7676500000000002E-2</c:v>
                </c:pt>
                <c:pt idx="76">
                  <c:v>3.6256499999999997E-2</c:v>
                </c:pt>
                <c:pt idx="77">
                  <c:v>3.5236000000000003E-2</c:v>
                </c:pt>
                <c:pt idx="78">
                  <c:v>3.4748500000000002E-2</c:v>
                </c:pt>
                <c:pt idx="79">
                  <c:v>3.4835000000000005E-2</c:v>
                </c:pt>
                <c:pt idx="80">
                  <c:v>3.5457500000000003E-2</c:v>
                </c:pt>
                <c:pt idx="81">
                  <c:v>3.6605499999999999E-2</c:v>
                </c:pt>
                <c:pt idx="82">
                  <c:v>3.8401500000000005E-2</c:v>
                </c:pt>
                <c:pt idx="83">
                  <c:v>4.1446999999999998E-2</c:v>
                </c:pt>
                <c:pt idx="84">
                  <c:v>4.7211000000000003E-2</c:v>
                </c:pt>
                <c:pt idx="85">
                  <c:v>5.7563500000000004E-2</c:v>
                </c:pt>
                <c:pt idx="86">
                  <c:v>7.37675E-2</c:v>
                </c:pt>
                <c:pt idx="87">
                  <c:v>9.5488000000000003E-2</c:v>
                </c:pt>
                <c:pt idx="88">
                  <c:v>0.1205715</c:v>
                </c:pt>
                <c:pt idx="89">
                  <c:v>0.146284</c:v>
                </c:pt>
                <c:pt idx="90">
                  <c:v>0.170767</c:v>
                </c:pt>
                <c:pt idx="91">
                  <c:v>0.19365550000000001</c:v>
                </c:pt>
                <c:pt idx="92">
                  <c:v>0.21529799999999999</c:v>
                </c:pt>
                <c:pt idx="93">
                  <c:v>0.23601899999999998</c:v>
                </c:pt>
                <c:pt idx="94">
                  <c:v>0.25578599999999996</c:v>
                </c:pt>
                <c:pt idx="95">
                  <c:v>0.27435799999999999</c:v>
                </c:pt>
                <c:pt idx="96">
                  <c:v>0.29149900000000001</c:v>
                </c:pt>
                <c:pt idx="97">
                  <c:v>0.30725599999999997</c:v>
                </c:pt>
                <c:pt idx="98">
                  <c:v>0.32134950000000001</c:v>
                </c:pt>
                <c:pt idx="99">
                  <c:v>0.33363200000000004</c:v>
                </c:pt>
                <c:pt idx="100">
                  <c:v>0.34412100000000001</c:v>
                </c:pt>
                <c:pt idx="101">
                  <c:v>0.35292049999999997</c:v>
                </c:pt>
                <c:pt idx="102">
                  <c:v>0.35986799999999997</c:v>
                </c:pt>
                <c:pt idx="103">
                  <c:v>0.36497950000000001</c:v>
                </c:pt>
                <c:pt idx="104">
                  <c:v>0.36882300000000001</c:v>
                </c:pt>
                <c:pt idx="105">
                  <c:v>0.371832</c:v>
                </c:pt>
                <c:pt idx="106">
                  <c:v>0.37426999999999999</c:v>
                </c:pt>
                <c:pt idx="107">
                  <c:v>0.37636250000000004</c:v>
                </c:pt>
                <c:pt idx="108">
                  <c:v>0.37812299999999999</c:v>
                </c:pt>
                <c:pt idx="109">
                  <c:v>0.37937149999999997</c:v>
                </c:pt>
                <c:pt idx="110">
                  <c:v>0.38058899999999996</c:v>
                </c:pt>
                <c:pt idx="111">
                  <c:v>0.38199249999999996</c:v>
                </c:pt>
                <c:pt idx="112">
                  <c:v>0.38337300000000002</c:v>
                </c:pt>
                <c:pt idx="113">
                  <c:v>0.38440750000000001</c:v>
                </c:pt>
                <c:pt idx="114">
                  <c:v>0.38512150000000001</c:v>
                </c:pt>
                <c:pt idx="115">
                  <c:v>0.38531349999999998</c:v>
                </c:pt>
                <c:pt idx="116">
                  <c:v>0.38509850000000001</c:v>
                </c:pt>
                <c:pt idx="117">
                  <c:v>0.38472600000000001</c:v>
                </c:pt>
                <c:pt idx="118">
                  <c:v>0.38422849999999997</c:v>
                </c:pt>
                <c:pt idx="119">
                  <c:v>0.38364700000000002</c:v>
                </c:pt>
                <c:pt idx="120">
                  <c:v>0.38281600000000005</c:v>
                </c:pt>
                <c:pt idx="121">
                  <c:v>0.38167849999999998</c:v>
                </c:pt>
                <c:pt idx="122">
                  <c:v>0.38005350000000004</c:v>
                </c:pt>
                <c:pt idx="123">
                  <c:v>0.37838349999999998</c:v>
                </c:pt>
                <c:pt idx="124">
                  <c:v>0.37711249999999996</c:v>
                </c:pt>
                <c:pt idx="125">
                  <c:v>0.37644549999999999</c:v>
                </c:pt>
                <c:pt idx="126">
                  <c:v>0.37580349999999996</c:v>
                </c:pt>
                <c:pt idx="127">
                  <c:v>0.37496099999999999</c:v>
                </c:pt>
                <c:pt idx="128">
                  <c:v>0.37423150000000005</c:v>
                </c:pt>
                <c:pt idx="129">
                  <c:v>0.37371650000000001</c:v>
                </c:pt>
                <c:pt idx="130">
                  <c:v>0.37331000000000003</c:v>
                </c:pt>
                <c:pt idx="131">
                  <c:v>0.37305850000000002</c:v>
                </c:pt>
                <c:pt idx="132">
                  <c:v>0.37287150000000002</c:v>
                </c:pt>
                <c:pt idx="133">
                  <c:v>0.372585</c:v>
                </c:pt>
                <c:pt idx="134">
                  <c:v>0.37251699999999999</c:v>
                </c:pt>
                <c:pt idx="135">
                  <c:v>0.37290200000000001</c:v>
                </c:pt>
                <c:pt idx="136">
                  <c:v>0.3736775</c:v>
                </c:pt>
                <c:pt idx="137">
                  <c:v>0.37462949999999995</c:v>
                </c:pt>
                <c:pt idx="138">
                  <c:v>0.37566650000000001</c:v>
                </c:pt>
                <c:pt idx="139">
                  <c:v>0.3762674999999999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C036-4A4D-B340-09876A98FCF4}"/>
            </c:ext>
          </c:extLst>
        </c:ser>
        <c:ser>
          <c:idx val="1"/>
          <c:order val="1"/>
          <c:tx>
            <c:strRef>
              <c:f>Sheet1!$AP$4</c:f>
              <c:strCache>
                <c:ptCount val="1"/>
                <c:pt idx="0">
                  <c:v>Dark brown tissue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xVal>
            <c:numRef>
              <c:f>Sheet1!$AN$5:$AN$144</c:f>
              <c:numCache>
                <c:formatCode>General</c:formatCode>
                <c:ptCount val="140"/>
                <c:pt idx="0">
                  <c:v>451.25</c:v>
                </c:pt>
                <c:pt idx="1">
                  <c:v>454.040009</c:v>
                </c:pt>
                <c:pt idx="2">
                  <c:v>456.82000699999998</c:v>
                </c:pt>
                <c:pt idx="3">
                  <c:v>459.60998499999999</c:v>
                </c:pt>
                <c:pt idx="4">
                  <c:v>462.39999399999999</c:v>
                </c:pt>
                <c:pt idx="5">
                  <c:v>465.19000199999999</c:v>
                </c:pt>
                <c:pt idx="6">
                  <c:v>467.98001099999999</c:v>
                </c:pt>
                <c:pt idx="7">
                  <c:v>470.77999899999998</c:v>
                </c:pt>
                <c:pt idx="8">
                  <c:v>473.57000699999998</c:v>
                </c:pt>
                <c:pt idx="9">
                  <c:v>476.36999500000002</c:v>
                </c:pt>
                <c:pt idx="10">
                  <c:v>479.16000400000001</c:v>
                </c:pt>
                <c:pt idx="11">
                  <c:v>481.959991</c:v>
                </c:pt>
                <c:pt idx="12">
                  <c:v>484.76001000000002</c:v>
                </c:pt>
                <c:pt idx="13">
                  <c:v>487.55999800000001</c:v>
                </c:pt>
                <c:pt idx="14">
                  <c:v>490.35998499999999</c:v>
                </c:pt>
                <c:pt idx="15">
                  <c:v>493.16000400000001</c:v>
                </c:pt>
                <c:pt idx="16">
                  <c:v>495.97000100000002</c:v>
                </c:pt>
                <c:pt idx="17">
                  <c:v>498.76998900000001</c:v>
                </c:pt>
                <c:pt idx="18">
                  <c:v>501.57998700000002</c:v>
                </c:pt>
                <c:pt idx="19">
                  <c:v>504.39001500000001</c:v>
                </c:pt>
                <c:pt idx="20">
                  <c:v>507.19000199999999</c:v>
                </c:pt>
                <c:pt idx="21">
                  <c:v>510</c:v>
                </c:pt>
                <c:pt idx="22">
                  <c:v>512.80999799999995</c:v>
                </c:pt>
                <c:pt idx="23">
                  <c:v>515.63000499999998</c:v>
                </c:pt>
                <c:pt idx="24">
                  <c:v>518.44000200000005</c:v>
                </c:pt>
                <c:pt idx="25">
                  <c:v>521.25</c:v>
                </c:pt>
                <c:pt idx="26">
                  <c:v>524.07000700000003</c:v>
                </c:pt>
                <c:pt idx="27">
                  <c:v>526.88000499999998</c:v>
                </c:pt>
                <c:pt idx="28">
                  <c:v>529.70001200000002</c:v>
                </c:pt>
                <c:pt idx="29">
                  <c:v>532.52002000000005</c:v>
                </c:pt>
                <c:pt idx="30">
                  <c:v>535.34002699999996</c:v>
                </c:pt>
                <c:pt idx="31">
                  <c:v>538.15997300000004</c:v>
                </c:pt>
                <c:pt idx="32">
                  <c:v>540.98999000000003</c:v>
                </c:pt>
                <c:pt idx="33">
                  <c:v>543.80999799999995</c:v>
                </c:pt>
                <c:pt idx="34">
                  <c:v>546.63000499999998</c:v>
                </c:pt>
                <c:pt idx="35">
                  <c:v>549.46002199999998</c:v>
                </c:pt>
                <c:pt idx="36">
                  <c:v>552.28997800000002</c:v>
                </c:pt>
                <c:pt idx="37">
                  <c:v>555.11999500000002</c:v>
                </c:pt>
                <c:pt idx="38">
                  <c:v>557.94000200000005</c:v>
                </c:pt>
                <c:pt idx="39">
                  <c:v>560.78002900000001</c:v>
                </c:pt>
                <c:pt idx="40">
                  <c:v>563.60998500000005</c:v>
                </c:pt>
                <c:pt idx="41">
                  <c:v>566.44000200000005</c:v>
                </c:pt>
                <c:pt idx="42">
                  <c:v>569.27002000000005</c:v>
                </c:pt>
                <c:pt idx="43">
                  <c:v>572.10998500000005</c:v>
                </c:pt>
                <c:pt idx="44">
                  <c:v>574.95001200000002</c:v>
                </c:pt>
                <c:pt idx="45">
                  <c:v>577.78002900000001</c:v>
                </c:pt>
                <c:pt idx="46">
                  <c:v>580.61999500000002</c:v>
                </c:pt>
                <c:pt idx="47">
                  <c:v>583.46002199999998</c:v>
                </c:pt>
                <c:pt idx="48">
                  <c:v>586.29998799999998</c:v>
                </c:pt>
                <c:pt idx="49">
                  <c:v>589.15002400000003</c:v>
                </c:pt>
                <c:pt idx="50">
                  <c:v>591.98999000000003</c:v>
                </c:pt>
                <c:pt idx="51">
                  <c:v>594.84002699999996</c:v>
                </c:pt>
                <c:pt idx="52">
                  <c:v>597.67999299999997</c:v>
                </c:pt>
                <c:pt idx="53">
                  <c:v>600.53002900000001</c:v>
                </c:pt>
                <c:pt idx="54">
                  <c:v>603.38000499999998</c:v>
                </c:pt>
                <c:pt idx="55">
                  <c:v>606.22997999999995</c:v>
                </c:pt>
                <c:pt idx="56">
                  <c:v>609.080017</c:v>
                </c:pt>
                <c:pt idx="57">
                  <c:v>611.92999299999997</c:v>
                </c:pt>
                <c:pt idx="58">
                  <c:v>614.78002900000001</c:v>
                </c:pt>
                <c:pt idx="59">
                  <c:v>617.64001499999995</c:v>
                </c:pt>
                <c:pt idx="60">
                  <c:v>620.48999000000003</c:v>
                </c:pt>
                <c:pt idx="61">
                  <c:v>623.34997599999997</c:v>
                </c:pt>
                <c:pt idx="62">
                  <c:v>626.21002199999998</c:v>
                </c:pt>
                <c:pt idx="63">
                  <c:v>629.07000700000003</c:v>
                </c:pt>
                <c:pt idx="64">
                  <c:v>631.92999299999997</c:v>
                </c:pt>
                <c:pt idx="65">
                  <c:v>634.78997800000002</c:v>
                </c:pt>
                <c:pt idx="66">
                  <c:v>637.65002400000003</c:v>
                </c:pt>
                <c:pt idx="67">
                  <c:v>640.51000999999997</c:v>
                </c:pt>
                <c:pt idx="68">
                  <c:v>643.38000499999998</c:v>
                </c:pt>
                <c:pt idx="69">
                  <c:v>646.23999000000003</c:v>
                </c:pt>
                <c:pt idx="70">
                  <c:v>649.10998500000005</c:v>
                </c:pt>
                <c:pt idx="71">
                  <c:v>651.97997999999995</c:v>
                </c:pt>
                <c:pt idx="72">
                  <c:v>654.84997599999997</c:v>
                </c:pt>
                <c:pt idx="73">
                  <c:v>657.71997099999999</c:v>
                </c:pt>
                <c:pt idx="74">
                  <c:v>660.59002699999996</c:v>
                </c:pt>
                <c:pt idx="75">
                  <c:v>663.46997099999999</c:v>
                </c:pt>
                <c:pt idx="76">
                  <c:v>666.34002699999996</c:v>
                </c:pt>
                <c:pt idx="77">
                  <c:v>669.21997099999999</c:v>
                </c:pt>
                <c:pt idx="78">
                  <c:v>672.09002699999996</c:v>
                </c:pt>
                <c:pt idx="79">
                  <c:v>674.96997099999999</c:v>
                </c:pt>
                <c:pt idx="80">
                  <c:v>677.84997599999997</c:v>
                </c:pt>
                <c:pt idx="81">
                  <c:v>680.72997999999995</c:v>
                </c:pt>
                <c:pt idx="82">
                  <c:v>683.60998500000005</c:v>
                </c:pt>
                <c:pt idx="83">
                  <c:v>686.48999000000003</c:v>
                </c:pt>
                <c:pt idx="84">
                  <c:v>689.38000499999998</c:v>
                </c:pt>
                <c:pt idx="85">
                  <c:v>692.26000999999997</c:v>
                </c:pt>
                <c:pt idx="86">
                  <c:v>695.15002400000003</c:v>
                </c:pt>
                <c:pt idx="87">
                  <c:v>698.03002900000001</c:v>
                </c:pt>
                <c:pt idx="88">
                  <c:v>700.919983</c:v>
                </c:pt>
                <c:pt idx="89">
                  <c:v>703.80999799999995</c:v>
                </c:pt>
                <c:pt idx="90">
                  <c:v>706.70001200000002</c:v>
                </c:pt>
                <c:pt idx="91">
                  <c:v>709.59997599999997</c:v>
                </c:pt>
                <c:pt idx="92">
                  <c:v>712.48999000000003</c:v>
                </c:pt>
                <c:pt idx="93">
                  <c:v>715.38000499999998</c:v>
                </c:pt>
                <c:pt idx="94">
                  <c:v>718.28002900000001</c:v>
                </c:pt>
                <c:pt idx="95">
                  <c:v>721.17999299999997</c:v>
                </c:pt>
                <c:pt idx="96">
                  <c:v>724.07000700000003</c:v>
                </c:pt>
                <c:pt idx="97">
                  <c:v>726.96997099999999</c:v>
                </c:pt>
                <c:pt idx="98">
                  <c:v>729.86999500000002</c:v>
                </c:pt>
                <c:pt idx="99">
                  <c:v>732.77002000000005</c:v>
                </c:pt>
                <c:pt idx="100">
                  <c:v>735.67999299999997</c:v>
                </c:pt>
                <c:pt idx="101">
                  <c:v>738.580017</c:v>
                </c:pt>
                <c:pt idx="102">
                  <c:v>741.48999000000003</c:v>
                </c:pt>
                <c:pt idx="103">
                  <c:v>744.39001499999995</c:v>
                </c:pt>
                <c:pt idx="104">
                  <c:v>747.29998799999998</c:v>
                </c:pt>
                <c:pt idx="105">
                  <c:v>750.21002199999998</c:v>
                </c:pt>
                <c:pt idx="106">
                  <c:v>753.11999500000002</c:v>
                </c:pt>
                <c:pt idx="107">
                  <c:v>756.03002900000001</c:v>
                </c:pt>
                <c:pt idx="108">
                  <c:v>758.94000200000005</c:v>
                </c:pt>
                <c:pt idx="109">
                  <c:v>761.84997599999997</c:v>
                </c:pt>
                <c:pt idx="110">
                  <c:v>764.77002000000005</c:v>
                </c:pt>
                <c:pt idx="111">
                  <c:v>767.67999299999997</c:v>
                </c:pt>
                <c:pt idx="112">
                  <c:v>770.59997599999997</c:v>
                </c:pt>
                <c:pt idx="113">
                  <c:v>773.52002000000005</c:v>
                </c:pt>
                <c:pt idx="114">
                  <c:v>776.44000200000005</c:v>
                </c:pt>
                <c:pt idx="115">
                  <c:v>779.35998500000005</c:v>
                </c:pt>
                <c:pt idx="116">
                  <c:v>782.28002900000001</c:v>
                </c:pt>
                <c:pt idx="117">
                  <c:v>785.20001200000002</c:v>
                </c:pt>
                <c:pt idx="118">
                  <c:v>788.11999500000002</c:v>
                </c:pt>
                <c:pt idx="119">
                  <c:v>791.04998799999998</c:v>
                </c:pt>
                <c:pt idx="120">
                  <c:v>793.97997999999995</c:v>
                </c:pt>
                <c:pt idx="121">
                  <c:v>796.90002400000003</c:v>
                </c:pt>
                <c:pt idx="122">
                  <c:v>799.830017</c:v>
                </c:pt>
                <c:pt idx="123">
                  <c:v>802.76000999999997</c:v>
                </c:pt>
                <c:pt idx="124">
                  <c:v>805.69000200000005</c:v>
                </c:pt>
                <c:pt idx="125">
                  <c:v>808.61999500000002</c:v>
                </c:pt>
                <c:pt idx="126">
                  <c:v>811.55999799999995</c:v>
                </c:pt>
                <c:pt idx="127">
                  <c:v>814.48999000000003</c:v>
                </c:pt>
                <c:pt idx="128">
                  <c:v>817.42999299999997</c:v>
                </c:pt>
                <c:pt idx="129">
                  <c:v>820.35998500000005</c:v>
                </c:pt>
                <c:pt idx="130">
                  <c:v>823.29998799999998</c:v>
                </c:pt>
                <c:pt idx="131">
                  <c:v>826.23999000000003</c:v>
                </c:pt>
                <c:pt idx="132">
                  <c:v>829.17999299999997</c:v>
                </c:pt>
                <c:pt idx="133">
                  <c:v>832.11999500000002</c:v>
                </c:pt>
                <c:pt idx="134">
                  <c:v>835.07000700000003</c:v>
                </c:pt>
                <c:pt idx="135">
                  <c:v>838.01000999999997</c:v>
                </c:pt>
                <c:pt idx="136">
                  <c:v>840.95001200000002</c:v>
                </c:pt>
                <c:pt idx="137">
                  <c:v>843.90002400000003</c:v>
                </c:pt>
                <c:pt idx="138">
                  <c:v>846.84997599999997</c:v>
                </c:pt>
                <c:pt idx="139">
                  <c:v>849.79998799999998</c:v>
                </c:pt>
              </c:numCache>
            </c:numRef>
          </c:xVal>
          <c:yVal>
            <c:numRef>
              <c:f>Sheet1!$AP$5:$AP$144</c:f>
              <c:numCache>
                <c:formatCode>General</c:formatCode>
                <c:ptCount val="140"/>
                <c:pt idx="0">
                  <c:v>4.2293999999999998E-2</c:v>
                </c:pt>
                <c:pt idx="1">
                  <c:v>4.1763499999999995E-2</c:v>
                </c:pt>
                <c:pt idx="2">
                  <c:v>4.0875499999999995E-2</c:v>
                </c:pt>
                <c:pt idx="3">
                  <c:v>4.05265E-2</c:v>
                </c:pt>
                <c:pt idx="4">
                  <c:v>4.1214000000000001E-2</c:v>
                </c:pt>
                <c:pt idx="5">
                  <c:v>4.1609500000000001E-2</c:v>
                </c:pt>
                <c:pt idx="6">
                  <c:v>4.1270500000000002E-2</c:v>
                </c:pt>
                <c:pt idx="7">
                  <c:v>4.0507500000000002E-2</c:v>
                </c:pt>
                <c:pt idx="8">
                  <c:v>4.0403000000000001E-2</c:v>
                </c:pt>
                <c:pt idx="9">
                  <c:v>4.0301500000000004E-2</c:v>
                </c:pt>
                <c:pt idx="10">
                  <c:v>4.0719499999999999E-2</c:v>
                </c:pt>
                <c:pt idx="11">
                  <c:v>4.0939000000000003E-2</c:v>
                </c:pt>
                <c:pt idx="12">
                  <c:v>4.0996999999999999E-2</c:v>
                </c:pt>
                <c:pt idx="13">
                  <c:v>4.1188500000000003E-2</c:v>
                </c:pt>
                <c:pt idx="14">
                  <c:v>4.2023500000000005E-2</c:v>
                </c:pt>
                <c:pt idx="15">
                  <c:v>4.3059500000000001E-2</c:v>
                </c:pt>
                <c:pt idx="16">
                  <c:v>4.3492000000000003E-2</c:v>
                </c:pt>
                <c:pt idx="17">
                  <c:v>4.4126499999999999E-2</c:v>
                </c:pt>
                <c:pt idx="18">
                  <c:v>4.5224500000000001E-2</c:v>
                </c:pt>
                <c:pt idx="19">
                  <c:v>4.7059500000000004E-2</c:v>
                </c:pt>
                <c:pt idx="20">
                  <c:v>4.8996999999999999E-2</c:v>
                </c:pt>
                <c:pt idx="21">
                  <c:v>5.0558499999999999E-2</c:v>
                </c:pt>
                <c:pt idx="22">
                  <c:v>5.2721999999999998E-2</c:v>
                </c:pt>
                <c:pt idx="23">
                  <c:v>5.5878999999999998E-2</c:v>
                </c:pt>
                <c:pt idx="24">
                  <c:v>5.9238499999999999E-2</c:v>
                </c:pt>
                <c:pt idx="25">
                  <c:v>6.1981500000000002E-2</c:v>
                </c:pt>
                <c:pt idx="26">
                  <c:v>6.4548500000000009E-2</c:v>
                </c:pt>
                <c:pt idx="27">
                  <c:v>6.7363000000000006E-2</c:v>
                </c:pt>
                <c:pt idx="28">
                  <c:v>7.0163000000000003E-2</c:v>
                </c:pt>
                <c:pt idx="29">
                  <c:v>7.2344999999999993E-2</c:v>
                </c:pt>
                <c:pt idx="30">
                  <c:v>7.4089000000000002E-2</c:v>
                </c:pt>
                <c:pt idx="31">
                  <c:v>7.5610999999999998E-2</c:v>
                </c:pt>
                <c:pt idx="32">
                  <c:v>7.7090999999999993E-2</c:v>
                </c:pt>
                <c:pt idx="33">
                  <c:v>7.8361E-2</c:v>
                </c:pt>
                <c:pt idx="34">
                  <c:v>7.9573500000000005E-2</c:v>
                </c:pt>
                <c:pt idx="35">
                  <c:v>8.0860000000000001E-2</c:v>
                </c:pt>
                <c:pt idx="36">
                  <c:v>8.2082500000000003E-2</c:v>
                </c:pt>
                <c:pt idx="37">
                  <c:v>8.3216999999999999E-2</c:v>
                </c:pt>
                <c:pt idx="38">
                  <c:v>8.3914500000000003E-2</c:v>
                </c:pt>
                <c:pt idx="39">
                  <c:v>8.4293000000000007E-2</c:v>
                </c:pt>
                <c:pt idx="40">
                  <c:v>8.4240499999999996E-2</c:v>
                </c:pt>
                <c:pt idx="41">
                  <c:v>8.4004999999999996E-2</c:v>
                </c:pt>
                <c:pt idx="42">
                  <c:v>8.3498000000000003E-2</c:v>
                </c:pt>
                <c:pt idx="43">
                  <c:v>8.2715000000000011E-2</c:v>
                </c:pt>
                <c:pt idx="44">
                  <c:v>8.1757999999999997E-2</c:v>
                </c:pt>
                <c:pt idx="45">
                  <c:v>8.0781000000000006E-2</c:v>
                </c:pt>
                <c:pt idx="46">
                  <c:v>8.0310999999999994E-2</c:v>
                </c:pt>
                <c:pt idx="47">
                  <c:v>8.0005500000000007E-2</c:v>
                </c:pt>
                <c:pt idx="48">
                  <c:v>7.9824499999999993E-2</c:v>
                </c:pt>
                <c:pt idx="49">
                  <c:v>7.9733499999999999E-2</c:v>
                </c:pt>
                <c:pt idx="50">
                  <c:v>8.0056500000000003E-2</c:v>
                </c:pt>
                <c:pt idx="51">
                  <c:v>8.0296499999999993E-2</c:v>
                </c:pt>
                <c:pt idx="52">
                  <c:v>8.0531500000000006E-2</c:v>
                </c:pt>
                <c:pt idx="53">
                  <c:v>8.0759999999999998E-2</c:v>
                </c:pt>
                <c:pt idx="54">
                  <c:v>8.1190999999999999E-2</c:v>
                </c:pt>
                <c:pt idx="55">
                  <c:v>8.1238500000000005E-2</c:v>
                </c:pt>
                <c:pt idx="56">
                  <c:v>8.1051000000000012E-2</c:v>
                </c:pt>
                <c:pt idx="57">
                  <c:v>8.0365999999999993E-2</c:v>
                </c:pt>
                <c:pt idx="58">
                  <c:v>7.9822000000000004E-2</c:v>
                </c:pt>
                <c:pt idx="59">
                  <c:v>7.9392999999999991E-2</c:v>
                </c:pt>
                <c:pt idx="60">
                  <c:v>7.9127000000000003E-2</c:v>
                </c:pt>
                <c:pt idx="61">
                  <c:v>7.9172500000000007E-2</c:v>
                </c:pt>
                <c:pt idx="62">
                  <c:v>7.9678499999999999E-2</c:v>
                </c:pt>
                <c:pt idx="63">
                  <c:v>8.035500000000001E-2</c:v>
                </c:pt>
                <c:pt idx="64">
                  <c:v>8.0771000000000009E-2</c:v>
                </c:pt>
                <c:pt idx="65">
                  <c:v>8.0801999999999999E-2</c:v>
                </c:pt>
                <c:pt idx="66">
                  <c:v>8.0266499999999991E-2</c:v>
                </c:pt>
                <c:pt idx="67">
                  <c:v>7.8966999999999996E-2</c:v>
                </c:pt>
                <c:pt idx="68">
                  <c:v>7.7213000000000004E-2</c:v>
                </c:pt>
                <c:pt idx="69">
                  <c:v>7.5454999999999994E-2</c:v>
                </c:pt>
                <c:pt idx="70">
                  <c:v>7.4093999999999993E-2</c:v>
                </c:pt>
                <c:pt idx="71">
                  <c:v>7.3269000000000001E-2</c:v>
                </c:pt>
                <c:pt idx="72">
                  <c:v>7.2287999999999991E-2</c:v>
                </c:pt>
                <c:pt idx="73">
                  <c:v>7.0842000000000002E-2</c:v>
                </c:pt>
                <c:pt idx="74">
                  <c:v>6.8890499999999993E-2</c:v>
                </c:pt>
                <c:pt idx="75">
                  <c:v>6.6853999999999997E-2</c:v>
                </c:pt>
                <c:pt idx="76">
                  <c:v>6.4677999999999999E-2</c:v>
                </c:pt>
                <c:pt idx="77">
                  <c:v>6.294749999999999E-2</c:v>
                </c:pt>
                <c:pt idx="78">
                  <c:v>6.1912000000000002E-2</c:v>
                </c:pt>
                <c:pt idx="79">
                  <c:v>6.1797500000000005E-2</c:v>
                </c:pt>
                <c:pt idx="80">
                  <c:v>6.2213499999999998E-2</c:v>
                </c:pt>
                <c:pt idx="81">
                  <c:v>6.3569000000000001E-2</c:v>
                </c:pt>
                <c:pt idx="82">
                  <c:v>6.6443500000000003E-2</c:v>
                </c:pt>
                <c:pt idx="83">
                  <c:v>7.2100999999999998E-2</c:v>
                </c:pt>
                <c:pt idx="84">
                  <c:v>8.1500000000000003E-2</c:v>
                </c:pt>
                <c:pt idx="85">
                  <c:v>9.44575E-2</c:v>
                </c:pt>
                <c:pt idx="86">
                  <c:v>0.11036750000000001</c:v>
                </c:pt>
                <c:pt idx="87">
                  <c:v>0.12793599999999999</c:v>
                </c:pt>
                <c:pt idx="88">
                  <c:v>0.14612249999999999</c:v>
                </c:pt>
                <c:pt idx="89">
                  <c:v>0.16298000000000001</c:v>
                </c:pt>
                <c:pt idx="90">
                  <c:v>0.17795250000000001</c:v>
                </c:pt>
                <c:pt idx="91">
                  <c:v>0.19094050000000001</c:v>
                </c:pt>
                <c:pt idx="92">
                  <c:v>0.20319100000000001</c:v>
                </c:pt>
                <c:pt idx="93">
                  <c:v>0.2145745</c:v>
                </c:pt>
                <c:pt idx="94">
                  <c:v>0.225324</c:v>
                </c:pt>
                <c:pt idx="95">
                  <c:v>0.23513899999999999</c:v>
                </c:pt>
                <c:pt idx="96">
                  <c:v>0.24440450000000002</c:v>
                </c:pt>
                <c:pt idx="97">
                  <c:v>0.2526775</c:v>
                </c:pt>
                <c:pt idx="98">
                  <c:v>0.26092650000000001</c:v>
                </c:pt>
                <c:pt idx="99">
                  <c:v>0.26839849999999998</c:v>
                </c:pt>
                <c:pt idx="100">
                  <c:v>0.27492499999999997</c:v>
                </c:pt>
                <c:pt idx="101">
                  <c:v>0.280609</c:v>
                </c:pt>
                <c:pt idx="102">
                  <c:v>0.2860395</c:v>
                </c:pt>
                <c:pt idx="103">
                  <c:v>0.29039000000000004</c:v>
                </c:pt>
                <c:pt idx="104">
                  <c:v>0.29358300000000004</c:v>
                </c:pt>
                <c:pt idx="105">
                  <c:v>0.29646749999999999</c:v>
                </c:pt>
                <c:pt idx="106">
                  <c:v>0.29982500000000001</c:v>
                </c:pt>
                <c:pt idx="107">
                  <c:v>0.3036335</c:v>
                </c:pt>
                <c:pt idx="108">
                  <c:v>0.30669550000000001</c:v>
                </c:pt>
                <c:pt idx="109">
                  <c:v>0.3094055</c:v>
                </c:pt>
                <c:pt idx="110">
                  <c:v>0.31215550000000003</c:v>
                </c:pt>
                <c:pt idx="111">
                  <c:v>0.31505549999999999</c:v>
                </c:pt>
                <c:pt idx="112">
                  <c:v>0.31753750000000003</c:v>
                </c:pt>
                <c:pt idx="113">
                  <c:v>0.32047999999999999</c:v>
                </c:pt>
                <c:pt idx="114">
                  <c:v>0.32204749999999999</c:v>
                </c:pt>
                <c:pt idx="115">
                  <c:v>0.32322050000000002</c:v>
                </c:pt>
                <c:pt idx="116">
                  <c:v>0.3246655</c:v>
                </c:pt>
                <c:pt idx="117">
                  <c:v>0.3271905</c:v>
                </c:pt>
                <c:pt idx="118">
                  <c:v>0.32911950000000001</c:v>
                </c:pt>
                <c:pt idx="119">
                  <c:v>0.32939050000000003</c:v>
                </c:pt>
                <c:pt idx="120">
                  <c:v>0.32930649999999995</c:v>
                </c:pt>
                <c:pt idx="121">
                  <c:v>0.32931299999999997</c:v>
                </c:pt>
                <c:pt idx="122">
                  <c:v>0.33053500000000002</c:v>
                </c:pt>
                <c:pt idx="123">
                  <c:v>0.3307505</c:v>
                </c:pt>
                <c:pt idx="124">
                  <c:v>0.33157550000000002</c:v>
                </c:pt>
                <c:pt idx="125">
                  <c:v>0.33140150000000002</c:v>
                </c:pt>
                <c:pt idx="126">
                  <c:v>0.33159899999999998</c:v>
                </c:pt>
                <c:pt idx="127">
                  <c:v>0.33212750000000002</c:v>
                </c:pt>
                <c:pt idx="128">
                  <c:v>0.33416650000000003</c:v>
                </c:pt>
                <c:pt idx="129">
                  <c:v>0.33540400000000004</c:v>
                </c:pt>
                <c:pt idx="130">
                  <c:v>0.33663549999999998</c:v>
                </c:pt>
                <c:pt idx="131">
                  <c:v>0.33743999999999996</c:v>
                </c:pt>
                <c:pt idx="132">
                  <c:v>0.33820899999999998</c:v>
                </c:pt>
                <c:pt idx="133">
                  <c:v>0.33898050000000002</c:v>
                </c:pt>
                <c:pt idx="134">
                  <c:v>0.3403485</c:v>
                </c:pt>
                <c:pt idx="135">
                  <c:v>0.34118000000000004</c:v>
                </c:pt>
                <c:pt idx="136">
                  <c:v>0.34101749999999997</c:v>
                </c:pt>
                <c:pt idx="137">
                  <c:v>0.34297900000000003</c:v>
                </c:pt>
                <c:pt idx="138">
                  <c:v>0.34592299999999998</c:v>
                </c:pt>
                <c:pt idx="139">
                  <c:v>0.3478594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C036-4A4D-B340-09876A98FCF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22197600"/>
        <c:axId val="2113553632"/>
      </c:scatterChart>
      <c:valAx>
        <c:axId val="2122197600"/>
        <c:scaling>
          <c:orientation val="minMax"/>
          <c:max val="850"/>
          <c:min val="45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Wavelength [nm]</a:t>
                </a:r>
              </a:p>
            </c:rich>
          </c:tx>
          <c:layout>
            <c:manualLayout>
              <c:xMode val="edge"/>
              <c:yMode val="edge"/>
              <c:x val="0.40236023622047246"/>
              <c:y val="0.9182872798573028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113553632"/>
        <c:crosses val="autoZero"/>
        <c:crossBetween val="midCat"/>
      </c:valAx>
      <c:valAx>
        <c:axId val="2113553632"/>
        <c:scaling>
          <c:orientation val="minMax"/>
          <c:max val="0.4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Reflectance [%/100]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122197600"/>
        <c:crosses val="autoZero"/>
        <c:crossBetween val="midCat"/>
        <c:majorUnit val="0.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strRef>
              <c:f>Graphs!$AL$4</c:f>
              <c:strCache>
                <c:ptCount val="1"/>
                <c:pt idx="0">
                  <c:v>Healthy tissue</c:v>
                </c:pt>
              </c:strCache>
            </c:strRef>
          </c:tx>
          <c:spPr>
            <a:ln w="19050" cap="rnd">
              <a:solidFill>
                <a:srgbClr val="06C60B"/>
              </a:solidFill>
              <a:round/>
            </a:ln>
            <a:effectLst/>
          </c:spPr>
          <c:marker>
            <c:symbol val="none"/>
          </c:marker>
          <c:xVal>
            <c:numRef>
              <c:f>Graphs!$AK$5:$AK$144</c:f>
              <c:numCache>
                <c:formatCode>General</c:formatCode>
                <c:ptCount val="140"/>
                <c:pt idx="0">
                  <c:v>451.25</c:v>
                </c:pt>
                <c:pt idx="1">
                  <c:v>454.040009</c:v>
                </c:pt>
                <c:pt idx="2">
                  <c:v>456.82000699999998</c:v>
                </c:pt>
                <c:pt idx="3">
                  <c:v>459.60998499999999</c:v>
                </c:pt>
                <c:pt idx="4">
                  <c:v>462.39999399999999</c:v>
                </c:pt>
                <c:pt idx="5">
                  <c:v>465.19000199999999</c:v>
                </c:pt>
                <c:pt idx="6">
                  <c:v>467.98001099999999</c:v>
                </c:pt>
                <c:pt idx="7">
                  <c:v>470.77999899999998</c:v>
                </c:pt>
                <c:pt idx="8">
                  <c:v>473.57000699999998</c:v>
                </c:pt>
                <c:pt idx="9">
                  <c:v>476.36999500000002</c:v>
                </c:pt>
                <c:pt idx="10">
                  <c:v>479.16000400000001</c:v>
                </c:pt>
                <c:pt idx="11">
                  <c:v>481.959991</c:v>
                </c:pt>
                <c:pt idx="12">
                  <c:v>484.76001000000002</c:v>
                </c:pt>
                <c:pt idx="13">
                  <c:v>487.55999800000001</c:v>
                </c:pt>
                <c:pt idx="14">
                  <c:v>490.35998499999999</c:v>
                </c:pt>
                <c:pt idx="15">
                  <c:v>493.16000400000001</c:v>
                </c:pt>
                <c:pt idx="16">
                  <c:v>495.97000100000002</c:v>
                </c:pt>
                <c:pt idx="17">
                  <c:v>498.76998900000001</c:v>
                </c:pt>
                <c:pt idx="18">
                  <c:v>501.57998700000002</c:v>
                </c:pt>
                <c:pt idx="19">
                  <c:v>504.39001500000001</c:v>
                </c:pt>
                <c:pt idx="20">
                  <c:v>507.19000199999999</c:v>
                </c:pt>
                <c:pt idx="21">
                  <c:v>510</c:v>
                </c:pt>
                <c:pt idx="22">
                  <c:v>512.80999799999995</c:v>
                </c:pt>
                <c:pt idx="23">
                  <c:v>515.63000499999998</c:v>
                </c:pt>
                <c:pt idx="24">
                  <c:v>518.44000200000005</c:v>
                </c:pt>
                <c:pt idx="25">
                  <c:v>521.25</c:v>
                </c:pt>
                <c:pt idx="26">
                  <c:v>524.07000700000003</c:v>
                </c:pt>
                <c:pt idx="27">
                  <c:v>526.88000499999998</c:v>
                </c:pt>
                <c:pt idx="28">
                  <c:v>529.70001200000002</c:v>
                </c:pt>
                <c:pt idx="29">
                  <c:v>532.52002000000005</c:v>
                </c:pt>
                <c:pt idx="30">
                  <c:v>535.34002699999996</c:v>
                </c:pt>
                <c:pt idx="31">
                  <c:v>538.15997300000004</c:v>
                </c:pt>
                <c:pt idx="32">
                  <c:v>540.98999000000003</c:v>
                </c:pt>
                <c:pt idx="33">
                  <c:v>543.80999799999995</c:v>
                </c:pt>
                <c:pt idx="34">
                  <c:v>546.63000499999998</c:v>
                </c:pt>
                <c:pt idx="35">
                  <c:v>549.46002199999998</c:v>
                </c:pt>
                <c:pt idx="36">
                  <c:v>552.28997800000002</c:v>
                </c:pt>
                <c:pt idx="37">
                  <c:v>555.11999500000002</c:v>
                </c:pt>
                <c:pt idx="38">
                  <c:v>557.94000200000005</c:v>
                </c:pt>
                <c:pt idx="39">
                  <c:v>560.78002900000001</c:v>
                </c:pt>
                <c:pt idx="40">
                  <c:v>563.60998500000005</c:v>
                </c:pt>
                <c:pt idx="41">
                  <c:v>566.44000200000005</c:v>
                </c:pt>
                <c:pt idx="42">
                  <c:v>569.27002000000005</c:v>
                </c:pt>
                <c:pt idx="43">
                  <c:v>572.10998500000005</c:v>
                </c:pt>
                <c:pt idx="44">
                  <c:v>574.95001200000002</c:v>
                </c:pt>
                <c:pt idx="45">
                  <c:v>577.78002900000001</c:v>
                </c:pt>
                <c:pt idx="46">
                  <c:v>580.61999500000002</c:v>
                </c:pt>
                <c:pt idx="47">
                  <c:v>583.46002199999998</c:v>
                </c:pt>
                <c:pt idx="48">
                  <c:v>586.29998799999998</c:v>
                </c:pt>
                <c:pt idx="49">
                  <c:v>589.15002400000003</c:v>
                </c:pt>
                <c:pt idx="50">
                  <c:v>591.98999000000003</c:v>
                </c:pt>
                <c:pt idx="51">
                  <c:v>594.84002699999996</c:v>
                </c:pt>
                <c:pt idx="52">
                  <c:v>597.67999299999997</c:v>
                </c:pt>
                <c:pt idx="53">
                  <c:v>600.53002900000001</c:v>
                </c:pt>
                <c:pt idx="54">
                  <c:v>603.38000499999998</c:v>
                </c:pt>
                <c:pt idx="55">
                  <c:v>606.22997999999995</c:v>
                </c:pt>
                <c:pt idx="56">
                  <c:v>609.080017</c:v>
                </c:pt>
                <c:pt idx="57">
                  <c:v>611.92999299999997</c:v>
                </c:pt>
                <c:pt idx="58">
                  <c:v>614.78002900000001</c:v>
                </c:pt>
                <c:pt idx="59">
                  <c:v>617.64001499999995</c:v>
                </c:pt>
                <c:pt idx="60">
                  <c:v>620.48999000000003</c:v>
                </c:pt>
                <c:pt idx="61">
                  <c:v>623.34997599999997</c:v>
                </c:pt>
                <c:pt idx="62">
                  <c:v>626.21002199999998</c:v>
                </c:pt>
                <c:pt idx="63">
                  <c:v>629.07000700000003</c:v>
                </c:pt>
                <c:pt idx="64">
                  <c:v>631.92999299999997</c:v>
                </c:pt>
                <c:pt idx="65">
                  <c:v>634.78997800000002</c:v>
                </c:pt>
                <c:pt idx="66">
                  <c:v>637.65002400000003</c:v>
                </c:pt>
                <c:pt idx="67">
                  <c:v>640.51000999999997</c:v>
                </c:pt>
                <c:pt idx="68">
                  <c:v>643.38000499999998</c:v>
                </c:pt>
                <c:pt idx="69">
                  <c:v>646.23999000000003</c:v>
                </c:pt>
                <c:pt idx="70">
                  <c:v>649.10998500000005</c:v>
                </c:pt>
                <c:pt idx="71">
                  <c:v>651.97997999999995</c:v>
                </c:pt>
                <c:pt idx="72">
                  <c:v>654.84997599999997</c:v>
                </c:pt>
                <c:pt idx="73">
                  <c:v>657.71997099999999</c:v>
                </c:pt>
                <c:pt idx="74">
                  <c:v>660.59002699999996</c:v>
                </c:pt>
                <c:pt idx="75">
                  <c:v>663.46997099999999</c:v>
                </c:pt>
                <c:pt idx="76">
                  <c:v>666.34002699999996</c:v>
                </c:pt>
                <c:pt idx="77">
                  <c:v>669.21997099999999</c:v>
                </c:pt>
                <c:pt idx="78">
                  <c:v>672.09002699999996</c:v>
                </c:pt>
                <c:pt idx="79">
                  <c:v>674.96997099999999</c:v>
                </c:pt>
                <c:pt idx="80">
                  <c:v>677.84997599999997</c:v>
                </c:pt>
                <c:pt idx="81">
                  <c:v>680.72997999999995</c:v>
                </c:pt>
                <c:pt idx="82">
                  <c:v>683.60998500000005</c:v>
                </c:pt>
                <c:pt idx="83">
                  <c:v>686.48999000000003</c:v>
                </c:pt>
                <c:pt idx="84">
                  <c:v>689.38000499999998</c:v>
                </c:pt>
                <c:pt idx="85">
                  <c:v>692.26000999999997</c:v>
                </c:pt>
                <c:pt idx="86">
                  <c:v>695.15002400000003</c:v>
                </c:pt>
                <c:pt idx="87">
                  <c:v>698.03002900000001</c:v>
                </c:pt>
                <c:pt idx="88">
                  <c:v>700.919983</c:v>
                </c:pt>
                <c:pt idx="89">
                  <c:v>703.80999799999995</c:v>
                </c:pt>
                <c:pt idx="90">
                  <c:v>706.70001200000002</c:v>
                </c:pt>
                <c:pt idx="91">
                  <c:v>709.59997599999997</c:v>
                </c:pt>
                <c:pt idx="92">
                  <c:v>712.48999000000003</c:v>
                </c:pt>
                <c:pt idx="93">
                  <c:v>715.38000499999998</c:v>
                </c:pt>
                <c:pt idx="94">
                  <c:v>718.28002900000001</c:v>
                </c:pt>
                <c:pt idx="95">
                  <c:v>721.17999299999997</c:v>
                </c:pt>
                <c:pt idx="96">
                  <c:v>724.07000700000003</c:v>
                </c:pt>
                <c:pt idx="97">
                  <c:v>726.96997099999999</c:v>
                </c:pt>
                <c:pt idx="98">
                  <c:v>729.86999500000002</c:v>
                </c:pt>
                <c:pt idx="99">
                  <c:v>732.77002000000005</c:v>
                </c:pt>
                <c:pt idx="100">
                  <c:v>735.67999299999997</c:v>
                </c:pt>
                <c:pt idx="101">
                  <c:v>738.580017</c:v>
                </c:pt>
                <c:pt idx="102">
                  <c:v>741.48999000000003</c:v>
                </c:pt>
                <c:pt idx="103">
                  <c:v>744.39001499999995</c:v>
                </c:pt>
                <c:pt idx="104">
                  <c:v>747.29998799999998</c:v>
                </c:pt>
                <c:pt idx="105">
                  <c:v>750.21002199999998</c:v>
                </c:pt>
                <c:pt idx="106">
                  <c:v>753.11999500000002</c:v>
                </c:pt>
                <c:pt idx="107">
                  <c:v>756.03002900000001</c:v>
                </c:pt>
                <c:pt idx="108">
                  <c:v>758.94000200000005</c:v>
                </c:pt>
                <c:pt idx="109">
                  <c:v>761.84997599999997</c:v>
                </c:pt>
                <c:pt idx="110">
                  <c:v>764.77002000000005</c:v>
                </c:pt>
                <c:pt idx="111">
                  <c:v>767.67999299999997</c:v>
                </c:pt>
                <c:pt idx="112">
                  <c:v>770.59997599999997</c:v>
                </c:pt>
                <c:pt idx="113">
                  <c:v>773.52002000000005</c:v>
                </c:pt>
                <c:pt idx="114">
                  <c:v>776.44000200000005</c:v>
                </c:pt>
                <c:pt idx="115">
                  <c:v>779.35998500000005</c:v>
                </c:pt>
                <c:pt idx="116">
                  <c:v>782.28002900000001</c:v>
                </c:pt>
                <c:pt idx="117">
                  <c:v>785.20001200000002</c:v>
                </c:pt>
                <c:pt idx="118">
                  <c:v>788.11999500000002</c:v>
                </c:pt>
                <c:pt idx="119">
                  <c:v>791.04998799999998</c:v>
                </c:pt>
                <c:pt idx="120">
                  <c:v>793.97997999999995</c:v>
                </c:pt>
                <c:pt idx="121">
                  <c:v>796.90002400000003</c:v>
                </c:pt>
                <c:pt idx="122">
                  <c:v>799.830017</c:v>
                </c:pt>
                <c:pt idx="123">
                  <c:v>802.76000999999997</c:v>
                </c:pt>
                <c:pt idx="124">
                  <c:v>805.69000200000005</c:v>
                </c:pt>
                <c:pt idx="125">
                  <c:v>808.61999500000002</c:v>
                </c:pt>
                <c:pt idx="126">
                  <c:v>811.55999799999995</c:v>
                </c:pt>
                <c:pt idx="127">
                  <c:v>814.48999000000003</c:v>
                </c:pt>
                <c:pt idx="128">
                  <c:v>817.42999299999997</c:v>
                </c:pt>
                <c:pt idx="129">
                  <c:v>820.35998500000005</c:v>
                </c:pt>
                <c:pt idx="130">
                  <c:v>823.29998799999998</c:v>
                </c:pt>
                <c:pt idx="131">
                  <c:v>826.23999000000003</c:v>
                </c:pt>
                <c:pt idx="132">
                  <c:v>829.17999299999997</c:v>
                </c:pt>
                <c:pt idx="133">
                  <c:v>832.11999500000002</c:v>
                </c:pt>
                <c:pt idx="134">
                  <c:v>835.07000700000003</c:v>
                </c:pt>
                <c:pt idx="135">
                  <c:v>838.01000999999997</c:v>
                </c:pt>
                <c:pt idx="136">
                  <c:v>840.95001200000002</c:v>
                </c:pt>
                <c:pt idx="137">
                  <c:v>843.90002400000003</c:v>
                </c:pt>
                <c:pt idx="138">
                  <c:v>846.84997599999997</c:v>
                </c:pt>
                <c:pt idx="139">
                  <c:v>849.79998799999998</c:v>
                </c:pt>
              </c:numCache>
            </c:numRef>
          </c:xVal>
          <c:yVal>
            <c:numRef>
              <c:f>Graphs!$AL$5:$AL$144</c:f>
              <c:numCache>
                <c:formatCode>General</c:formatCode>
                <c:ptCount val="140"/>
                <c:pt idx="0">
                  <c:v>4.6848000000000001E-2</c:v>
                </c:pt>
                <c:pt idx="1">
                  <c:v>4.6823500000000004E-2</c:v>
                </c:pt>
                <c:pt idx="2">
                  <c:v>4.6704499999999996E-2</c:v>
                </c:pt>
                <c:pt idx="3">
                  <c:v>4.6497499999999997E-2</c:v>
                </c:pt>
                <c:pt idx="4">
                  <c:v>4.6108750000000004E-2</c:v>
                </c:pt>
                <c:pt idx="5">
                  <c:v>4.5720749999999998E-2</c:v>
                </c:pt>
                <c:pt idx="6">
                  <c:v>4.5311500000000005E-2</c:v>
                </c:pt>
                <c:pt idx="7">
                  <c:v>4.5030250000000001E-2</c:v>
                </c:pt>
                <c:pt idx="8">
                  <c:v>4.4718750000000002E-2</c:v>
                </c:pt>
                <c:pt idx="9">
                  <c:v>4.4511999999999996E-2</c:v>
                </c:pt>
                <c:pt idx="10">
                  <c:v>4.4347999999999999E-2</c:v>
                </c:pt>
                <c:pt idx="11">
                  <c:v>4.4250499999999998E-2</c:v>
                </c:pt>
                <c:pt idx="12">
                  <c:v>4.4093499999999994E-2</c:v>
                </c:pt>
                <c:pt idx="13">
                  <c:v>4.405125E-2</c:v>
                </c:pt>
                <c:pt idx="14">
                  <c:v>4.4122000000000001E-2</c:v>
                </c:pt>
                <c:pt idx="15">
                  <c:v>4.4385500000000001E-2</c:v>
                </c:pt>
                <c:pt idx="16">
                  <c:v>4.4906750000000009E-2</c:v>
                </c:pt>
                <c:pt idx="17">
                  <c:v>4.5838000000000004E-2</c:v>
                </c:pt>
                <c:pt idx="18">
                  <c:v>4.7343749999999997E-2</c:v>
                </c:pt>
                <c:pt idx="19">
                  <c:v>4.9707249999999994E-2</c:v>
                </c:pt>
                <c:pt idx="20">
                  <c:v>5.3136750000000003E-2</c:v>
                </c:pt>
                <c:pt idx="21">
                  <c:v>5.7651749999999995E-2</c:v>
                </c:pt>
                <c:pt idx="22">
                  <c:v>6.3304749999999993E-2</c:v>
                </c:pt>
                <c:pt idx="23">
                  <c:v>7.0137000000000005E-2</c:v>
                </c:pt>
                <c:pt idx="24">
                  <c:v>7.8180750000000007E-2</c:v>
                </c:pt>
                <c:pt idx="25">
                  <c:v>8.7096499999999993E-2</c:v>
                </c:pt>
                <c:pt idx="26">
                  <c:v>9.6171000000000006E-2</c:v>
                </c:pt>
                <c:pt idx="27">
                  <c:v>0.10456625</c:v>
                </c:pt>
                <c:pt idx="28">
                  <c:v>0.11172650000000001</c:v>
                </c:pt>
                <c:pt idx="29">
                  <c:v>0.11734449999999999</c:v>
                </c:pt>
                <c:pt idx="30">
                  <c:v>0.1214595</c:v>
                </c:pt>
                <c:pt idx="31">
                  <c:v>0.12427674999999999</c:v>
                </c:pt>
                <c:pt idx="32">
                  <c:v>0.1261805</c:v>
                </c:pt>
                <c:pt idx="33">
                  <c:v>0.12765775000000001</c:v>
                </c:pt>
                <c:pt idx="34">
                  <c:v>0.12908249999999999</c:v>
                </c:pt>
                <c:pt idx="35">
                  <c:v>0.13041049999999998</c:v>
                </c:pt>
                <c:pt idx="36">
                  <c:v>0.13121450000000001</c:v>
                </c:pt>
                <c:pt idx="37">
                  <c:v>0.13093399999999999</c:v>
                </c:pt>
                <c:pt idx="38">
                  <c:v>0.12926075000000001</c:v>
                </c:pt>
                <c:pt idx="39">
                  <c:v>0.12633225000000001</c:v>
                </c:pt>
                <c:pt idx="40">
                  <c:v>0.122408</c:v>
                </c:pt>
                <c:pt idx="41">
                  <c:v>0.11753449999999999</c:v>
                </c:pt>
                <c:pt idx="42">
                  <c:v>0.11179375000000001</c:v>
                </c:pt>
                <c:pt idx="43">
                  <c:v>0.10563500000000001</c:v>
                </c:pt>
                <c:pt idx="44">
                  <c:v>9.9766750000000001E-2</c:v>
                </c:pt>
                <c:pt idx="45">
                  <c:v>9.4701000000000007E-2</c:v>
                </c:pt>
                <c:pt idx="46">
                  <c:v>9.0478750000000011E-2</c:v>
                </c:pt>
                <c:pt idx="47">
                  <c:v>8.6953749999999996E-2</c:v>
                </c:pt>
                <c:pt idx="48">
                  <c:v>8.4028249999999999E-2</c:v>
                </c:pt>
                <c:pt idx="49">
                  <c:v>8.166625000000001E-2</c:v>
                </c:pt>
                <c:pt idx="50">
                  <c:v>7.9820250000000009E-2</c:v>
                </c:pt>
                <c:pt idx="51">
                  <c:v>7.8462250000000011E-2</c:v>
                </c:pt>
                <c:pt idx="52">
                  <c:v>7.7395249999999999E-2</c:v>
                </c:pt>
                <c:pt idx="53">
                  <c:v>7.6303250000000003E-2</c:v>
                </c:pt>
                <c:pt idx="54">
                  <c:v>7.4852500000000002E-2</c:v>
                </c:pt>
                <c:pt idx="55">
                  <c:v>7.2817500000000007E-2</c:v>
                </c:pt>
                <c:pt idx="56">
                  <c:v>7.0221249999999999E-2</c:v>
                </c:pt>
                <c:pt idx="57">
                  <c:v>6.7336499999999994E-2</c:v>
                </c:pt>
                <c:pt idx="58">
                  <c:v>6.4523999999999998E-2</c:v>
                </c:pt>
                <c:pt idx="59">
                  <c:v>6.2053249999999997E-2</c:v>
                </c:pt>
                <c:pt idx="60">
                  <c:v>6.0093000000000001E-2</c:v>
                </c:pt>
                <c:pt idx="61">
                  <c:v>5.8728250000000003E-2</c:v>
                </c:pt>
                <c:pt idx="62">
                  <c:v>5.79345E-2</c:v>
                </c:pt>
                <c:pt idx="63">
                  <c:v>5.7556999999999997E-2</c:v>
                </c:pt>
                <c:pt idx="64">
                  <c:v>5.7193250000000001E-2</c:v>
                </c:pt>
                <c:pt idx="65">
                  <c:v>5.6375500000000002E-2</c:v>
                </c:pt>
                <c:pt idx="66">
                  <c:v>5.4884000000000002E-2</c:v>
                </c:pt>
                <c:pt idx="67">
                  <c:v>5.2892750000000002E-2</c:v>
                </c:pt>
                <c:pt idx="68">
                  <c:v>5.0647249999999998E-2</c:v>
                </c:pt>
                <c:pt idx="69">
                  <c:v>4.8422000000000007E-2</c:v>
                </c:pt>
                <c:pt idx="70">
                  <c:v>4.6509250000000002E-2</c:v>
                </c:pt>
                <c:pt idx="71">
                  <c:v>4.4989500000000002E-2</c:v>
                </c:pt>
                <c:pt idx="72">
                  <c:v>4.3546500000000002E-2</c:v>
                </c:pt>
                <c:pt idx="73">
                  <c:v>4.1917749999999997E-2</c:v>
                </c:pt>
                <c:pt idx="74">
                  <c:v>4.0167500000000002E-2</c:v>
                </c:pt>
                <c:pt idx="75">
                  <c:v>3.8523749999999995E-2</c:v>
                </c:pt>
                <c:pt idx="76">
                  <c:v>3.7152250000000005E-2</c:v>
                </c:pt>
                <c:pt idx="77">
                  <c:v>3.6177000000000001E-2</c:v>
                </c:pt>
                <c:pt idx="78">
                  <c:v>3.5674000000000004E-2</c:v>
                </c:pt>
                <c:pt idx="79">
                  <c:v>3.5635E-2</c:v>
                </c:pt>
                <c:pt idx="80">
                  <c:v>3.6048999999999998E-2</c:v>
                </c:pt>
                <c:pt idx="81">
                  <c:v>3.6912749999999994E-2</c:v>
                </c:pt>
                <c:pt idx="82">
                  <c:v>3.8351750000000004E-2</c:v>
                </c:pt>
                <c:pt idx="83">
                  <c:v>4.0921250000000006E-2</c:v>
                </c:pt>
                <c:pt idx="84">
                  <c:v>4.6019499999999998E-2</c:v>
                </c:pt>
                <c:pt idx="85">
                  <c:v>5.5477750000000006E-2</c:v>
                </c:pt>
                <c:pt idx="86">
                  <c:v>7.0616999999999999E-2</c:v>
                </c:pt>
                <c:pt idx="87">
                  <c:v>9.1243749999999998E-2</c:v>
                </c:pt>
                <c:pt idx="88">
                  <c:v>0.115339</c:v>
                </c:pt>
                <c:pt idx="89">
                  <c:v>0.14022774999999998</c:v>
                </c:pt>
                <c:pt idx="90">
                  <c:v>0.16413475</c:v>
                </c:pt>
                <c:pt idx="91">
                  <c:v>0.18669549999999999</c:v>
                </c:pt>
                <c:pt idx="92">
                  <c:v>0.20821800000000001</c:v>
                </c:pt>
                <c:pt idx="93">
                  <c:v>0.22884225000000002</c:v>
                </c:pt>
                <c:pt idx="94">
                  <c:v>0.24850800000000001</c:v>
                </c:pt>
                <c:pt idx="95">
                  <c:v>0.26695849999999999</c:v>
                </c:pt>
                <c:pt idx="96">
                  <c:v>0.28401975000000002</c:v>
                </c:pt>
                <c:pt idx="97">
                  <c:v>0.29962449999999996</c:v>
                </c:pt>
                <c:pt idx="98">
                  <c:v>0.31357499999999999</c:v>
                </c:pt>
                <c:pt idx="99">
                  <c:v>0.3256365</c:v>
                </c:pt>
                <c:pt idx="100">
                  <c:v>0.3358255</c:v>
                </c:pt>
                <c:pt idx="101">
                  <c:v>0.34430150000000004</c:v>
                </c:pt>
                <c:pt idx="102">
                  <c:v>0.35100299999999995</c:v>
                </c:pt>
                <c:pt idx="103">
                  <c:v>0.35597000000000001</c:v>
                </c:pt>
                <c:pt idx="104">
                  <c:v>0.35965674999999997</c:v>
                </c:pt>
                <c:pt idx="105">
                  <c:v>0.36248199999999997</c:v>
                </c:pt>
                <c:pt idx="106">
                  <c:v>0.36466749999999998</c:v>
                </c:pt>
                <c:pt idx="107">
                  <c:v>0.36650525</c:v>
                </c:pt>
                <c:pt idx="108">
                  <c:v>0.36798724999999999</c:v>
                </c:pt>
                <c:pt idx="109">
                  <c:v>0.36893325000000005</c:v>
                </c:pt>
                <c:pt idx="110">
                  <c:v>0.36970400000000003</c:v>
                </c:pt>
                <c:pt idx="111">
                  <c:v>0.37049850000000001</c:v>
                </c:pt>
                <c:pt idx="112">
                  <c:v>0.37111325000000006</c:v>
                </c:pt>
                <c:pt idx="113">
                  <c:v>0.37140925000000002</c:v>
                </c:pt>
                <c:pt idx="114">
                  <c:v>0.371471</c:v>
                </c:pt>
                <c:pt idx="115">
                  <c:v>0.37113099999999999</c:v>
                </c:pt>
                <c:pt idx="116">
                  <c:v>0.37036400000000003</c:v>
                </c:pt>
                <c:pt idx="117">
                  <c:v>0.36954350000000002</c:v>
                </c:pt>
                <c:pt idx="118">
                  <c:v>0.36861174999999996</c:v>
                </c:pt>
                <c:pt idx="119">
                  <c:v>0.36753174999999999</c:v>
                </c:pt>
                <c:pt idx="120">
                  <c:v>0.3662475</c:v>
                </c:pt>
                <c:pt idx="121">
                  <c:v>0.36481650000000004</c:v>
                </c:pt>
                <c:pt idx="122">
                  <c:v>0.36330924999999997</c:v>
                </c:pt>
                <c:pt idx="123">
                  <c:v>0.36224974999999998</c:v>
                </c:pt>
                <c:pt idx="124">
                  <c:v>0.36167300000000002</c:v>
                </c:pt>
                <c:pt idx="125">
                  <c:v>0.36135100000000003</c:v>
                </c:pt>
                <c:pt idx="126">
                  <c:v>0.36081799999999997</c:v>
                </c:pt>
                <c:pt idx="127">
                  <c:v>0.36000750000000004</c:v>
                </c:pt>
                <c:pt idx="128">
                  <c:v>0.35909374999999999</c:v>
                </c:pt>
                <c:pt idx="129">
                  <c:v>0.358344</c:v>
                </c:pt>
                <c:pt idx="130">
                  <c:v>0.35775349999999995</c:v>
                </c:pt>
                <c:pt idx="131">
                  <c:v>0.35736224999999999</c:v>
                </c:pt>
                <c:pt idx="132">
                  <c:v>0.35722124999999993</c:v>
                </c:pt>
                <c:pt idx="133">
                  <c:v>0.35741250000000002</c:v>
                </c:pt>
                <c:pt idx="134">
                  <c:v>0.35765675000000002</c:v>
                </c:pt>
                <c:pt idx="135">
                  <c:v>0.35811874999999993</c:v>
                </c:pt>
                <c:pt idx="136">
                  <c:v>0.358713</c:v>
                </c:pt>
                <c:pt idx="137">
                  <c:v>0.35945125000000006</c:v>
                </c:pt>
                <c:pt idx="138">
                  <c:v>0.36016075000000003</c:v>
                </c:pt>
                <c:pt idx="139">
                  <c:v>0.3606282499999999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1831-48AC-9C36-2D9335821AE6}"/>
            </c:ext>
          </c:extLst>
        </c:ser>
        <c:ser>
          <c:idx val="1"/>
          <c:order val="1"/>
          <c:tx>
            <c:strRef>
              <c:f>Graphs!$AM$4</c:f>
              <c:strCache>
                <c:ptCount val="1"/>
                <c:pt idx="0">
                  <c:v>Dark brown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xVal>
            <c:numRef>
              <c:f>Graphs!$AK$5:$AK$144</c:f>
              <c:numCache>
                <c:formatCode>General</c:formatCode>
                <c:ptCount val="140"/>
                <c:pt idx="0">
                  <c:v>451.25</c:v>
                </c:pt>
                <c:pt idx="1">
                  <c:v>454.040009</c:v>
                </c:pt>
                <c:pt idx="2">
                  <c:v>456.82000699999998</c:v>
                </c:pt>
                <c:pt idx="3">
                  <c:v>459.60998499999999</c:v>
                </c:pt>
                <c:pt idx="4">
                  <c:v>462.39999399999999</c:v>
                </c:pt>
                <c:pt idx="5">
                  <c:v>465.19000199999999</c:v>
                </c:pt>
                <c:pt idx="6">
                  <c:v>467.98001099999999</c:v>
                </c:pt>
                <c:pt idx="7">
                  <c:v>470.77999899999998</c:v>
                </c:pt>
                <c:pt idx="8">
                  <c:v>473.57000699999998</c:v>
                </c:pt>
                <c:pt idx="9">
                  <c:v>476.36999500000002</c:v>
                </c:pt>
                <c:pt idx="10">
                  <c:v>479.16000400000001</c:v>
                </c:pt>
                <c:pt idx="11">
                  <c:v>481.959991</c:v>
                </c:pt>
                <c:pt idx="12">
                  <c:v>484.76001000000002</c:v>
                </c:pt>
                <c:pt idx="13">
                  <c:v>487.55999800000001</c:v>
                </c:pt>
                <c:pt idx="14">
                  <c:v>490.35998499999999</c:v>
                </c:pt>
                <c:pt idx="15">
                  <c:v>493.16000400000001</c:v>
                </c:pt>
                <c:pt idx="16">
                  <c:v>495.97000100000002</c:v>
                </c:pt>
                <c:pt idx="17">
                  <c:v>498.76998900000001</c:v>
                </c:pt>
                <c:pt idx="18">
                  <c:v>501.57998700000002</c:v>
                </c:pt>
                <c:pt idx="19">
                  <c:v>504.39001500000001</c:v>
                </c:pt>
                <c:pt idx="20">
                  <c:v>507.19000199999999</c:v>
                </c:pt>
                <c:pt idx="21">
                  <c:v>510</c:v>
                </c:pt>
                <c:pt idx="22">
                  <c:v>512.80999799999995</c:v>
                </c:pt>
                <c:pt idx="23">
                  <c:v>515.63000499999998</c:v>
                </c:pt>
                <c:pt idx="24">
                  <c:v>518.44000200000005</c:v>
                </c:pt>
                <c:pt idx="25">
                  <c:v>521.25</c:v>
                </c:pt>
                <c:pt idx="26">
                  <c:v>524.07000700000003</c:v>
                </c:pt>
                <c:pt idx="27">
                  <c:v>526.88000499999998</c:v>
                </c:pt>
                <c:pt idx="28">
                  <c:v>529.70001200000002</c:v>
                </c:pt>
                <c:pt idx="29">
                  <c:v>532.52002000000005</c:v>
                </c:pt>
                <c:pt idx="30">
                  <c:v>535.34002699999996</c:v>
                </c:pt>
                <c:pt idx="31">
                  <c:v>538.15997300000004</c:v>
                </c:pt>
                <c:pt idx="32">
                  <c:v>540.98999000000003</c:v>
                </c:pt>
                <c:pt idx="33">
                  <c:v>543.80999799999995</c:v>
                </c:pt>
                <c:pt idx="34">
                  <c:v>546.63000499999998</c:v>
                </c:pt>
                <c:pt idx="35">
                  <c:v>549.46002199999998</c:v>
                </c:pt>
                <c:pt idx="36">
                  <c:v>552.28997800000002</c:v>
                </c:pt>
                <c:pt idx="37">
                  <c:v>555.11999500000002</c:v>
                </c:pt>
                <c:pt idx="38">
                  <c:v>557.94000200000005</c:v>
                </c:pt>
                <c:pt idx="39">
                  <c:v>560.78002900000001</c:v>
                </c:pt>
                <c:pt idx="40">
                  <c:v>563.60998500000005</c:v>
                </c:pt>
                <c:pt idx="41">
                  <c:v>566.44000200000005</c:v>
                </c:pt>
                <c:pt idx="42">
                  <c:v>569.27002000000005</c:v>
                </c:pt>
                <c:pt idx="43">
                  <c:v>572.10998500000005</c:v>
                </c:pt>
                <c:pt idx="44">
                  <c:v>574.95001200000002</c:v>
                </c:pt>
                <c:pt idx="45">
                  <c:v>577.78002900000001</c:v>
                </c:pt>
                <c:pt idx="46">
                  <c:v>580.61999500000002</c:v>
                </c:pt>
                <c:pt idx="47">
                  <c:v>583.46002199999998</c:v>
                </c:pt>
                <c:pt idx="48">
                  <c:v>586.29998799999998</c:v>
                </c:pt>
                <c:pt idx="49">
                  <c:v>589.15002400000003</c:v>
                </c:pt>
                <c:pt idx="50">
                  <c:v>591.98999000000003</c:v>
                </c:pt>
                <c:pt idx="51">
                  <c:v>594.84002699999996</c:v>
                </c:pt>
                <c:pt idx="52">
                  <c:v>597.67999299999997</c:v>
                </c:pt>
                <c:pt idx="53">
                  <c:v>600.53002900000001</c:v>
                </c:pt>
                <c:pt idx="54">
                  <c:v>603.38000499999998</c:v>
                </c:pt>
                <c:pt idx="55">
                  <c:v>606.22997999999995</c:v>
                </c:pt>
                <c:pt idx="56">
                  <c:v>609.080017</c:v>
                </c:pt>
                <c:pt idx="57">
                  <c:v>611.92999299999997</c:v>
                </c:pt>
                <c:pt idx="58">
                  <c:v>614.78002900000001</c:v>
                </c:pt>
                <c:pt idx="59">
                  <c:v>617.64001499999995</c:v>
                </c:pt>
                <c:pt idx="60">
                  <c:v>620.48999000000003</c:v>
                </c:pt>
                <c:pt idx="61">
                  <c:v>623.34997599999997</c:v>
                </c:pt>
                <c:pt idx="62">
                  <c:v>626.21002199999998</c:v>
                </c:pt>
                <c:pt idx="63">
                  <c:v>629.07000700000003</c:v>
                </c:pt>
                <c:pt idx="64">
                  <c:v>631.92999299999997</c:v>
                </c:pt>
                <c:pt idx="65">
                  <c:v>634.78997800000002</c:v>
                </c:pt>
                <c:pt idx="66">
                  <c:v>637.65002400000003</c:v>
                </c:pt>
                <c:pt idx="67">
                  <c:v>640.51000999999997</c:v>
                </c:pt>
                <c:pt idx="68">
                  <c:v>643.38000499999998</c:v>
                </c:pt>
                <c:pt idx="69">
                  <c:v>646.23999000000003</c:v>
                </c:pt>
                <c:pt idx="70">
                  <c:v>649.10998500000005</c:v>
                </c:pt>
                <c:pt idx="71">
                  <c:v>651.97997999999995</c:v>
                </c:pt>
                <c:pt idx="72">
                  <c:v>654.84997599999997</c:v>
                </c:pt>
                <c:pt idx="73">
                  <c:v>657.71997099999999</c:v>
                </c:pt>
                <c:pt idx="74">
                  <c:v>660.59002699999996</c:v>
                </c:pt>
                <c:pt idx="75">
                  <c:v>663.46997099999999</c:v>
                </c:pt>
                <c:pt idx="76">
                  <c:v>666.34002699999996</c:v>
                </c:pt>
                <c:pt idx="77">
                  <c:v>669.21997099999999</c:v>
                </c:pt>
                <c:pt idx="78">
                  <c:v>672.09002699999996</c:v>
                </c:pt>
                <c:pt idx="79">
                  <c:v>674.96997099999999</c:v>
                </c:pt>
                <c:pt idx="80">
                  <c:v>677.84997599999997</c:v>
                </c:pt>
                <c:pt idx="81">
                  <c:v>680.72997999999995</c:v>
                </c:pt>
                <c:pt idx="82">
                  <c:v>683.60998500000005</c:v>
                </c:pt>
                <c:pt idx="83">
                  <c:v>686.48999000000003</c:v>
                </c:pt>
                <c:pt idx="84">
                  <c:v>689.38000499999998</c:v>
                </c:pt>
                <c:pt idx="85">
                  <c:v>692.26000999999997</c:v>
                </c:pt>
                <c:pt idx="86">
                  <c:v>695.15002400000003</c:v>
                </c:pt>
                <c:pt idx="87">
                  <c:v>698.03002900000001</c:v>
                </c:pt>
                <c:pt idx="88">
                  <c:v>700.919983</c:v>
                </c:pt>
                <c:pt idx="89">
                  <c:v>703.80999799999995</c:v>
                </c:pt>
                <c:pt idx="90">
                  <c:v>706.70001200000002</c:v>
                </c:pt>
                <c:pt idx="91">
                  <c:v>709.59997599999997</c:v>
                </c:pt>
                <c:pt idx="92">
                  <c:v>712.48999000000003</c:v>
                </c:pt>
                <c:pt idx="93">
                  <c:v>715.38000499999998</c:v>
                </c:pt>
                <c:pt idx="94">
                  <c:v>718.28002900000001</c:v>
                </c:pt>
                <c:pt idx="95">
                  <c:v>721.17999299999997</c:v>
                </c:pt>
                <c:pt idx="96">
                  <c:v>724.07000700000003</c:v>
                </c:pt>
                <c:pt idx="97">
                  <c:v>726.96997099999999</c:v>
                </c:pt>
                <c:pt idx="98">
                  <c:v>729.86999500000002</c:v>
                </c:pt>
                <c:pt idx="99">
                  <c:v>732.77002000000005</c:v>
                </c:pt>
                <c:pt idx="100">
                  <c:v>735.67999299999997</c:v>
                </c:pt>
                <c:pt idx="101">
                  <c:v>738.580017</c:v>
                </c:pt>
                <c:pt idx="102">
                  <c:v>741.48999000000003</c:v>
                </c:pt>
                <c:pt idx="103">
                  <c:v>744.39001499999995</c:v>
                </c:pt>
                <c:pt idx="104">
                  <c:v>747.29998799999998</c:v>
                </c:pt>
                <c:pt idx="105">
                  <c:v>750.21002199999998</c:v>
                </c:pt>
                <c:pt idx="106">
                  <c:v>753.11999500000002</c:v>
                </c:pt>
                <c:pt idx="107">
                  <c:v>756.03002900000001</c:v>
                </c:pt>
                <c:pt idx="108">
                  <c:v>758.94000200000005</c:v>
                </c:pt>
                <c:pt idx="109">
                  <c:v>761.84997599999997</c:v>
                </c:pt>
                <c:pt idx="110">
                  <c:v>764.77002000000005</c:v>
                </c:pt>
                <c:pt idx="111">
                  <c:v>767.67999299999997</c:v>
                </c:pt>
                <c:pt idx="112">
                  <c:v>770.59997599999997</c:v>
                </c:pt>
                <c:pt idx="113">
                  <c:v>773.52002000000005</c:v>
                </c:pt>
                <c:pt idx="114">
                  <c:v>776.44000200000005</c:v>
                </c:pt>
                <c:pt idx="115">
                  <c:v>779.35998500000005</c:v>
                </c:pt>
                <c:pt idx="116">
                  <c:v>782.28002900000001</c:v>
                </c:pt>
                <c:pt idx="117">
                  <c:v>785.20001200000002</c:v>
                </c:pt>
                <c:pt idx="118">
                  <c:v>788.11999500000002</c:v>
                </c:pt>
                <c:pt idx="119">
                  <c:v>791.04998799999998</c:v>
                </c:pt>
                <c:pt idx="120">
                  <c:v>793.97997999999995</c:v>
                </c:pt>
                <c:pt idx="121">
                  <c:v>796.90002400000003</c:v>
                </c:pt>
                <c:pt idx="122">
                  <c:v>799.830017</c:v>
                </c:pt>
                <c:pt idx="123">
                  <c:v>802.76000999999997</c:v>
                </c:pt>
                <c:pt idx="124">
                  <c:v>805.69000200000005</c:v>
                </c:pt>
                <c:pt idx="125">
                  <c:v>808.61999500000002</c:v>
                </c:pt>
                <c:pt idx="126">
                  <c:v>811.55999799999995</c:v>
                </c:pt>
                <c:pt idx="127">
                  <c:v>814.48999000000003</c:v>
                </c:pt>
                <c:pt idx="128">
                  <c:v>817.42999299999997</c:v>
                </c:pt>
                <c:pt idx="129">
                  <c:v>820.35998500000005</c:v>
                </c:pt>
                <c:pt idx="130">
                  <c:v>823.29998799999998</c:v>
                </c:pt>
                <c:pt idx="131">
                  <c:v>826.23999000000003</c:v>
                </c:pt>
                <c:pt idx="132">
                  <c:v>829.17999299999997</c:v>
                </c:pt>
                <c:pt idx="133">
                  <c:v>832.11999500000002</c:v>
                </c:pt>
                <c:pt idx="134">
                  <c:v>835.07000700000003</c:v>
                </c:pt>
                <c:pt idx="135">
                  <c:v>838.01000999999997</c:v>
                </c:pt>
                <c:pt idx="136">
                  <c:v>840.95001200000002</c:v>
                </c:pt>
                <c:pt idx="137">
                  <c:v>843.90002400000003</c:v>
                </c:pt>
                <c:pt idx="138">
                  <c:v>846.84997599999997</c:v>
                </c:pt>
                <c:pt idx="139">
                  <c:v>849.79998799999998</c:v>
                </c:pt>
              </c:numCache>
            </c:numRef>
          </c:xVal>
          <c:yVal>
            <c:numRef>
              <c:f>Graphs!$AM$5:$AM$144</c:f>
              <c:numCache>
                <c:formatCode>General</c:formatCode>
                <c:ptCount val="140"/>
                <c:pt idx="0">
                  <c:v>4.3734500000000003E-2</c:v>
                </c:pt>
                <c:pt idx="1">
                  <c:v>4.4072E-2</c:v>
                </c:pt>
                <c:pt idx="2">
                  <c:v>4.4041750000000005E-2</c:v>
                </c:pt>
                <c:pt idx="3">
                  <c:v>4.4022749999999999E-2</c:v>
                </c:pt>
                <c:pt idx="4">
                  <c:v>4.3966500000000006E-2</c:v>
                </c:pt>
                <c:pt idx="5">
                  <c:v>4.3915999999999997E-2</c:v>
                </c:pt>
                <c:pt idx="6">
                  <c:v>4.3694250000000004E-2</c:v>
                </c:pt>
                <c:pt idx="7">
                  <c:v>4.3678750000000002E-2</c:v>
                </c:pt>
                <c:pt idx="8">
                  <c:v>4.3608749999999995E-2</c:v>
                </c:pt>
                <c:pt idx="9">
                  <c:v>4.3954750000000001E-2</c:v>
                </c:pt>
                <c:pt idx="10">
                  <c:v>4.4215250000000005E-2</c:v>
                </c:pt>
                <c:pt idx="11">
                  <c:v>4.428725E-2</c:v>
                </c:pt>
                <c:pt idx="12">
                  <c:v>4.4181999999999999E-2</c:v>
                </c:pt>
                <c:pt idx="13">
                  <c:v>4.4530500000000001E-2</c:v>
                </c:pt>
                <c:pt idx="14">
                  <c:v>4.4910249999999999E-2</c:v>
                </c:pt>
                <c:pt idx="15">
                  <c:v>4.5566499999999996E-2</c:v>
                </c:pt>
                <c:pt idx="16">
                  <c:v>4.6274250000000003E-2</c:v>
                </c:pt>
                <c:pt idx="17">
                  <c:v>4.70275E-2</c:v>
                </c:pt>
                <c:pt idx="18">
                  <c:v>4.8169000000000003E-2</c:v>
                </c:pt>
                <c:pt idx="19">
                  <c:v>4.9862249999999997E-2</c:v>
                </c:pt>
                <c:pt idx="20">
                  <c:v>5.2090499999999998E-2</c:v>
                </c:pt>
                <c:pt idx="21">
                  <c:v>5.4922499999999999E-2</c:v>
                </c:pt>
                <c:pt idx="22">
                  <c:v>5.8348249999999997E-2</c:v>
                </c:pt>
                <c:pt idx="23">
                  <c:v>6.1843750000000003E-2</c:v>
                </c:pt>
                <c:pt idx="24">
                  <c:v>6.5609749999999994E-2</c:v>
                </c:pt>
                <c:pt idx="25">
                  <c:v>6.9565500000000002E-2</c:v>
                </c:pt>
                <c:pt idx="26">
                  <c:v>7.3740250000000007E-2</c:v>
                </c:pt>
                <c:pt idx="27">
                  <c:v>7.7447000000000002E-2</c:v>
                </c:pt>
                <c:pt idx="28">
                  <c:v>8.062975E-2</c:v>
                </c:pt>
                <c:pt idx="29">
                  <c:v>8.34675E-2</c:v>
                </c:pt>
                <c:pt idx="30">
                  <c:v>8.5959999999999995E-2</c:v>
                </c:pt>
                <c:pt idx="31">
                  <c:v>8.7880750000000007E-2</c:v>
                </c:pt>
                <c:pt idx="32">
                  <c:v>8.9348499999999997E-2</c:v>
                </c:pt>
                <c:pt idx="33">
                  <c:v>9.0828249999999999E-2</c:v>
                </c:pt>
                <c:pt idx="34">
                  <c:v>9.2432999999999987E-2</c:v>
                </c:pt>
                <c:pt idx="35">
                  <c:v>9.389575E-2</c:v>
                </c:pt>
                <c:pt idx="36">
                  <c:v>9.5226000000000005E-2</c:v>
                </c:pt>
                <c:pt idx="37">
                  <c:v>9.6089499999999994E-2</c:v>
                </c:pt>
                <c:pt idx="38">
                  <c:v>9.6446500000000004E-2</c:v>
                </c:pt>
                <c:pt idx="39">
                  <c:v>9.6349999999999991E-2</c:v>
                </c:pt>
                <c:pt idx="40">
                  <c:v>9.5906250000000012E-2</c:v>
                </c:pt>
                <c:pt idx="41">
                  <c:v>9.4953499999999996E-2</c:v>
                </c:pt>
                <c:pt idx="42">
                  <c:v>9.3505249999999998E-2</c:v>
                </c:pt>
                <c:pt idx="43">
                  <c:v>9.1721499999999997E-2</c:v>
                </c:pt>
                <c:pt idx="44">
                  <c:v>9.0046249999999994E-2</c:v>
                </c:pt>
                <c:pt idx="45">
                  <c:v>8.8604000000000002E-2</c:v>
                </c:pt>
                <c:pt idx="46">
                  <c:v>8.7555250000000001E-2</c:v>
                </c:pt>
                <c:pt idx="47">
                  <c:v>8.6693500000000007E-2</c:v>
                </c:pt>
                <c:pt idx="48">
                  <c:v>8.6138500000000007E-2</c:v>
                </c:pt>
                <c:pt idx="49">
                  <c:v>8.5802249999999997E-2</c:v>
                </c:pt>
                <c:pt idx="50">
                  <c:v>8.5671250000000004E-2</c:v>
                </c:pt>
                <c:pt idx="51">
                  <c:v>8.5705249999999983E-2</c:v>
                </c:pt>
                <c:pt idx="52">
                  <c:v>8.5915000000000019E-2</c:v>
                </c:pt>
                <c:pt idx="53">
                  <c:v>8.6107249999999996E-2</c:v>
                </c:pt>
                <c:pt idx="54">
                  <c:v>8.6119000000000001E-2</c:v>
                </c:pt>
                <c:pt idx="55">
                  <c:v>8.5768000000000011E-2</c:v>
                </c:pt>
                <c:pt idx="56">
                  <c:v>8.5097000000000006E-2</c:v>
                </c:pt>
                <c:pt idx="57">
                  <c:v>8.4208999999999992E-2</c:v>
                </c:pt>
                <c:pt idx="58">
                  <c:v>8.3258499999999985E-2</c:v>
                </c:pt>
                <c:pt idx="59">
                  <c:v>8.2409999999999997E-2</c:v>
                </c:pt>
                <c:pt idx="60">
                  <c:v>8.1897499999999998E-2</c:v>
                </c:pt>
                <c:pt idx="61">
                  <c:v>8.1699250000000001E-2</c:v>
                </c:pt>
                <c:pt idx="62">
                  <c:v>8.1907750000000001E-2</c:v>
                </c:pt>
                <c:pt idx="63">
                  <c:v>8.2415500000000003E-2</c:v>
                </c:pt>
                <c:pt idx="64">
                  <c:v>8.2948250000000001E-2</c:v>
                </c:pt>
                <c:pt idx="65">
                  <c:v>8.302000000000001E-2</c:v>
                </c:pt>
                <c:pt idx="66">
                  <c:v>8.2488249999999999E-2</c:v>
                </c:pt>
                <c:pt idx="67">
                  <c:v>8.1305749999999996E-2</c:v>
                </c:pt>
                <c:pt idx="68">
                  <c:v>7.9620250000000004E-2</c:v>
                </c:pt>
                <c:pt idx="69">
                  <c:v>7.7822749999999996E-2</c:v>
                </c:pt>
                <c:pt idx="70">
                  <c:v>7.6332750000000005E-2</c:v>
                </c:pt>
                <c:pt idx="71">
                  <c:v>7.5173000000000004E-2</c:v>
                </c:pt>
                <c:pt idx="72">
                  <c:v>7.4077999999999991E-2</c:v>
                </c:pt>
                <c:pt idx="73">
                  <c:v>7.2616E-2</c:v>
                </c:pt>
                <c:pt idx="74">
                  <c:v>7.0766999999999997E-2</c:v>
                </c:pt>
                <c:pt idx="75">
                  <c:v>6.872375E-2</c:v>
                </c:pt>
                <c:pt idx="76">
                  <c:v>6.6850500000000007E-2</c:v>
                </c:pt>
                <c:pt idx="77">
                  <c:v>6.5272750000000004E-2</c:v>
                </c:pt>
                <c:pt idx="78">
                  <c:v>6.4320249999999995E-2</c:v>
                </c:pt>
                <c:pt idx="79">
                  <c:v>6.4082750000000008E-2</c:v>
                </c:pt>
                <c:pt idx="80">
                  <c:v>6.451875E-2</c:v>
                </c:pt>
                <c:pt idx="81">
                  <c:v>6.5758499999999998E-2</c:v>
                </c:pt>
                <c:pt idx="82">
                  <c:v>6.8499749999999998E-2</c:v>
                </c:pt>
                <c:pt idx="83">
                  <c:v>7.3682750000000005E-2</c:v>
                </c:pt>
                <c:pt idx="84">
                  <c:v>8.2124500000000003E-2</c:v>
                </c:pt>
                <c:pt idx="85">
                  <c:v>9.4453750000000003E-2</c:v>
                </c:pt>
                <c:pt idx="86">
                  <c:v>0.11060424999999999</c:v>
                </c:pt>
                <c:pt idx="87">
                  <c:v>0.12951925</c:v>
                </c:pt>
                <c:pt idx="88">
                  <c:v>0.14917174999999999</c:v>
                </c:pt>
                <c:pt idx="89">
                  <c:v>0.16776425</c:v>
                </c:pt>
                <c:pt idx="90">
                  <c:v>0.184721</c:v>
                </c:pt>
                <c:pt idx="91">
                  <c:v>0.20003425</c:v>
                </c:pt>
                <c:pt idx="92">
                  <c:v>0.214257</c:v>
                </c:pt>
                <c:pt idx="93">
                  <c:v>0.2275095</c:v>
                </c:pt>
                <c:pt idx="94">
                  <c:v>0.24002899999999999</c:v>
                </c:pt>
                <c:pt idx="95">
                  <c:v>0.25165975000000002</c:v>
                </c:pt>
                <c:pt idx="96">
                  <c:v>0.26254274999999999</c:v>
                </c:pt>
                <c:pt idx="97">
                  <c:v>0.27270625000000004</c:v>
                </c:pt>
                <c:pt idx="98">
                  <c:v>0.28181674999999995</c:v>
                </c:pt>
                <c:pt idx="99">
                  <c:v>0.28984025000000002</c:v>
                </c:pt>
                <c:pt idx="100">
                  <c:v>0.29667049999999995</c:v>
                </c:pt>
                <c:pt idx="101">
                  <c:v>0.30274200000000001</c:v>
                </c:pt>
                <c:pt idx="102">
                  <c:v>0.30786150000000001</c:v>
                </c:pt>
                <c:pt idx="103">
                  <c:v>0.3121815</c:v>
                </c:pt>
                <c:pt idx="104">
                  <c:v>0.31590125000000002</c:v>
                </c:pt>
                <c:pt idx="105">
                  <c:v>0.31926224999999997</c:v>
                </c:pt>
                <c:pt idx="106">
                  <c:v>0.32220150000000003</c:v>
                </c:pt>
                <c:pt idx="107">
                  <c:v>0.32464100000000001</c:v>
                </c:pt>
                <c:pt idx="108">
                  <c:v>0.32728275000000001</c:v>
                </c:pt>
                <c:pt idx="109">
                  <c:v>0.32981074999999999</c:v>
                </c:pt>
                <c:pt idx="110">
                  <c:v>0.33219625000000003</c:v>
                </c:pt>
                <c:pt idx="111">
                  <c:v>0.33442375000000002</c:v>
                </c:pt>
                <c:pt idx="112">
                  <c:v>0.33672875000000002</c:v>
                </c:pt>
                <c:pt idx="113">
                  <c:v>0.33811325000000003</c:v>
                </c:pt>
                <c:pt idx="114">
                  <c:v>0.33936025000000003</c:v>
                </c:pt>
                <c:pt idx="115">
                  <c:v>0.34068150000000003</c:v>
                </c:pt>
                <c:pt idx="116">
                  <c:v>0.34160250000000003</c:v>
                </c:pt>
                <c:pt idx="117">
                  <c:v>0.34202399999999999</c:v>
                </c:pt>
                <c:pt idx="118">
                  <c:v>0.342032</c:v>
                </c:pt>
                <c:pt idx="119">
                  <c:v>0.34219249999999996</c:v>
                </c:pt>
                <c:pt idx="120">
                  <c:v>0.34191125</c:v>
                </c:pt>
                <c:pt idx="121">
                  <c:v>0.34204875000000001</c:v>
                </c:pt>
                <c:pt idx="122">
                  <c:v>0.34172750000000002</c:v>
                </c:pt>
                <c:pt idx="123">
                  <c:v>0.34184825000000002</c:v>
                </c:pt>
                <c:pt idx="124">
                  <c:v>0.34281100000000003</c:v>
                </c:pt>
                <c:pt idx="125">
                  <c:v>0.34399049999999998</c:v>
                </c:pt>
                <c:pt idx="126">
                  <c:v>0.34421500000000005</c:v>
                </c:pt>
                <c:pt idx="127">
                  <c:v>0.34422900000000001</c:v>
                </c:pt>
                <c:pt idx="128">
                  <c:v>0.34444675000000002</c:v>
                </c:pt>
                <c:pt idx="129">
                  <c:v>0.34511225000000001</c:v>
                </c:pt>
                <c:pt idx="130">
                  <c:v>0.34527174999999999</c:v>
                </c:pt>
                <c:pt idx="131">
                  <c:v>0.34610225000000006</c:v>
                </c:pt>
                <c:pt idx="132">
                  <c:v>0.34599049999999998</c:v>
                </c:pt>
                <c:pt idx="133">
                  <c:v>0.34633399999999998</c:v>
                </c:pt>
                <c:pt idx="134">
                  <c:v>0.34716924999999998</c:v>
                </c:pt>
                <c:pt idx="135">
                  <c:v>0.34865625</c:v>
                </c:pt>
                <c:pt idx="136">
                  <c:v>0.34986075</c:v>
                </c:pt>
                <c:pt idx="137">
                  <c:v>0.35195375000000001</c:v>
                </c:pt>
                <c:pt idx="138">
                  <c:v>0.35260974999999994</c:v>
                </c:pt>
                <c:pt idx="139">
                  <c:v>0.351702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1831-48AC-9C36-2D9335821AE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64286512"/>
        <c:axId val="1715282304"/>
      </c:scatterChart>
      <c:valAx>
        <c:axId val="764286512"/>
        <c:scaling>
          <c:orientation val="minMax"/>
          <c:max val="850"/>
          <c:min val="45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Wavelength [nm]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15282304"/>
        <c:crosses val="autoZero"/>
        <c:crossBetween val="midCat"/>
      </c:valAx>
      <c:valAx>
        <c:axId val="171528230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Reflectance [%/100]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764286512"/>
        <c:crosses val="autoZero"/>
        <c:crossBetween val="midCat"/>
        <c:majorUnit val="0.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strRef>
              <c:f>Graphs!$AT$4</c:f>
              <c:strCache>
                <c:ptCount val="1"/>
                <c:pt idx="0">
                  <c:v>Healthy tissue</c:v>
                </c:pt>
              </c:strCache>
            </c:strRef>
          </c:tx>
          <c:spPr>
            <a:ln w="19050" cap="rnd">
              <a:solidFill>
                <a:srgbClr val="06C60B"/>
              </a:solidFill>
              <a:round/>
            </a:ln>
            <a:effectLst/>
          </c:spPr>
          <c:marker>
            <c:symbol val="none"/>
          </c:marker>
          <c:xVal>
            <c:numRef>
              <c:f>Graphs!$AS$5:$AS$144</c:f>
              <c:numCache>
                <c:formatCode>General</c:formatCode>
                <c:ptCount val="140"/>
                <c:pt idx="0">
                  <c:v>451.25</c:v>
                </c:pt>
                <c:pt idx="1">
                  <c:v>454.040009</c:v>
                </c:pt>
                <c:pt idx="2">
                  <c:v>456.82000699999998</c:v>
                </c:pt>
                <c:pt idx="3">
                  <c:v>459.60998499999999</c:v>
                </c:pt>
                <c:pt idx="4">
                  <c:v>462.39999399999999</c:v>
                </c:pt>
                <c:pt idx="5">
                  <c:v>465.19000199999999</c:v>
                </c:pt>
                <c:pt idx="6">
                  <c:v>467.98001099999999</c:v>
                </c:pt>
                <c:pt idx="7">
                  <c:v>470.77999899999998</c:v>
                </c:pt>
                <c:pt idx="8">
                  <c:v>473.57000699999998</c:v>
                </c:pt>
                <c:pt idx="9">
                  <c:v>476.36999500000002</c:v>
                </c:pt>
                <c:pt idx="10">
                  <c:v>479.16000400000001</c:v>
                </c:pt>
                <c:pt idx="11">
                  <c:v>481.959991</c:v>
                </c:pt>
                <c:pt idx="12">
                  <c:v>484.76001000000002</c:v>
                </c:pt>
                <c:pt idx="13">
                  <c:v>487.55999800000001</c:v>
                </c:pt>
                <c:pt idx="14">
                  <c:v>490.35998499999999</c:v>
                </c:pt>
                <c:pt idx="15">
                  <c:v>493.16000400000001</c:v>
                </c:pt>
                <c:pt idx="16">
                  <c:v>495.97000100000002</c:v>
                </c:pt>
                <c:pt idx="17">
                  <c:v>498.76998900000001</c:v>
                </c:pt>
                <c:pt idx="18">
                  <c:v>501.57998700000002</c:v>
                </c:pt>
                <c:pt idx="19">
                  <c:v>504.39001500000001</c:v>
                </c:pt>
                <c:pt idx="20">
                  <c:v>507.19000199999999</c:v>
                </c:pt>
                <c:pt idx="21">
                  <c:v>510</c:v>
                </c:pt>
                <c:pt idx="22">
                  <c:v>512.80999799999995</c:v>
                </c:pt>
                <c:pt idx="23">
                  <c:v>515.63000499999998</c:v>
                </c:pt>
                <c:pt idx="24">
                  <c:v>518.44000200000005</c:v>
                </c:pt>
                <c:pt idx="25">
                  <c:v>521.25</c:v>
                </c:pt>
                <c:pt idx="26">
                  <c:v>524.07000700000003</c:v>
                </c:pt>
                <c:pt idx="27">
                  <c:v>526.88000499999998</c:v>
                </c:pt>
                <c:pt idx="28">
                  <c:v>529.70001200000002</c:v>
                </c:pt>
                <c:pt idx="29">
                  <c:v>532.52002000000005</c:v>
                </c:pt>
                <c:pt idx="30">
                  <c:v>535.34002699999996</c:v>
                </c:pt>
                <c:pt idx="31">
                  <c:v>538.15997300000004</c:v>
                </c:pt>
                <c:pt idx="32">
                  <c:v>540.98999000000003</c:v>
                </c:pt>
                <c:pt idx="33">
                  <c:v>543.80999799999995</c:v>
                </c:pt>
                <c:pt idx="34">
                  <c:v>546.63000499999998</c:v>
                </c:pt>
                <c:pt idx="35">
                  <c:v>549.46002199999998</c:v>
                </c:pt>
                <c:pt idx="36">
                  <c:v>552.28997800000002</c:v>
                </c:pt>
                <c:pt idx="37">
                  <c:v>555.11999500000002</c:v>
                </c:pt>
                <c:pt idx="38">
                  <c:v>557.94000200000005</c:v>
                </c:pt>
                <c:pt idx="39">
                  <c:v>560.78002900000001</c:v>
                </c:pt>
                <c:pt idx="40">
                  <c:v>563.60998500000005</c:v>
                </c:pt>
                <c:pt idx="41">
                  <c:v>566.44000200000005</c:v>
                </c:pt>
                <c:pt idx="42">
                  <c:v>569.27002000000005</c:v>
                </c:pt>
                <c:pt idx="43">
                  <c:v>572.10998500000005</c:v>
                </c:pt>
                <c:pt idx="44">
                  <c:v>574.95001200000002</c:v>
                </c:pt>
                <c:pt idx="45">
                  <c:v>577.78002900000001</c:v>
                </c:pt>
                <c:pt idx="46">
                  <c:v>580.61999500000002</c:v>
                </c:pt>
                <c:pt idx="47">
                  <c:v>583.46002199999998</c:v>
                </c:pt>
                <c:pt idx="48">
                  <c:v>586.29998799999998</c:v>
                </c:pt>
                <c:pt idx="49">
                  <c:v>589.15002400000003</c:v>
                </c:pt>
                <c:pt idx="50">
                  <c:v>591.98999000000003</c:v>
                </c:pt>
                <c:pt idx="51">
                  <c:v>594.84002699999996</c:v>
                </c:pt>
                <c:pt idx="52">
                  <c:v>597.67999299999997</c:v>
                </c:pt>
                <c:pt idx="53">
                  <c:v>600.53002900000001</c:v>
                </c:pt>
                <c:pt idx="54">
                  <c:v>603.38000499999998</c:v>
                </c:pt>
                <c:pt idx="55">
                  <c:v>606.22997999999995</c:v>
                </c:pt>
                <c:pt idx="56">
                  <c:v>609.080017</c:v>
                </c:pt>
                <c:pt idx="57">
                  <c:v>611.92999299999997</c:v>
                </c:pt>
                <c:pt idx="58">
                  <c:v>614.78002900000001</c:v>
                </c:pt>
                <c:pt idx="59">
                  <c:v>617.64001499999995</c:v>
                </c:pt>
                <c:pt idx="60">
                  <c:v>620.48999000000003</c:v>
                </c:pt>
                <c:pt idx="61">
                  <c:v>623.34997599999997</c:v>
                </c:pt>
                <c:pt idx="62">
                  <c:v>626.21002199999998</c:v>
                </c:pt>
                <c:pt idx="63">
                  <c:v>629.07000700000003</c:v>
                </c:pt>
                <c:pt idx="64">
                  <c:v>631.92999299999997</c:v>
                </c:pt>
                <c:pt idx="65">
                  <c:v>634.78997800000002</c:v>
                </c:pt>
                <c:pt idx="66">
                  <c:v>637.65002400000003</c:v>
                </c:pt>
                <c:pt idx="67">
                  <c:v>640.51000999999997</c:v>
                </c:pt>
                <c:pt idx="68">
                  <c:v>643.38000499999998</c:v>
                </c:pt>
                <c:pt idx="69">
                  <c:v>646.23999000000003</c:v>
                </c:pt>
                <c:pt idx="70">
                  <c:v>649.10998500000005</c:v>
                </c:pt>
                <c:pt idx="71">
                  <c:v>651.97997999999995</c:v>
                </c:pt>
                <c:pt idx="72">
                  <c:v>654.84997599999997</c:v>
                </c:pt>
                <c:pt idx="73">
                  <c:v>657.71997099999999</c:v>
                </c:pt>
                <c:pt idx="74">
                  <c:v>660.59002699999996</c:v>
                </c:pt>
                <c:pt idx="75">
                  <c:v>663.46997099999999</c:v>
                </c:pt>
                <c:pt idx="76">
                  <c:v>666.34002699999996</c:v>
                </c:pt>
                <c:pt idx="77">
                  <c:v>669.21997099999999</c:v>
                </c:pt>
                <c:pt idx="78">
                  <c:v>672.09002699999996</c:v>
                </c:pt>
                <c:pt idx="79">
                  <c:v>674.96997099999999</c:v>
                </c:pt>
                <c:pt idx="80">
                  <c:v>677.84997599999997</c:v>
                </c:pt>
                <c:pt idx="81">
                  <c:v>680.72997999999995</c:v>
                </c:pt>
                <c:pt idx="82">
                  <c:v>683.60998500000005</c:v>
                </c:pt>
                <c:pt idx="83">
                  <c:v>686.48999000000003</c:v>
                </c:pt>
                <c:pt idx="84">
                  <c:v>689.38000499999998</c:v>
                </c:pt>
                <c:pt idx="85">
                  <c:v>692.26000999999997</c:v>
                </c:pt>
                <c:pt idx="86">
                  <c:v>695.15002400000003</c:v>
                </c:pt>
                <c:pt idx="87">
                  <c:v>698.03002900000001</c:v>
                </c:pt>
                <c:pt idx="88">
                  <c:v>700.919983</c:v>
                </c:pt>
                <c:pt idx="89">
                  <c:v>703.80999799999995</c:v>
                </c:pt>
                <c:pt idx="90">
                  <c:v>706.70001200000002</c:v>
                </c:pt>
                <c:pt idx="91">
                  <c:v>709.59997599999997</c:v>
                </c:pt>
                <c:pt idx="92">
                  <c:v>712.48999000000003</c:v>
                </c:pt>
                <c:pt idx="93">
                  <c:v>715.38000499999998</c:v>
                </c:pt>
                <c:pt idx="94">
                  <c:v>718.28002900000001</c:v>
                </c:pt>
                <c:pt idx="95">
                  <c:v>721.17999299999997</c:v>
                </c:pt>
                <c:pt idx="96">
                  <c:v>724.07000700000003</c:v>
                </c:pt>
                <c:pt idx="97">
                  <c:v>726.96997099999999</c:v>
                </c:pt>
                <c:pt idx="98">
                  <c:v>729.86999500000002</c:v>
                </c:pt>
                <c:pt idx="99">
                  <c:v>732.77002000000005</c:v>
                </c:pt>
                <c:pt idx="100">
                  <c:v>735.67999299999997</c:v>
                </c:pt>
                <c:pt idx="101">
                  <c:v>738.580017</c:v>
                </c:pt>
                <c:pt idx="102">
                  <c:v>741.48999000000003</c:v>
                </c:pt>
                <c:pt idx="103">
                  <c:v>744.39001499999995</c:v>
                </c:pt>
                <c:pt idx="104">
                  <c:v>747.29998799999998</c:v>
                </c:pt>
                <c:pt idx="105">
                  <c:v>750.21002199999998</c:v>
                </c:pt>
                <c:pt idx="106">
                  <c:v>753.11999500000002</c:v>
                </c:pt>
                <c:pt idx="107">
                  <c:v>756.03002900000001</c:v>
                </c:pt>
                <c:pt idx="108">
                  <c:v>758.94000200000005</c:v>
                </c:pt>
                <c:pt idx="109">
                  <c:v>761.84997599999997</c:v>
                </c:pt>
                <c:pt idx="110">
                  <c:v>764.77002000000005</c:v>
                </c:pt>
                <c:pt idx="111">
                  <c:v>767.67999299999997</c:v>
                </c:pt>
                <c:pt idx="112">
                  <c:v>770.59997599999997</c:v>
                </c:pt>
                <c:pt idx="113">
                  <c:v>773.52002000000005</c:v>
                </c:pt>
                <c:pt idx="114">
                  <c:v>776.44000200000005</c:v>
                </c:pt>
                <c:pt idx="115">
                  <c:v>779.35998500000005</c:v>
                </c:pt>
                <c:pt idx="116">
                  <c:v>782.28002900000001</c:v>
                </c:pt>
                <c:pt idx="117">
                  <c:v>785.20001200000002</c:v>
                </c:pt>
                <c:pt idx="118">
                  <c:v>788.11999500000002</c:v>
                </c:pt>
                <c:pt idx="119">
                  <c:v>791.04998799999998</c:v>
                </c:pt>
                <c:pt idx="120">
                  <c:v>793.97997999999995</c:v>
                </c:pt>
                <c:pt idx="121">
                  <c:v>796.90002400000003</c:v>
                </c:pt>
                <c:pt idx="122">
                  <c:v>799.830017</c:v>
                </c:pt>
                <c:pt idx="123">
                  <c:v>802.76000999999997</c:v>
                </c:pt>
                <c:pt idx="124">
                  <c:v>805.69000200000005</c:v>
                </c:pt>
                <c:pt idx="125">
                  <c:v>808.61999500000002</c:v>
                </c:pt>
                <c:pt idx="126">
                  <c:v>811.55999799999995</c:v>
                </c:pt>
                <c:pt idx="127">
                  <c:v>814.48999000000003</c:v>
                </c:pt>
                <c:pt idx="128">
                  <c:v>817.42999299999997</c:v>
                </c:pt>
                <c:pt idx="129">
                  <c:v>820.35998500000005</c:v>
                </c:pt>
                <c:pt idx="130">
                  <c:v>823.29998799999998</c:v>
                </c:pt>
                <c:pt idx="131">
                  <c:v>826.23999000000003</c:v>
                </c:pt>
                <c:pt idx="132">
                  <c:v>829.17999299999997</c:v>
                </c:pt>
                <c:pt idx="133">
                  <c:v>832.11999500000002</c:v>
                </c:pt>
                <c:pt idx="134">
                  <c:v>835.07000700000003</c:v>
                </c:pt>
                <c:pt idx="135">
                  <c:v>838.01000999999997</c:v>
                </c:pt>
                <c:pt idx="136">
                  <c:v>840.95001200000002</c:v>
                </c:pt>
                <c:pt idx="137">
                  <c:v>843.90002400000003</c:v>
                </c:pt>
                <c:pt idx="138">
                  <c:v>846.84997599999997</c:v>
                </c:pt>
                <c:pt idx="139">
                  <c:v>849.79998799999998</c:v>
                </c:pt>
              </c:numCache>
            </c:numRef>
          </c:xVal>
          <c:yVal>
            <c:numRef>
              <c:f>Graphs!$AT$5:$AT$144</c:f>
              <c:numCache>
                <c:formatCode>General</c:formatCode>
                <c:ptCount val="140"/>
                <c:pt idx="0">
                  <c:v>4.9174000000000002E-2</c:v>
                </c:pt>
                <c:pt idx="1">
                  <c:v>4.9002749999999998E-2</c:v>
                </c:pt>
                <c:pt idx="2">
                  <c:v>4.8694500000000002E-2</c:v>
                </c:pt>
                <c:pt idx="3">
                  <c:v>4.8208000000000001E-2</c:v>
                </c:pt>
                <c:pt idx="4">
                  <c:v>4.7678250000000005E-2</c:v>
                </c:pt>
                <c:pt idx="5">
                  <c:v>4.7181750000000001E-2</c:v>
                </c:pt>
                <c:pt idx="6">
                  <c:v>4.6776999999999999E-2</c:v>
                </c:pt>
                <c:pt idx="7">
                  <c:v>4.6351250000000004E-2</c:v>
                </c:pt>
                <c:pt idx="8">
                  <c:v>4.6068750000000006E-2</c:v>
                </c:pt>
                <c:pt idx="9">
                  <c:v>4.5901999999999998E-2</c:v>
                </c:pt>
                <c:pt idx="10">
                  <c:v>4.5825000000000005E-2</c:v>
                </c:pt>
                <c:pt idx="11">
                  <c:v>4.5721499999999998E-2</c:v>
                </c:pt>
                <c:pt idx="12">
                  <c:v>4.5616750000000005E-2</c:v>
                </c:pt>
                <c:pt idx="13">
                  <c:v>4.5698749999999996E-2</c:v>
                </c:pt>
                <c:pt idx="14">
                  <c:v>4.600075E-2</c:v>
                </c:pt>
                <c:pt idx="15">
                  <c:v>4.6551249999999995E-2</c:v>
                </c:pt>
                <c:pt idx="16">
                  <c:v>4.7401750000000006E-2</c:v>
                </c:pt>
                <c:pt idx="17">
                  <c:v>4.8711749999999998E-2</c:v>
                </c:pt>
                <c:pt idx="18">
                  <c:v>5.0631999999999996E-2</c:v>
                </c:pt>
                <c:pt idx="19">
                  <c:v>5.3267750000000003E-2</c:v>
                </c:pt>
                <c:pt idx="20">
                  <c:v>5.6806500000000003E-2</c:v>
                </c:pt>
                <c:pt idx="21">
                  <c:v>6.1329500000000002E-2</c:v>
                </c:pt>
                <c:pt idx="22">
                  <c:v>6.7025249999999995E-2</c:v>
                </c:pt>
                <c:pt idx="23">
                  <c:v>7.401075E-2</c:v>
                </c:pt>
                <c:pt idx="24">
                  <c:v>8.2243999999999998E-2</c:v>
                </c:pt>
                <c:pt idx="25">
                  <c:v>9.125575000000001E-2</c:v>
                </c:pt>
                <c:pt idx="26">
                  <c:v>0.10039675000000001</c:v>
                </c:pt>
                <c:pt idx="27">
                  <c:v>0.10901125</c:v>
                </c:pt>
                <c:pt idx="28">
                  <c:v>0.116367</c:v>
                </c:pt>
                <c:pt idx="29">
                  <c:v>0.12204025000000002</c:v>
                </c:pt>
                <c:pt idx="30">
                  <c:v>0.126078</c:v>
                </c:pt>
                <c:pt idx="31">
                  <c:v>0.12879299999999999</c:v>
                </c:pt>
                <c:pt idx="32">
                  <c:v>0.13053724999999999</c:v>
                </c:pt>
                <c:pt idx="33">
                  <c:v>0.131857</c:v>
                </c:pt>
                <c:pt idx="34">
                  <c:v>0.13315150000000001</c:v>
                </c:pt>
                <c:pt idx="35">
                  <c:v>0.13438324999999998</c:v>
                </c:pt>
                <c:pt idx="36">
                  <c:v>0.13512150000000001</c:v>
                </c:pt>
                <c:pt idx="37">
                  <c:v>0.13485125000000001</c:v>
                </c:pt>
                <c:pt idx="38">
                  <c:v>0.13330425000000001</c:v>
                </c:pt>
                <c:pt idx="39">
                  <c:v>0.13050025000000001</c:v>
                </c:pt>
                <c:pt idx="40">
                  <c:v>0.12663099999999999</c:v>
                </c:pt>
                <c:pt idx="41">
                  <c:v>0.12175925</c:v>
                </c:pt>
                <c:pt idx="42">
                  <c:v>0.11606</c:v>
                </c:pt>
                <c:pt idx="43">
                  <c:v>0.109985</c:v>
                </c:pt>
                <c:pt idx="44">
                  <c:v>0.104217</c:v>
                </c:pt>
                <c:pt idx="45">
                  <c:v>9.9184749999999988E-2</c:v>
                </c:pt>
                <c:pt idx="46">
                  <c:v>9.4965500000000008E-2</c:v>
                </c:pt>
                <c:pt idx="47">
                  <c:v>9.14045E-2</c:v>
                </c:pt>
                <c:pt idx="48">
                  <c:v>8.8406249999999992E-2</c:v>
                </c:pt>
                <c:pt idx="49">
                  <c:v>8.5927000000000003E-2</c:v>
                </c:pt>
                <c:pt idx="50">
                  <c:v>8.3957000000000004E-2</c:v>
                </c:pt>
                <c:pt idx="51">
                  <c:v>8.2449250000000002E-2</c:v>
                </c:pt>
                <c:pt idx="52">
                  <c:v>8.125375E-2</c:v>
                </c:pt>
                <c:pt idx="53">
                  <c:v>8.0127749999999998E-2</c:v>
                </c:pt>
                <c:pt idx="54">
                  <c:v>7.8727000000000005E-2</c:v>
                </c:pt>
                <c:pt idx="55">
                  <c:v>7.6798749999999999E-2</c:v>
                </c:pt>
                <c:pt idx="56">
                  <c:v>7.4342749999999999E-2</c:v>
                </c:pt>
                <c:pt idx="57">
                  <c:v>7.1577249999999995E-2</c:v>
                </c:pt>
                <c:pt idx="58">
                  <c:v>6.8803500000000004E-2</c:v>
                </c:pt>
                <c:pt idx="59">
                  <c:v>6.6306249999999997E-2</c:v>
                </c:pt>
                <c:pt idx="60">
                  <c:v>6.432525E-2</c:v>
                </c:pt>
                <c:pt idx="61">
                  <c:v>6.2916E-2</c:v>
                </c:pt>
                <c:pt idx="62">
                  <c:v>6.2066999999999997E-2</c:v>
                </c:pt>
                <c:pt idx="63">
                  <c:v>6.1584749999999994E-2</c:v>
                </c:pt>
                <c:pt idx="64">
                  <c:v>6.1035249999999999E-2</c:v>
                </c:pt>
                <c:pt idx="65">
                  <c:v>5.9895750000000005E-2</c:v>
                </c:pt>
                <c:pt idx="66">
                  <c:v>5.79835E-2</c:v>
                </c:pt>
                <c:pt idx="67">
                  <c:v>5.5576250000000001E-2</c:v>
                </c:pt>
                <c:pt idx="68">
                  <c:v>5.301575E-2</c:v>
                </c:pt>
                <c:pt idx="69">
                  <c:v>5.062875E-2</c:v>
                </c:pt>
                <c:pt idx="70">
                  <c:v>4.8669749999999998E-2</c:v>
                </c:pt>
                <c:pt idx="71">
                  <c:v>4.7193500000000006E-2</c:v>
                </c:pt>
                <c:pt idx="72">
                  <c:v>4.5848249999999993E-2</c:v>
                </c:pt>
                <c:pt idx="73">
                  <c:v>4.4327749999999999E-2</c:v>
                </c:pt>
                <c:pt idx="74">
                  <c:v>4.2666249999999996E-2</c:v>
                </c:pt>
                <c:pt idx="75">
                  <c:v>4.1083000000000001E-2</c:v>
                </c:pt>
                <c:pt idx="76">
                  <c:v>3.9757750000000001E-2</c:v>
                </c:pt>
                <c:pt idx="77">
                  <c:v>3.8838999999999999E-2</c:v>
                </c:pt>
                <c:pt idx="78">
                  <c:v>3.8449500000000005E-2</c:v>
                </c:pt>
                <c:pt idx="79">
                  <c:v>3.865275E-2</c:v>
                </c:pt>
                <c:pt idx="80">
                  <c:v>3.9440250000000003E-2</c:v>
                </c:pt>
                <c:pt idx="81">
                  <c:v>4.0793000000000003E-2</c:v>
                </c:pt>
                <c:pt idx="82">
                  <c:v>4.2809750000000001E-2</c:v>
                </c:pt>
                <c:pt idx="83">
                  <c:v>4.6005749999999998E-2</c:v>
                </c:pt>
                <c:pt idx="84">
                  <c:v>5.1769500000000003E-2</c:v>
                </c:pt>
                <c:pt idx="85">
                  <c:v>6.1909499999999999E-2</c:v>
                </c:pt>
                <c:pt idx="86">
                  <c:v>7.7727749999999998E-2</c:v>
                </c:pt>
                <c:pt idx="87">
                  <c:v>9.8920250000000001E-2</c:v>
                </c:pt>
                <c:pt idx="88">
                  <c:v>0.12349550000000001</c:v>
                </c:pt>
                <c:pt idx="89">
                  <c:v>0.14867675</c:v>
                </c:pt>
                <c:pt idx="90">
                  <c:v>0.17264475000000001</c:v>
                </c:pt>
                <c:pt idx="91">
                  <c:v>0.1949805</c:v>
                </c:pt>
                <c:pt idx="92">
                  <c:v>0.21612049999999999</c:v>
                </c:pt>
                <c:pt idx="93">
                  <c:v>0.23629</c:v>
                </c:pt>
                <c:pt idx="94">
                  <c:v>0.25547975000000001</c:v>
                </c:pt>
                <c:pt idx="95">
                  <c:v>0.27346749999999997</c:v>
                </c:pt>
                <c:pt idx="96">
                  <c:v>0.29002499999999998</c:v>
                </c:pt>
                <c:pt idx="97">
                  <c:v>0.30516500000000002</c:v>
                </c:pt>
                <c:pt idx="98">
                  <c:v>0.31871350000000004</c:v>
                </c:pt>
                <c:pt idx="99">
                  <c:v>0.33050125000000002</c:v>
                </c:pt>
                <c:pt idx="100">
                  <c:v>0.34046874999999999</c:v>
                </c:pt>
                <c:pt idx="101">
                  <c:v>0.34873199999999999</c:v>
                </c:pt>
                <c:pt idx="102">
                  <c:v>0.35525525000000002</c:v>
                </c:pt>
                <c:pt idx="103">
                  <c:v>0.36006775000000002</c:v>
                </c:pt>
                <c:pt idx="104">
                  <c:v>0.36358874999999996</c:v>
                </c:pt>
                <c:pt idx="105">
                  <c:v>0.36615474999999997</c:v>
                </c:pt>
                <c:pt idx="106">
                  <c:v>0.368091</c:v>
                </c:pt>
                <c:pt idx="107">
                  <c:v>0.36993550000000003</c:v>
                </c:pt>
                <c:pt idx="108">
                  <c:v>0.37148049999999999</c:v>
                </c:pt>
                <c:pt idx="109">
                  <c:v>0.37255325000000006</c:v>
                </c:pt>
                <c:pt idx="110">
                  <c:v>0.37347075000000002</c:v>
                </c:pt>
                <c:pt idx="111">
                  <c:v>0.37450399999999995</c:v>
                </c:pt>
                <c:pt idx="112">
                  <c:v>0.37532624999999997</c:v>
                </c:pt>
                <c:pt idx="113">
                  <c:v>0.375969</c:v>
                </c:pt>
                <c:pt idx="114">
                  <c:v>0.37644475000000005</c:v>
                </c:pt>
                <c:pt idx="115">
                  <c:v>0.37652825000000001</c:v>
                </c:pt>
                <c:pt idx="116">
                  <c:v>0.37623674999999995</c:v>
                </c:pt>
                <c:pt idx="117">
                  <c:v>0.3758745</c:v>
                </c:pt>
                <c:pt idx="118">
                  <c:v>0.37524200000000002</c:v>
                </c:pt>
                <c:pt idx="119">
                  <c:v>0.37440399999999996</c:v>
                </c:pt>
                <c:pt idx="120">
                  <c:v>0.37342500000000001</c:v>
                </c:pt>
                <c:pt idx="121">
                  <c:v>0.37212725000000002</c:v>
                </c:pt>
                <c:pt idx="122">
                  <c:v>0.37052374999999999</c:v>
                </c:pt>
                <c:pt idx="123">
                  <c:v>0.36906550000000005</c:v>
                </c:pt>
                <c:pt idx="124">
                  <c:v>0.36813574999999998</c:v>
                </c:pt>
                <c:pt idx="125">
                  <c:v>0.36735400000000001</c:v>
                </c:pt>
                <c:pt idx="126">
                  <c:v>0.36653049999999998</c:v>
                </c:pt>
                <c:pt idx="127">
                  <c:v>0.3657765</c:v>
                </c:pt>
                <c:pt idx="128">
                  <c:v>0.36518775000000003</c:v>
                </c:pt>
                <c:pt idx="129">
                  <c:v>0.36454799999999998</c:v>
                </c:pt>
                <c:pt idx="130">
                  <c:v>0.36383474999999998</c:v>
                </c:pt>
                <c:pt idx="131">
                  <c:v>0.36325324999999997</c:v>
                </c:pt>
                <c:pt idx="132">
                  <c:v>0.36295699999999997</c:v>
                </c:pt>
                <c:pt idx="133">
                  <c:v>0.36285925000000002</c:v>
                </c:pt>
                <c:pt idx="134">
                  <c:v>0.36287849999999999</c:v>
                </c:pt>
                <c:pt idx="135">
                  <c:v>0.363039</c:v>
                </c:pt>
                <c:pt idx="136">
                  <c:v>0.36344325000000005</c:v>
                </c:pt>
                <c:pt idx="137">
                  <c:v>0.36415750000000002</c:v>
                </c:pt>
                <c:pt idx="138">
                  <c:v>0.36520249999999999</c:v>
                </c:pt>
                <c:pt idx="139">
                  <c:v>0.3660037500000000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46E1-46EE-BC5D-0241D8C233D9}"/>
            </c:ext>
          </c:extLst>
        </c:ser>
        <c:ser>
          <c:idx val="1"/>
          <c:order val="1"/>
          <c:tx>
            <c:strRef>
              <c:f>Graphs!$AU$4</c:f>
              <c:strCache>
                <c:ptCount val="1"/>
                <c:pt idx="0">
                  <c:v>Dark brown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xVal>
            <c:numRef>
              <c:f>Graphs!$AS$5:$AS$144</c:f>
              <c:numCache>
                <c:formatCode>General</c:formatCode>
                <c:ptCount val="140"/>
                <c:pt idx="0">
                  <c:v>451.25</c:v>
                </c:pt>
                <c:pt idx="1">
                  <c:v>454.040009</c:v>
                </c:pt>
                <c:pt idx="2">
                  <c:v>456.82000699999998</c:v>
                </c:pt>
                <c:pt idx="3">
                  <c:v>459.60998499999999</c:v>
                </c:pt>
                <c:pt idx="4">
                  <c:v>462.39999399999999</c:v>
                </c:pt>
                <c:pt idx="5">
                  <c:v>465.19000199999999</c:v>
                </c:pt>
                <c:pt idx="6">
                  <c:v>467.98001099999999</c:v>
                </c:pt>
                <c:pt idx="7">
                  <c:v>470.77999899999998</c:v>
                </c:pt>
                <c:pt idx="8">
                  <c:v>473.57000699999998</c:v>
                </c:pt>
                <c:pt idx="9">
                  <c:v>476.36999500000002</c:v>
                </c:pt>
                <c:pt idx="10">
                  <c:v>479.16000400000001</c:v>
                </c:pt>
                <c:pt idx="11">
                  <c:v>481.959991</c:v>
                </c:pt>
                <c:pt idx="12">
                  <c:v>484.76001000000002</c:v>
                </c:pt>
                <c:pt idx="13">
                  <c:v>487.55999800000001</c:v>
                </c:pt>
                <c:pt idx="14">
                  <c:v>490.35998499999999</c:v>
                </c:pt>
                <c:pt idx="15">
                  <c:v>493.16000400000001</c:v>
                </c:pt>
                <c:pt idx="16">
                  <c:v>495.97000100000002</c:v>
                </c:pt>
                <c:pt idx="17">
                  <c:v>498.76998900000001</c:v>
                </c:pt>
                <c:pt idx="18">
                  <c:v>501.57998700000002</c:v>
                </c:pt>
                <c:pt idx="19">
                  <c:v>504.39001500000001</c:v>
                </c:pt>
                <c:pt idx="20">
                  <c:v>507.19000199999999</c:v>
                </c:pt>
                <c:pt idx="21">
                  <c:v>510</c:v>
                </c:pt>
                <c:pt idx="22">
                  <c:v>512.80999799999995</c:v>
                </c:pt>
                <c:pt idx="23">
                  <c:v>515.63000499999998</c:v>
                </c:pt>
                <c:pt idx="24">
                  <c:v>518.44000200000005</c:v>
                </c:pt>
                <c:pt idx="25">
                  <c:v>521.25</c:v>
                </c:pt>
                <c:pt idx="26">
                  <c:v>524.07000700000003</c:v>
                </c:pt>
                <c:pt idx="27">
                  <c:v>526.88000499999998</c:v>
                </c:pt>
                <c:pt idx="28">
                  <c:v>529.70001200000002</c:v>
                </c:pt>
                <c:pt idx="29">
                  <c:v>532.52002000000005</c:v>
                </c:pt>
                <c:pt idx="30">
                  <c:v>535.34002699999996</c:v>
                </c:pt>
                <c:pt idx="31">
                  <c:v>538.15997300000004</c:v>
                </c:pt>
                <c:pt idx="32">
                  <c:v>540.98999000000003</c:v>
                </c:pt>
                <c:pt idx="33">
                  <c:v>543.80999799999995</c:v>
                </c:pt>
                <c:pt idx="34">
                  <c:v>546.63000499999998</c:v>
                </c:pt>
                <c:pt idx="35">
                  <c:v>549.46002199999998</c:v>
                </c:pt>
                <c:pt idx="36">
                  <c:v>552.28997800000002</c:v>
                </c:pt>
                <c:pt idx="37">
                  <c:v>555.11999500000002</c:v>
                </c:pt>
                <c:pt idx="38">
                  <c:v>557.94000200000005</c:v>
                </c:pt>
                <c:pt idx="39">
                  <c:v>560.78002900000001</c:v>
                </c:pt>
                <c:pt idx="40">
                  <c:v>563.60998500000005</c:v>
                </c:pt>
                <c:pt idx="41">
                  <c:v>566.44000200000005</c:v>
                </c:pt>
                <c:pt idx="42">
                  <c:v>569.27002000000005</c:v>
                </c:pt>
                <c:pt idx="43">
                  <c:v>572.10998500000005</c:v>
                </c:pt>
                <c:pt idx="44">
                  <c:v>574.95001200000002</c:v>
                </c:pt>
                <c:pt idx="45">
                  <c:v>577.78002900000001</c:v>
                </c:pt>
                <c:pt idx="46">
                  <c:v>580.61999500000002</c:v>
                </c:pt>
                <c:pt idx="47">
                  <c:v>583.46002199999998</c:v>
                </c:pt>
                <c:pt idx="48">
                  <c:v>586.29998799999998</c:v>
                </c:pt>
                <c:pt idx="49">
                  <c:v>589.15002400000003</c:v>
                </c:pt>
                <c:pt idx="50">
                  <c:v>591.98999000000003</c:v>
                </c:pt>
                <c:pt idx="51">
                  <c:v>594.84002699999996</c:v>
                </c:pt>
                <c:pt idx="52">
                  <c:v>597.67999299999997</c:v>
                </c:pt>
                <c:pt idx="53">
                  <c:v>600.53002900000001</c:v>
                </c:pt>
                <c:pt idx="54">
                  <c:v>603.38000499999998</c:v>
                </c:pt>
                <c:pt idx="55">
                  <c:v>606.22997999999995</c:v>
                </c:pt>
                <c:pt idx="56">
                  <c:v>609.080017</c:v>
                </c:pt>
                <c:pt idx="57">
                  <c:v>611.92999299999997</c:v>
                </c:pt>
                <c:pt idx="58">
                  <c:v>614.78002900000001</c:v>
                </c:pt>
                <c:pt idx="59">
                  <c:v>617.64001499999995</c:v>
                </c:pt>
                <c:pt idx="60">
                  <c:v>620.48999000000003</c:v>
                </c:pt>
                <c:pt idx="61">
                  <c:v>623.34997599999997</c:v>
                </c:pt>
                <c:pt idx="62">
                  <c:v>626.21002199999998</c:v>
                </c:pt>
                <c:pt idx="63">
                  <c:v>629.07000700000003</c:v>
                </c:pt>
                <c:pt idx="64">
                  <c:v>631.92999299999997</c:v>
                </c:pt>
                <c:pt idx="65">
                  <c:v>634.78997800000002</c:v>
                </c:pt>
                <c:pt idx="66">
                  <c:v>637.65002400000003</c:v>
                </c:pt>
                <c:pt idx="67">
                  <c:v>640.51000999999997</c:v>
                </c:pt>
                <c:pt idx="68">
                  <c:v>643.38000499999998</c:v>
                </c:pt>
                <c:pt idx="69">
                  <c:v>646.23999000000003</c:v>
                </c:pt>
                <c:pt idx="70">
                  <c:v>649.10998500000005</c:v>
                </c:pt>
                <c:pt idx="71">
                  <c:v>651.97997999999995</c:v>
                </c:pt>
                <c:pt idx="72">
                  <c:v>654.84997599999997</c:v>
                </c:pt>
                <c:pt idx="73">
                  <c:v>657.71997099999999</c:v>
                </c:pt>
                <c:pt idx="74">
                  <c:v>660.59002699999996</c:v>
                </c:pt>
                <c:pt idx="75">
                  <c:v>663.46997099999999</c:v>
                </c:pt>
                <c:pt idx="76">
                  <c:v>666.34002699999996</c:v>
                </c:pt>
                <c:pt idx="77">
                  <c:v>669.21997099999999</c:v>
                </c:pt>
                <c:pt idx="78">
                  <c:v>672.09002699999996</c:v>
                </c:pt>
                <c:pt idx="79">
                  <c:v>674.96997099999999</c:v>
                </c:pt>
                <c:pt idx="80">
                  <c:v>677.84997599999997</c:v>
                </c:pt>
                <c:pt idx="81">
                  <c:v>680.72997999999995</c:v>
                </c:pt>
                <c:pt idx="82">
                  <c:v>683.60998500000005</c:v>
                </c:pt>
                <c:pt idx="83">
                  <c:v>686.48999000000003</c:v>
                </c:pt>
                <c:pt idx="84">
                  <c:v>689.38000499999998</c:v>
                </c:pt>
                <c:pt idx="85">
                  <c:v>692.26000999999997</c:v>
                </c:pt>
                <c:pt idx="86">
                  <c:v>695.15002400000003</c:v>
                </c:pt>
                <c:pt idx="87">
                  <c:v>698.03002900000001</c:v>
                </c:pt>
                <c:pt idx="88">
                  <c:v>700.919983</c:v>
                </c:pt>
                <c:pt idx="89">
                  <c:v>703.80999799999995</c:v>
                </c:pt>
                <c:pt idx="90">
                  <c:v>706.70001200000002</c:v>
                </c:pt>
                <c:pt idx="91">
                  <c:v>709.59997599999997</c:v>
                </c:pt>
                <c:pt idx="92">
                  <c:v>712.48999000000003</c:v>
                </c:pt>
                <c:pt idx="93">
                  <c:v>715.38000499999998</c:v>
                </c:pt>
                <c:pt idx="94">
                  <c:v>718.28002900000001</c:v>
                </c:pt>
                <c:pt idx="95">
                  <c:v>721.17999299999997</c:v>
                </c:pt>
                <c:pt idx="96">
                  <c:v>724.07000700000003</c:v>
                </c:pt>
                <c:pt idx="97">
                  <c:v>726.96997099999999</c:v>
                </c:pt>
                <c:pt idx="98">
                  <c:v>729.86999500000002</c:v>
                </c:pt>
                <c:pt idx="99">
                  <c:v>732.77002000000005</c:v>
                </c:pt>
                <c:pt idx="100">
                  <c:v>735.67999299999997</c:v>
                </c:pt>
                <c:pt idx="101">
                  <c:v>738.580017</c:v>
                </c:pt>
                <c:pt idx="102">
                  <c:v>741.48999000000003</c:v>
                </c:pt>
                <c:pt idx="103">
                  <c:v>744.39001499999995</c:v>
                </c:pt>
                <c:pt idx="104">
                  <c:v>747.29998799999998</c:v>
                </c:pt>
                <c:pt idx="105">
                  <c:v>750.21002199999998</c:v>
                </c:pt>
                <c:pt idx="106">
                  <c:v>753.11999500000002</c:v>
                </c:pt>
                <c:pt idx="107">
                  <c:v>756.03002900000001</c:v>
                </c:pt>
                <c:pt idx="108">
                  <c:v>758.94000200000005</c:v>
                </c:pt>
                <c:pt idx="109">
                  <c:v>761.84997599999997</c:v>
                </c:pt>
                <c:pt idx="110">
                  <c:v>764.77002000000005</c:v>
                </c:pt>
                <c:pt idx="111">
                  <c:v>767.67999299999997</c:v>
                </c:pt>
                <c:pt idx="112">
                  <c:v>770.59997599999997</c:v>
                </c:pt>
                <c:pt idx="113">
                  <c:v>773.52002000000005</c:v>
                </c:pt>
                <c:pt idx="114">
                  <c:v>776.44000200000005</c:v>
                </c:pt>
                <c:pt idx="115">
                  <c:v>779.35998500000005</c:v>
                </c:pt>
                <c:pt idx="116">
                  <c:v>782.28002900000001</c:v>
                </c:pt>
                <c:pt idx="117">
                  <c:v>785.20001200000002</c:v>
                </c:pt>
                <c:pt idx="118">
                  <c:v>788.11999500000002</c:v>
                </c:pt>
                <c:pt idx="119">
                  <c:v>791.04998799999998</c:v>
                </c:pt>
                <c:pt idx="120">
                  <c:v>793.97997999999995</c:v>
                </c:pt>
                <c:pt idx="121">
                  <c:v>796.90002400000003</c:v>
                </c:pt>
                <c:pt idx="122">
                  <c:v>799.830017</c:v>
                </c:pt>
                <c:pt idx="123">
                  <c:v>802.76000999999997</c:v>
                </c:pt>
                <c:pt idx="124">
                  <c:v>805.69000200000005</c:v>
                </c:pt>
                <c:pt idx="125">
                  <c:v>808.61999500000002</c:v>
                </c:pt>
                <c:pt idx="126">
                  <c:v>811.55999799999995</c:v>
                </c:pt>
                <c:pt idx="127">
                  <c:v>814.48999000000003</c:v>
                </c:pt>
                <c:pt idx="128">
                  <c:v>817.42999299999997</c:v>
                </c:pt>
                <c:pt idx="129">
                  <c:v>820.35998500000005</c:v>
                </c:pt>
                <c:pt idx="130">
                  <c:v>823.29998799999998</c:v>
                </c:pt>
                <c:pt idx="131">
                  <c:v>826.23999000000003</c:v>
                </c:pt>
                <c:pt idx="132">
                  <c:v>829.17999299999997</c:v>
                </c:pt>
                <c:pt idx="133">
                  <c:v>832.11999500000002</c:v>
                </c:pt>
                <c:pt idx="134">
                  <c:v>835.07000700000003</c:v>
                </c:pt>
                <c:pt idx="135">
                  <c:v>838.01000999999997</c:v>
                </c:pt>
                <c:pt idx="136">
                  <c:v>840.95001200000002</c:v>
                </c:pt>
                <c:pt idx="137">
                  <c:v>843.90002400000003</c:v>
                </c:pt>
                <c:pt idx="138">
                  <c:v>846.84997599999997</c:v>
                </c:pt>
                <c:pt idx="139">
                  <c:v>849.79998799999998</c:v>
                </c:pt>
              </c:numCache>
            </c:numRef>
          </c:xVal>
          <c:yVal>
            <c:numRef>
              <c:f>Graphs!$AU$5:$AU$144</c:f>
              <c:numCache>
                <c:formatCode>General</c:formatCode>
                <c:ptCount val="140"/>
                <c:pt idx="0">
                  <c:v>4.6327E-2</c:v>
                </c:pt>
                <c:pt idx="1">
                  <c:v>4.6538500000000003E-2</c:v>
                </c:pt>
                <c:pt idx="2">
                  <c:v>4.6419749999999996E-2</c:v>
                </c:pt>
                <c:pt idx="3">
                  <c:v>4.5898250000000002E-2</c:v>
                </c:pt>
                <c:pt idx="4">
                  <c:v>4.5618250000000006E-2</c:v>
                </c:pt>
                <c:pt idx="5">
                  <c:v>4.5455750000000003E-2</c:v>
                </c:pt>
                <c:pt idx="6">
                  <c:v>4.5201500000000006E-2</c:v>
                </c:pt>
                <c:pt idx="7">
                  <c:v>4.5387499999999997E-2</c:v>
                </c:pt>
                <c:pt idx="8">
                  <c:v>4.5590499999999999E-2</c:v>
                </c:pt>
                <c:pt idx="9">
                  <c:v>4.5821000000000001E-2</c:v>
                </c:pt>
                <c:pt idx="10">
                  <c:v>4.5755249999999997E-2</c:v>
                </c:pt>
                <c:pt idx="11">
                  <c:v>4.5793749999999994E-2</c:v>
                </c:pt>
                <c:pt idx="12">
                  <c:v>4.5986250000000006E-2</c:v>
                </c:pt>
                <c:pt idx="13">
                  <c:v>4.6184499999999996E-2</c:v>
                </c:pt>
                <c:pt idx="14">
                  <c:v>4.6563999999999994E-2</c:v>
                </c:pt>
                <c:pt idx="15">
                  <c:v>4.7182500000000002E-2</c:v>
                </c:pt>
                <c:pt idx="16">
                  <c:v>4.8241499999999993E-2</c:v>
                </c:pt>
                <c:pt idx="17">
                  <c:v>4.9436499999999994E-2</c:v>
                </c:pt>
                <c:pt idx="18">
                  <c:v>5.117625E-2</c:v>
                </c:pt>
                <c:pt idx="19">
                  <c:v>5.3306999999999993E-2</c:v>
                </c:pt>
                <c:pt idx="20">
                  <c:v>5.5865750000000006E-2</c:v>
                </c:pt>
                <c:pt idx="21">
                  <c:v>5.8816500000000001E-2</c:v>
                </c:pt>
                <c:pt idx="22">
                  <c:v>6.2551999999999996E-2</c:v>
                </c:pt>
                <c:pt idx="23">
                  <c:v>6.6663250000000007E-2</c:v>
                </c:pt>
                <c:pt idx="24">
                  <c:v>7.127E-2</c:v>
                </c:pt>
                <c:pt idx="25">
                  <c:v>7.6121250000000001E-2</c:v>
                </c:pt>
                <c:pt idx="26">
                  <c:v>8.1024750000000006E-2</c:v>
                </c:pt>
                <c:pt idx="27">
                  <c:v>8.5401250000000012E-2</c:v>
                </c:pt>
                <c:pt idx="28">
                  <c:v>8.9352500000000001E-2</c:v>
                </c:pt>
                <c:pt idx="29">
                  <c:v>9.2541249999999992E-2</c:v>
                </c:pt>
                <c:pt idx="30">
                  <c:v>9.5206249999999992E-2</c:v>
                </c:pt>
                <c:pt idx="31">
                  <c:v>9.7116499999999994E-2</c:v>
                </c:pt>
                <c:pt idx="32">
                  <c:v>9.8794500000000007E-2</c:v>
                </c:pt>
                <c:pt idx="33">
                  <c:v>0.10017925</c:v>
                </c:pt>
                <c:pt idx="34">
                  <c:v>0.10160174999999999</c:v>
                </c:pt>
                <c:pt idx="35">
                  <c:v>0.10291149999999999</c:v>
                </c:pt>
                <c:pt idx="36">
                  <c:v>0.104185</c:v>
                </c:pt>
                <c:pt idx="37">
                  <c:v>0.10500100000000001</c:v>
                </c:pt>
                <c:pt idx="38">
                  <c:v>0.10526125</c:v>
                </c:pt>
                <c:pt idx="39">
                  <c:v>0.10484900000000001</c:v>
                </c:pt>
                <c:pt idx="40">
                  <c:v>0.10384075000000001</c:v>
                </c:pt>
                <c:pt idx="41">
                  <c:v>0.10229974999999999</c:v>
                </c:pt>
                <c:pt idx="42">
                  <c:v>0.10036225</c:v>
                </c:pt>
                <c:pt idx="43">
                  <c:v>9.8124749999999997E-2</c:v>
                </c:pt>
                <c:pt idx="44">
                  <c:v>9.6017749999999999E-2</c:v>
                </c:pt>
                <c:pt idx="45">
                  <c:v>9.420075E-2</c:v>
                </c:pt>
                <c:pt idx="46">
                  <c:v>9.2659000000000005E-2</c:v>
                </c:pt>
                <c:pt idx="47">
                  <c:v>9.1341999999999993E-2</c:v>
                </c:pt>
                <c:pt idx="48">
                  <c:v>9.0275499999999995E-2</c:v>
                </c:pt>
                <c:pt idx="49">
                  <c:v>8.946875E-2</c:v>
                </c:pt>
                <c:pt idx="50">
                  <c:v>8.8902250000000002E-2</c:v>
                </c:pt>
                <c:pt idx="51">
                  <c:v>8.8679250000000015E-2</c:v>
                </c:pt>
                <c:pt idx="52">
                  <c:v>8.8577750000000011E-2</c:v>
                </c:pt>
                <c:pt idx="53">
                  <c:v>8.8563000000000003E-2</c:v>
                </c:pt>
                <c:pt idx="54">
                  <c:v>8.8373750000000001E-2</c:v>
                </c:pt>
                <c:pt idx="55">
                  <c:v>8.7763499999999994E-2</c:v>
                </c:pt>
                <c:pt idx="56">
                  <c:v>8.6784749999999994E-2</c:v>
                </c:pt>
                <c:pt idx="57">
                  <c:v>8.553849999999999E-2</c:v>
                </c:pt>
                <c:pt idx="58">
                  <c:v>8.4263749999999998E-2</c:v>
                </c:pt>
                <c:pt idx="59">
                  <c:v>8.3022750000000006E-2</c:v>
                </c:pt>
                <c:pt idx="60">
                  <c:v>8.2217249999999992E-2</c:v>
                </c:pt>
                <c:pt idx="61">
                  <c:v>8.1795249999999986E-2</c:v>
                </c:pt>
                <c:pt idx="62">
                  <c:v>8.1741000000000008E-2</c:v>
                </c:pt>
                <c:pt idx="63">
                  <c:v>8.1978499999999982E-2</c:v>
                </c:pt>
                <c:pt idx="64">
                  <c:v>8.2101750000000001E-2</c:v>
                </c:pt>
                <c:pt idx="65">
                  <c:v>8.1685250000000001E-2</c:v>
                </c:pt>
                <c:pt idx="66">
                  <c:v>8.0372750000000007E-2</c:v>
                </c:pt>
                <c:pt idx="67">
                  <c:v>7.8524250000000004E-2</c:v>
                </c:pt>
                <c:pt idx="68">
                  <c:v>7.6347749999999992E-2</c:v>
                </c:pt>
                <c:pt idx="69">
                  <c:v>7.4276250000000002E-2</c:v>
                </c:pt>
                <c:pt idx="70">
                  <c:v>7.2524249999999998E-2</c:v>
                </c:pt>
                <c:pt idx="71">
                  <c:v>7.1192000000000005E-2</c:v>
                </c:pt>
                <c:pt idx="72">
                  <c:v>7.0010500000000003E-2</c:v>
                </c:pt>
                <c:pt idx="73">
                  <c:v>6.8603749999999991E-2</c:v>
                </c:pt>
                <c:pt idx="74">
                  <c:v>6.6830000000000001E-2</c:v>
                </c:pt>
                <c:pt idx="75">
                  <c:v>6.4847999999999989E-2</c:v>
                </c:pt>
                <c:pt idx="76">
                  <c:v>6.3002000000000002E-2</c:v>
                </c:pt>
                <c:pt idx="77">
                  <c:v>6.1580250000000003E-2</c:v>
                </c:pt>
                <c:pt idx="78">
                  <c:v>6.0670000000000002E-2</c:v>
                </c:pt>
                <c:pt idx="79">
                  <c:v>6.0497999999999996E-2</c:v>
                </c:pt>
                <c:pt idx="80">
                  <c:v>6.115425E-2</c:v>
                </c:pt>
                <c:pt idx="81">
                  <c:v>6.2866499999999992E-2</c:v>
                </c:pt>
                <c:pt idx="82">
                  <c:v>6.5877249999999998E-2</c:v>
                </c:pt>
                <c:pt idx="83">
                  <c:v>7.1199999999999986E-2</c:v>
                </c:pt>
                <c:pt idx="84">
                  <c:v>7.9837750000000013E-2</c:v>
                </c:pt>
                <c:pt idx="85">
                  <c:v>9.2530249999999994E-2</c:v>
                </c:pt>
                <c:pt idx="86">
                  <c:v>0.10905975000000001</c:v>
                </c:pt>
                <c:pt idx="87">
                  <c:v>0.12853075</c:v>
                </c:pt>
                <c:pt idx="88">
                  <c:v>0.1488525</c:v>
                </c:pt>
                <c:pt idx="89">
                  <c:v>0.1679985</c:v>
                </c:pt>
                <c:pt idx="90">
                  <c:v>0.18521399999999999</c:v>
                </c:pt>
                <c:pt idx="91">
                  <c:v>0.2008055</c:v>
                </c:pt>
                <c:pt idx="92">
                  <c:v>0.21513274999999998</c:v>
                </c:pt>
                <c:pt idx="93">
                  <c:v>0.22863575000000003</c:v>
                </c:pt>
                <c:pt idx="94">
                  <c:v>0.24120124999999998</c:v>
                </c:pt>
                <c:pt idx="95">
                  <c:v>0.25284625000000005</c:v>
                </c:pt>
                <c:pt idx="96">
                  <c:v>0.26348250000000001</c:v>
                </c:pt>
                <c:pt idx="97">
                  <c:v>0.27345625000000001</c:v>
                </c:pt>
                <c:pt idx="98">
                  <c:v>0.28226275000000001</c:v>
                </c:pt>
                <c:pt idx="99">
                  <c:v>0.28996474999999999</c:v>
                </c:pt>
                <c:pt idx="100">
                  <c:v>0.29663874999999995</c:v>
                </c:pt>
                <c:pt idx="101">
                  <c:v>0.30265824999999996</c:v>
                </c:pt>
                <c:pt idx="102">
                  <c:v>0.30760900000000002</c:v>
                </c:pt>
                <c:pt idx="103">
                  <c:v>0.31151300000000004</c:v>
                </c:pt>
                <c:pt idx="104">
                  <c:v>0.31451425</c:v>
                </c:pt>
                <c:pt idx="105">
                  <c:v>0.31709199999999998</c:v>
                </c:pt>
                <c:pt idx="106">
                  <c:v>0.31970525</c:v>
                </c:pt>
                <c:pt idx="107">
                  <c:v>0.32227974999999998</c:v>
                </c:pt>
                <c:pt idx="108">
                  <c:v>0.32480474999999998</c:v>
                </c:pt>
                <c:pt idx="109">
                  <c:v>0.326957</c:v>
                </c:pt>
                <c:pt idx="110">
                  <c:v>0.32892925000000001</c:v>
                </c:pt>
                <c:pt idx="111">
                  <c:v>0.33089174999999998</c:v>
                </c:pt>
                <c:pt idx="112">
                  <c:v>0.33278750000000001</c:v>
                </c:pt>
                <c:pt idx="113">
                  <c:v>0.33493800000000001</c:v>
                </c:pt>
                <c:pt idx="114">
                  <c:v>0.33639200000000002</c:v>
                </c:pt>
                <c:pt idx="115">
                  <c:v>0.33781650000000002</c:v>
                </c:pt>
                <c:pt idx="116">
                  <c:v>0.33870400000000001</c:v>
                </c:pt>
                <c:pt idx="117">
                  <c:v>0.33951025000000001</c:v>
                </c:pt>
                <c:pt idx="118">
                  <c:v>0.33992749999999994</c:v>
                </c:pt>
                <c:pt idx="119">
                  <c:v>0.33988000000000002</c:v>
                </c:pt>
                <c:pt idx="120">
                  <c:v>0.33974625000000003</c:v>
                </c:pt>
                <c:pt idx="121">
                  <c:v>0.33951474999999998</c:v>
                </c:pt>
                <c:pt idx="122">
                  <c:v>0.33912075000000003</c:v>
                </c:pt>
                <c:pt idx="123">
                  <c:v>0.33844799999999997</c:v>
                </c:pt>
                <c:pt idx="124">
                  <c:v>0.33854600000000001</c:v>
                </c:pt>
                <c:pt idx="125">
                  <c:v>0.33951724999999999</c:v>
                </c:pt>
                <c:pt idx="126">
                  <c:v>0.34</c:v>
                </c:pt>
                <c:pt idx="127">
                  <c:v>0.34009299999999998</c:v>
                </c:pt>
                <c:pt idx="128">
                  <c:v>0.34009025000000004</c:v>
                </c:pt>
                <c:pt idx="129">
                  <c:v>0.34026049999999997</c:v>
                </c:pt>
                <c:pt idx="130">
                  <c:v>0.33989199999999997</c:v>
                </c:pt>
                <c:pt idx="131">
                  <c:v>0.34038474999999996</c:v>
                </c:pt>
                <c:pt idx="132">
                  <c:v>0.34014624999999998</c:v>
                </c:pt>
                <c:pt idx="133">
                  <c:v>0.34024074999999998</c:v>
                </c:pt>
                <c:pt idx="134">
                  <c:v>0.34081</c:v>
                </c:pt>
                <c:pt idx="135">
                  <c:v>0.34218375000000001</c:v>
                </c:pt>
                <c:pt idx="136">
                  <c:v>0.34273474999999998</c:v>
                </c:pt>
                <c:pt idx="137">
                  <c:v>0.34362000000000004</c:v>
                </c:pt>
                <c:pt idx="138">
                  <c:v>0.34549750000000001</c:v>
                </c:pt>
                <c:pt idx="139">
                  <c:v>0.34680125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46E1-46EE-BC5D-0241D8C233D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64298576"/>
        <c:axId val="612915328"/>
      </c:scatterChart>
      <c:valAx>
        <c:axId val="764298576"/>
        <c:scaling>
          <c:orientation val="minMax"/>
          <c:max val="850"/>
          <c:min val="45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Wavelength [nm]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12915328"/>
        <c:crosses val="autoZero"/>
        <c:crossBetween val="midCat"/>
      </c:valAx>
      <c:valAx>
        <c:axId val="61291532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Reflectance [%/100]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764298576"/>
        <c:crosses val="autoZero"/>
        <c:crossBetween val="midCat"/>
        <c:majorUnit val="0.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643569553805775"/>
          <c:y val="4.0642497812773404E-2"/>
          <c:w val="0.79908508311461068"/>
          <c:h val="0.78589074803149606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AVG healthy'!$BD$4</c:f>
              <c:strCache>
                <c:ptCount val="1"/>
                <c:pt idx="0">
                  <c:v>CO 39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1"/>
            <c:plus>
              <c:numRef>
                <c:f>'AVG healthy'!$BG$5:$BG$144</c:f>
                <c:numCache>
                  <c:formatCode>General</c:formatCode>
                  <c:ptCount val="140"/>
                  <c:pt idx="0">
                    <c:v>1.3727861863290858E-3</c:v>
                  </c:pt>
                  <c:pt idx="1">
                    <c:v>1.3728908635183645E-3</c:v>
                  </c:pt>
                  <c:pt idx="2">
                    <c:v>1.3713811923108529E-3</c:v>
                  </c:pt>
                  <c:pt idx="3">
                    <c:v>1.3485975349850753E-3</c:v>
                  </c:pt>
                  <c:pt idx="4">
                    <c:v>1.3711716240361331E-3</c:v>
                  </c:pt>
                  <c:pt idx="5">
                    <c:v>1.3957097310367478E-3</c:v>
                  </c:pt>
                  <c:pt idx="6">
                    <c:v>1.4487223773259823E-3</c:v>
                  </c:pt>
                  <c:pt idx="7">
                    <c:v>1.4722207168168596E-3</c:v>
                  </c:pt>
                  <c:pt idx="8">
                    <c:v>1.5098803349584881E-3</c:v>
                  </c:pt>
                  <c:pt idx="9">
                    <c:v>1.5459666235873493E-3</c:v>
                  </c:pt>
                  <c:pt idx="10">
                    <c:v>1.5431739329745257E-3</c:v>
                  </c:pt>
                  <c:pt idx="11">
                    <c:v>1.5520760234987426E-3</c:v>
                  </c:pt>
                  <c:pt idx="12">
                    <c:v>1.5950074613441546E-3</c:v>
                  </c:pt>
                  <c:pt idx="13">
                    <c:v>1.6379687533722548E-3</c:v>
                  </c:pt>
                  <c:pt idx="14">
                    <c:v>1.6161237492220695E-3</c:v>
                  </c:pt>
                  <c:pt idx="15">
                    <c:v>1.6057813869354311E-3</c:v>
                  </c:pt>
                  <c:pt idx="16">
                    <c:v>1.5990068510351092E-3</c:v>
                  </c:pt>
                  <c:pt idx="17">
                    <c:v>1.5855582647372926E-3</c:v>
                  </c:pt>
                  <c:pt idx="18">
                    <c:v>1.5880352559259202E-3</c:v>
                  </c:pt>
                  <c:pt idx="19">
                    <c:v>1.6546307119725367E-3</c:v>
                  </c:pt>
                  <c:pt idx="20">
                    <c:v>1.8556855040218606E-3</c:v>
                  </c:pt>
                  <c:pt idx="21">
                    <c:v>2.2205685759848406E-3</c:v>
                  </c:pt>
                  <c:pt idx="22">
                    <c:v>2.6841247298785799E-3</c:v>
                  </c:pt>
                  <c:pt idx="23">
                    <c:v>3.2292229942809496E-3</c:v>
                  </c:pt>
                  <c:pt idx="24">
                    <c:v>3.8233270012692608E-3</c:v>
                  </c:pt>
                  <c:pt idx="25">
                    <c:v>4.4624931908140084E-3</c:v>
                  </c:pt>
                  <c:pt idx="26">
                    <c:v>5.0740364119246841E-3</c:v>
                  </c:pt>
                  <c:pt idx="27">
                    <c:v>5.6113905840958584E-3</c:v>
                  </c:pt>
                  <c:pt idx="28">
                    <c:v>6.0691877266071184E-3</c:v>
                  </c:pt>
                  <c:pt idx="29">
                    <c:v>6.439562524538027E-3</c:v>
                  </c:pt>
                  <c:pt idx="30">
                    <c:v>6.7261982264863948E-3</c:v>
                  </c:pt>
                  <c:pt idx="31">
                    <c:v>6.9425375743050509E-3</c:v>
                  </c:pt>
                  <c:pt idx="32">
                    <c:v>7.0918317098568277E-3</c:v>
                  </c:pt>
                  <c:pt idx="33">
                    <c:v>7.2105619300747575E-3</c:v>
                  </c:pt>
                  <c:pt idx="34">
                    <c:v>7.3131052651803814E-3</c:v>
                  </c:pt>
                  <c:pt idx="35">
                    <c:v>7.3855742464589234E-3</c:v>
                  </c:pt>
                  <c:pt idx="36">
                    <c:v>7.4247232624997149E-3</c:v>
                  </c:pt>
                  <c:pt idx="37">
                    <c:v>7.4276664594879168E-3</c:v>
                  </c:pt>
                  <c:pt idx="38">
                    <c:v>7.3985844731739425E-3</c:v>
                  </c:pt>
                  <c:pt idx="39">
                    <c:v>7.3324192366404934E-3</c:v>
                  </c:pt>
                  <c:pt idx="40">
                    <c:v>7.2614994244283981E-3</c:v>
                  </c:pt>
                  <c:pt idx="41">
                    <c:v>7.1617198712323523E-3</c:v>
                  </c:pt>
                  <c:pt idx="42">
                    <c:v>7.0360913028021405E-3</c:v>
                  </c:pt>
                  <c:pt idx="43">
                    <c:v>6.9034809687124896E-3</c:v>
                  </c:pt>
                  <c:pt idx="44">
                    <c:v>6.7905351165583935E-3</c:v>
                  </c:pt>
                  <c:pt idx="45">
                    <c:v>6.6765145889334521E-3</c:v>
                  </c:pt>
                  <c:pt idx="46">
                    <c:v>6.5809443634034723E-3</c:v>
                  </c:pt>
                  <c:pt idx="47">
                    <c:v>6.5008025272343464E-3</c:v>
                  </c:pt>
                  <c:pt idx="48">
                    <c:v>6.4588408049442714E-3</c:v>
                  </c:pt>
                  <c:pt idx="49">
                    <c:v>6.4371098124911732E-3</c:v>
                  </c:pt>
                  <c:pt idx="50">
                    <c:v>6.4388161650654101E-3</c:v>
                  </c:pt>
                  <c:pt idx="51">
                    <c:v>6.4552991804889357E-3</c:v>
                  </c:pt>
                  <c:pt idx="52">
                    <c:v>6.4752781324646878E-3</c:v>
                  </c:pt>
                  <c:pt idx="53">
                    <c:v>6.4930059714255282E-3</c:v>
                  </c:pt>
                  <c:pt idx="54">
                    <c:v>6.5028760619031973E-3</c:v>
                  </c:pt>
                  <c:pt idx="55">
                    <c:v>6.5054938537865885E-3</c:v>
                  </c:pt>
                  <c:pt idx="56">
                    <c:v>6.497463609883969E-3</c:v>
                  </c:pt>
                  <c:pt idx="57">
                    <c:v>6.4840895106912941E-3</c:v>
                  </c:pt>
                  <c:pt idx="58">
                    <c:v>6.4717094780929896E-3</c:v>
                  </c:pt>
                  <c:pt idx="59">
                    <c:v>6.4683371776207803E-3</c:v>
                  </c:pt>
                  <c:pt idx="60">
                    <c:v>6.4795206956543457E-3</c:v>
                  </c:pt>
                  <c:pt idx="61">
                    <c:v>6.5083989302873232E-3</c:v>
                  </c:pt>
                  <c:pt idx="62">
                    <c:v>6.5475959053719413E-3</c:v>
                  </c:pt>
                  <c:pt idx="63">
                    <c:v>6.6018249741270083E-3</c:v>
                  </c:pt>
                  <c:pt idx="64">
                    <c:v>6.6748075891893428E-3</c:v>
                  </c:pt>
                  <c:pt idx="65">
                    <c:v>6.7665206082397423E-3</c:v>
                  </c:pt>
                  <c:pt idx="66">
                    <c:v>6.8630685987227883E-3</c:v>
                  </c:pt>
                  <c:pt idx="67">
                    <c:v>6.9288332299392765E-3</c:v>
                  </c:pt>
                  <c:pt idx="68">
                    <c:v>6.9483075379959368E-3</c:v>
                  </c:pt>
                  <c:pt idx="69">
                    <c:v>6.9256640795458861E-3</c:v>
                  </c:pt>
                  <c:pt idx="70">
                    <c:v>6.8640005030507177E-3</c:v>
                  </c:pt>
                  <c:pt idx="71">
                    <c:v>6.7649426271960073E-3</c:v>
                  </c:pt>
                  <c:pt idx="72">
                    <c:v>6.6187219322516883E-3</c:v>
                  </c:pt>
                  <c:pt idx="73">
                    <c:v>6.4258251892017459E-3</c:v>
                  </c:pt>
                  <c:pt idx="74">
                    <c:v>6.1927472874434963E-3</c:v>
                  </c:pt>
                  <c:pt idx="75">
                    <c:v>5.9433620089537394E-3</c:v>
                  </c:pt>
                  <c:pt idx="76">
                    <c:v>5.698485752307165E-3</c:v>
                  </c:pt>
                  <c:pt idx="77">
                    <c:v>5.4786029897414407E-3</c:v>
                  </c:pt>
                  <c:pt idx="78">
                    <c:v>5.3120241463874077E-3</c:v>
                  </c:pt>
                  <c:pt idx="79">
                    <c:v>5.2076594045664584E-3</c:v>
                  </c:pt>
                  <c:pt idx="80">
                    <c:v>5.1809747396433454E-3</c:v>
                  </c:pt>
                  <c:pt idx="81">
                    <c:v>5.2697338927051793E-3</c:v>
                  </c:pt>
                  <c:pt idx="82">
                    <c:v>5.5364195431653294E-3</c:v>
                  </c:pt>
                  <c:pt idx="83">
                    <c:v>5.9864425539799294E-3</c:v>
                  </c:pt>
                  <c:pt idx="84">
                    <c:v>6.4892960384642547E-3</c:v>
                  </c:pt>
                  <c:pt idx="85">
                    <c:v>6.8113343082018664E-3</c:v>
                  </c:pt>
                  <c:pt idx="86">
                    <c:v>6.8020942687007577E-3</c:v>
                  </c:pt>
                  <c:pt idx="87">
                    <c:v>6.4673983360486109E-3</c:v>
                  </c:pt>
                  <c:pt idx="88">
                    <c:v>6.0574761010746513E-3</c:v>
                  </c:pt>
                  <c:pt idx="89">
                    <c:v>5.7665348588738854E-3</c:v>
                  </c:pt>
                  <c:pt idx="90">
                    <c:v>5.5657131447945825E-3</c:v>
                  </c:pt>
                  <c:pt idx="91">
                    <c:v>5.3853551114655725E-3</c:v>
                  </c:pt>
                  <c:pt idx="92">
                    <c:v>5.2074427760078167E-3</c:v>
                  </c:pt>
                  <c:pt idx="93">
                    <c:v>5.0539632029627662E-3</c:v>
                  </c:pt>
                  <c:pt idx="94">
                    <c:v>4.9439890663312601E-3</c:v>
                  </c:pt>
                  <c:pt idx="95">
                    <c:v>4.8919451609763494E-3</c:v>
                  </c:pt>
                  <c:pt idx="96">
                    <c:v>4.9377903848841784E-3</c:v>
                  </c:pt>
                  <c:pt idx="97">
                    <c:v>5.1748306229892072E-3</c:v>
                  </c:pt>
                  <c:pt idx="98">
                    <c:v>5.5641309201393194E-3</c:v>
                  </c:pt>
                  <c:pt idx="99">
                    <c:v>5.9732349631968088E-3</c:v>
                  </c:pt>
                  <c:pt idx="100">
                    <c:v>6.3438374891844219E-3</c:v>
                  </c:pt>
                  <c:pt idx="101">
                    <c:v>6.630792507742473E-3</c:v>
                  </c:pt>
                  <c:pt idx="102">
                    <c:v>6.8444038383860479E-3</c:v>
                  </c:pt>
                  <c:pt idx="103">
                    <c:v>6.9840416710147853E-3</c:v>
                  </c:pt>
                  <c:pt idx="104">
                    <c:v>7.0346219905636316E-3</c:v>
                  </c:pt>
                  <c:pt idx="105">
                    <c:v>7.0403952015171646E-3</c:v>
                  </c:pt>
                  <c:pt idx="106">
                    <c:v>7.0143515405491717E-3</c:v>
                  </c:pt>
                  <c:pt idx="107">
                    <c:v>6.9880442876593864E-3</c:v>
                  </c:pt>
                  <c:pt idx="108">
                    <c:v>6.930470819830452E-3</c:v>
                  </c:pt>
                  <c:pt idx="109">
                    <c:v>6.8832823300194433E-3</c:v>
                  </c:pt>
                  <c:pt idx="110">
                    <c:v>6.782666090028101E-3</c:v>
                  </c:pt>
                  <c:pt idx="111">
                    <c:v>6.6810632824272093E-3</c:v>
                  </c:pt>
                  <c:pt idx="112">
                    <c:v>6.6197589366658906E-3</c:v>
                  </c:pt>
                  <c:pt idx="113">
                    <c:v>6.5824522982419961E-3</c:v>
                  </c:pt>
                  <c:pt idx="114">
                    <c:v>6.5130085883416365E-3</c:v>
                  </c:pt>
                  <c:pt idx="115">
                    <c:v>6.4182993854333525E-3</c:v>
                  </c:pt>
                  <c:pt idx="116">
                    <c:v>6.3460908654764045E-3</c:v>
                  </c:pt>
                  <c:pt idx="117">
                    <c:v>6.2799455318601517E-3</c:v>
                  </c:pt>
                  <c:pt idx="118">
                    <c:v>6.2350697228363595E-3</c:v>
                  </c:pt>
                  <c:pt idx="119">
                    <c:v>6.2572914821786268E-3</c:v>
                  </c:pt>
                  <c:pt idx="120">
                    <c:v>6.2810612175304599E-3</c:v>
                  </c:pt>
                  <c:pt idx="121">
                    <c:v>6.2349596957792363E-3</c:v>
                  </c:pt>
                  <c:pt idx="122">
                    <c:v>6.1366440926407207E-3</c:v>
                  </c:pt>
                  <c:pt idx="123">
                    <c:v>6.0723123914946595E-3</c:v>
                  </c:pt>
                  <c:pt idx="124">
                    <c:v>6.0229737357065227E-3</c:v>
                  </c:pt>
                  <c:pt idx="125">
                    <c:v>5.9619524323192476E-3</c:v>
                  </c:pt>
                  <c:pt idx="126">
                    <c:v>5.9270809086087364E-3</c:v>
                  </c:pt>
                  <c:pt idx="127">
                    <c:v>5.9312483611848096E-3</c:v>
                  </c:pt>
                  <c:pt idx="128">
                    <c:v>5.9204081302209662E-3</c:v>
                  </c:pt>
                  <c:pt idx="129">
                    <c:v>5.9058489318322988E-3</c:v>
                  </c:pt>
                  <c:pt idx="130">
                    <c:v>5.8617412308963023E-3</c:v>
                  </c:pt>
                  <c:pt idx="131">
                    <c:v>5.8465514929098693E-3</c:v>
                  </c:pt>
                  <c:pt idx="132">
                    <c:v>5.8462923313748246E-3</c:v>
                  </c:pt>
                  <c:pt idx="133">
                    <c:v>5.9138929747615532E-3</c:v>
                  </c:pt>
                  <c:pt idx="134">
                    <c:v>5.9294122813862808E-3</c:v>
                  </c:pt>
                  <c:pt idx="135">
                    <c:v>5.9419331938455004E-3</c:v>
                  </c:pt>
                  <c:pt idx="136">
                    <c:v>5.9841520498203904E-3</c:v>
                  </c:pt>
                  <c:pt idx="137">
                    <c:v>6.0455339505741355E-3</c:v>
                  </c:pt>
                  <c:pt idx="138">
                    <c:v>6.0527909047134471E-3</c:v>
                  </c:pt>
                  <c:pt idx="139">
                    <c:v>6.0799766180881665E-3</c:v>
                  </c:pt>
                </c:numCache>
              </c:numRef>
            </c:plus>
            <c:minus>
              <c:numRef>
                <c:f>'AVG healthy'!$BG$5:$BG$144</c:f>
                <c:numCache>
                  <c:formatCode>General</c:formatCode>
                  <c:ptCount val="140"/>
                  <c:pt idx="0">
                    <c:v>1.3727861863290858E-3</c:v>
                  </c:pt>
                  <c:pt idx="1">
                    <c:v>1.3728908635183645E-3</c:v>
                  </c:pt>
                  <c:pt idx="2">
                    <c:v>1.3713811923108529E-3</c:v>
                  </c:pt>
                  <c:pt idx="3">
                    <c:v>1.3485975349850753E-3</c:v>
                  </c:pt>
                  <c:pt idx="4">
                    <c:v>1.3711716240361331E-3</c:v>
                  </c:pt>
                  <c:pt idx="5">
                    <c:v>1.3957097310367478E-3</c:v>
                  </c:pt>
                  <c:pt idx="6">
                    <c:v>1.4487223773259823E-3</c:v>
                  </c:pt>
                  <c:pt idx="7">
                    <c:v>1.4722207168168596E-3</c:v>
                  </c:pt>
                  <c:pt idx="8">
                    <c:v>1.5098803349584881E-3</c:v>
                  </c:pt>
                  <c:pt idx="9">
                    <c:v>1.5459666235873493E-3</c:v>
                  </c:pt>
                  <c:pt idx="10">
                    <c:v>1.5431739329745257E-3</c:v>
                  </c:pt>
                  <c:pt idx="11">
                    <c:v>1.5520760234987426E-3</c:v>
                  </c:pt>
                  <c:pt idx="12">
                    <c:v>1.5950074613441546E-3</c:v>
                  </c:pt>
                  <c:pt idx="13">
                    <c:v>1.6379687533722548E-3</c:v>
                  </c:pt>
                  <c:pt idx="14">
                    <c:v>1.6161237492220695E-3</c:v>
                  </c:pt>
                  <c:pt idx="15">
                    <c:v>1.6057813869354311E-3</c:v>
                  </c:pt>
                  <c:pt idx="16">
                    <c:v>1.5990068510351092E-3</c:v>
                  </c:pt>
                  <c:pt idx="17">
                    <c:v>1.5855582647372926E-3</c:v>
                  </c:pt>
                  <c:pt idx="18">
                    <c:v>1.5880352559259202E-3</c:v>
                  </c:pt>
                  <c:pt idx="19">
                    <c:v>1.6546307119725367E-3</c:v>
                  </c:pt>
                  <c:pt idx="20">
                    <c:v>1.8556855040218606E-3</c:v>
                  </c:pt>
                  <c:pt idx="21">
                    <c:v>2.2205685759848406E-3</c:v>
                  </c:pt>
                  <c:pt idx="22">
                    <c:v>2.6841247298785799E-3</c:v>
                  </c:pt>
                  <c:pt idx="23">
                    <c:v>3.2292229942809496E-3</c:v>
                  </c:pt>
                  <c:pt idx="24">
                    <c:v>3.8233270012692608E-3</c:v>
                  </c:pt>
                  <c:pt idx="25">
                    <c:v>4.4624931908140084E-3</c:v>
                  </c:pt>
                  <c:pt idx="26">
                    <c:v>5.0740364119246841E-3</c:v>
                  </c:pt>
                  <c:pt idx="27">
                    <c:v>5.6113905840958584E-3</c:v>
                  </c:pt>
                  <c:pt idx="28">
                    <c:v>6.0691877266071184E-3</c:v>
                  </c:pt>
                  <c:pt idx="29">
                    <c:v>6.439562524538027E-3</c:v>
                  </c:pt>
                  <c:pt idx="30">
                    <c:v>6.7261982264863948E-3</c:v>
                  </c:pt>
                  <c:pt idx="31">
                    <c:v>6.9425375743050509E-3</c:v>
                  </c:pt>
                  <c:pt idx="32">
                    <c:v>7.0918317098568277E-3</c:v>
                  </c:pt>
                  <c:pt idx="33">
                    <c:v>7.2105619300747575E-3</c:v>
                  </c:pt>
                  <c:pt idx="34">
                    <c:v>7.3131052651803814E-3</c:v>
                  </c:pt>
                  <c:pt idx="35">
                    <c:v>7.3855742464589234E-3</c:v>
                  </c:pt>
                  <c:pt idx="36">
                    <c:v>7.4247232624997149E-3</c:v>
                  </c:pt>
                  <c:pt idx="37">
                    <c:v>7.4276664594879168E-3</c:v>
                  </c:pt>
                  <c:pt idx="38">
                    <c:v>7.3985844731739425E-3</c:v>
                  </c:pt>
                  <c:pt idx="39">
                    <c:v>7.3324192366404934E-3</c:v>
                  </c:pt>
                  <c:pt idx="40">
                    <c:v>7.2614994244283981E-3</c:v>
                  </c:pt>
                  <c:pt idx="41">
                    <c:v>7.1617198712323523E-3</c:v>
                  </c:pt>
                  <c:pt idx="42">
                    <c:v>7.0360913028021405E-3</c:v>
                  </c:pt>
                  <c:pt idx="43">
                    <c:v>6.9034809687124896E-3</c:v>
                  </c:pt>
                  <c:pt idx="44">
                    <c:v>6.7905351165583935E-3</c:v>
                  </c:pt>
                  <c:pt idx="45">
                    <c:v>6.6765145889334521E-3</c:v>
                  </c:pt>
                  <c:pt idx="46">
                    <c:v>6.5809443634034723E-3</c:v>
                  </c:pt>
                  <c:pt idx="47">
                    <c:v>6.5008025272343464E-3</c:v>
                  </c:pt>
                  <c:pt idx="48">
                    <c:v>6.4588408049442714E-3</c:v>
                  </c:pt>
                  <c:pt idx="49">
                    <c:v>6.4371098124911732E-3</c:v>
                  </c:pt>
                  <c:pt idx="50">
                    <c:v>6.4388161650654101E-3</c:v>
                  </c:pt>
                  <c:pt idx="51">
                    <c:v>6.4552991804889357E-3</c:v>
                  </c:pt>
                  <c:pt idx="52">
                    <c:v>6.4752781324646878E-3</c:v>
                  </c:pt>
                  <c:pt idx="53">
                    <c:v>6.4930059714255282E-3</c:v>
                  </c:pt>
                  <c:pt idx="54">
                    <c:v>6.5028760619031973E-3</c:v>
                  </c:pt>
                  <c:pt idx="55">
                    <c:v>6.5054938537865885E-3</c:v>
                  </c:pt>
                  <c:pt idx="56">
                    <c:v>6.497463609883969E-3</c:v>
                  </c:pt>
                  <c:pt idx="57">
                    <c:v>6.4840895106912941E-3</c:v>
                  </c:pt>
                  <c:pt idx="58">
                    <c:v>6.4717094780929896E-3</c:v>
                  </c:pt>
                  <c:pt idx="59">
                    <c:v>6.4683371776207803E-3</c:v>
                  </c:pt>
                  <c:pt idx="60">
                    <c:v>6.4795206956543457E-3</c:v>
                  </c:pt>
                  <c:pt idx="61">
                    <c:v>6.5083989302873232E-3</c:v>
                  </c:pt>
                  <c:pt idx="62">
                    <c:v>6.5475959053719413E-3</c:v>
                  </c:pt>
                  <c:pt idx="63">
                    <c:v>6.6018249741270083E-3</c:v>
                  </c:pt>
                  <c:pt idx="64">
                    <c:v>6.6748075891893428E-3</c:v>
                  </c:pt>
                  <c:pt idx="65">
                    <c:v>6.7665206082397423E-3</c:v>
                  </c:pt>
                  <c:pt idx="66">
                    <c:v>6.8630685987227883E-3</c:v>
                  </c:pt>
                  <c:pt idx="67">
                    <c:v>6.9288332299392765E-3</c:v>
                  </c:pt>
                  <c:pt idx="68">
                    <c:v>6.9483075379959368E-3</c:v>
                  </c:pt>
                  <c:pt idx="69">
                    <c:v>6.9256640795458861E-3</c:v>
                  </c:pt>
                  <c:pt idx="70">
                    <c:v>6.8640005030507177E-3</c:v>
                  </c:pt>
                  <c:pt idx="71">
                    <c:v>6.7649426271960073E-3</c:v>
                  </c:pt>
                  <c:pt idx="72">
                    <c:v>6.6187219322516883E-3</c:v>
                  </c:pt>
                  <c:pt idx="73">
                    <c:v>6.4258251892017459E-3</c:v>
                  </c:pt>
                  <c:pt idx="74">
                    <c:v>6.1927472874434963E-3</c:v>
                  </c:pt>
                  <c:pt idx="75">
                    <c:v>5.9433620089537394E-3</c:v>
                  </c:pt>
                  <c:pt idx="76">
                    <c:v>5.698485752307165E-3</c:v>
                  </c:pt>
                  <c:pt idx="77">
                    <c:v>5.4786029897414407E-3</c:v>
                  </c:pt>
                  <c:pt idx="78">
                    <c:v>5.3120241463874077E-3</c:v>
                  </c:pt>
                  <c:pt idx="79">
                    <c:v>5.2076594045664584E-3</c:v>
                  </c:pt>
                  <c:pt idx="80">
                    <c:v>5.1809747396433454E-3</c:v>
                  </c:pt>
                  <c:pt idx="81">
                    <c:v>5.2697338927051793E-3</c:v>
                  </c:pt>
                  <c:pt idx="82">
                    <c:v>5.5364195431653294E-3</c:v>
                  </c:pt>
                  <c:pt idx="83">
                    <c:v>5.9864425539799294E-3</c:v>
                  </c:pt>
                  <c:pt idx="84">
                    <c:v>6.4892960384642547E-3</c:v>
                  </c:pt>
                  <c:pt idx="85">
                    <c:v>6.8113343082018664E-3</c:v>
                  </c:pt>
                  <c:pt idx="86">
                    <c:v>6.8020942687007577E-3</c:v>
                  </c:pt>
                  <c:pt idx="87">
                    <c:v>6.4673983360486109E-3</c:v>
                  </c:pt>
                  <c:pt idx="88">
                    <c:v>6.0574761010746513E-3</c:v>
                  </c:pt>
                  <c:pt idx="89">
                    <c:v>5.7665348588738854E-3</c:v>
                  </c:pt>
                  <c:pt idx="90">
                    <c:v>5.5657131447945825E-3</c:v>
                  </c:pt>
                  <c:pt idx="91">
                    <c:v>5.3853551114655725E-3</c:v>
                  </c:pt>
                  <c:pt idx="92">
                    <c:v>5.2074427760078167E-3</c:v>
                  </c:pt>
                  <c:pt idx="93">
                    <c:v>5.0539632029627662E-3</c:v>
                  </c:pt>
                  <c:pt idx="94">
                    <c:v>4.9439890663312601E-3</c:v>
                  </c:pt>
                  <c:pt idx="95">
                    <c:v>4.8919451609763494E-3</c:v>
                  </c:pt>
                  <c:pt idx="96">
                    <c:v>4.9377903848841784E-3</c:v>
                  </c:pt>
                  <c:pt idx="97">
                    <c:v>5.1748306229892072E-3</c:v>
                  </c:pt>
                  <c:pt idx="98">
                    <c:v>5.5641309201393194E-3</c:v>
                  </c:pt>
                  <c:pt idx="99">
                    <c:v>5.9732349631968088E-3</c:v>
                  </c:pt>
                  <c:pt idx="100">
                    <c:v>6.3438374891844219E-3</c:v>
                  </c:pt>
                  <c:pt idx="101">
                    <c:v>6.630792507742473E-3</c:v>
                  </c:pt>
                  <c:pt idx="102">
                    <c:v>6.8444038383860479E-3</c:v>
                  </c:pt>
                  <c:pt idx="103">
                    <c:v>6.9840416710147853E-3</c:v>
                  </c:pt>
                  <c:pt idx="104">
                    <c:v>7.0346219905636316E-3</c:v>
                  </c:pt>
                  <c:pt idx="105">
                    <c:v>7.0403952015171646E-3</c:v>
                  </c:pt>
                  <c:pt idx="106">
                    <c:v>7.0143515405491717E-3</c:v>
                  </c:pt>
                  <c:pt idx="107">
                    <c:v>6.9880442876593864E-3</c:v>
                  </c:pt>
                  <c:pt idx="108">
                    <c:v>6.930470819830452E-3</c:v>
                  </c:pt>
                  <c:pt idx="109">
                    <c:v>6.8832823300194433E-3</c:v>
                  </c:pt>
                  <c:pt idx="110">
                    <c:v>6.782666090028101E-3</c:v>
                  </c:pt>
                  <c:pt idx="111">
                    <c:v>6.6810632824272093E-3</c:v>
                  </c:pt>
                  <c:pt idx="112">
                    <c:v>6.6197589366658906E-3</c:v>
                  </c:pt>
                  <c:pt idx="113">
                    <c:v>6.5824522982419961E-3</c:v>
                  </c:pt>
                  <c:pt idx="114">
                    <c:v>6.5130085883416365E-3</c:v>
                  </c:pt>
                  <c:pt idx="115">
                    <c:v>6.4182993854333525E-3</c:v>
                  </c:pt>
                  <c:pt idx="116">
                    <c:v>6.3460908654764045E-3</c:v>
                  </c:pt>
                  <c:pt idx="117">
                    <c:v>6.2799455318601517E-3</c:v>
                  </c:pt>
                  <c:pt idx="118">
                    <c:v>6.2350697228363595E-3</c:v>
                  </c:pt>
                  <c:pt idx="119">
                    <c:v>6.2572914821786268E-3</c:v>
                  </c:pt>
                  <c:pt idx="120">
                    <c:v>6.2810612175304599E-3</c:v>
                  </c:pt>
                  <c:pt idx="121">
                    <c:v>6.2349596957792363E-3</c:v>
                  </c:pt>
                  <c:pt idx="122">
                    <c:v>6.1366440926407207E-3</c:v>
                  </c:pt>
                  <c:pt idx="123">
                    <c:v>6.0723123914946595E-3</c:v>
                  </c:pt>
                  <c:pt idx="124">
                    <c:v>6.0229737357065227E-3</c:v>
                  </c:pt>
                  <c:pt idx="125">
                    <c:v>5.9619524323192476E-3</c:v>
                  </c:pt>
                  <c:pt idx="126">
                    <c:v>5.9270809086087364E-3</c:v>
                  </c:pt>
                  <c:pt idx="127">
                    <c:v>5.9312483611848096E-3</c:v>
                  </c:pt>
                  <c:pt idx="128">
                    <c:v>5.9204081302209662E-3</c:v>
                  </c:pt>
                  <c:pt idx="129">
                    <c:v>5.9058489318322988E-3</c:v>
                  </c:pt>
                  <c:pt idx="130">
                    <c:v>5.8617412308963023E-3</c:v>
                  </c:pt>
                  <c:pt idx="131">
                    <c:v>5.8465514929098693E-3</c:v>
                  </c:pt>
                  <c:pt idx="132">
                    <c:v>5.8462923313748246E-3</c:v>
                  </c:pt>
                  <c:pt idx="133">
                    <c:v>5.9138929747615532E-3</c:v>
                  </c:pt>
                  <c:pt idx="134">
                    <c:v>5.9294122813862808E-3</c:v>
                  </c:pt>
                  <c:pt idx="135">
                    <c:v>5.9419331938455004E-3</c:v>
                  </c:pt>
                  <c:pt idx="136">
                    <c:v>5.9841520498203904E-3</c:v>
                  </c:pt>
                  <c:pt idx="137">
                    <c:v>6.0455339505741355E-3</c:v>
                  </c:pt>
                  <c:pt idx="138">
                    <c:v>6.0527909047134471E-3</c:v>
                  </c:pt>
                  <c:pt idx="139">
                    <c:v>6.0799766180881665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x"/>
            <c:errBarType val="both"/>
            <c:errValType val="fixedVal"/>
            <c:noEndCap val="0"/>
            <c:val val="1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AVG healthy'!$BC$5:$BC$144</c:f>
              <c:numCache>
                <c:formatCode>General</c:formatCode>
                <c:ptCount val="140"/>
                <c:pt idx="0">
                  <c:v>451.25</c:v>
                </c:pt>
                <c:pt idx="1">
                  <c:v>454.040009</c:v>
                </c:pt>
                <c:pt idx="2">
                  <c:v>456.82000699999998</c:v>
                </c:pt>
                <c:pt idx="3">
                  <c:v>459.60998499999999</c:v>
                </c:pt>
                <c:pt idx="4">
                  <c:v>462.39999399999999</c:v>
                </c:pt>
                <c:pt idx="5">
                  <c:v>465.19000199999999</c:v>
                </c:pt>
                <c:pt idx="6">
                  <c:v>467.98001099999999</c:v>
                </c:pt>
                <c:pt idx="7">
                  <c:v>470.77999899999998</c:v>
                </c:pt>
                <c:pt idx="8">
                  <c:v>473.57000699999998</c:v>
                </c:pt>
                <c:pt idx="9">
                  <c:v>476.36999500000002</c:v>
                </c:pt>
                <c:pt idx="10">
                  <c:v>479.16000400000001</c:v>
                </c:pt>
                <c:pt idx="11">
                  <c:v>481.959991</c:v>
                </c:pt>
                <c:pt idx="12">
                  <c:v>484.76001000000002</c:v>
                </c:pt>
                <c:pt idx="13">
                  <c:v>487.55999800000001</c:v>
                </c:pt>
                <c:pt idx="14">
                  <c:v>490.35998499999999</c:v>
                </c:pt>
                <c:pt idx="15">
                  <c:v>493.16000400000001</c:v>
                </c:pt>
                <c:pt idx="16">
                  <c:v>495.97000100000002</c:v>
                </c:pt>
                <c:pt idx="17">
                  <c:v>498.76998900000001</c:v>
                </c:pt>
                <c:pt idx="18">
                  <c:v>501.57998700000002</c:v>
                </c:pt>
                <c:pt idx="19">
                  <c:v>504.39001500000001</c:v>
                </c:pt>
                <c:pt idx="20">
                  <c:v>507.19000199999999</c:v>
                </c:pt>
                <c:pt idx="21">
                  <c:v>510</c:v>
                </c:pt>
                <c:pt idx="22">
                  <c:v>512.80999799999995</c:v>
                </c:pt>
                <c:pt idx="23">
                  <c:v>515.63000499999998</c:v>
                </c:pt>
                <c:pt idx="24">
                  <c:v>518.44000200000005</c:v>
                </c:pt>
                <c:pt idx="25">
                  <c:v>521.25</c:v>
                </c:pt>
                <c:pt idx="26">
                  <c:v>524.07000700000003</c:v>
                </c:pt>
                <c:pt idx="27">
                  <c:v>526.88000499999998</c:v>
                </c:pt>
                <c:pt idx="28">
                  <c:v>529.70001200000002</c:v>
                </c:pt>
                <c:pt idx="29">
                  <c:v>532.52002000000005</c:v>
                </c:pt>
                <c:pt idx="30">
                  <c:v>535.34002699999996</c:v>
                </c:pt>
                <c:pt idx="31">
                  <c:v>538.15997300000004</c:v>
                </c:pt>
                <c:pt idx="32">
                  <c:v>540.98999000000003</c:v>
                </c:pt>
                <c:pt idx="33">
                  <c:v>543.80999799999995</c:v>
                </c:pt>
                <c:pt idx="34">
                  <c:v>546.63000499999998</c:v>
                </c:pt>
                <c:pt idx="35">
                  <c:v>549.46002199999998</c:v>
                </c:pt>
                <c:pt idx="36">
                  <c:v>552.28997800000002</c:v>
                </c:pt>
                <c:pt idx="37">
                  <c:v>555.11999500000002</c:v>
                </c:pt>
                <c:pt idx="38">
                  <c:v>557.94000200000005</c:v>
                </c:pt>
                <c:pt idx="39">
                  <c:v>560.78002900000001</c:v>
                </c:pt>
                <c:pt idx="40">
                  <c:v>563.60998500000005</c:v>
                </c:pt>
                <c:pt idx="41">
                  <c:v>566.44000200000005</c:v>
                </c:pt>
                <c:pt idx="42">
                  <c:v>569.27002000000005</c:v>
                </c:pt>
                <c:pt idx="43">
                  <c:v>572.10998500000005</c:v>
                </c:pt>
                <c:pt idx="44">
                  <c:v>574.95001200000002</c:v>
                </c:pt>
                <c:pt idx="45">
                  <c:v>577.78002900000001</c:v>
                </c:pt>
                <c:pt idx="46">
                  <c:v>580.61999500000002</c:v>
                </c:pt>
                <c:pt idx="47">
                  <c:v>583.46002199999998</c:v>
                </c:pt>
                <c:pt idx="48">
                  <c:v>586.29998799999998</c:v>
                </c:pt>
                <c:pt idx="49">
                  <c:v>589.15002400000003</c:v>
                </c:pt>
                <c:pt idx="50">
                  <c:v>591.98999000000003</c:v>
                </c:pt>
                <c:pt idx="51">
                  <c:v>594.84002699999996</c:v>
                </c:pt>
                <c:pt idx="52">
                  <c:v>597.67999299999997</c:v>
                </c:pt>
                <c:pt idx="53">
                  <c:v>600.53002900000001</c:v>
                </c:pt>
                <c:pt idx="54">
                  <c:v>603.38000499999998</c:v>
                </c:pt>
                <c:pt idx="55">
                  <c:v>606.22997999999995</c:v>
                </c:pt>
                <c:pt idx="56">
                  <c:v>609.080017</c:v>
                </c:pt>
                <c:pt idx="57">
                  <c:v>611.92999299999997</c:v>
                </c:pt>
                <c:pt idx="58">
                  <c:v>614.78002900000001</c:v>
                </c:pt>
                <c:pt idx="59">
                  <c:v>617.64001499999995</c:v>
                </c:pt>
                <c:pt idx="60">
                  <c:v>620.48999000000003</c:v>
                </c:pt>
                <c:pt idx="61">
                  <c:v>623.34997599999997</c:v>
                </c:pt>
                <c:pt idx="62">
                  <c:v>626.21002199999998</c:v>
                </c:pt>
                <c:pt idx="63">
                  <c:v>629.07000700000003</c:v>
                </c:pt>
                <c:pt idx="64">
                  <c:v>631.92999299999997</c:v>
                </c:pt>
                <c:pt idx="65">
                  <c:v>634.78997800000002</c:v>
                </c:pt>
                <c:pt idx="66">
                  <c:v>637.65002400000003</c:v>
                </c:pt>
                <c:pt idx="67">
                  <c:v>640.51000999999997</c:v>
                </c:pt>
                <c:pt idx="68">
                  <c:v>643.38000499999998</c:v>
                </c:pt>
                <c:pt idx="69">
                  <c:v>646.23999000000003</c:v>
                </c:pt>
                <c:pt idx="70">
                  <c:v>649.10998500000005</c:v>
                </c:pt>
                <c:pt idx="71">
                  <c:v>651.97997999999995</c:v>
                </c:pt>
                <c:pt idx="72">
                  <c:v>654.84997599999997</c:v>
                </c:pt>
                <c:pt idx="73">
                  <c:v>657.71997099999999</c:v>
                </c:pt>
                <c:pt idx="74">
                  <c:v>660.59002699999996</c:v>
                </c:pt>
                <c:pt idx="75">
                  <c:v>663.46997099999999</c:v>
                </c:pt>
                <c:pt idx="76">
                  <c:v>666.34002699999996</c:v>
                </c:pt>
                <c:pt idx="77">
                  <c:v>669.21997099999999</c:v>
                </c:pt>
                <c:pt idx="78">
                  <c:v>672.09002699999996</c:v>
                </c:pt>
                <c:pt idx="79">
                  <c:v>674.96997099999999</c:v>
                </c:pt>
                <c:pt idx="80">
                  <c:v>677.84997599999997</c:v>
                </c:pt>
                <c:pt idx="81">
                  <c:v>680.72997999999995</c:v>
                </c:pt>
                <c:pt idx="82">
                  <c:v>683.60998500000005</c:v>
                </c:pt>
                <c:pt idx="83">
                  <c:v>686.48999000000003</c:v>
                </c:pt>
                <c:pt idx="84">
                  <c:v>689.38000499999998</c:v>
                </c:pt>
                <c:pt idx="85">
                  <c:v>692.26000999999997</c:v>
                </c:pt>
                <c:pt idx="86">
                  <c:v>695.15002400000003</c:v>
                </c:pt>
                <c:pt idx="87">
                  <c:v>698.03002900000001</c:v>
                </c:pt>
                <c:pt idx="88">
                  <c:v>700.919983</c:v>
                </c:pt>
                <c:pt idx="89">
                  <c:v>703.80999799999995</c:v>
                </c:pt>
                <c:pt idx="90">
                  <c:v>706.70001200000002</c:v>
                </c:pt>
                <c:pt idx="91">
                  <c:v>709.59997599999997</c:v>
                </c:pt>
                <c:pt idx="92">
                  <c:v>712.48999000000003</c:v>
                </c:pt>
                <c:pt idx="93">
                  <c:v>715.38000499999998</c:v>
                </c:pt>
                <c:pt idx="94">
                  <c:v>718.28002900000001</c:v>
                </c:pt>
                <c:pt idx="95">
                  <c:v>721.17999299999997</c:v>
                </c:pt>
                <c:pt idx="96">
                  <c:v>724.07000700000003</c:v>
                </c:pt>
                <c:pt idx="97">
                  <c:v>726.96997099999999</c:v>
                </c:pt>
                <c:pt idx="98">
                  <c:v>729.86999500000002</c:v>
                </c:pt>
                <c:pt idx="99">
                  <c:v>732.77002000000005</c:v>
                </c:pt>
                <c:pt idx="100">
                  <c:v>735.67999299999997</c:v>
                </c:pt>
                <c:pt idx="101">
                  <c:v>738.580017</c:v>
                </c:pt>
                <c:pt idx="102">
                  <c:v>741.48999000000003</c:v>
                </c:pt>
                <c:pt idx="103">
                  <c:v>744.39001499999995</c:v>
                </c:pt>
                <c:pt idx="104">
                  <c:v>747.29998799999998</c:v>
                </c:pt>
                <c:pt idx="105">
                  <c:v>750.21002199999998</c:v>
                </c:pt>
                <c:pt idx="106">
                  <c:v>753.11999500000002</c:v>
                </c:pt>
                <c:pt idx="107">
                  <c:v>756.03002900000001</c:v>
                </c:pt>
                <c:pt idx="108">
                  <c:v>758.94000200000005</c:v>
                </c:pt>
                <c:pt idx="109">
                  <c:v>761.84997599999997</c:v>
                </c:pt>
                <c:pt idx="110">
                  <c:v>764.77002000000005</c:v>
                </c:pt>
                <c:pt idx="111">
                  <c:v>767.67999299999997</c:v>
                </c:pt>
                <c:pt idx="112">
                  <c:v>770.59997599999997</c:v>
                </c:pt>
                <c:pt idx="113">
                  <c:v>773.52002000000005</c:v>
                </c:pt>
                <c:pt idx="114">
                  <c:v>776.44000200000005</c:v>
                </c:pt>
                <c:pt idx="115">
                  <c:v>779.35998500000005</c:v>
                </c:pt>
                <c:pt idx="116">
                  <c:v>782.28002900000001</c:v>
                </c:pt>
                <c:pt idx="117">
                  <c:v>785.20001200000002</c:v>
                </c:pt>
                <c:pt idx="118">
                  <c:v>788.11999500000002</c:v>
                </c:pt>
                <c:pt idx="119">
                  <c:v>791.04998799999998</c:v>
                </c:pt>
                <c:pt idx="120">
                  <c:v>793.97997999999995</c:v>
                </c:pt>
                <c:pt idx="121">
                  <c:v>796.90002400000003</c:v>
                </c:pt>
                <c:pt idx="122">
                  <c:v>799.830017</c:v>
                </c:pt>
                <c:pt idx="123">
                  <c:v>802.76000999999997</c:v>
                </c:pt>
                <c:pt idx="124">
                  <c:v>805.69000200000005</c:v>
                </c:pt>
                <c:pt idx="125">
                  <c:v>808.61999500000002</c:v>
                </c:pt>
                <c:pt idx="126">
                  <c:v>811.55999799999995</c:v>
                </c:pt>
                <c:pt idx="127">
                  <c:v>814.48999000000003</c:v>
                </c:pt>
                <c:pt idx="128">
                  <c:v>817.42999299999997</c:v>
                </c:pt>
                <c:pt idx="129">
                  <c:v>820.35998500000005</c:v>
                </c:pt>
                <c:pt idx="130">
                  <c:v>823.29998799999998</c:v>
                </c:pt>
                <c:pt idx="131">
                  <c:v>826.23999000000003</c:v>
                </c:pt>
                <c:pt idx="132">
                  <c:v>829.17999299999997</c:v>
                </c:pt>
                <c:pt idx="133">
                  <c:v>832.11999500000002</c:v>
                </c:pt>
                <c:pt idx="134">
                  <c:v>835.07000700000003</c:v>
                </c:pt>
                <c:pt idx="135">
                  <c:v>838.01000999999997</c:v>
                </c:pt>
                <c:pt idx="136">
                  <c:v>840.95001200000002</c:v>
                </c:pt>
                <c:pt idx="137">
                  <c:v>843.90002400000003</c:v>
                </c:pt>
                <c:pt idx="138">
                  <c:v>846.84997599999997</c:v>
                </c:pt>
                <c:pt idx="139">
                  <c:v>849.79998799999998</c:v>
                </c:pt>
              </c:numCache>
            </c:numRef>
          </c:xVal>
          <c:yVal>
            <c:numRef>
              <c:f>'AVG healthy'!$BD$5:$BD$144</c:f>
              <c:numCache>
                <c:formatCode>General</c:formatCode>
                <c:ptCount val="140"/>
                <c:pt idx="0">
                  <c:v>4.8885437500000004E-2</c:v>
                </c:pt>
                <c:pt idx="1">
                  <c:v>4.8919625000000008E-2</c:v>
                </c:pt>
                <c:pt idx="2">
                  <c:v>4.8837375000000002E-2</c:v>
                </c:pt>
                <c:pt idx="3">
                  <c:v>4.8618562500000004E-2</c:v>
                </c:pt>
                <c:pt idx="4">
                  <c:v>4.8549874999999999E-2</c:v>
                </c:pt>
                <c:pt idx="5">
                  <c:v>4.8439937500000002E-2</c:v>
                </c:pt>
                <c:pt idx="6">
                  <c:v>4.8292937500000001E-2</c:v>
                </c:pt>
                <c:pt idx="7">
                  <c:v>4.8155125E-2</c:v>
                </c:pt>
                <c:pt idx="8">
                  <c:v>4.8115437499999997E-2</c:v>
                </c:pt>
                <c:pt idx="9">
                  <c:v>4.8100562500000006E-2</c:v>
                </c:pt>
                <c:pt idx="10">
                  <c:v>4.8044500000000004E-2</c:v>
                </c:pt>
                <c:pt idx="11">
                  <c:v>4.8124812500000003E-2</c:v>
                </c:pt>
                <c:pt idx="12">
                  <c:v>4.8319062500000003E-2</c:v>
                </c:pt>
                <c:pt idx="13">
                  <c:v>4.8840562500000004E-2</c:v>
                </c:pt>
                <c:pt idx="14">
                  <c:v>4.9678812500000002E-2</c:v>
                </c:pt>
                <c:pt idx="15">
                  <c:v>5.0866500000000002E-2</c:v>
                </c:pt>
                <c:pt idx="16">
                  <c:v>5.2444875000000002E-2</c:v>
                </c:pt>
                <c:pt idx="17">
                  <c:v>5.4601687500000003E-2</c:v>
                </c:pt>
                <c:pt idx="18">
                  <c:v>5.7581000000000007E-2</c:v>
                </c:pt>
                <c:pt idx="19">
                  <c:v>6.1453562500000003E-2</c:v>
                </c:pt>
                <c:pt idx="20">
                  <c:v>6.6466999999999998E-2</c:v>
                </c:pt>
                <c:pt idx="21">
                  <c:v>7.2674125000000006E-2</c:v>
                </c:pt>
                <c:pt idx="22">
                  <c:v>8.0181249999999996E-2</c:v>
                </c:pt>
                <c:pt idx="23">
                  <c:v>8.8911937499999996E-2</c:v>
                </c:pt>
                <c:pt idx="24">
                  <c:v>9.8714250000000003E-2</c:v>
                </c:pt>
                <c:pt idx="25">
                  <c:v>0.109096625</c:v>
                </c:pt>
                <c:pt idx="26">
                  <c:v>0.119383375</c:v>
                </c:pt>
                <c:pt idx="27">
                  <c:v>0.12888762500000001</c:v>
                </c:pt>
                <c:pt idx="28">
                  <c:v>0.13714593749999998</c:v>
                </c:pt>
                <c:pt idx="29">
                  <c:v>0.14386093750000001</c:v>
                </c:pt>
                <c:pt idx="30">
                  <c:v>0.14917012499999999</c:v>
                </c:pt>
                <c:pt idx="31">
                  <c:v>0.15329356249999998</c:v>
                </c:pt>
                <c:pt idx="32">
                  <c:v>0.1565653125</c:v>
                </c:pt>
                <c:pt idx="33">
                  <c:v>0.1592765625</c:v>
                </c:pt>
                <c:pt idx="34">
                  <c:v>0.16172993749999998</c:v>
                </c:pt>
                <c:pt idx="35">
                  <c:v>0.16392656250000001</c:v>
                </c:pt>
                <c:pt idx="36">
                  <c:v>0.16563381249999998</c:v>
                </c:pt>
                <c:pt idx="37">
                  <c:v>0.16652187499999999</c:v>
                </c:pt>
                <c:pt idx="38">
                  <c:v>0.1663865625</c:v>
                </c:pt>
                <c:pt idx="39">
                  <c:v>0.16520631250000001</c:v>
                </c:pt>
                <c:pt idx="40">
                  <c:v>0.16308606249999999</c:v>
                </c:pt>
                <c:pt idx="41">
                  <c:v>0.16006200000000004</c:v>
                </c:pt>
                <c:pt idx="42">
                  <c:v>0.15622968749999999</c:v>
                </c:pt>
                <c:pt idx="43">
                  <c:v>0.15182999999999999</c:v>
                </c:pt>
                <c:pt idx="44">
                  <c:v>0.14740237499999997</c:v>
                </c:pt>
                <c:pt idx="45">
                  <c:v>0.14343131250000002</c:v>
                </c:pt>
                <c:pt idx="46">
                  <c:v>0.14007412499999999</c:v>
                </c:pt>
                <c:pt idx="47">
                  <c:v>0.13725324999999999</c:v>
                </c:pt>
                <c:pt idx="48">
                  <c:v>0.1348805625</c:v>
                </c:pt>
                <c:pt idx="49">
                  <c:v>0.13295574999999998</c:v>
                </c:pt>
                <c:pt idx="50">
                  <c:v>0.131507875</c:v>
                </c:pt>
                <c:pt idx="51">
                  <c:v>0.13045800000000002</c:v>
                </c:pt>
                <c:pt idx="52">
                  <c:v>0.1296288125</c:v>
                </c:pt>
                <c:pt idx="53">
                  <c:v>0.12874118749999999</c:v>
                </c:pt>
                <c:pt idx="54">
                  <c:v>0.12749987499999998</c:v>
                </c:pt>
                <c:pt idx="55">
                  <c:v>0.12560081249999999</c:v>
                </c:pt>
                <c:pt idx="56">
                  <c:v>0.12298787500000001</c:v>
                </c:pt>
                <c:pt idx="57">
                  <c:v>0.11985575000000001</c:v>
                </c:pt>
                <c:pt idx="58">
                  <c:v>0.1165655625</c:v>
                </c:pt>
                <c:pt idx="59">
                  <c:v>0.11352581249999999</c:v>
                </c:pt>
                <c:pt idx="60">
                  <c:v>0.11106843750000001</c:v>
                </c:pt>
                <c:pt idx="61">
                  <c:v>0.1094206875</c:v>
                </c:pt>
                <c:pt idx="62">
                  <c:v>0.10857168750000001</c:v>
                </c:pt>
                <c:pt idx="63">
                  <c:v>0.1083104375</c:v>
                </c:pt>
                <c:pt idx="64">
                  <c:v>0.10798481250000001</c:v>
                </c:pt>
                <c:pt idx="65">
                  <c:v>0.10679087500000001</c:v>
                </c:pt>
                <c:pt idx="66">
                  <c:v>0.10421731249999999</c:v>
                </c:pt>
                <c:pt idx="67">
                  <c:v>0.10045656250000001</c:v>
                </c:pt>
                <c:pt idx="68">
                  <c:v>9.5996437500000004E-2</c:v>
                </c:pt>
                <c:pt idx="69">
                  <c:v>9.1442062500000004E-2</c:v>
                </c:pt>
                <c:pt idx="70">
                  <c:v>8.7429562500000002E-2</c:v>
                </c:pt>
                <c:pt idx="71">
                  <c:v>8.4184499999999995E-2</c:v>
                </c:pt>
                <c:pt idx="72">
                  <c:v>8.1077562500000006E-2</c:v>
                </c:pt>
                <c:pt idx="73">
                  <c:v>7.7336937500000008E-2</c:v>
                </c:pt>
                <c:pt idx="74">
                  <c:v>7.2856250000000011E-2</c:v>
                </c:pt>
                <c:pt idx="75">
                  <c:v>6.8125624999999995E-2</c:v>
                </c:pt>
                <c:pt idx="76">
                  <c:v>6.3633687500000008E-2</c:v>
                </c:pt>
                <c:pt idx="77">
                  <c:v>5.9821437500000005E-2</c:v>
                </c:pt>
                <c:pt idx="78">
                  <c:v>5.70588125E-2</c:v>
                </c:pt>
                <c:pt idx="79">
                  <c:v>5.5529687500000001E-2</c:v>
                </c:pt>
                <c:pt idx="80">
                  <c:v>5.5303500000000005E-2</c:v>
                </c:pt>
                <c:pt idx="81">
                  <c:v>5.6674187500000001E-2</c:v>
                </c:pt>
                <c:pt idx="82">
                  <c:v>6.0528125000000002E-2</c:v>
                </c:pt>
                <c:pt idx="83">
                  <c:v>6.8299437500000004E-2</c:v>
                </c:pt>
                <c:pt idx="84">
                  <c:v>8.1492187500000007E-2</c:v>
                </c:pt>
                <c:pt idx="85">
                  <c:v>0.10065199999999999</c:v>
                </c:pt>
                <c:pt idx="86">
                  <c:v>0.124999</c:v>
                </c:pt>
                <c:pt idx="87">
                  <c:v>0.15227025</c:v>
                </c:pt>
                <c:pt idx="88">
                  <c:v>0.17939681249999997</c:v>
                </c:pt>
                <c:pt idx="89">
                  <c:v>0.20369206249999999</c:v>
                </c:pt>
                <c:pt idx="90">
                  <c:v>0.22430499999999998</c:v>
                </c:pt>
                <c:pt idx="91">
                  <c:v>0.24169443749999997</c:v>
                </c:pt>
                <c:pt idx="92">
                  <c:v>0.25685868749999996</c:v>
                </c:pt>
                <c:pt idx="93">
                  <c:v>0.27031862499999998</c:v>
                </c:pt>
                <c:pt idx="94">
                  <c:v>0.28232937499999999</c:v>
                </c:pt>
                <c:pt idx="95">
                  <c:v>0.29295674999999999</c:v>
                </c:pt>
                <c:pt idx="96">
                  <c:v>0.30238062500000001</c:v>
                </c:pt>
                <c:pt idx="97">
                  <c:v>0.31078737499999998</c:v>
                </c:pt>
                <c:pt idx="98">
                  <c:v>0.31813137499999999</c:v>
                </c:pt>
                <c:pt idx="99">
                  <c:v>0.32433043750000001</c:v>
                </c:pt>
                <c:pt idx="100">
                  <c:v>0.32957999999999998</c:v>
                </c:pt>
                <c:pt idx="101">
                  <c:v>0.33401618750000006</c:v>
                </c:pt>
                <c:pt idx="102">
                  <c:v>0.33755418749999999</c:v>
                </c:pt>
                <c:pt idx="103">
                  <c:v>0.34011718750000003</c:v>
                </c:pt>
                <c:pt idx="104">
                  <c:v>0.34219543750000003</c:v>
                </c:pt>
                <c:pt idx="105">
                  <c:v>0.34401225000000002</c:v>
                </c:pt>
                <c:pt idx="106">
                  <c:v>0.34563549999999998</c:v>
                </c:pt>
                <c:pt idx="107">
                  <c:v>0.34733112500000007</c:v>
                </c:pt>
                <c:pt idx="108">
                  <c:v>0.34904162500000002</c:v>
                </c:pt>
                <c:pt idx="109">
                  <c:v>0.35057143749999997</c:v>
                </c:pt>
                <c:pt idx="110">
                  <c:v>0.35212387499999998</c:v>
                </c:pt>
                <c:pt idx="111">
                  <c:v>0.35378549999999997</c:v>
                </c:pt>
                <c:pt idx="112">
                  <c:v>0.35523337499999996</c:v>
                </c:pt>
                <c:pt idx="113">
                  <c:v>0.35645443749999994</c:v>
                </c:pt>
                <c:pt idx="114">
                  <c:v>0.35764275000000001</c:v>
                </c:pt>
                <c:pt idx="115">
                  <c:v>0.35841506249999999</c:v>
                </c:pt>
                <c:pt idx="116">
                  <c:v>0.3587193125</c:v>
                </c:pt>
                <c:pt idx="117">
                  <c:v>0.35876906249999996</c:v>
                </c:pt>
                <c:pt idx="118">
                  <c:v>0.35865431250000002</c:v>
                </c:pt>
                <c:pt idx="119">
                  <c:v>0.3582431875</c:v>
                </c:pt>
                <c:pt idx="120">
                  <c:v>0.35762993749999994</c:v>
                </c:pt>
                <c:pt idx="121">
                  <c:v>0.35678306250000003</c:v>
                </c:pt>
                <c:pt idx="122">
                  <c:v>0.35579043749999995</c:v>
                </c:pt>
                <c:pt idx="123">
                  <c:v>0.35504887499999999</c:v>
                </c:pt>
                <c:pt idx="124">
                  <c:v>0.35467243749999999</c:v>
                </c:pt>
                <c:pt idx="125">
                  <c:v>0.35436381249999999</c:v>
                </c:pt>
                <c:pt idx="126">
                  <c:v>0.35385881250000006</c:v>
                </c:pt>
                <c:pt idx="127">
                  <c:v>0.3533333125</c:v>
                </c:pt>
                <c:pt idx="128">
                  <c:v>0.35296387499999998</c:v>
                </c:pt>
                <c:pt idx="129">
                  <c:v>0.3526685625</c:v>
                </c:pt>
                <c:pt idx="130">
                  <c:v>0.352475125</c:v>
                </c:pt>
                <c:pt idx="131">
                  <c:v>0.35243799999999997</c:v>
                </c:pt>
                <c:pt idx="132">
                  <c:v>0.352595875</c:v>
                </c:pt>
                <c:pt idx="133">
                  <c:v>0.35280243749999995</c:v>
                </c:pt>
                <c:pt idx="134">
                  <c:v>0.35315725000000003</c:v>
                </c:pt>
                <c:pt idx="135">
                  <c:v>0.35384199999999999</c:v>
                </c:pt>
                <c:pt idx="136">
                  <c:v>0.3546979375</c:v>
                </c:pt>
                <c:pt idx="137">
                  <c:v>0.3558635</c:v>
                </c:pt>
                <c:pt idx="138">
                  <c:v>0.35706950000000004</c:v>
                </c:pt>
                <c:pt idx="139">
                  <c:v>0.3578820000000000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58CB-495F-A5F3-069958DEBAFD}"/>
            </c:ext>
          </c:extLst>
        </c:ser>
        <c:ser>
          <c:idx val="1"/>
          <c:order val="1"/>
          <c:tx>
            <c:strRef>
              <c:f>'AVG healthy'!$BE$4</c:f>
              <c:strCache>
                <c:ptCount val="1"/>
                <c:pt idx="0">
                  <c:v>Nipponbare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1"/>
            <c:plus>
              <c:numRef>
                <c:f>'AVG healthy'!$BH$5:$BH$144</c:f>
                <c:numCache>
                  <c:formatCode>General</c:formatCode>
                  <c:ptCount val="140"/>
                  <c:pt idx="0">
                    <c:v>1.2219217845123175E-3</c:v>
                  </c:pt>
                  <c:pt idx="1">
                    <c:v>1.2594512478373134E-3</c:v>
                  </c:pt>
                  <c:pt idx="2">
                    <c:v>1.2925291009817513E-3</c:v>
                  </c:pt>
                  <c:pt idx="3">
                    <c:v>1.3197641963002464E-3</c:v>
                  </c:pt>
                  <c:pt idx="4">
                    <c:v>1.3652836840129061E-3</c:v>
                  </c:pt>
                  <c:pt idx="5">
                    <c:v>1.3815232798521622E-3</c:v>
                  </c:pt>
                  <c:pt idx="6">
                    <c:v>1.3737628336130971E-3</c:v>
                  </c:pt>
                  <c:pt idx="7">
                    <c:v>1.3735082945022863E-3</c:v>
                  </c:pt>
                  <c:pt idx="8">
                    <c:v>1.3933720964591271E-3</c:v>
                  </c:pt>
                  <c:pt idx="9">
                    <c:v>1.3944876317707748E-3</c:v>
                  </c:pt>
                  <c:pt idx="10">
                    <c:v>1.394542519959368E-3</c:v>
                  </c:pt>
                  <c:pt idx="11">
                    <c:v>1.3969345662038159E-3</c:v>
                  </c:pt>
                  <c:pt idx="12">
                    <c:v>1.4068704753684156E-3</c:v>
                  </c:pt>
                  <c:pt idx="13">
                    <c:v>1.4286077077759135E-3</c:v>
                  </c:pt>
                  <c:pt idx="14">
                    <c:v>1.4601488952260243E-3</c:v>
                  </c:pt>
                  <c:pt idx="15">
                    <c:v>1.5009685526580321E-3</c:v>
                  </c:pt>
                  <c:pt idx="16">
                    <c:v>1.5405197741222274E-3</c:v>
                  </c:pt>
                  <c:pt idx="17">
                    <c:v>1.5866994522205711E-3</c:v>
                  </c:pt>
                  <c:pt idx="18">
                    <c:v>1.6453856903586232E-3</c:v>
                  </c:pt>
                  <c:pt idx="19">
                    <c:v>1.7144182974657969E-3</c:v>
                  </c:pt>
                  <c:pt idx="20">
                    <c:v>1.8242028352402251E-3</c:v>
                  </c:pt>
                  <c:pt idx="21">
                    <c:v>1.9544633308673878E-3</c:v>
                  </c:pt>
                  <c:pt idx="22">
                    <c:v>2.1240066401800681E-3</c:v>
                  </c:pt>
                  <c:pt idx="23">
                    <c:v>2.2943997434690978E-3</c:v>
                  </c:pt>
                  <c:pt idx="24">
                    <c:v>2.4871609731787927E-3</c:v>
                  </c:pt>
                  <c:pt idx="25">
                    <c:v>2.6724290442398861E-3</c:v>
                  </c:pt>
                  <c:pt idx="26">
                    <c:v>2.8494249465381184E-3</c:v>
                  </c:pt>
                  <c:pt idx="27">
                    <c:v>3.0015604060387308E-3</c:v>
                  </c:pt>
                  <c:pt idx="28">
                    <c:v>3.1514821496260986E-3</c:v>
                  </c:pt>
                  <c:pt idx="29">
                    <c:v>3.2896381458017484E-3</c:v>
                  </c:pt>
                  <c:pt idx="30">
                    <c:v>3.4140613721124332E-3</c:v>
                  </c:pt>
                  <c:pt idx="31">
                    <c:v>3.5300649196310669E-3</c:v>
                  </c:pt>
                  <c:pt idx="32">
                    <c:v>3.6426971926992006E-3</c:v>
                  </c:pt>
                  <c:pt idx="33">
                    <c:v>3.7336055257248084E-3</c:v>
                  </c:pt>
                  <c:pt idx="34">
                    <c:v>3.8144942717842031E-3</c:v>
                  </c:pt>
                  <c:pt idx="35">
                    <c:v>3.868029705681765E-3</c:v>
                  </c:pt>
                  <c:pt idx="36">
                    <c:v>3.9174738602838714E-3</c:v>
                  </c:pt>
                  <c:pt idx="37">
                    <c:v>3.96709272690908E-3</c:v>
                  </c:pt>
                  <c:pt idx="38">
                    <c:v>4.0269629597183918E-3</c:v>
                  </c:pt>
                  <c:pt idx="39">
                    <c:v>4.0872698189942875E-3</c:v>
                  </c:pt>
                  <c:pt idx="40">
                    <c:v>4.1558589042690322E-3</c:v>
                  </c:pt>
                  <c:pt idx="41">
                    <c:v>4.2254120170808502E-3</c:v>
                  </c:pt>
                  <c:pt idx="42">
                    <c:v>4.2863156389742144E-3</c:v>
                  </c:pt>
                  <c:pt idx="43">
                    <c:v>4.3329225870874667E-3</c:v>
                  </c:pt>
                  <c:pt idx="44">
                    <c:v>4.3587868762056817E-3</c:v>
                  </c:pt>
                  <c:pt idx="45">
                    <c:v>4.365305474172269E-3</c:v>
                  </c:pt>
                  <c:pt idx="46">
                    <c:v>4.3650538893523789E-3</c:v>
                  </c:pt>
                  <c:pt idx="47">
                    <c:v>4.3627640491674729E-3</c:v>
                  </c:pt>
                  <c:pt idx="48">
                    <c:v>4.358835722577903E-3</c:v>
                  </c:pt>
                  <c:pt idx="49">
                    <c:v>4.3580153127756238E-3</c:v>
                  </c:pt>
                  <c:pt idx="50">
                    <c:v>4.3625555103433957E-3</c:v>
                  </c:pt>
                  <c:pt idx="51">
                    <c:v>4.368026013106774E-3</c:v>
                  </c:pt>
                  <c:pt idx="52">
                    <c:v>4.3662790814487581E-3</c:v>
                  </c:pt>
                  <c:pt idx="53">
                    <c:v>4.3547978281786876E-3</c:v>
                  </c:pt>
                  <c:pt idx="54">
                    <c:v>4.3373080502639829E-3</c:v>
                  </c:pt>
                  <c:pt idx="55">
                    <c:v>4.306270575036214E-3</c:v>
                  </c:pt>
                  <c:pt idx="56">
                    <c:v>4.2531805752346738E-3</c:v>
                  </c:pt>
                  <c:pt idx="57">
                    <c:v>4.1831653879318099E-3</c:v>
                  </c:pt>
                  <c:pt idx="58">
                    <c:v>4.1031437800818308E-3</c:v>
                  </c:pt>
                  <c:pt idx="59">
                    <c:v>4.027062596622776E-3</c:v>
                  </c:pt>
                  <c:pt idx="60">
                    <c:v>3.9648422723917191E-3</c:v>
                  </c:pt>
                  <c:pt idx="61">
                    <c:v>3.925161890541368E-3</c:v>
                  </c:pt>
                  <c:pt idx="62">
                    <c:v>3.9058805129648065E-3</c:v>
                  </c:pt>
                  <c:pt idx="63">
                    <c:v>3.9022335969735897E-3</c:v>
                  </c:pt>
                  <c:pt idx="64">
                    <c:v>3.9094080369145821E-3</c:v>
                  </c:pt>
                  <c:pt idx="65">
                    <c:v>3.9043564240084342E-3</c:v>
                  </c:pt>
                  <c:pt idx="66">
                    <c:v>3.8663142479517382E-3</c:v>
                  </c:pt>
                  <c:pt idx="67">
                    <c:v>3.7888784910802176E-3</c:v>
                  </c:pt>
                  <c:pt idx="68">
                    <c:v>3.670328436808036E-3</c:v>
                  </c:pt>
                  <c:pt idx="69">
                    <c:v>3.5324963929949092E-3</c:v>
                  </c:pt>
                  <c:pt idx="70">
                    <c:v>3.3968181910550227E-3</c:v>
                  </c:pt>
                  <c:pt idx="71">
                    <c:v>3.2766988793763727E-3</c:v>
                  </c:pt>
                  <c:pt idx="72">
                    <c:v>3.138577595278321E-3</c:v>
                  </c:pt>
                  <c:pt idx="73">
                    <c:v>2.957587466909755E-3</c:v>
                  </c:pt>
                  <c:pt idx="74">
                    <c:v>2.7432646938050031E-3</c:v>
                  </c:pt>
                  <c:pt idx="75">
                    <c:v>2.5173574959040683E-3</c:v>
                  </c:pt>
                  <c:pt idx="76">
                    <c:v>2.3017450364977944E-3</c:v>
                  </c:pt>
                  <c:pt idx="77">
                    <c:v>2.1073163952229938E-3</c:v>
                  </c:pt>
                  <c:pt idx="78">
                    <c:v>1.9545150639250467E-3</c:v>
                  </c:pt>
                  <c:pt idx="79">
                    <c:v>1.8479043959905117E-3</c:v>
                  </c:pt>
                  <c:pt idx="80">
                    <c:v>1.7877341130474885E-3</c:v>
                  </c:pt>
                  <c:pt idx="81">
                    <c:v>1.7827496226983483E-3</c:v>
                  </c:pt>
                  <c:pt idx="82">
                    <c:v>1.8673049339111144E-3</c:v>
                  </c:pt>
                  <c:pt idx="83">
                    <c:v>2.0955501538065489E-3</c:v>
                  </c:pt>
                  <c:pt idx="84">
                    <c:v>2.4909665648562532E-3</c:v>
                  </c:pt>
                  <c:pt idx="85">
                    <c:v>2.9924398223152241E-3</c:v>
                  </c:pt>
                  <c:pt idx="86">
                    <c:v>3.4867137483483978E-3</c:v>
                  </c:pt>
                  <c:pt idx="87">
                    <c:v>3.8505968936708049E-3</c:v>
                  </c:pt>
                  <c:pt idx="88">
                    <c:v>4.0247479066144445E-3</c:v>
                  </c:pt>
                  <c:pt idx="89">
                    <c:v>4.0216895093263373E-3</c:v>
                  </c:pt>
                  <c:pt idx="90">
                    <c:v>3.9023427843521323E-3</c:v>
                  </c:pt>
                  <c:pt idx="91">
                    <c:v>3.7254671589211576E-3</c:v>
                  </c:pt>
                  <c:pt idx="92">
                    <c:v>3.5336994593905633E-3</c:v>
                  </c:pt>
                  <c:pt idx="93">
                    <c:v>3.3588539625086589E-3</c:v>
                  </c:pt>
                  <c:pt idx="94">
                    <c:v>3.2402148402998592E-3</c:v>
                  </c:pt>
                  <c:pt idx="95">
                    <c:v>3.1917529447950295E-3</c:v>
                  </c:pt>
                  <c:pt idx="96">
                    <c:v>3.2401491952106492E-3</c:v>
                  </c:pt>
                  <c:pt idx="97">
                    <c:v>3.3676369997575062E-3</c:v>
                  </c:pt>
                  <c:pt idx="98">
                    <c:v>3.5634620302251166E-3</c:v>
                  </c:pt>
                  <c:pt idx="99">
                    <c:v>3.7685932853786614E-3</c:v>
                  </c:pt>
                  <c:pt idx="100">
                    <c:v>3.9866648723250022E-3</c:v>
                  </c:pt>
                  <c:pt idx="101">
                    <c:v>4.1911070989859075E-3</c:v>
                  </c:pt>
                  <c:pt idx="102">
                    <c:v>4.3820757154842344E-3</c:v>
                  </c:pt>
                  <c:pt idx="103">
                    <c:v>4.5181612139283903E-3</c:v>
                  </c:pt>
                  <c:pt idx="104">
                    <c:v>4.6139154474366638E-3</c:v>
                  </c:pt>
                  <c:pt idx="105">
                    <c:v>4.6486547802486126E-3</c:v>
                  </c:pt>
                  <c:pt idx="106">
                    <c:v>4.6533297754242208E-3</c:v>
                  </c:pt>
                  <c:pt idx="107">
                    <c:v>4.6385131368057754E-3</c:v>
                  </c:pt>
                  <c:pt idx="108">
                    <c:v>4.6548751787877495E-3</c:v>
                  </c:pt>
                  <c:pt idx="109">
                    <c:v>4.6545921644656884E-3</c:v>
                  </c:pt>
                  <c:pt idx="110">
                    <c:v>4.628471926067584E-3</c:v>
                  </c:pt>
                  <c:pt idx="111">
                    <c:v>4.5772608997848175E-3</c:v>
                  </c:pt>
                  <c:pt idx="112">
                    <c:v>4.5422002034360628E-3</c:v>
                  </c:pt>
                  <c:pt idx="113">
                    <c:v>4.5147535258076681E-3</c:v>
                  </c:pt>
                  <c:pt idx="114">
                    <c:v>4.4817529162149419E-3</c:v>
                  </c:pt>
                  <c:pt idx="115">
                    <c:v>4.4968845424342724E-3</c:v>
                  </c:pt>
                  <c:pt idx="116">
                    <c:v>4.5461511161648503E-3</c:v>
                  </c:pt>
                  <c:pt idx="117">
                    <c:v>4.5590159786619774E-3</c:v>
                  </c:pt>
                  <c:pt idx="118">
                    <c:v>4.538786887182988E-3</c:v>
                  </c:pt>
                  <c:pt idx="119">
                    <c:v>4.5795239917481387E-3</c:v>
                  </c:pt>
                  <c:pt idx="120">
                    <c:v>4.6627787135747152E-3</c:v>
                  </c:pt>
                  <c:pt idx="121">
                    <c:v>4.7080844744086196E-3</c:v>
                  </c:pt>
                  <c:pt idx="122">
                    <c:v>4.6784882270481543E-3</c:v>
                  </c:pt>
                  <c:pt idx="123">
                    <c:v>4.6587396368566406E-3</c:v>
                  </c:pt>
                  <c:pt idx="124">
                    <c:v>4.584395618351382E-3</c:v>
                  </c:pt>
                  <c:pt idx="125">
                    <c:v>4.516104019669457E-3</c:v>
                  </c:pt>
                  <c:pt idx="126">
                    <c:v>4.5246062140157162E-3</c:v>
                  </c:pt>
                  <c:pt idx="127">
                    <c:v>4.6059088060468479E-3</c:v>
                  </c:pt>
                  <c:pt idx="128">
                    <c:v>4.6164321093872694E-3</c:v>
                  </c:pt>
                  <c:pt idx="129">
                    <c:v>4.6241714103071041E-3</c:v>
                  </c:pt>
                  <c:pt idx="130">
                    <c:v>4.6855624404368319E-3</c:v>
                  </c:pt>
                  <c:pt idx="131">
                    <c:v>4.7787448388153771E-3</c:v>
                  </c:pt>
                  <c:pt idx="132">
                    <c:v>4.8530479135624489E-3</c:v>
                  </c:pt>
                  <c:pt idx="133">
                    <c:v>4.9363375840146308E-3</c:v>
                  </c:pt>
                  <c:pt idx="134">
                    <c:v>4.9744748650924729E-3</c:v>
                  </c:pt>
                  <c:pt idx="135">
                    <c:v>5.048913876226125E-3</c:v>
                  </c:pt>
                  <c:pt idx="136">
                    <c:v>5.1001948276811256E-3</c:v>
                  </c:pt>
                  <c:pt idx="137">
                    <c:v>5.1686749653194353E-3</c:v>
                  </c:pt>
                  <c:pt idx="138">
                    <c:v>5.2365394566052641E-3</c:v>
                  </c:pt>
                  <c:pt idx="139">
                    <c:v>6.0860904378885819E-3</c:v>
                  </c:pt>
                </c:numCache>
              </c:numRef>
            </c:plus>
            <c:minus>
              <c:numRef>
                <c:f>'AVG healthy'!$BH$5:$BH$144</c:f>
                <c:numCache>
                  <c:formatCode>General</c:formatCode>
                  <c:ptCount val="140"/>
                  <c:pt idx="0">
                    <c:v>1.2219217845123175E-3</c:v>
                  </c:pt>
                  <c:pt idx="1">
                    <c:v>1.2594512478373134E-3</c:v>
                  </c:pt>
                  <c:pt idx="2">
                    <c:v>1.2925291009817513E-3</c:v>
                  </c:pt>
                  <c:pt idx="3">
                    <c:v>1.3197641963002464E-3</c:v>
                  </c:pt>
                  <c:pt idx="4">
                    <c:v>1.3652836840129061E-3</c:v>
                  </c:pt>
                  <c:pt idx="5">
                    <c:v>1.3815232798521622E-3</c:v>
                  </c:pt>
                  <c:pt idx="6">
                    <c:v>1.3737628336130971E-3</c:v>
                  </c:pt>
                  <c:pt idx="7">
                    <c:v>1.3735082945022863E-3</c:v>
                  </c:pt>
                  <c:pt idx="8">
                    <c:v>1.3933720964591271E-3</c:v>
                  </c:pt>
                  <c:pt idx="9">
                    <c:v>1.3944876317707748E-3</c:v>
                  </c:pt>
                  <c:pt idx="10">
                    <c:v>1.394542519959368E-3</c:v>
                  </c:pt>
                  <c:pt idx="11">
                    <c:v>1.3969345662038159E-3</c:v>
                  </c:pt>
                  <c:pt idx="12">
                    <c:v>1.4068704753684156E-3</c:v>
                  </c:pt>
                  <c:pt idx="13">
                    <c:v>1.4286077077759135E-3</c:v>
                  </c:pt>
                  <c:pt idx="14">
                    <c:v>1.4601488952260243E-3</c:v>
                  </c:pt>
                  <c:pt idx="15">
                    <c:v>1.5009685526580321E-3</c:v>
                  </c:pt>
                  <c:pt idx="16">
                    <c:v>1.5405197741222274E-3</c:v>
                  </c:pt>
                  <c:pt idx="17">
                    <c:v>1.5866994522205711E-3</c:v>
                  </c:pt>
                  <c:pt idx="18">
                    <c:v>1.6453856903586232E-3</c:v>
                  </c:pt>
                  <c:pt idx="19">
                    <c:v>1.7144182974657969E-3</c:v>
                  </c:pt>
                  <c:pt idx="20">
                    <c:v>1.8242028352402251E-3</c:v>
                  </c:pt>
                  <c:pt idx="21">
                    <c:v>1.9544633308673878E-3</c:v>
                  </c:pt>
                  <c:pt idx="22">
                    <c:v>2.1240066401800681E-3</c:v>
                  </c:pt>
                  <c:pt idx="23">
                    <c:v>2.2943997434690978E-3</c:v>
                  </c:pt>
                  <c:pt idx="24">
                    <c:v>2.4871609731787927E-3</c:v>
                  </c:pt>
                  <c:pt idx="25">
                    <c:v>2.6724290442398861E-3</c:v>
                  </c:pt>
                  <c:pt idx="26">
                    <c:v>2.8494249465381184E-3</c:v>
                  </c:pt>
                  <c:pt idx="27">
                    <c:v>3.0015604060387308E-3</c:v>
                  </c:pt>
                  <c:pt idx="28">
                    <c:v>3.1514821496260986E-3</c:v>
                  </c:pt>
                  <c:pt idx="29">
                    <c:v>3.2896381458017484E-3</c:v>
                  </c:pt>
                  <c:pt idx="30">
                    <c:v>3.4140613721124332E-3</c:v>
                  </c:pt>
                  <c:pt idx="31">
                    <c:v>3.5300649196310669E-3</c:v>
                  </c:pt>
                  <c:pt idx="32">
                    <c:v>3.6426971926992006E-3</c:v>
                  </c:pt>
                  <c:pt idx="33">
                    <c:v>3.7336055257248084E-3</c:v>
                  </c:pt>
                  <c:pt idx="34">
                    <c:v>3.8144942717842031E-3</c:v>
                  </c:pt>
                  <c:pt idx="35">
                    <c:v>3.868029705681765E-3</c:v>
                  </c:pt>
                  <c:pt idx="36">
                    <c:v>3.9174738602838714E-3</c:v>
                  </c:pt>
                  <c:pt idx="37">
                    <c:v>3.96709272690908E-3</c:v>
                  </c:pt>
                  <c:pt idx="38">
                    <c:v>4.0269629597183918E-3</c:v>
                  </c:pt>
                  <c:pt idx="39">
                    <c:v>4.0872698189942875E-3</c:v>
                  </c:pt>
                  <c:pt idx="40">
                    <c:v>4.1558589042690322E-3</c:v>
                  </c:pt>
                  <c:pt idx="41">
                    <c:v>4.2254120170808502E-3</c:v>
                  </c:pt>
                  <c:pt idx="42">
                    <c:v>4.2863156389742144E-3</c:v>
                  </c:pt>
                  <c:pt idx="43">
                    <c:v>4.3329225870874667E-3</c:v>
                  </c:pt>
                  <c:pt idx="44">
                    <c:v>4.3587868762056817E-3</c:v>
                  </c:pt>
                  <c:pt idx="45">
                    <c:v>4.365305474172269E-3</c:v>
                  </c:pt>
                  <c:pt idx="46">
                    <c:v>4.3650538893523789E-3</c:v>
                  </c:pt>
                  <c:pt idx="47">
                    <c:v>4.3627640491674729E-3</c:v>
                  </c:pt>
                  <c:pt idx="48">
                    <c:v>4.358835722577903E-3</c:v>
                  </c:pt>
                  <c:pt idx="49">
                    <c:v>4.3580153127756238E-3</c:v>
                  </c:pt>
                  <c:pt idx="50">
                    <c:v>4.3625555103433957E-3</c:v>
                  </c:pt>
                  <c:pt idx="51">
                    <c:v>4.368026013106774E-3</c:v>
                  </c:pt>
                  <c:pt idx="52">
                    <c:v>4.3662790814487581E-3</c:v>
                  </c:pt>
                  <c:pt idx="53">
                    <c:v>4.3547978281786876E-3</c:v>
                  </c:pt>
                  <c:pt idx="54">
                    <c:v>4.3373080502639829E-3</c:v>
                  </c:pt>
                  <c:pt idx="55">
                    <c:v>4.306270575036214E-3</c:v>
                  </c:pt>
                  <c:pt idx="56">
                    <c:v>4.2531805752346738E-3</c:v>
                  </c:pt>
                  <c:pt idx="57">
                    <c:v>4.1831653879318099E-3</c:v>
                  </c:pt>
                  <c:pt idx="58">
                    <c:v>4.1031437800818308E-3</c:v>
                  </c:pt>
                  <c:pt idx="59">
                    <c:v>4.027062596622776E-3</c:v>
                  </c:pt>
                  <c:pt idx="60">
                    <c:v>3.9648422723917191E-3</c:v>
                  </c:pt>
                  <c:pt idx="61">
                    <c:v>3.925161890541368E-3</c:v>
                  </c:pt>
                  <c:pt idx="62">
                    <c:v>3.9058805129648065E-3</c:v>
                  </c:pt>
                  <c:pt idx="63">
                    <c:v>3.9022335969735897E-3</c:v>
                  </c:pt>
                  <c:pt idx="64">
                    <c:v>3.9094080369145821E-3</c:v>
                  </c:pt>
                  <c:pt idx="65">
                    <c:v>3.9043564240084342E-3</c:v>
                  </c:pt>
                  <c:pt idx="66">
                    <c:v>3.8663142479517382E-3</c:v>
                  </c:pt>
                  <c:pt idx="67">
                    <c:v>3.7888784910802176E-3</c:v>
                  </c:pt>
                  <c:pt idx="68">
                    <c:v>3.670328436808036E-3</c:v>
                  </c:pt>
                  <c:pt idx="69">
                    <c:v>3.5324963929949092E-3</c:v>
                  </c:pt>
                  <c:pt idx="70">
                    <c:v>3.3968181910550227E-3</c:v>
                  </c:pt>
                  <c:pt idx="71">
                    <c:v>3.2766988793763727E-3</c:v>
                  </c:pt>
                  <c:pt idx="72">
                    <c:v>3.138577595278321E-3</c:v>
                  </c:pt>
                  <c:pt idx="73">
                    <c:v>2.957587466909755E-3</c:v>
                  </c:pt>
                  <c:pt idx="74">
                    <c:v>2.7432646938050031E-3</c:v>
                  </c:pt>
                  <c:pt idx="75">
                    <c:v>2.5173574959040683E-3</c:v>
                  </c:pt>
                  <c:pt idx="76">
                    <c:v>2.3017450364977944E-3</c:v>
                  </c:pt>
                  <c:pt idx="77">
                    <c:v>2.1073163952229938E-3</c:v>
                  </c:pt>
                  <c:pt idx="78">
                    <c:v>1.9545150639250467E-3</c:v>
                  </c:pt>
                  <c:pt idx="79">
                    <c:v>1.8479043959905117E-3</c:v>
                  </c:pt>
                  <c:pt idx="80">
                    <c:v>1.7877341130474885E-3</c:v>
                  </c:pt>
                  <c:pt idx="81">
                    <c:v>1.7827496226983483E-3</c:v>
                  </c:pt>
                  <c:pt idx="82">
                    <c:v>1.8673049339111144E-3</c:v>
                  </c:pt>
                  <c:pt idx="83">
                    <c:v>2.0955501538065489E-3</c:v>
                  </c:pt>
                  <c:pt idx="84">
                    <c:v>2.4909665648562532E-3</c:v>
                  </c:pt>
                  <c:pt idx="85">
                    <c:v>2.9924398223152241E-3</c:v>
                  </c:pt>
                  <c:pt idx="86">
                    <c:v>3.4867137483483978E-3</c:v>
                  </c:pt>
                  <c:pt idx="87">
                    <c:v>3.8505968936708049E-3</c:v>
                  </c:pt>
                  <c:pt idx="88">
                    <c:v>4.0247479066144445E-3</c:v>
                  </c:pt>
                  <c:pt idx="89">
                    <c:v>4.0216895093263373E-3</c:v>
                  </c:pt>
                  <c:pt idx="90">
                    <c:v>3.9023427843521323E-3</c:v>
                  </c:pt>
                  <c:pt idx="91">
                    <c:v>3.7254671589211576E-3</c:v>
                  </c:pt>
                  <c:pt idx="92">
                    <c:v>3.5336994593905633E-3</c:v>
                  </c:pt>
                  <c:pt idx="93">
                    <c:v>3.3588539625086589E-3</c:v>
                  </c:pt>
                  <c:pt idx="94">
                    <c:v>3.2402148402998592E-3</c:v>
                  </c:pt>
                  <c:pt idx="95">
                    <c:v>3.1917529447950295E-3</c:v>
                  </c:pt>
                  <c:pt idx="96">
                    <c:v>3.2401491952106492E-3</c:v>
                  </c:pt>
                  <c:pt idx="97">
                    <c:v>3.3676369997575062E-3</c:v>
                  </c:pt>
                  <c:pt idx="98">
                    <c:v>3.5634620302251166E-3</c:v>
                  </c:pt>
                  <c:pt idx="99">
                    <c:v>3.7685932853786614E-3</c:v>
                  </c:pt>
                  <c:pt idx="100">
                    <c:v>3.9866648723250022E-3</c:v>
                  </c:pt>
                  <c:pt idx="101">
                    <c:v>4.1911070989859075E-3</c:v>
                  </c:pt>
                  <c:pt idx="102">
                    <c:v>4.3820757154842344E-3</c:v>
                  </c:pt>
                  <c:pt idx="103">
                    <c:v>4.5181612139283903E-3</c:v>
                  </c:pt>
                  <c:pt idx="104">
                    <c:v>4.6139154474366638E-3</c:v>
                  </c:pt>
                  <c:pt idx="105">
                    <c:v>4.6486547802486126E-3</c:v>
                  </c:pt>
                  <c:pt idx="106">
                    <c:v>4.6533297754242208E-3</c:v>
                  </c:pt>
                  <c:pt idx="107">
                    <c:v>4.6385131368057754E-3</c:v>
                  </c:pt>
                  <c:pt idx="108">
                    <c:v>4.6548751787877495E-3</c:v>
                  </c:pt>
                  <c:pt idx="109">
                    <c:v>4.6545921644656884E-3</c:v>
                  </c:pt>
                  <c:pt idx="110">
                    <c:v>4.628471926067584E-3</c:v>
                  </c:pt>
                  <c:pt idx="111">
                    <c:v>4.5772608997848175E-3</c:v>
                  </c:pt>
                  <c:pt idx="112">
                    <c:v>4.5422002034360628E-3</c:v>
                  </c:pt>
                  <c:pt idx="113">
                    <c:v>4.5147535258076681E-3</c:v>
                  </c:pt>
                  <c:pt idx="114">
                    <c:v>4.4817529162149419E-3</c:v>
                  </c:pt>
                  <c:pt idx="115">
                    <c:v>4.4968845424342724E-3</c:v>
                  </c:pt>
                  <c:pt idx="116">
                    <c:v>4.5461511161648503E-3</c:v>
                  </c:pt>
                  <c:pt idx="117">
                    <c:v>4.5590159786619774E-3</c:v>
                  </c:pt>
                  <c:pt idx="118">
                    <c:v>4.538786887182988E-3</c:v>
                  </c:pt>
                  <c:pt idx="119">
                    <c:v>4.5795239917481387E-3</c:v>
                  </c:pt>
                  <c:pt idx="120">
                    <c:v>4.6627787135747152E-3</c:v>
                  </c:pt>
                  <c:pt idx="121">
                    <c:v>4.7080844744086196E-3</c:v>
                  </c:pt>
                  <c:pt idx="122">
                    <c:v>4.6784882270481543E-3</c:v>
                  </c:pt>
                  <c:pt idx="123">
                    <c:v>4.6587396368566406E-3</c:v>
                  </c:pt>
                  <c:pt idx="124">
                    <c:v>4.584395618351382E-3</c:v>
                  </c:pt>
                  <c:pt idx="125">
                    <c:v>4.516104019669457E-3</c:v>
                  </c:pt>
                  <c:pt idx="126">
                    <c:v>4.5246062140157162E-3</c:v>
                  </c:pt>
                  <c:pt idx="127">
                    <c:v>4.6059088060468479E-3</c:v>
                  </c:pt>
                  <c:pt idx="128">
                    <c:v>4.6164321093872694E-3</c:v>
                  </c:pt>
                  <c:pt idx="129">
                    <c:v>4.6241714103071041E-3</c:v>
                  </c:pt>
                  <c:pt idx="130">
                    <c:v>4.6855624404368319E-3</c:v>
                  </c:pt>
                  <c:pt idx="131">
                    <c:v>4.7787448388153771E-3</c:v>
                  </c:pt>
                  <c:pt idx="132">
                    <c:v>4.8530479135624489E-3</c:v>
                  </c:pt>
                  <c:pt idx="133">
                    <c:v>4.9363375840146308E-3</c:v>
                  </c:pt>
                  <c:pt idx="134">
                    <c:v>4.9744748650924729E-3</c:v>
                  </c:pt>
                  <c:pt idx="135">
                    <c:v>5.048913876226125E-3</c:v>
                  </c:pt>
                  <c:pt idx="136">
                    <c:v>5.1001948276811256E-3</c:v>
                  </c:pt>
                  <c:pt idx="137">
                    <c:v>5.1686749653194353E-3</c:v>
                  </c:pt>
                  <c:pt idx="138">
                    <c:v>5.2365394566052641E-3</c:v>
                  </c:pt>
                  <c:pt idx="139">
                    <c:v>6.0860904378885819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x"/>
            <c:errBarType val="both"/>
            <c:errValType val="fixedVal"/>
            <c:noEndCap val="0"/>
            <c:val val="1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AVG healthy'!$BC$5:$BC$144</c:f>
              <c:numCache>
                <c:formatCode>General</c:formatCode>
                <c:ptCount val="140"/>
                <c:pt idx="0">
                  <c:v>451.25</c:v>
                </c:pt>
                <c:pt idx="1">
                  <c:v>454.040009</c:v>
                </c:pt>
                <c:pt idx="2">
                  <c:v>456.82000699999998</c:v>
                </c:pt>
                <c:pt idx="3">
                  <c:v>459.60998499999999</c:v>
                </c:pt>
                <c:pt idx="4">
                  <c:v>462.39999399999999</c:v>
                </c:pt>
                <c:pt idx="5">
                  <c:v>465.19000199999999</c:v>
                </c:pt>
                <c:pt idx="6">
                  <c:v>467.98001099999999</c:v>
                </c:pt>
                <c:pt idx="7">
                  <c:v>470.77999899999998</c:v>
                </c:pt>
                <c:pt idx="8">
                  <c:v>473.57000699999998</c:v>
                </c:pt>
                <c:pt idx="9">
                  <c:v>476.36999500000002</c:v>
                </c:pt>
                <c:pt idx="10">
                  <c:v>479.16000400000001</c:v>
                </c:pt>
                <c:pt idx="11">
                  <c:v>481.959991</c:v>
                </c:pt>
                <c:pt idx="12">
                  <c:v>484.76001000000002</c:v>
                </c:pt>
                <c:pt idx="13">
                  <c:v>487.55999800000001</c:v>
                </c:pt>
                <c:pt idx="14">
                  <c:v>490.35998499999999</c:v>
                </c:pt>
                <c:pt idx="15">
                  <c:v>493.16000400000001</c:v>
                </c:pt>
                <c:pt idx="16">
                  <c:v>495.97000100000002</c:v>
                </c:pt>
                <c:pt idx="17">
                  <c:v>498.76998900000001</c:v>
                </c:pt>
                <c:pt idx="18">
                  <c:v>501.57998700000002</c:v>
                </c:pt>
                <c:pt idx="19">
                  <c:v>504.39001500000001</c:v>
                </c:pt>
                <c:pt idx="20">
                  <c:v>507.19000199999999</c:v>
                </c:pt>
                <c:pt idx="21">
                  <c:v>510</c:v>
                </c:pt>
                <c:pt idx="22">
                  <c:v>512.80999799999995</c:v>
                </c:pt>
                <c:pt idx="23">
                  <c:v>515.63000499999998</c:v>
                </c:pt>
                <c:pt idx="24">
                  <c:v>518.44000200000005</c:v>
                </c:pt>
                <c:pt idx="25">
                  <c:v>521.25</c:v>
                </c:pt>
                <c:pt idx="26">
                  <c:v>524.07000700000003</c:v>
                </c:pt>
                <c:pt idx="27">
                  <c:v>526.88000499999998</c:v>
                </c:pt>
                <c:pt idx="28">
                  <c:v>529.70001200000002</c:v>
                </c:pt>
                <c:pt idx="29">
                  <c:v>532.52002000000005</c:v>
                </c:pt>
                <c:pt idx="30">
                  <c:v>535.34002699999996</c:v>
                </c:pt>
                <c:pt idx="31">
                  <c:v>538.15997300000004</c:v>
                </c:pt>
                <c:pt idx="32">
                  <c:v>540.98999000000003</c:v>
                </c:pt>
                <c:pt idx="33">
                  <c:v>543.80999799999995</c:v>
                </c:pt>
                <c:pt idx="34">
                  <c:v>546.63000499999998</c:v>
                </c:pt>
                <c:pt idx="35">
                  <c:v>549.46002199999998</c:v>
                </c:pt>
                <c:pt idx="36">
                  <c:v>552.28997800000002</c:v>
                </c:pt>
                <c:pt idx="37">
                  <c:v>555.11999500000002</c:v>
                </c:pt>
                <c:pt idx="38">
                  <c:v>557.94000200000005</c:v>
                </c:pt>
                <c:pt idx="39">
                  <c:v>560.78002900000001</c:v>
                </c:pt>
                <c:pt idx="40">
                  <c:v>563.60998500000005</c:v>
                </c:pt>
                <c:pt idx="41">
                  <c:v>566.44000200000005</c:v>
                </c:pt>
                <c:pt idx="42">
                  <c:v>569.27002000000005</c:v>
                </c:pt>
                <c:pt idx="43">
                  <c:v>572.10998500000005</c:v>
                </c:pt>
                <c:pt idx="44">
                  <c:v>574.95001200000002</c:v>
                </c:pt>
                <c:pt idx="45">
                  <c:v>577.78002900000001</c:v>
                </c:pt>
                <c:pt idx="46">
                  <c:v>580.61999500000002</c:v>
                </c:pt>
                <c:pt idx="47">
                  <c:v>583.46002199999998</c:v>
                </c:pt>
                <c:pt idx="48">
                  <c:v>586.29998799999998</c:v>
                </c:pt>
                <c:pt idx="49">
                  <c:v>589.15002400000003</c:v>
                </c:pt>
                <c:pt idx="50">
                  <c:v>591.98999000000003</c:v>
                </c:pt>
                <c:pt idx="51">
                  <c:v>594.84002699999996</c:v>
                </c:pt>
                <c:pt idx="52">
                  <c:v>597.67999299999997</c:v>
                </c:pt>
                <c:pt idx="53">
                  <c:v>600.53002900000001</c:v>
                </c:pt>
                <c:pt idx="54">
                  <c:v>603.38000499999998</c:v>
                </c:pt>
                <c:pt idx="55">
                  <c:v>606.22997999999995</c:v>
                </c:pt>
                <c:pt idx="56">
                  <c:v>609.080017</c:v>
                </c:pt>
                <c:pt idx="57">
                  <c:v>611.92999299999997</c:v>
                </c:pt>
                <c:pt idx="58">
                  <c:v>614.78002900000001</c:v>
                </c:pt>
                <c:pt idx="59">
                  <c:v>617.64001499999995</c:v>
                </c:pt>
                <c:pt idx="60">
                  <c:v>620.48999000000003</c:v>
                </c:pt>
                <c:pt idx="61">
                  <c:v>623.34997599999997</c:v>
                </c:pt>
                <c:pt idx="62">
                  <c:v>626.21002199999998</c:v>
                </c:pt>
                <c:pt idx="63">
                  <c:v>629.07000700000003</c:v>
                </c:pt>
                <c:pt idx="64">
                  <c:v>631.92999299999997</c:v>
                </c:pt>
                <c:pt idx="65">
                  <c:v>634.78997800000002</c:v>
                </c:pt>
                <c:pt idx="66">
                  <c:v>637.65002400000003</c:v>
                </c:pt>
                <c:pt idx="67">
                  <c:v>640.51000999999997</c:v>
                </c:pt>
                <c:pt idx="68">
                  <c:v>643.38000499999998</c:v>
                </c:pt>
                <c:pt idx="69">
                  <c:v>646.23999000000003</c:v>
                </c:pt>
                <c:pt idx="70">
                  <c:v>649.10998500000005</c:v>
                </c:pt>
                <c:pt idx="71">
                  <c:v>651.97997999999995</c:v>
                </c:pt>
                <c:pt idx="72">
                  <c:v>654.84997599999997</c:v>
                </c:pt>
                <c:pt idx="73">
                  <c:v>657.71997099999999</c:v>
                </c:pt>
                <c:pt idx="74">
                  <c:v>660.59002699999996</c:v>
                </c:pt>
                <c:pt idx="75">
                  <c:v>663.46997099999999</c:v>
                </c:pt>
                <c:pt idx="76">
                  <c:v>666.34002699999996</c:v>
                </c:pt>
                <c:pt idx="77">
                  <c:v>669.21997099999999</c:v>
                </c:pt>
                <c:pt idx="78">
                  <c:v>672.09002699999996</c:v>
                </c:pt>
                <c:pt idx="79">
                  <c:v>674.96997099999999</c:v>
                </c:pt>
                <c:pt idx="80">
                  <c:v>677.84997599999997</c:v>
                </c:pt>
                <c:pt idx="81">
                  <c:v>680.72997999999995</c:v>
                </c:pt>
                <c:pt idx="82">
                  <c:v>683.60998500000005</c:v>
                </c:pt>
                <c:pt idx="83">
                  <c:v>686.48999000000003</c:v>
                </c:pt>
                <c:pt idx="84">
                  <c:v>689.38000499999998</c:v>
                </c:pt>
                <c:pt idx="85">
                  <c:v>692.26000999999997</c:v>
                </c:pt>
                <c:pt idx="86">
                  <c:v>695.15002400000003</c:v>
                </c:pt>
                <c:pt idx="87">
                  <c:v>698.03002900000001</c:v>
                </c:pt>
                <c:pt idx="88">
                  <c:v>700.919983</c:v>
                </c:pt>
                <c:pt idx="89">
                  <c:v>703.80999799999995</c:v>
                </c:pt>
                <c:pt idx="90">
                  <c:v>706.70001200000002</c:v>
                </c:pt>
                <c:pt idx="91">
                  <c:v>709.59997599999997</c:v>
                </c:pt>
                <c:pt idx="92">
                  <c:v>712.48999000000003</c:v>
                </c:pt>
                <c:pt idx="93">
                  <c:v>715.38000499999998</c:v>
                </c:pt>
                <c:pt idx="94">
                  <c:v>718.28002900000001</c:v>
                </c:pt>
                <c:pt idx="95">
                  <c:v>721.17999299999997</c:v>
                </c:pt>
                <c:pt idx="96">
                  <c:v>724.07000700000003</c:v>
                </c:pt>
                <c:pt idx="97">
                  <c:v>726.96997099999999</c:v>
                </c:pt>
                <c:pt idx="98">
                  <c:v>729.86999500000002</c:v>
                </c:pt>
                <c:pt idx="99">
                  <c:v>732.77002000000005</c:v>
                </c:pt>
                <c:pt idx="100">
                  <c:v>735.67999299999997</c:v>
                </c:pt>
                <c:pt idx="101">
                  <c:v>738.580017</c:v>
                </c:pt>
                <c:pt idx="102">
                  <c:v>741.48999000000003</c:v>
                </c:pt>
                <c:pt idx="103">
                  <c:v>744.39001499999995</c:v>
                </c:pt>
                <c:pt idx="104">
                  <c:v>747.29998799999998</c:v>
                </c:pt>
                <c:pt idx="105">
                  <c:v>750.21002199999998</c:v>
                </c:pt>
                <c:pt idx="106">
                  <c:v>753.11999500000002</c:v>
                </c:pt>
                <c:pt idx="107">
                  <c:v>756.03002900000001</c:v>
                </c:pt>
                <c:pt idx="108">
                  <c:v>758.94000200000005</c:v>
                </c:pt>
                <c:pt idx="109">
                  <c:v>761.84997599999997</c:v>
                </c:pt>
                <c:pt idx="110">
                  <c:v>764.77002000000005</c:v>
                </c:pt>
                <c:pt idx="111">
                  <c:v>767.67999299999997</c:v>
                </c:pt>
                <c:pt idx="112">
                  <c:v>770.59997599999997</c:v>
                </c:pt>
                <c:pt idx="113">
                  <c:v>773.52002000000005</c:v>
                </c:pt>
                <c:pt idx="114">
                  <c:v>776.44000200000005</c:v>
                </c:pt>
                <c:pt idx="115">
                  <c:v>779.35998500000005</c:v>
                </c:pt>
                <c:pt idx="116">
                  <c:v>782.28002900000001</c:v>
                </c:pt>
                <c:pt idx="117">
                  <c:v>785.20001200000002</c:v>
                </c:pt>
                <c:pt idx="118">
                  <c:v>788.11999500000002</c:v>
                </c:pt>
                <c:pt idx="119">
                  <c:v>791.04998799999998</c:v>
                </c:pt>
                <c:pt idx="120">
                  <c:v>793.97997999999995</c:v>
                </c:pt>
                <c:pt idx="121">
                  <c:v>796.90002400000003</c:v>
                </c:pt>
                <c:pt idx="122">
                  <c:v>799.830017</c:v>
                </c:pt>
                <c:pt idx="123">
                  <c:v>802.76000999999997</c:v>
                </c:pt>
                <c:pt idx="124">
                  <c:v>805.69000200000005</c:v>
                </c:pt>
                <c:pt idx="125">
                  <c:v>808.61999500000002</c:v>
                </c:pt>
                <c:pt idx="126">
                  <c:v>811.55999799999995</c:v>
                </c:pt>
                <c:pt idx="127">
                  <c:v>814.48999000000003</c:v>
                </c:pt>
                <c:pt idx="128">
                  <c:v>817.42999299999997</c:v>
                </c:pt>
                <c:pt idx="129">
                  <c:v>820.35998500000005</c:v>
                </c:pt>
                <c:pt idx="130">
                  <c:v>823.29998799999998</c:v>
                </c:pt>
                <c:pt idx="131">
                  <c:v>826.23999000000003</c:v>
                </c:pt>
                <c:pt idx="132">
                  <c:v>829.17999299999997</c:v>
                </c:pt>
                <c:pt idx="133">
                  <c:v>832.11999500000002</c:v>
                </c:pt>
                <c:pt idx="134">
                  <c:v>835.07000700000003</c:v>
                </c:pt>
                <c:pt idx="135">
                  <c:v>838.01000999999997</c:v>
                </c:pt>
                <c:pt idx="136">
                  <c:v>840.95001200000002</c:v>
                </c:pt>
                <c:pt idx="137">
                  <c:v>843.90002400000003</c:v>
                </c:pt>
                <c:pt idx="138">
                  <c:v>846.84997599999997</c:v>
                </c:pt>
                <c:pt idx="139">
                  <c:v>849.79998799999998</c:v>
                </c:pt>
              </c:numCache>
            </c:numRef>
          </c:xVal>
          <c:yVal>
            <c:numRef>
              <c:f>'AVG healthy'!$BE$5:$BE$144</c:f>
              <c:numCache>
                <c:formatCode>General</c:formatCode>
                <c:ptCount val="140"/>
                <c:pt idx="0">
                  <c:v>5.2441874999999999E-2</c:v>
                </c:pt>
                <c:pt idx="1">
                  <c:v>5.2460062500000001E-2</c:v>
                </c:pt>
                <c:pt idx="2">
                  <c:v>5.2343937499999993E-2</c:v>
                </c:pt>
                <c:pt idx="3">
                  <c:v>5.2047000000000003E-2</c:v>
                </c:pt>
                <c:pt idx="4">
                  <c:v>5.1686999999999997E-2</c:v>
                </c:pt>
                <c:pt idx="5">
                  <c:v>5.1348125000000001E-2</c:v>
                </c:pt>
                <c:pt idx="6">
                  <c:v>5.1080374999999997E-2</c:v>
                </c:pt>
                <c:pt idx="7">
                  <c:v>5.0849187500000004E-2</c:v>
                </c:pt>
                <c:pt idx="8">
                  <c:v>5.0594187499999999E-2</c:v>
                </c:pt>
                <c:pt idx="9">
                  <c:v>5.0416499999999989E-2</c:v>
                </c:pt>
                <c:pt idx="10">
                  <c:v>5.0277562499999998E-2</c:v>
                </c:pt>
                <c:pt idx="11">
                  <c:v>5.0186750000000002E-2</c:v>
                </c:pt>
                <c:pt idx="12">
                  <c:v>5.0136187499999998E-2</c:v>
                </c:pt>
                <c:pt idx="13">
                  <c:v>5.0416749999999996E-2</c:v>
                </c:pt>
                <c:pt idx="14">
                  <c:v>5.0997249999999994E-2</c:v>
                </c:pt>
                <c:pt idx="15">
                  <c:v>5.1870625000000004E-2</c:v>
                </c:pt>
                <c:pt idx="16">
                  <c:v>5.3005437499999995E-2</c:v>
                </c:pt>
                <c:pt idx="17">
                  <c:v>5.4614999999999997E-2</c:v>
                </c:pt>
                <c:pt idx="18">
                  <c:v>5.6952937499999995E-2</c:v>
                </c:pt>
                <c:pt idx="19">
                  <c:v>6.0109499999999996E-2</c:v>
                </c:pt>
                <c:pt idx="20">
                  <c:v>6.4318750000000008E-2</c:v>
                </c:pt>
                <c:pt idx="21">
                  <c:v>6.971150000000001E-2</c:v>
                </c:pt>
                <c:pt idx="22">
                  <c:v>7.6528312500000001E-2</c:v>
                </c:pt>
                <c:pt idx="23">
                  <c:v>8.47563125E-2</c:v>
                </c:pt>
                <c:pt idx="24">
                  <c:v>9.4285499999999994E-2</c:v>
                </c:pt>
                <c:pt idx="25">
                  <c:v>0.1046750625</c:v>
                </c:pt>
                <c:pt idx="26">
                  <c:v>0.115239625</c:v>
                </c:pt>
                <c:pt idx="27">
                  <c:v>0.12514287499999999</c:v>
                </c:pt>
                <c:pt idx="28">
                  <c:v>0.13361243749999999</c:v>
                </c:pt>
                <c:pt idx="29">
                  <c:v>0.14028956249999996</c:v>
                </c:pt>
                <c:pt idx="30">
                  <c:v>0.14525456250000002</c:v>
                </c:pt>
                <c:pt idx="31">
                  <c:v>0.14880968750000001</c:v>
                </c:pt>
                <c:pt idx="32">
                  <c:v>0.15135956249999999</c:v>
                </c:pt>
                <c:pt idx="33">
                  <c:v>0.15339125000000003</c:v>
                </c:pt>
                <c:pt idx="34">
                  <c:v>0.15526818749999999</c:v>
                </c:pt>
                <c:pt idx="35">
                  <c:v>0.15694225000000001</c:v>
                </c:pt>
                <c:pt idx="36">
                  <c:v>0.15810712499999999</c:v>
                </c:pt>
                <c:pt idx="37">
                  <c:v>0.15827231250000001</c:v>
                </c:pt>
                <c:pt idx="38">
                  <c:v>0.15718556249999999</c:v>
                </c:pt>
                <c:pt idx="39">
                  <c:v>0.15483112499999999</c:v>
                </c:pt>
                <c:pt idx="40">
                  <c:v>0.15143862499999999</c:v>
                </c:pt>
                <c:pt idx="41">
                  <c:v>0.14701131250000002</c:v>
                </c:pt>
                <c:pt idx="42">
                  <c:v>0.14164625</c:v>
                </c:pt>
                <c:pt idx="43">
                  <c:v>0.135723125</c:v>
                </c:pt>
                <c:pt idx="44">
                  <c:v>0.12995962499999997</c:v>
                </c:pt>
                <c:pt idx="45">
                  <c:v>0.124812375</c:v>
                </c:pt>
                <c:pt idx="46">
                  <c:v>0.12041612500000001</c:v>
                </c:pt>
                <c:pt idx="47">
                  <c:v>0.11665837499999999</c:v>
                </c:pt>
                <c:pt idx="48">
                  <c:v>0.1135004375</c:v>
                </c:pt>
                <c:pt idx="49">
                  <c:v>0.11088606249999999</c:v>
                </c:pt>
                <c:pt idx="50">
                  <c:v>0.10884256249999999</c:v>
                </c:pt>
                <c:pt idx="51">
                  <c:v>0.10728987500000001</c:v>
                </c:pt>
                <c:pt idx="52">
                  <c:v>0.10606362499999999</c:v>
                </c:pt>
                <c:pt idx="53">
                  <c:v>0.10482724999999998</c:v>
                </c:pt>
                <c:pt idx="54">
                  <c:v>0.10322625000000001</c:v>
                </c:pt>
                <c:pt idx="55">
                  <c:v>0.10093225</c:v>
                </c:pt>
                <c:pt idx="56">
                  <c:v>9.7949875000000006E-2</c:v>
                </c:pt>
                <c:pt idx="57">
                  <c:v>9.4545500000000005E-2</c:v>
                </c:pt>
                <c:pt idx="58">
                  <c:v>9.1097000000000011E-2</c:v>
                </c:pt>
                <c:pt idx="59">
                  <c:v>8.7976687500000011E-2</c:v>
                </c:pt>
                <c:pt idx="60">
                  <c:v>8.5476500000000011E-2</c:v>
                </c:pt>
                <c:pt idx="61">
                  <c:v>8.3736312499999993E-2</c:v>
                </c:pt>
                <c:pt idx="62">
                  <c:v>8.2720999999999989E-2</c:v>
                </c:pt>
                <c:pt idx="63">
                  <c:v>8.2229374999999993E-2</c:v>
                </c:pt>
                <c:pt idx="64">
                  <c:v>8.1698937500000013E-2</c:v>
                </c:pt>
                <c:pt idx="65">
                  <c:v>8.0498812500000003E-2</c:v>
                </c:pt>
                <c:pt idx="66">
                  <c:v>7.8292562499999996E-2</c:v>
                </c:pt>
                <c:pt idx="67">
                  <c:v>7.5304187499999994E-2</c:v>
                </c:pt>
                <c:pt idx="68">
                  <c:v>7.1893249999999992E-2</c:v>
                </c:pt>
                <c:pt idx="69">
                  <c:v>6.8523749999999994E-2</c:v>
                </c:pt>
                <c:pt idx="70">
                  <c:v>6.5603374999999992E-2</c:v>
                </c:pt>
                <c:pt idx="71">
                  <c:v>6.3245312499999998E-2</c:v>
                </c:pt>
                <c:pt idx="72">
                  <c:v>6.0958375000000002E-2</c:v>
                </c:pt>
                <c:pt idx="73">
                  <c:v>5.8274499999999993E-2</c:v>
                </c:pt>
                <c:pt idx="74">
                  <c:v>5.52128125E-2</c:v>
                </c:pt>
                <c:pt idx="75">
                  <c:v>5.2158749999999997E-2</c:v>
                </c:pt>
                <c:pt idx="76">
                  <c:v>4.9426874999999995E-2</c:v>
                </c:pt>
                <c:pt idx="77">
                  <c:v>4.7290499999999999E-2</c:v>
                </c:pt>
                <c:pt idx="78">
                  <c:v>4.59606875E-2</c:v>
                </c:pt>
                <c:pt idx="79">
                  <c:v>4.5538749999999996E-2</c:v>
                </c:pt>
                <c:pt idx="80">
                  <c:v>4.6022812500000003E-2</c:v>
                </c:pt>
                <c:pt idx="81">
                  <c:v>4.7477812499999994E-2</c:v>
                </c:pt>
                <c:pt idx="82">
                  <c:v>5.0212125000000003E-2</c:v>
                </c:pt>
                <c:pt idx="83">
                  <c:v>5.5095249999999998E-2</c:v>
                </c:pt>
                <c:pt idx="84">
                  <c:v>6.3713312499999994E-2</c:v>
                </c:pt>
                <c:pt idx="85">
                  <c:v>7.7642437499999994E-2</c:v>
                </c:pt>
                <c:pt idx="86">
                  <c:v>9.7515062500000013E-2</c:v>
                </c:pt>
                <c:pt idx="87">
                  <c:v>0.1223466875</c:v>
                </c:pt>
                <c:pt idx="88">
                  <c:v>0.1494849375</c:v>
                </c:pt>
                <c:pt idx="89">
                  <c:v>0.17579706249999999</c:v>
                </c:pt>
                <c:pt idx="90">
                  <c:v>0.19948712499999999</c:v>
                </c:pt>
                <c:pt idx="91">
                  <c:v>0.22049987500000001</c:v>
                </c:pt>
                <c:pt idx="92">
                  <c:v>0.23955100000000001</c:v>
                </c:pt>
                <c:pt idx="93">
                  <c:v>0.25702981250000001</c:v>
                </c:pt>
                <c:pt idx="94">
                  <c:v>0.27306981249999995</c:v>
                </c:pt>
                <c:pt idx="95">
                  <c:v>0.28757525</c:v>
                </c:pt>
                <c:pt idx="96">
                  <c:v>0.30062500000000003</c:v>
                </c:pt>
                <c:pt idx="97">
                  <c:v>0.31238437500000005</c:v>
                </c:pt>
                <c:pt idx="98">
                  <c:v>0.32278125000000002</c:v>
                </c:pt>
                <c:pt idx="99">
                  <c:v>0.33165900000000004</c:v>
                </c:pt>
                <c:pt idx="100">
                  <c:v>0.33917787499999996</c:v>
                </c:pt>
                <c:pt idx="101">
                  <c:v>0.34545287499999999</c:v>
                </c:pt>
                <c:pt idx="102">
                  <c:v>0.350385</c:v>
                </c:pt>
                <c:pt idx="103">
                  <c:v>0.35396349999999999</c:v>
                </c:pt>
                <c:pt idx="104">
                  <c:v>0.3566645625</c:v>
                </c:pt>
                <c:pt idx="105">
                  <c:v>0.35879625000000004</c:v>
                </c:pt>
                <c:pt idx="106">
                  <c:v>0.3604754375</c:v>
                </c:pt>
                <c:pt idx="107">
                  <c:v>0.3620536875</c:v>
                </c:pt>
                <c:pt idx="108">
                  <c:v>0.36344968749999995</c:v>
                </c:pt>
                <c:pt idx="109">
                  <c:v>0.36460843749999999</c:v>
                </c:pt>
                <c:pt idx="110">
                  <c:v>0.36577706249999997</c:v>
                </c:pt>
                <c:pt idx="111">
                  <c:v>0.36709356250000003</c:v>
                </c:pt>
                <c:pt idx="112">
                  <c:v>0.36817937499999998</c:v>
                </c:pt>
                <c:pt idx="113">
                  <c:v>0.36901668750000005</c:v>
                </c:pt>
                <c:pt idx="114">
                  <c:v>0.36974974999999999</c:v>
                </c:pt>
                <c:pt idx="115">
                  <c:v>0.37009025000000001</c:v>
                </c:pt>
                <c:pt idx="116">
                  <c:v>0.37001481250000001</c:v>
                </c:pt>
                <c:pt idx="117">
                  <c:v>0.36981531249999999</c:v>
                </c:pt>
                <c:pt idx="118">
                  <c:v>0.36942418749999995</c:v>
                </c:pt>
                <c:pt idx="119">
                  <c:v>0.36878381250000003</c:v>
                </c:pt>
                <c:pt idx="120">
                  <c:v>0.367839625</c:v>
                </c:pt>
                <c:pt idx="121">
                  <c:v>0.36654106249999996</c:v>
                </c:pt>
                <c:pt idx="122">
                  <c:v>0.3650314375</c:v>
                </c:pt>
                <c:pt idx="123">
                  <c:v>0.3637534375</c:v>
                </c:pt>
                <c:pt idx="124">
                  <c:v>0.36298168749999998</c:v>
                </c:pt>
                <c:pt idx="125">
                  <c:v>0.36244681249999999</c:v>
                </c:pt>
                <c:pt idx="126">
                  <c:v>0.36169037500000001</c:v>
                </c:pt>
                <c:pt idx="127">
                  <c:v>0.36083518749999999</c:v>
                </c:pt>
                <c:pt idx="128">
                  <c:v>0.36007975000000003</c:v>
                </c:pt>
                <c:pt idx="129">
                  <c:v>0.35959968749999993</c:v>
                </c:pt>
                <c:pt idx="130">
                  <c:v>0.35910168749999999</c:v>
                </c:pt>
                <c:pt idx="131">
                  <c:v>0.35865837499999997</c:v>
                </c:pt>
                <c:pt idx="132">
                  <c:v>0.3584858125</c:v>
                </c:pt>
                <c:pt idx="133">
                  <c:v>0.35856850000000001</c:v>
                </c:pt>
                <c:pt idx="134">
                  <c:v>0.35875887500000003</c:v>
                </c:pt>
                <c:pt idx="135">
                  <c:v>0.35917868750000004</c:v>
                </c:pt>
                <c:pt idx="136">
                  <c:v>0.35980806249999997</c:v>
                </c:pt>
                <c:pt idx="137">
                  <c:v>0.36072156249999998</c:v>
                </c:pt>
                <c:pt idx="138">
                  <c:v>0.361583875</c:v>
                </c:pt>
                <c:pt idx="139">
                  <c:v>0.362219375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58CB-495F-A5F3-069958DEBAFD}"/>
            </c:ext>
          </c:extLst>
        </c:ser>
        <c:ser>
          <c:idx val="2"/>
          <c:order val="2"/>
          <c:tx>
            <c:strRef>
              <c:f>'AVG healthy'!$BF$4</c:f>
              <c:strCache>
                <c:ptCount val="1"/>
                <c:pt idx="0">
                  <c:v> IR64 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1"/>
            <c:plus>
              <c:numRef>
                <c:f>'AVG healthy'!$BI$5:$BI$144</c:f>
                <c:numCache>
                  <c:formatCode>General</c:formatCode>
                  <c:ptCount val="140"/>
                  <c:pt idx="0">
                    <c:v>5.1800821043447934E-4</c:v>
                  </c:pt>
                  <c:pt idx="1">
                    <c:v>5.420464638777715E-4</c:v>
                  </c:pt>
                  <c:pt idx="2">
                    <c:v>5.5627517091518387E-4</c:v>
                  </c:pt>
                  <c:pt idx="3">
                    <c:v>5.4724099387543741E-4</c:v>
                  </c:pt>
                  <c:pt idx="4">
                    <c:v>5.4465012334778992E-4</c:v>
                  </c:pt>
                  <c:pt idx="5">
                    <c:v>5.4771087690853339E-4</c:v>
                  </c:pt>
                  <c:pt idx="6">
                    <c:v>5.3517767140332081E-4</c:v>
                  </c:pt>
                  <c:pt idx="7">
                    <c:v>5.3158493655740529E-4</c:v>
                  </c:pt>
                  <c:pt idx="8">
                    <c:v>5.356421837759295E-4</c:v>
                  </c:pt>
                  <c:pt idx="9">
                    <c:v>5.8799510194741157E-4</c:v>
                  </c:pt>
                  <c:pt idx="10">
                    <c:v>5.9962756670824623E-4</c:v>
                  </c:pt>
                  <c:pt idx="11">
                    <c:v>5.7936703492010469E-4</c:v>
                  </c:pt>
                  <c:pt idx="12">
                    <c:v>5.5385476446907788E-4</c:v>
                  </c:pt>
                  <c:pt idx="13">
                    <c:v>5.8025575531342748E-4</c:v>
                  </c:pt>
                  <c:pt idx="14">
                    <c:v>6.0959709571103472E-4</c:v>
                  </c:pt>
                  <c:pt idx="15">
                    <c:v>6.2054151961322057E-4</c:v>
                  </c:pt>
                  <c:pt idx="16">
                    <c:v>6.3299840494473753E-4</c:v>
                  </c:pt>
                  <c:pt idx="17">
                    <c:v>6.7850301580650162E-4</c:v>
                  </c:pt>
                  <c:pt idx="18">
                    <c:v>7.3206506825181138E-4</c:v>
                  </c:pt>
                  <c:pt idx="19">
                    <c:v>7.7473728358714883E-4</c:v>
                  </c:pt>
                  <c:pt idx="20">
                    <c:v>8.2666846783287066E-4</c:v>
                  </c:pt>
                  <c:pt idx="21">
                    <c:v>9.2058831562269287E-4</c:v>
                  </c:pt>
                  <c:pt idx="22">
                    <c:v>1.0329850459344376E-3</c:v>
                  </c:pt>
                  <c:pt idx="23">
                    <c:v>1.1395503834553194E-3</c:v>
                  </c:pt>
                  <c:pt idx="24">
                    <c:v>1.240895095235699E-3</c:v>
                  </c:pt>
                  <c:pt idx="25">
                    <c:v>1.3575457929403917E-3</c:v>
                  </c:pt>
                  <c:pt idx="26">
                    <c:v>1.4681361343971831E-3</c:v>
                  </c:pt>
                  <c:pt idx="27">
                    <c:v>1.539653907575312E-3</c:v>
                  </c:pt>
                  <c:pt idx="28">
                    <c:v>1.575343142568149E-3</c:v>
                  </c:pt>
                  <c:pt idx="29">
                    <c:v>1.609046201772915E-3</c:v>
                  </c:pt>
                  <c:pt idx="30">
                    <c:v>1.6463757104553905E-3</c:v>
                  </c:pt>
                  <c:pt idx="31">
                    <c:v>1.6613205221738484E-3</c:v>
                  </c:pt>
                  <c:pt idx="32">
                    <c:v>1.6855243740511398E-3</c:v>
                  </c:pt>
                  <c:pt idx="33">
                    <c:v>1.7252938904906111E-3</c:v>
                  </c:pt>
                  <c:pt idx="34">
                    <c:v>1.777166803180061E-3</c:v>
                  </c:pt>
                  <c:pt idx="35">
                    <c:v>1.814810274766161E-3</c:v>
                  </c:pt>
                  <c:pt idx="36">
                    <c:v>1.8438402396853027E-3</c:v>
                  </c:pt>
                  <c:pt idx="37">
                    <c:v>1.8686241505683342E-3</c:v>
                  </c:pt>
                  <c:pt idx="38">
                    <c:v>1.8856770575846865E-3</c:v>
                  </c:pt>
                  <c:pt idx="39">
                    <c:v>1.8919571097705166E-3</c:v>
                  </c:pt>
                  <c:pt idx="40">
                    <c:v>1.8824085037877673E-3</c:v>
                  </c:pt>
                  <c:pt idx="41">
                    <c:v>1.8698191175019307E-3</c:v>
                  </c:pt>
                  <c:pt idx="42">
                    <c:v>1.8537255909126383E-3</c:v>
                  </c:pt>
                  <c:pt idx="43">
                    <c:v>1.815065599725784E-3</c:v>
                  </c:pt>
                  <c:pt idx="44">
                    <c:v>1.7680033468394009E-3</c:v>
                  </c:pt>
                  <c:pt idx="45">
                    <c:v>1.7160849504198033E-3</c:v>
                  </c:pt>
                  <c:pt idx="46">
                    <c:v>1.6776970539775457E-3</c:v>
                  </c:pt>
                  <c:pt idx="47">
                    <c:v>1.6386253208999896E-3</c:v>
                  </c:pt>
                  <c:pt idx="48">
                    <c:v>1.6057537927621989E-3</c:v>
                  </c:pt>
                  <c:pt idx="49">
                    <c:v>1.5724567286213719E-3</c:v>
                  </c:pt>
                  <c:pt idx="50">
                    <c:v>1.5547460739005173E-3</c:v>
                  </c:pt>
                  <c:pt idx="51">
                    <c:v>1.5404398882199204E-3</c:v>
                  </c:pt>
                  <c:pt idx="52">
                    <c:v>1.5344591942208165E-3</c:v>
                  </c:pt>
                  <c:pt idx="53">
                    <c:v>1.5259028537409824E-3</c:v>
                  </c:pt>
                  <c:pt idx="54">
                    <c:v>1.5117761771702323E-3</c:v>
                  </c:pt>
                  <c:pt idx="55">
                    <c:v>1.4778139093933104E-3</c:v>
                  </c:pt>
                  <c:pt idx="56">
                    <c:v>1.4292533237256436E-3</c:v>
                  </c:pt>
                  <c:pt idx="57">
                    <c:v>1.3774329855198236E-3</c:v>
                  </c:pt>
                  <c:pt idx="58">
                    <c:v>1.3284504743003235E-3</c:v>
                  </c:pt>
                  <c:pt idx="59">
                    <c:v>1.2828232829660583E-3</c:v>
                  </c:pt>
                  <c:pt idx="60">
                    <c:v>1.2451145905662021E-3</c:v>
                  </c:pt>
                  <c:pt idx="61">
                    <c:v>1.2195783250183111E-3</c:v>
                  </c:pt>
                  <c:pt idx="62">
                    <c:v>1.20360987462902E-3</c:v>
                  </c:pt>
                  <c:pt idx="63">
                    <c:v>1.1939731958261128E-3</c:v>
                  </c:pt>
                  <c:pt idx="64">
                    <c:v>1.1885418980677686E-3</c:v>
                  </c:pt>
                  <c:pt idx="65">
                    <c:v>1.1742989537521281E-3</c:v>
                  </c:pt>
                  <c:pt idx="66">
                    <c:v>1.1473841433770624E-3</c:v>
                  </c:pt>
                  <c:pt idx="67">
                    <c:v>1.1092417682981516E-3</c:v>
                  </c:pt>
                  <c:pt idx="68">
                    <c:v>1.064252239794228E-3</c:v>
                  </c:pt>
                  <c:pt idx="69">
                    <c:v>1.0166901903540934E-3</c:v>
                  </c:pt>
                  <c:pt idx="70">
                    <c:v>9.7258615243544469E-4</c:v>
                  </c:pt>
                  <c:pt idx="71">
                    <c:v>9.2701394061629283E-4</c:v>
                  </c:pt>
                  <c:pt idx="72">
                    <c:v>8.7596692508964762E-4</c:v>
                  </c:pt>
                  <c:pt idx="73">
                    <c:v>8.1601788844266464E-4</c:v>
                  </c:pt>
                  <c:pt idx="74">
                    <c:v>7.5159831039815382E-4</c:v>
                  </c:pt>
                  <c:pt idx="75">
                    <c:v>6.9304374210891475E-4</c:v>
                  </c:pt>
                  <c:pt idx="76">
                    <c:v>6.4559642347941236E-4</c:v>
                  </c:pt>
                  <c:pt idx="77">
                    <c:v>6.1467594359890438E-4</c:v>
                  </c:pt>
                  <c:pt idx="78">
                    <c:v>6.0106946174147261E-4</c:v>
                  </c:pt>
                  <c:pt idx="79">
                    <c:v>6.0669814677310346E-4</c:v>
                  </c:pt>
                  <c:pt idx="80">
                    <c:v>6.2145639713029333E-4</c:v>
                  </c:pt>
                  <c:pt idx="81">
                    <c:v>6.9987103559455293E-4</c:v>
                  </c:pt>
                  <c:pt idx="82">
                    <c:v>8.1807683675281986E-4</c:v>
                  </c:pt>
                  <c:pt idx="83">
                    <c:v>8.7293745551543761E-4</c:v>
                  </c:pt>
                  <c:pt idx="84">
                    <c:v>8.7113162296419545E-4</c:v>
                  </c:pt>
                  <c:pt idx="85">
                    <c:v>9.218557406500727E-4</c:v>
                  </c:pt>
                  <c:pt idx="86">
                    <c:v>1.1081826173559191E-3</c:v>
                  </c:pt>
                  <c:pt idx="87">
                    <c:v>1.3255271980187281E-3</c:v>
                  </c:pt>
                  <c:pt idx="88">
                    <c:v>1.522804105836498E-3</c:v>
                  </c:pt>
                  <c:pt idx="89">
                    <c:v>1.6761693666342485E-3</c:v>
                  </c:pt>
                  <c:pt idx="90">
                    <c:v>1.7618440209524746E-3</c:v>
                  </c:pt>
                  <c:pt idx="91">
                    <c:v>1.7880267634545997E-3</c:v>
                  </c:pt>
                  <c:pt idx="92">
                    <c:v>1.7678870807685571E-3</c:v>
                  </c:pt>
                  <c:pt idx="93">
                    <c:v>1.7232417341769384E-3</c:v>
                  </c:pt>
                  <c:pt idx="94">
                    <c:v>1.6483060458313483E-3</c:v>
                  </c:pt>
                  <c:pt idx="95">
                    <c:v>1.5483377188930587E-3</c:v>
                  </c:pt>
                  <c:pt idx="96">
                    <c:v>1.4454308546378643E-3</c:v>
                  </c:pt>
                  <c:pt idx="97">
                    <c:v>1.3283150594144554E-3</c:v>
                  </c:pt>
                  <c:pt idx="98">
                    <c:v>1.2432778549046305E-3</c:v>
                  </c:pt>
                  <c:pt idx="99">
                    <c:v>1.1846291520828749E-3</c:v>
                  </c:pt>
                  <c:pt idx="100">
                    <c:v>1.2030623260626254E-3</c:v>
                  </c:pt>
                  <c:pt idx="101">
                    <c:v>1.2204094336436156E-3</c:v>
                  </c:pt>
                  <c:pt idx="102">
                    <c:v>1.2265977239592617E-3</c:v>
                  </c:pt>
                  <c:pt idx="103">
                    <c:v>1.2179754822047668E-3</c:v>
                  </c:pt>
                  <c:pt idx="104">
                    <c:v>1.1798000264434539E-3</c:v>
                  </c:pt>
                  <c:pt idx="105">
                    <c:v>1.0894972074741835E-3</c:v>
                  </c:pt>
                  <c:pt idx="106">
                    <c:v>1.0121703329958529E-3</c:v>
                  </c:pt>
                  <c:pt idx="107">
                    <c:v>9.6136207642657525E-4</c:v>
                  </c:pt>
                  <c:pt idx="108">
                    <c:v>9.6655095404608903E-4</c:v>
                  </c:pt>
                  <c:pt idx="109">
                    <c:v>9.8533714980623618E-4</c:v>
                  </c:pt>
                  <c:pt idx="110">
                    <c:v>9.8796708330774544E-4</c:v>
                  </c:pt>
                  <c:pt idx="111">
                    <c:v>9.7573951463991889E-4</c:v>
                  </c:pt>
                  <c:pt idx="112">
                    <c:v>9.588231704493734E-4</c:v>
                  </c:pt>
                  <c:pt idx="113">
                    <c:v>9.2179954689301411E-4</c:v>
                  </c:pt>
                  <c:pt idx="114">
                    <c:v>9.2705246894949278E-4</c:v>
                  </c:pt>
                  <c:pt idx="115">
                    <c:v>9.5285348216949187E-4</c:v>
                  </c:pt>
                  <c:pt idx="116">
                    <c:v>9.6576167455884702E-4</c:v>
                  </c:pt>
                  <c:pt idx="117">
                    <c:v>9.7213535653170255E-4</c:v>
                  </c:pt>
                  <c:pt idx="118">
                    <c:v>1.0378126051993411E-3</c:v>
                  </c:pt>
                  <c:pt idx="119">
                    <c:v>1.1145963531042722E-3</c:v>
                  </c:pt>
                  <c:pt idx="120">
                    <c:v>1.1622869765886758E-3</c:v>
                  </c:pt>
                  <c:pt idx="121">
                    <c:v>1.1728010920097356E-3</c:v>
                  </c:pt>
                  <c:pt idx="122">
                    <c:v>1.1549166864436718E-3</c:v>
                  </c:pt>
                  <c:pt idx="123">
                    <c:v>1.1335540945694707E-3</c:v>
                  </c:pt>
                  <c:pt idx="124">
                    <c:v>1.1846084382539932E-3</c:v>
                  </c:pt>
                  <c:pt idx="125">
                    <c:v>1.2037613765730659E-3</c:v>
                  </c:pt>
                  <c:pt idx="126">
                    <c:v>1.1637618512861418E-3</c:v>
                  </c:pt>
                  <c:pt idx="127">
                    <c:v>1.1187695343673658E-3</c:v>
                  </c:pt>
                  <c:pt idx="128">
                    <c:v>1.1587568207734661E-3</c:v>
                  </c:pt>
                  <c:pt idx="129">
                    <c:v>1.1283048625274909E-3</c:v>
                  </c:pt>
                  <c:pt idx="130">
                    <c:v>1.0532073283293746E-3</c:v>
                  </c:pt>
                  <c:pt idx="131">
                    <c:v>1.0561744478921331E-3</c:v>
                  </c:pt>
                  <c:pt idx="132">
                    <c:v>1.1214637367511317E-3</c:v>
                  </c:pt>
                  <c:pt idx="133">
                    <c:v>1.2288779269051216E-3</c:v>
                  </c:pt>
                  <c:pt idx="134">
                    <c:v>1.3074623878593728E-3</c:v>
                  </c:pt>
                  <c:pt idx="135">
                    <c:v>1.4134127505667604E-3</c:v>
                  </c:pt>
                  <c:pt idx="136">
                    <c:v>1.4754018209397557E-3</c:v>
                  </c:pt>
                  <c:pt idx="137">
                    <c:v>1.583010762371455E-3</c:v>
                  </c:pt>
                  <c:pt idx="138">
                    <c:v>1.6092609383119641E-3</c:v>
                  </c:pt>
                  <c:pt idx="139">
                    <c:v>1.6026361958938395E-3</c:v>
                  </c:pt>
                </c:numCache>
              </c:numRef>
            </c:plus>
            <c:minus>
              <c:numRef>
                <c:f>'AVG healthy'!$BI$5:$BI$144</c:f>
                <c:numCache>
                  <c:formatCode>General</c:formatCode>
                  <c:ptCount val="140"/>
                  <c:pt idx="0">
                    <c:v>5.1800821043447934E-4</c:v>
                  </c:pt>
                  <c:pt idx="1">
                    <c:v>5.420464638777715E-4</c:v>
                  </c:pt>
                  <c:pt idx="2">
                    <c:v>5.5627517091518387E-4</c:v>
                  </c:pt>
                  <c:pt idx="3">
                    <c:v>5.4724099387543741E-4</c:v>
                  </c:pt>
                  <c:pt idx="4">
                    <c:v>5.4465012334778992E-4</c:v>
                  </c:pt>
                  <c:pt idx="5">
                    <c:v>5.4771087690853339E-4</c:v>
                  </c:pt>
                  <c:pt idx="6">
                    <c:v>5.3517767140332081E-4</c:v>
                  </c:pt>
                  <c:pt idx="7">
                    <c:v>5.3158493655740529E-4</c:v>
                  </c:pt>
                  <c:pt idx="8">
                    <c:v>5.356421837759295E-4</c:v>
                  </c:pt>
                  <c:pt idx="9">
                    <c:v>5.8799510194741157E-4</c:v>
                  </c:pt>
                  <c:pt idx="10">
                    <c:v>5.9962756670824623E-4</c:v>
                  </c:pt>
                  <c:pt idx="11">
                    <c:v>5.7936703492010469E-4</c:v>
                  </c:pt>
                  <c:pt idx="12">
                    <c:v>5.5385476446907788E-4</c:v>
                  </c:pt>
                  <c:pt idx="13">
                    <c:v>5.8025575531342748E-4</c:v>
                  </c:pt>
                  <c:pt idx="14">
                    <c:v>6.0959709571103472E-4</c:v>
                  </c:pt>
                  <c:pt idx="15">
                    <c:v>6.2054151961322057E-4</c:v>
                  </c:pt>
                  <c:pt idx="16">
                    <c:v>6.3299840494473753E-4</c:v>
                  </c:pt>
                  <c:pt idx="17">
                    <c:v>6.7850301580650162E-4</c:v>
                  </c:pt>
                  <c:pt idx="18">
                    <c:v>7.3206506825181138E-4</c:v>
                  </c:pt>
                  <c:pt idx="19">
                    <c:v>7.7473728358714883E-4</c:v>
                  </c:pt>
                  <c:pt idx="20">
                    <c:v>8.2666846783287066E-4</c:v>
                  </c:pt>
                  <c:pt idx="21">
                    <c:v>9.2058831562269287E-4</c:v>
                  </c:pt>
                  <c:pt idx="22">
                    <c:v>1.0329850459344376E-3</c:v>
                  </c:pt>
                  <c:pt idx="23">
                    <c:v>1.1395503834553194E-3</c:v>
                  </c:pt>
                  <c:pt idx="24">
                    <c:v>1.240895095235699E-3</c:v>
                  </c:pt>
                  <c:pt idx="25">
                    <c:v>1.3575457929403917E-3</c:v>
                  </c:pt>
                  <c:pt idx="26">
                    <c:v>1.4681361343971831E-3</c:v>
                  </c:pt>
                  <c:pt idx="27">
                    <c:v>1.539653907575312E-3</c:v>
                  </c:pt>
                  <c:pt idx="28">
                    <c:v>1.575343142568149E-3</c:v>
                  </c:pt>
                  <c:pt idx="29">
                    <c:v>1.609046201772915E-3</c:v>
                  </c:pt>
                  <c:pt idx="30">
                    <c:v>1.6463757104553905E-3</c:v>
                  </c:pt>
                  <c:pt idx="31">
                    <c:v>1.6613205221738484E-3</c:v>
                  </c:pt>
                  <c:pt idx="32">
                    <c:v>1.6855243740511398E-3</c:v>
                  </c:pt>
                  <c:pt idx="33">
                    <c:v>1.7252938904906111E-3</c:v>
                  </c:pt>
                  <c:pt idx="34">
                    <c:v>1.777166803180061E-3</c:v>
                  </c:pt>
                  <c:pt idx="35">
                    <c:v>1.814810274766161E-3</c:v>
                  </c:pt>
                  <c:pt idx="36">
                    <c:v>1.8438402396853027E-3</c:v>
                  </c:pt>
                  <c:pt idx="37">
                    <c:v>1.8686241505683342E-3</c:v>
                  </c:pt>
                  <c:pt idx="38">
                    <c:v>1.8856770575846865E-3</c:v>
                  </c:pt>
                  <c:pt idx="39">
                    <c:v>1.8919571097705166E-3</c:v>
                  </c:pt>
                  <c:pt idx="40">
                    <c:v>1.8824085037877673E-3</c:v>
                  </c:pt>
                  <c:pt idx="41">
                    <c:v>1.8698191175019307E-3</c:v>
                  </c:pt>
                  <c:pt idx="42">
                    <c:v>1.8537255909126383E-3</c:v>
                  </c:pt>
                  <c:pt idx="43">
                    <c:v>1.815065599725784E-3</c:v>
                  </c:pt>
                  <c:pt idx="44">
                    <c:v>1.7680033468394009E-3</c:v>
                  </c:pt>
                  <c:pt idx="45">
                    <c:v>1.7160849504198033E-3</c:v>
                  </c:pt>
                  <c:pt idx="46">
                    <c:v>1.6776970539775457E-3</c:v>
                  </c:pt>
                  <c:pt idx="47">
                    <c:v>1.6386253208999896E-3</c:v>
                  </c:pt>
                  <c:pt idx="48">
                    <c:v>1.6057537927621989E-3</c:v>
                  </c:pt>
                  <c:pt idx="49">
                    <c:v>1.5724567286213719E-3</c:v>
                  </c:pt>
                  <c:pt idx="50">
                    <c:v>1.5547460739005173E-3</c:v>
                  </c:pt>
                  <c:pt idx="51">
                    <c:v>1.5404398882199204E-3</c:v>
                  </c:pt>
                  <c:pt idx="52">
                    <c:v>1.5344591942208165E-3</c:v>
                  </c:pt>
                  <c:pt idx="53">
                    <c:v>1.5259028537409824E-3</c:v>
                  </c:pt>
                  <c:pt idx="54">
                    <c:v>1.5117761771702323E-3</c:v>
                  </c:pt>
                  <c:pt idx="55">
                    <c:v>1.4778139093933104E-3</c:v>
                  </c:pt>
                  <c:pt idx="56">
                    <c:v>1.4292533237256436E-3</c:v>
                  </c:pt>
                  <c:pt idx="57">
                    <c:v>1.3774329855198236E-3</c:v>
                  </c:pt>
                  <c:pt idx="58">
                    <c:v>1.3284504743003235E-3</c:v>
                  </c:pt>
                  <c:pt idx="59">
                    <c:v>1.2828232829660583E-3</c:v>
                  </c:pt>
                  <c:pt idx="60">
                    <c:v>1.2451145905662021E-3</c:v>
                  </c:pt>
                  <c:pt idx="61">
                    <c:v>1.2195783250183111E-3</c:v>
                  </c:pt>
                  <c:pt idx="62">
                    <c:v>1.20360987462902E-3</c:v>
                  </c:pt>
                  <c:pt idx="63">
                    <c:v>1.1939731958261128E-3</c:v>
                  </c:pt>
                  <c:pt idx="64">
                    <c:v>1.1885418980677686E-3</c:v>
                  </c:pt>
                  <c:pt idx="65">
                    <c:v>1.1742989537521281E-3</c:v>
                  </c:pt>
                  <c:pt idx="66">
                    <c:v>1.1473841433770624E-3</c:v>
                  </c:pt>
                  <c:pt idx="67">
                    <c:v>1.1092417682981516E-3</c:v>
                  </c:pt>
                  <c:pt idx="68">
                    <c:v>1.064252239794228E-3</c:v>
                  </c:pt>
                  <c:pt idx="69">
                    <c:v>1.0166901903540934E-3</c:v>
                  </c:pt>
                  <c:pt idx="70">
                    <c:v>9.7258615243544469E-4</c:v>
                  </c:pt>
                  <c:pt idx="71">
                    <c:v>9.2701394061629283E-4</c:v>
                  </c:pt>
                  <c:pt idx="72">
                    <c:v>8.7596692508964762E-4</c:v>
                  </c:pt>
                  <c:pt idx="73">
                    <c:v>8.1601788844266464E-4</c:v>
                  </c:pt>
                  <c:pt idx="74">
                    <c:v>7.5159831039815382E-4</c:v>
                  </c:pt>
                  <c:pt idx="75">
                    <c:v>6.9304374210891475E-4</c:v>
                  </c:pt>
                  <c:pt idx="76">
                    <c:v>6.4559642347941236E-4</c:v>
                  </c:pt>
                  <c:pt idx="77">
                    <c:v>6.1467594359890438E-4</c:v>
                  </c:pt>
                  <c:pt idx="78">
                    <c:v>6.0106946174147261E-4</c:v>
                  </c:pt>
                  <c:pt idx="79">
                    <c:v>6.0669814677310346E-4</c:v>
                  </c:pt>
                  <c:pt idx="80">
                    <c:v>6.2145639713029333E-4</c:v>
                  </c:pt>
                  <c:pt idx="81">
                    <c:v>6.9987103559455293E-4</c:v>
                  </c:pt>
                  <c:pt idx="82">
                    <c:v>8.1807683675281986E-4</c:v>
                  </c:pt>
                  <c:pt idx="83">
                    <c:v>8.7293745551543761E-4</c:v>
                  </c:pt>
                  <c:pt idx="84">
                    <c:v>8.7113162296419545E-4</c:v>
                  </c:pt>
                  <c:pt idx="85">
                    <c:v>9.218557406500727E-4</c:v>
                  </c:pt>
                  <c:pt idx="86">
                    <c:v>1.1081826173559191E-3</c:v>
                  </c:pt>
                  <c:pt idx="87">
                    <c:v>1.3255271980187281E-3</c:v>
                  </c:pt>
                  <c:pt idx="88">
                    <c:v>1.522804105836498E-3</c:v>
                  </c:pt>
                  <c:pt idx="89">
                    <c:v>1.6761693666342485E-3</c:v>
                  </c:pt>
                  <c:pt idx="90">
                    <c:v>1.7618440209524746E-3</c:v>
                  </c:pt>
                  <c:pt idx="91">
                    <c:v>1.7880267634545997E-3</c:v>
                  </c:pt>
                  <c:pt idx="92">
                    <c:v>1.7678870807685571E-3</c:v>
                  </c:pt>
                  <c:pt idx="93">
                    <c:v>1.7232417341769384E-3</c:v>
                  </c:pt>
                  <c:pt idx="94">
                    <c:v>1.6483060458313483E-3</c:v>
                  </c:pt>
                  <c:pt idx="95">
                    <c:v>1.5483377188930587E-3</c:v>
                  </c:pt>
                  <c:pt idx="96">
                    <c:v>1.4454308546378643E-3</c:v>
                  </c:pt>
                  <c:pt idx="97">
                    <c:v>1.3283150594144554E-3</c:v>
                  </c:pt>
                  <c:pt idx="98">
                    <c:v>1.2432778549046305E-3</c:v>
                  </c:pt>
                  <c:pt idx="99">
                    <c:v>1.1846291520828749E-3</c:v>
                  </c:pt>
                  <c:pt idx="100">
                    <c:v>1.2030623260626254E-3</c:v>
                  </c:pt>
                  <c:pt idx="101">
                    <c:v>1.2204094336436156E-3</c:v>
                  </c:pt>
                  <c:pt idx="102">
                    <c:v>1.2265977239592617E-3</c:v>
                  </c:pt>
                  <c:pt idx="103">
                    <c:v>1.2179754822047668E-3</c:v>
                  </c:pt>
                  <c:pt idx="104">
                    <c:v>1.1798000264434539E-3</c:v>
                  </c:pt>
                  <c:pt idx="105">
                    <c:v>1.0894972074741835E-3</c:v>
                  </c:pt>
                  <c:pt idx="106">
                    <c:v>1.0121703329958529E-3</c:v>
                  </c:pt>
                  <c:pt idx="107">
                    <c:v>9.6136207642657525E-4</c:v>
                  </c:pt>
                  <c:pt idx="108">
                    <c:v>9.6655095404608903E-4</c:v>
                  </c:pt>
                  <c:pt idx="109">
                    <c:v>9.8533714980623618E-4</c:v>
                  </c:pt>
                  <c:pt idx="110">
                    <c:v>9.8796708330774544E-4</c:v>
                  </c:pt>
                  <c:pt idx="111">
                    <c:v>9.7573951463991889E-4</c:v>
                  </c:pt>
                  <c:pt idx="112">
                    <c:v>9.588231704493734E-4</c:v>
                  </c:pt>
                  <c:pt idx="113">
                    <c:v>9.2179954689301411E-4</c:v>
                  </c:pt>
                  <c:pt idx="114">
                    <c:v>9.2705246894949278E-4</c:v>
                  </c:pt>
                  <c:pt idx="115">
                    <c:v>9.5285348216949187E-4</c:v>
                  </c:pt>
                  <c:pt idx="116">
                    <c:v>9.6576167455884702E-4</c:v>
                  </c:pt>
                  <c:pt idx="117">
                    <c:v>9.7213535653170255E-4</c:v>
                  </c:pt>
                  <c:pt idx="118">
                    <c:v>1.0378126051993411E-3</c:v>
                  </c:pt>
                  <c:pt idx="119">
                    <c:v>1.1145963531042722E-3</c:v>
                  </c:pt>
                  <c:pt idx="120">
                    <c:v>1.1622869765886758E-3</c:v>
                  </c:pt>
                  <c:pt idx="121">
                    <c:v>1.1728010920097356E-3</c:v>
                  </c:pt>
                  <c:pt idx="122">
                    <c:v>1.1549166864436718E-3</c:v>
                  </c:pt>
                  <c:pt idx="123">
                    <c:v>1.1335540945694707E-3</c:v>
                  </c:pt>
                  <c:pt idx="124">
                    <c:v>1.1846084382539932E-3</c:v>
                  </c:pt>
                  <c:pt idx="125">
                    <c:v>1.2037613765730659E-3</c:v>
                  </c:pt>
                  <c:pt idx="126">
                    <c:v>1.1637618512861418E-3</c:v>
                  </c:pt>
                  <c:pt idx="127">
                    <c:v>1.1187695343673658E-3</c:v>
                  </c:pt>
                  <c:pt idx="128">
                    <c:v>1.1587568207734661E-3</c:v>
                  </c:pt>
                  <c:pt idx="129">
                    <c:v>1.1283048625274909E-3</c:v>
                  </c:pt>
                  <c:pt idx="130">
                    <c:v>1.0532073283293746E-3</c:v>
                  </c:pt>
                  <c:pt idx="131">
                    <c:v>1.0561744478921331E-3</c:v>
                  </c:pt>
                  <c:pt idx="132">
                    <c:v>1.1214637367511317E-3</c:v>
                  </c:pt>
                  <c:pt idx="133">
                    <c:v>1.2288779269051216E-3</c:v>
                  </c:pt>
                  <c:pt idx="134">
                    <c:v>1.3074623878593728E-3</c:v>
                  </c:pt>
                  <c:pt idx="135">
                    <c:v>1.4134127505667604E-3</c:v>
                  </c:pt>
                  <c:pt idx="136">
                    <c:v>1.4754018209397557E-3</c:v>
                  </c:pt>
                  <c:pt idx="137">
                    <c:v>1.583010762371455E-3</c:v>
                  </c:pt>
                  <c:pt idx="138">
                    <c:v>1.6092609383119641E-3</c:v>
                  </c:pt>
                  <c:pt idx="139">
                    <c:v>1.6026361958938395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x"/>
            <c:errBarType val="both"/>
            <c:errValType val="fixedVal"/>
            <c:noEndCap val="0"/>
            <c:val val="1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AVG healthy'!$BC$5:$BC$144</c:f>
              <c:numCache>
                <c:formatCode>General</c:formatCode>
                <c:ptCount val="140"/>
                <c:pt idx="0">
                  <c:v>451.25</c:v>
                </c:pt>
                <c:pt idx="1">
                  <c:v>454.040009</c:v>
                </c:pt>
                <c:pt idx="2">
                  <c:v>456.82000699999998</c:v>
                </c:pt>
                <c:pt idx="3">
                  <c:v>459.60998499999999</c:v>
                </c:pt>
                <c:pt idx="4">
                  <c:v>462.39999399999999</c:v>
                </c:pt>
                <c:pt idx="5">
                  <c:v>465.19000199999999</c:v>
                </c:pt>
                <c:pt idx="6">
                  <c:v>467.98001099999999</c:v>
                </c:pt>
                <c:pt idx="7">
                  <c:v>470.77999899999998</c:v>
                </c:pt>
                <c:pt idx="8">
                  <c:v>473.57000699999998</c:v>
                </c:pt>
                <c:pt idx="9">
                  <c:v>476.36999500000002</c:v>
                </c:pt>
                <c:pt idx="10">
                  <c:v>479.16000400000001</c:v>
                </c:pt>
                <c:pt idx="11">
                  <c:v>481.959991</c:v>
                </c:pt>
                <c:pt idx="12">
                  <c:v>484.76001000000002</c:v>
                </c:pt>
                <c:pt idx="13">
                  <c:v>487.55999800000001</c:v>
                </c:pt>
                <c:pt idx="14">
                  <c:v>490.35998499999999</c:v>
                </c:pt>
                <c:pt idx="15">
                  <c:v>493.16000400000001</c:v>
                </c:pt>
                <c:pt idx="16">
                  <c:v>495.97000100000002</c:v>
                </c:pt>
                <c:pt idx="17">
                  <c:v>498.76998900000001</c:v>
                </c:pt>
                <c:pt idx="18">
                  <c:v>501.57998700000002</c:v>
                </c:pt>
                <c:pt idx="19">
                  <c:v>504.39001500000001</c:v>
                </c:pt>
                <c:pt idx="20">
                  <c:v>507.19000199999999</c:v>
                </c:pt>
                <c:pt idx="21">
                  <c:v>510</c:v>
                </c:pt>
                <c:pt idx="22">
                  <c:v>512.80999799999995</c:v>
                </c:pt>
                <c:pt idx="23">
                  <c:v>515.63000499999998</c:v>
                </c:pt>
                <c:pt idx="24">
                  <c:v>518.44000200000005</c:v>
                </c:pt>
                <c:pt idx="25">
                  <c:v>521.25</c:v>
                </c:pt>
                <c:pt idx="26">
                  <c:v>524.07000700000003</c:v>
                </c:pt>
                <c:pt idx="27">
                  <c:v>526.88000499999998</c:v>
                </c:pt>
                <c:pt idx="28">
                  <c:v>529.70001200000002</c:v>
                </c:pt>
                <c:pt idx="29">
                  <c:v>532.52002000000005</c:v>
                </c:pt>
                <c:pt idx="30">
                  <c:v>535.34002699999996</c:v>
                </c:pt>
                <c:pt idx="31">
                  <c:v>538.15997300000004</c:v>
                </c:pt>
                <c:pt idx="32">
                  <c:v>540.98999000000003</c:v>
                </c:pt>
                <c:pt idx="33">
                  <c:v>543.80999799999995</c:v>
                </c:pt>
                <c:pt idx="34">
                  <c:v>546.63000499999998</c:v>
                </c:pt>
                <c:pt idx="35">
                  <c:v>549.46002199999998</c:v>
                </c:pt>
                <c:pt idx="36">
                  <c:v>552.28997800000002</c:v>
                </c:pt>
                <c:pt idx="37">
                  <c:v>555.11999500000002</c:v>
                </c:pt>
                <c:pt idx="38">
                  <c:v>557.94000200000005</c:v>
                </c:pt>
                <c:pt idx="39">
                  <c:v>560.78002900000001</c:v>
                </c:pt>
                <c:pt idx="40">
                  <c:v>563.60998500000005</c:v>
                </c:pt>
                <c:pt idx="41">
                  <c:v>566.44000200000005</c:v>
                </c:pt>
                <c:pt idx="42">
                  <c:v>569.27002000000005</c:v>
                </c:pt>
                <c:pt idx="43">
                  <c:v>572.10998500000005</c:v>
                </c:pt>
                <c:pt idx="44">
                  <c:v>574.95001200000002</c:v>
                </c:pt>
                <c:pt idx="45">
                  <c:v>577.78002900000001</c:v>
                </c:pt>
                <c:pt idx="46">
                  <c:v>580.61999500000002</c:v>
                </c:pt>
                <c:pt idx="47">
                  <c:v>583.46002199999998</c:v>
                </c:pt>
                <c:pt idx="48">
                  <c:v>586.29998799999998</c:v>
                </c:pt>
                <c:pt idx="49">
                  <c:v>589.15002400000003</c:v>
                </c:pt>
                <c:pt idx="50">
                  <c:v>591.98999000000003</c:v>
                </c:pt>
                <c:pt idx="51">
                  <c:v>594.84002699999996</c:v>
                </c:pt>
                <c:pt idx="52">
                  <c:v>597.67999299999997</c:v>
                </c:pt>
                <c:pt idx="53">
                  <c:v>600.53002900000001</c:v>
                </c:pt>
                <c:pt idx="54">
                  <c:v>603.38000499999998</c:v>
                </c:pt>
                <c:pt idx="55">
                  <c:v>606.22997999999995</c:v>
                </c:pt>
                <c:pt idx="56">
                  <c:v>609.080017</c:v>
                </c:pt>
                <c:pt idx="57">
                  <c:v>611.92999299999997</c:v>
                </c:pt>
                <c:pt idx="58">
                  <c:v>614.78002900000001</c:v>
                </c:pt>
                <c:pt idx="59">
                  <c:v>617.64001499999995</c:v>
                </c:pt>
                <c:pt idx="60">
                  <c:v>620.48999000000003</c:v>
                </c:pt>
                <c:pt idx="61">
                  <c:v>623.34997599999997</c:v>
                </c:pt>
                <c:pt idx="62">
                  <c:v>626.21002199999998</c:v>
                </c:pt>
                <c:pt idx="63">
                  <c:v>629.07000700000003</c:v>
                </c:pt>
                <c:pt idx="64">
                  <c:v>631.92999299999997</c:v>
                </c:pt>
                <c:pt idx="65">
                  <c:v>634.78997800000002</c:v>
                </c:pt>
                <c:pt idx="66">
                  <c:v>637.65002400000003</c:v>
                </c:pt>
                <c:pt idx="67">
                  <c:v>640.51000999999997</c:v>
                </c:pt>
                <c:pt idx="68">
                  <c:v>643.38000499999998</c:v>
                </c:pt>
                <c:pt idx="69">
                  <c:v>646.23999000000003</c:v>
                </c:pt>
                <c:pt idx="70">
                  <c:v>649.10998500000005</c:v>
                </c:pt>
                <c:pt idx="71">
                  <c:v>651.97997999999995</c:v>
                </c:pt>
                <c:pt idx="72">
                  <c:v>654.84997599999997</c:v>
                </c:pt>
                <c:pt idx="73">
                  <c:v>657.71997099999999</c:v>
                </c:pt>
                <c:pt idx="74">
                  <c:v>660.59002699999996</c:v>
                </c:pt>
                <c:pt idx="75">
                  <c:v>663.46997099999999</c:v>
                </c:pt>
                <c:pt idx="76">
                  <c:v>666.34002699999996</c:v>
                </c:pt>
                <c:pt idx="77">
                  <c:v>669.21997099999999</c:v>
                </c:pt>
                <c:pt idx="78">
                  <c:v>672.09002699999996</c:v>
                </c:pt>
                <c:pt idx="79">
                  <c:v>674.96997099999999</c:v>
                </c:pt>
                <c:pt idx="80">
                  <c:v>677.84997599999997</c:v>
                </c:pt>
                <c:pt idx="81">
                  <c:v>680.72997999999995</c:v>
                </c:pt>
                <c:pt idx="82">
                  <c:v>683.60998500000005</c:v>
                </c:pt>
                <c:pt idx="83">
                  <c:v>686.48999000000003</c:v>
                </c:pt>
                <c:pt idx="84">
                  <c:v>689.38000499999998</c:v>
                </c:pt>
                <c:pt idx="85">
                  <c:v>692.26000999999997</c:v>
                </c:pt>
                <c:pt idx="86">
                  <c:v>695.15002400000003</c:v>
                </c:pt>
                <c:pt idx="87">
                  <c:v>698.03002900000001</c:v>
                </c:pt>
                <c:pt idx="88">
                  <c:v>700.919983</c:v>
                </c:pt>
                <c:pt idx="89">
                  <c:v>703.80999799999995</c:v>
                </c:pt>
                <c:pt idx="90">
                  <c:v>706.70001200000002</c:v>
                </c:pt>
                <c:pt idx="91">
                  <c:v>709.59997599999997</c:v>
                </c:pt>
                <c:pt idx="92">
                  <c:v>712.48999000000003</c:v>
                </c:pt>
                <c:pt idx="93">
                  <c:v>715.38000499999998</c:v>
                </c:pt>
                <c:pt idx="94">
                  <c:v>718.28002900000001</c:v>
                </c:pt>
                <c:pt idx="95">
                  <c:v>721.17999299999997</c:v>
                </c:pt>
                <c:pt idx="96">
                  <c:v>724.07000700000003</c:v>
                </c:pt>
                <c:pt idx="97">
                  <c:v>726.96997099999999</c:v>
                </c:pt>
                <c:pt idx="98">
                  <c:v>729.86999500000002</c:v>
                </c:pt>
                <c:pt idx="99">
                  <c:v>732.77002000000005</c:v>
                </c:pt>
                <c:pt idx="100">
                  <c:v>735.67999299999997</c:v>
                </c:pt>
                <c:pt idx="101">
                  <c:v>738.580017</c:v>
                </c:pt>
                <c:pt idx="102">
                  <c:v>741.48999000000003</c:v>
                </c:pt>
                <c:pt idx="103">
                  <c:v>744.39001499999995</c:v>
                </c:pt>
                <c:pt idx="104">
                  <c:v>747.29998799999998</c:v>
                </c:pt>
                <c:pt idx="105">
                  <c:v>750.21002199999998</c:v>
                </c:pt>
                <c:pt idx="106">
                  <c:v>753.11999500000002</c:v>
                </c:pt>
                <c:pt idx="107">
                  <c:v>756.03002900000001</c:v>
                </c:pt>
                <c:pt idx="108">
                  <c:v>758.94000200000005</c:v>
                </c:pt>
                <c:pt idx="109">
                  <c:v>761.84997599999997</c:v>
                </c:pt>
                <c:pt idx="110">
                  <c:v>764.77002000000005</c:v>
                </c:pt>
                <c:pt idx="111">
                  <c:v>767.67999299999997</c:v>
                </c:pt>
                <c:pt idx="112">
                  <c:v>770.59997599999997</c:v>
                </c:pt>
                <c:pt idx="113">
                  <c:v>773.52002000000005</c:v>
                </c:pt>
                <c:pt idx="114">
                  <c:v>776.44000200000005</c:v>
                </c:pt>
                <c:pt idx="115">
                  <c:v>779.35998500000005</c:v>
                </c:pt>
                <c:pt idx="116">
                  <c:v>782.28002900000001</c:v>
                </c:pt>
                <c:pt idx="117">
                  <c:v>785.20001200000002</c:v>
                </c:pt>
                <c:pt idx="118">
                  <c:v>788.11999500000002</c:v>
                </c:pt>
                <c:pt idx="119">
                  <c:v>791.04998799999998</c:v>
                </c:pt>
                <c:pt idx="120">
                  <c:v>793.97997999999995</c:v>
                </c:pt>
                <c:pt idx="121">
                  <c:v>796.90002400000003</c:v>
                </c:pt>
                <c:pt idx="122">
                  <c:v>799.830017</c:v>
                </c:pt>
                <c:pt idx="123">
                  <c:v>802.76000999999997</c:v>
                </c:pt>
                <c:pt idx="124">
                  <c:v>805.69000200000005</c:v>
                </c:pt>
                <c:pt idx="125">
                  <c:v>808.61999500000002</c:v>
                </c:pt>
                <c:pt idx="126">
                  <c:v>811.55999799999995</c:v>
                </c:pt>
                <c:pt idx="127">
                  <c:v>814.48999000000003</c:v>
                </c:pt>
                <c:pt idx="128">
                  <c:v>817.42999299999997</c:v>
                </c:pt>
                <c:pt idx="129">
                  <c:v>820.35998500000005</c:v>
                </c:pt>
                <c:pt idx="130">
                  <c:v>823.29998799999998</c:v>
                </c:pt>
                <c:pt idx="131">
                  <c:v>826.23999000000003</c:v>
                </c:pt>
                <c:pt idx="132">
                  <c:v>829.17999299999997</c:v>
                </c:pt>
                <c:pt idx="133">
                  <c:v>832.11999500000002</c:v>
                </c:pt>
                <c:pt idx="134">
                  <c:v>835.07000700000003</c:v>
                </c:pt>
                <c:pt idx="135">
                  <c:v>838.01000999999997</c:v>
                </c:pt>
                <c:pt idx="136">
                  <c:v>840.95001200000002</c:v>
                </c:pt>
                <c:pt idx="137">
                  <c:v>843.90002400000003</c:v>
                </c:pt>
                <c:pt idx="138">
                  <c:v>846.84997599999997</c:v>
                </c:pt>
                <c:pt idx="139">
                  <c:v>849.79998799999998</c:v>
                </c:pt>
              </c:numCache>
            </c:numRef>
          </c:xVal>
          <c:yVal>
            <c:numRef>
              <c:f>'AVG healthy'!$BF$5:$BF$144</c:f>
              <c:numCache>
                <c:formatCode>General</c:formatCode>
                <c:ptCount val="140"/>
                <c:pt idx="0">
                  <c:v>4.7231500000000003E-2</c:v>
                </c:pt>
                <c:pt idx="1">
                  <c:v>4.7126374999999998E-2</c:v>
                </c:pt>
                <c:pt idx="2">
                  <c:v>4.6850000000000003E-2</c:v>
                </c:pt>
                <c:pt idx="3">
                  <c:v>4.6405000000000002E-2</c:v>
                </c:pt>
                <c:pt idx="4">
                  <c:v>4.5935625000000001E-2</c:v>
                </c:pt>
                <c:pt idx="5">
                  <c:v>4.5484375E-2</c:v>
                </c:pt>
                <c:pt idx="6">
                  <c:v>4.50645E-2</c:v>
                </c:pt>
                <c:pt idx="7">
                  <c:v>4.4691624999999999E-2</c:v>
                </c:pt>
                <c:pt idx="8">
                  <c:v>4.4424125000000002E-2</c:v>
                </c:pt>
                <c:pt idx="9">
                  <c:v>4.43005E-2</c:v>
                </c:pt>
                <c:pt idx="10">
                  <c:v>4.4236499999999998E-2</c:v>
                </c:pt>
                <c:pt idx="11">
                  <c:v>4.4172999999999997E-2</c:v>
                </c:pt>
                <c:pt idx="12">
                  <c:v>4.4100374999999997E-2</c:v>
                </c:pt>
                <c:pt idx="13">
                  <c:v>4.4204124999999997E-2</c:v>
                </c:pt>
                <c:pt idx="14">
                  <c:v>4.4551624999999997E-2</c:v>
                </c:pt>
                <c:pt idx="15">
                  <c:v>4.5150374999999993E-2</c:v>
                </c:pt>
                <c:pt idx="16">
                  <c:v>4.6060375000000001E-2</c:v>
                </c:pt>
                <c:pt idx="17">
                  <c:v>4.7413125E-2</c:v>
                </c:pt>
                <c:pt idx="18">
                  <c:v>4.9367999999999995E-2</c:v>
                </c:pt>
                <c:pt idx="19">
                  <c:v>5.2064125000000003E-2</c:v>
                </c:pt>
                <c:pt idx="20">
                  <c:v>5.5689749999999996E-2</c:v>
                </c:pt>
                <c:pt idx="21">
                  <c:v>6.0372499999999996E-2</c:v>
                </c:pt>
                <c:pt idx="22">
                  <c:v>6.6218374999999996E-2</c:v>
                </c:pt>
                <c:pt idx="23">
                  <c:v>7.3364125000000002E-2</c:v>
                </c:pt>
                <c:pt idx="24">
                  <c:v>8.1746750000000007E-2</c:v>
                </c:pt>
                <c:pt idx="25">
                  <c:v>9.0903125000000001E-2</c:v>
                </c:pt>
                <c:pt idx="26">
                  <c:v>0.100134625</c:v>
                </c:pt>
                <c:pt idx="27">
                  <c:v>0.108766375</c:v>
                </c:pt>
                <c:pt idx="28">
                  <c:v>0.11611299999999999</c:v>
                </c:pt>
                <c:pt idx="29">
                  <c:v>0.121765125</c:v>
                </c:pt>
                <c:pt idx="30">
                  <c:v>0.12576999999999999</c:v>
                </c:pt>
                <c:pt idx="31">
                  <c:v>0.12846774999999999</c:v>
                </c:pt>
                <c:pt idx="32">
                  <c:v>0.130218375</c:v>
                </c:pt>
                <c:pt idx="33">
                  <c:v>0.13153300000000001</c:v>
                </c:pt>
                <c:pt idx="34">
                  <c:v>0.13279125</c:v>
                </c:pt>
                <c:pt idx="35">
                  <c:v>0.13396387500000001</c:v>
                </c:pt>
                <c:pt idx="36">
                  <c:v>0.13465474999999999</c:v>
                </c:pt>
                <c:pt idx="37">
                  <c:v>0.134333125</c:v>
                </c:pt>
                <c:pt idx="38">
                  <c:v>0.132730125</c:v>
                </c:pt>
                <c:pt idx="39">
                  <c:v>0.129859375</c:v>
                </c:pt>
                <c:pt idx="40">
                  <c:v>0.1259285</c:v>
                </c:pt>
                <c:pt idx="41">
                  <c:v>0.120985625</c:v>
                </c:pt>
                <c:pt idx="42">
                  <c:v>0.11520174999999999</c:v>
                </c:pt>
                <c:pt idx="43">
                  <c:v>0.1090395</c:v>
                </c:pt>
                <c:pt idx="44">
                  <c:v>0.103209</c:v>
                </c:pt>
                <c:pt idx="45">
                  <c:v>9.8138124999999993E-2</c:v>
                </c:pt>
                <c:pt idx="46">
                  <c:v>9.3894000000000005E-2</c:v>
                </c:pt>
                <c:pt idx="47">
                  <c:v>9.0300749999999999E-2</c:v>
                </c:pt>
                <c:pt idx="48">
                  <c:v>8.7283874999999997E-2</c:v>
                </c:pt>
                <c:pt idx="49">
                  <c:v>8.4787500000000002E-2</c:v>
                </c:pt>
                <c:pt idx="50">
                  <c:v>8.2818000000000003E-2</c:v>
                </c:pt>
                <c:pt idx="51">
                  <c:v>8.1318125000000005E-2</c:v>
                </c:pt>
                <c:pt idx="52">
                  <c:v>8.0128375000000002E-2</c:v>
                </c:pt>
                <c:pt idx="53">
                  <c:v>7.8981625E-2</c:v>
                </c:pt>
                <c:pt idx="54">
                  <c:v>7.7548499999999992E-2</c:v>
                </c:pt>
                <c:pt idx="55">
                  <c:v>7.5580874999999992E-2</c:v>
                </c:pt>
                <c:pt idx="56">
                  <c:v>7.3071374999999994E-2</c:v>
                </c:pt>
                <c:pt idx="57">
                  <c:v>7.0262875000000002E-2</c:v>
                </c:pt>
                <c:pt idx="58">
                  <c:v>6.7459500000000006E-2</c:v>
                </c:pt>
                <c:pt idx="59">
                  <c:v>6.4934875000000003E-2</c:v>
                </c:pt>
                <c:pt idx="60">
                  <c:v>6.2912124999999999E-2</c:v>
                </c:pt>
                <c:pt idx="61">
                  <c:v>6.1488500000000001E-2</c:v>
                </c:pt>
                <c:pt idx="62">
                  <c:v>6.0643249999999996E-2</c:v>
                </c:pt>
                <c:pt idx="63">
                  <c:v>6.0180624999999995E-2</c:v>
                </c:pt>
                <c:pt idx="64">
                  <c:v>5.9650374999999999E-2</c:v>
                </c:pt>
                <c:pt idx="65">
                  <c:v>5.8540124999999998E-2</c:v>
                </c:pt>
                <c:pt idx="66">
                  <c:v>5.6652250000000001E-2</c:v>
                </c:pt>
                <c:pt idx="67">
                  <c:v>5.4245374999999998E-2</c:v>
                </c:pt>
                <c:pt idx="68">
                  <c:v>5.1661625000000003E-2</c:v>
                </c:pt>
                <c:pt idx="69">
                  <c:v>4.9234374999999997E-2</c:v>
                </c:pt>
                <c:pt idx="70">
                  <c:v>4.7223874999999998E-2</c:v>
                </c:pt>
                <c:pt idx="71">
                  <c:v>4.5692000000000003E-2</c:v>
                </c:pt>
                <c:pt idx="72">
                  <c:v>4.4306874999999996E-2</c:v>
                </c:pt>
                <c:pt idx="73">
                  <c:v>4.2740124999999997E-2</c:v>
                </c:pt>
                <c:pt idx="74">
                  <c:v>4.1020874999999998E-2</c:v>
                </c:pt>
                <c:pt idx="75">
                  <c:v>3.9379750000000005E-2</c:v>
                </c:pt>
                <c:pt idx="76">
                  <c:v>3.8007125000000003E-2</c:v>
                </c:pt>
                <c:pt idx="77">
                  <c:v>3.7037500000000001E-2</c:v>
                </c:pt>
                <c:pt idx="78">
                  <c:v>3.6599000000000007E-2</c:v>
                </c:pt>
                <c:pt idx="79">
                  <c:v>3.6743875000000002E-2</c:v>
                </c:pt>
                <c:pt idx="80">
                  <c:v>3.7448875000000006E-2</c:v>
                </c:pt>
                <c:pt idx="81">
                  <c:v>3.8699250000000004E-2</c:v>
                </c:pt>
                <c:pt idx="82">
                  <c:v>4.0605625000000006E-2</c:v>
                </c:pt>
                <c:pt idx="83">
                  <c:v>4.3726374999999998E-2</c:v>
                </c:pt>
                <c:pt idx="84">
                  <c:v>4.949025E-2</c:v>
                </c:pt>
                <c:pt idx="85">
                  <c:v>5.9736499999999998E-2</c:v>
                </c:pt>
                <c:pt idx="86">
                  <c:v>7.5747624999999999E-2</c:v>
                </c:pt>
                <c:pt idx="87">
                  <c:v>9.7204125000000002E-2</c:v>
                </c:pt>
                <c:pt idx="88">
                  <c:v>0.1220335</c:v>
                </c:pt>
                <c:pt idx="89">
                  <c:v>0.147480375</c:v>
                </c:pt>
                <c:pt idx="90">
                  <c:v>0.17170587500000001</c:v>
                </c:pt>
                <c:pt idx="91">
                  <c:v>0.19431799999999999</c:v>
                </c:pt>
                <c:pt idx="92">
                  <c:v>0.21570924999999999</c:v>
                </c:pt>
                <c:pt idx="93">
                  <c:v>0.23615449999999999</c:v>
                </c:pt>
                <c:pt idx="94">
                  <c:v>0.25563287499999998</c:v>
                </c:pt>
                <c:pt idx="95">
                  <c:v>0.27391274999999998</c:v>
                </c:pt>
                <c:pt idx="96">
                  <c:v>0.29076199999999996</c:v>
                </c:pt>
                <c:pt idx="97">
                  <c:v>0.3062105</c:v>
                </c:pt>
                <c:pt idx="98">
                  <c:v>0.32003150000000002</c:v>
                </c:pt>
                <c:pt idx="99">
                  <c:v>0.33206662500000006</c:v>
                </c:pt>
                <c:pt idx="100">
                  <c:v>0.342294875</c:v>
                </c:pt>
                <c:pt idx="101">
                  <c:v>0.35082625000000001</c:v>
                </c:pt>
                <c:pt idx="102">
                  <c:v>0.35756162499999999</c:v>
                </c:pt>
                <c:pt idx="103">
                  <c:v>0.36252362500000002</c:v>
                </c:pt>
                <c:pt idx="104">
                  <c:v>0.36620587500000001</c:v>
                </c:pt>
                <c:pt idx="105">
                  <c:v>0.36899337499999996</c:v>
                </c:pt>
                <c:pt idx="106">
                  <c:v>0.37118050000000002</c:v>
                </c:pt>
                <c:pt idx="107">
                  <c:v>0.37314900000000006</c:v>
                </c:pt>
                <c:pt idx="108">
                  <c:v>0.37480174999999999</c:v>
                </c:pt>
                <c:pt idx="109">
                  <c:v>0.37596237500000002</c:v>
                </c:pt>
                <c:pt idx="110">
                  <c:v>0.37702987499999996</c:v>
                </c:pt>
                <c:pt idx="111">
                  <c:v>0.37824824999999995</c:v>
                </c:pt>
                <c:pt idx="112">
                  <c:v>0.37934962500000002</c:v>
                </c:pt>
                <c:pt idx="113">
                  <c:v>0.38018825000000001</c:v>
                </c:pt>
                <c:pt idx="114">
                  <c:v>0.380783125</c:v>
                </c:pt>
                <c:pt idx="115">
                  <c:v>0.38092087499999999</c:v>
                </c:pt>
                <c:pt idx="116">
                  <c:v>0.38066762499999995</c:v>
                </c:pt>
                <c:pt idx="117">
                  <c:v>0.38030025000000001</c:v>
                </c:pt>
                <c:pt idx="118">
                  <c:v>0.37973524999999997</c:v>
                </c:pt>
                <c:pt idx="119">
                  <c:v>0.37902550000000002</c:v>
                </c:pt>
                <c:pt idx="120">
                  <c:v>0.37812050000000003</c:v>
                </c:pt>
                <c:pt idx="121">
                  <c:v>0.37690287499999997</c:v>
                </c:pt>
                <c:pt idx="122">
                  <c:v>0.37528862500000004</c:v>
                </c:pt>
                <c:pt idx="123">
                  <c:v>0.37372450000000002</c:v>
                </c:pt>
                <c:pt idx="124">
                  <c:v>0.37262412499999997</c:v>
                </c:pt>
                <c:pt idx="125">
                  <c:v>0.37189974999999997</c:v>
                </c:pt>
                <c:pt idx="126">
                  <c:v>0.37116699999999997</c:v>
                </c:pt>
                <c:pt idx="127">
                  <c:v>0.37036875000000002</c:v>
                </c:pt>
                <c:pt idx="128">
                  <c:v>0.36970962500000004</c:v>
                </c:pt>
                <c:pt idx="129">
                  <c:v>0.36913225</c:v>
                </c:pt>
                <c:pt idx="130">
                  <c:v>0.36857237500000001</c:v>
                </c:pt>
                <c:pt idx="131">
                  <c:v>0.36815587500000002</c:v>
                </c:pt>
                <c:pt idx="132">
                  <c:v>0.36791425</c:v>
                </c:pt>
                <c:pt idx="133">
                  <c:v>0.36772212500000001</c:v>
                </c:pt>
                <c:pt idx="134">
                  <c:v>0.36769774999999999</c:v>
                </c:pt>
                <c:pt idx="135">
                  <c:v>0.36797049999999998</c:v>
                </c:pt>
                <c:pt idx="136">
                  <c:v>0.36856037500000005</c:v>
                </c:pt>
                <c:pt idx="137">
                  <c:v>0.36939349999999999</c:v>
                </c:pt>
                <c:pt idx="138">
                  <c:v>0.3704345</c:v>
                </c:pt>
                <c:pt idx="139">
                  <c:v>0.3711356249999999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58CB-495F-A5F3-069958DEBAF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9225455"/>
        <c:axId val="138469631"/>
      </c:scatterChart>
      <c:valAx>
        <c:axId val="189225455"/>
        <c:scaling>
          <c:orientation val="minMax"/>
          <c:max val="850"/>
          <c:min val="45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Wavelength [nm]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8469631"/>
        <c:crosses val="autoZero"/>
        <c:crossBetween val="midCat"/>
      </c:valAx>
      <c:valAx>
        <c:axId val="138469631"/>
        <c:scaling>
          <c:orientation val="minMax"/>
          <c:max val="0.4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Reflectance [%/100]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9225455"/>
        <c:crosses val="autoZero"/>
        <c:crossBetween val="midCat"/>
        <c:majorUnit val="0.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643569553805775"/>
          <c:y val="4.0301017060367456E-2"/>
          <c:w val="0.79616732283464553"/>
          <c:h val="0.78743766404199478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AVG healthy'!$AU$4</c:f>
              <c:strCache>
                <c:ptCount val="1"/>
                <c:pt idx="0">
                  <c:v>CO 39 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1"/>
            <c:plus>
              <c:numRef>
                <c:f>'AVG healthy'!$AX$5:$AX$144</c:f>
                <c:numCache>
                  <c:formatCode>General</c:formatCode>
                  <c:ptCount val="140"/>
                  <c:pt idx="0">
                    <c:v>1.4373510085115744E-3</c:v>
                  </c:pt>
                  <c:pt idx="1">
                    <c:v>1.4507419020865179E-3</c:v>
                  </c:pt>
                  <c:pt idx="2">
                    <c:v>1.4479252630357183E-3</c:v>
                  </c:pt>
                  <c:pt idx="3">
                    <c:v>1.4671731727277197E-3</c:v>
                  </c:pt>
                  <c:pt idx="4">
                    <c:v>1.4881607048615126E-3</c:v>
                  </c:pt>
                  <c:pt idx="5">
                    <c:v>1.5123369062377428E-3</c:v>
                  </c:pt>
                  <c:pt idx="6">
                    <c:v>1.5110967467174539E-3</c:v>
                  </c:pt>
                  <c:pt idx="7">
                    <c:v>1.5189243061296091E-3</c:v>
                  </c:pt>
                  <c:pt idx="8">
                    <c:v>1.5473590951656537E-3</c:v>
                  </c:pt>
                  <c:pt idx="9">
                    <c:v>1.5846464842266283E-3</c:v>
                  </c:pt>
                  <c:pt idx="10">
                    <c:v>1.6048907033228586E-3</c:v>
                  </c:pt>
                  <c:pt idx="11">
                    <c:v>1.6206148922576374E-3</c:v>
                  </c:pt>
                  <c:pt idx="12">
                    <c:v>1.6529647801344859E-3</c:v>
                  </c:pt>
                  <c:pt idx="13">
                    <c:v>1.7083143941385051E-3</c:v>
                  </c:pt>
                  <c:pt idx="14">
                    <c:v>1.7581095342329833E-3</c:v>
                  </c:pt>
                  <c:pt idx="15">
                    <c:v>1.8247648033271377E-3</c:v>
                  </c:pt>
                  <c:pt idx="16">
                    <c:v>1.9087360889559939E-3</c:v>
                  </c:pt>
                  <c:pt idx="17">
                    <c:v>2.0036042927492727E-3</c:v>
                  </c:pt>
                  <c:pt idx="18">
                    <c:v>2.102473009567592E-3</c:v>
                  </c:pt>
                  <c:pt idx="19">
                    <c:v>2.2147049553296128E-3</c:v>
                  </c:pt>
                  <c:pt idx="20">
                    <c:v>2.3512367050548548E-3</c:v>
                  </c:pt>
                  <c:pt idx="21">
                    <c:v>2.5379261680208748E-3</c:v>
                  </c:pt>
                  <c:pt idx="22">
                    <c:v>2.7652337010667253E-3</c:v>
                  </c:pt>
                  <c:pt idx="23">
                    <c:v>3.0129109172000084E-3</c:v>
                  </c:pt>
                  <c:pt idx="24">
                    <c:v>3.2442537631881753E-3</c:v>
                  </c:pt>
                  <c:pt idx="25">
                    <c:v>3.4658642049302003E-3</c:v>
                  </c:pt>
                  <c:pt idx="26">
                    <c:v>3.6684770510216572E-3</c:v>
                  </c:pt>
                  <c:pt idx="27">
                    <c:v>3.8410045290709731E-3</c:v>
                  </c:pt>
                  <c:pt idx="28">
                    <c:v>3.9765279950805177E-3</c:v>
                  </c:pt>
                  <c:pt idx="29">
                    <c:v>4.0944729148267231E-3</c:v>
                  </c:pt>
                  <c:pt idx="30">
                    <c:v>4.2029468473224006E-3</c:v>
                  </c:pt>
                  <c:pt idx="31">
                    <c:v>4.2904906800871881E-3</c:v>
                  </c:pt>
                  <c:pt idx="32">
                    <c:v>4.3603152735618034E-3</c:v>
                  </c:pt>
                  <c:pt idx="33">
                    <c:v>4.4264353125806214E-3</c:v>
                  </c:pt>
                  <c:pt idx="34">
                    <c:v>4.4857070684146422E-3</c:v>
                  </c:pt>
                  <c:pt idx="35">
                    <c:v>4.5337215939924517E-3</c:v>
                  </c:pt>
                  <c:pt idx="36">
                    <c:v>4.5798469215883337E-3</c:v>
                  </c:pt>
                  <c:pt idx="37">
                    <c:v>4.6319228312087755E-3</c:v>
                  </c:pt>
                  <c:pt idx="38">
                    <c:v>4.6744629615879853E-3</c:v>
                  </c:pt>
                  <c:pt idx="39">
                    <c:v>4.7182524091259727E-3</c:v>
                  </c:pt>
                  <c:pt idx="40">
                    <c:v>4.7785662574171004E-3</c:v>
                  </c:pt>
                  <c:pt idx="41">
                    <c:v>4.8534177211651524E-3</c:v>
                  </c:pt>
                  <c:pt idx="42">
                    <c:v>4.9226720448052657E-3</c:v>
                  </c:pt>
                  <c:pt idx="43">
                    <c:v>4.9851872555592919E-3</c:v>
                  </c:pt>
                  <c:pt idx="44">
                    <c:v>5.0464823857002111E-3</c:v>
                  </c:pt>
                  <c:pt idx="45">
                    <c:v>5.094724820173176E-3</c:v>
                  </c:pt>
                  <c:pt idx="46">
                    <c:v>5.1414268768277573E-3</c:v>
                  </c:pt>
                  <c:pt idx="47">
                    <c:v>5.1846754108284421E-3</c:v>
                  </c:pt>
                  <c:pt idx="48">
                    <c:v>5.2315314431236135E-3</c:v>
                  </c:pt>
                  <c:pt idx="49">
                    <c:v>5.2763515613912454E-3</c:v>
                  </c:pt>
                  <c:pt idx="50">
                    <c:v>5.3220030931088258E-3</c:v>
                  </c:pt>
                  <c:pt idx="51">
                    <c:v>5.3644292825990279E-3</c:v>
                  </c:pt>
                  <c:pt idx="52">
                    <c:v>5.4077256783148821E-3</c:v>
                  </c:pt>
                  <c:pt idx="53">
                    <c:v>5.4478605712847458E-3</c:v>
                  </c:pt>
                  <c:pt idx="54">
                    <c:v>5.4747167991371177E-3</c:v>
                  </c:pt>
                  <c:pt idx="55">
                    <c:v>5.483247716203116E-3</c:v>
                  </c:pt>
                  <c:pt idx="56">
                    <c:v>5.4682093609495124E-3</c:v>
                  </c:pt>
                  <c:pt idx="57">
                    <c:v>5.4385841788694555E-3</c:v>
                  </c:pt>
                  <c:pt idx="58">
                    <c:v>5.3972913493015792E-3</c:v>
                  </c:pt>
                  <c:pt idx="59">
                    <c:v>5.349748027389461E-3</c:v>
                  </c:pt>
                  <c:pt idx="60">
                    <c:v>5.2995457710061228E-3</c:v>
                  </c:pt>
                  <c:pt idx="61">
                    <c:v>5.2735801368551287E-3</c:v>
                  </c:pt>
                  <c:pt idx="62">
                    <c:v>5.2791591528436755E-3</c:v>
                  </c:pt>
                  <c:pt idx="63">
                    <c:v>5.300515377556869E-3</c:v>
                  </c:pt>
                  <c:pt idx="64">
                    <c:v>5.3128649845036145E-3</c:v>
                  </c:pt>
                  <c:pt idx="65">
                    <c:v>5.2995592959596844E-3</c:v>
                  </c:pt>
                  <c:pt idx="66">
                    <c:v>5.2371210713192595E-3</c:v>
                  </c:pt>
                  <c:pt idx="67">
                    <c:v>5.1152545056201548E-3</c:v>
                  </c:pt>
                  <c:pt idx="68">
                    <c:v>4.9452618566696357E-3</c:v>
                  </c:pt>
                  <c:pt idx="69">
                    <c:v>4.7570830156304636E-3</c:v>
                  </c:pt>
                  <c:pt idx="70">
                    <c:v>4.5821762194249759E-3</c:v>
                  </c:pt>
                  <c:pt idx="71">
                    <c:v>4.438348170310114E-3</c:v>
                  </c:pt>
                  <c:pt idx="72">
                    <c:v>4.2909944662104698E-3</c:v>
                  </c:pt>
                  <c:pt idx="73">
                    <c:v>4.1018130257661177E-3</c:v>
                  </c:pt>
                  <c:pt idx="74">
                    <c:v>3.8541177895304976E-3</c:v>
                  </c:pt>
                  <c:pt idx="75">
                    <c:v>3.5742074458389155E-3</c:v>
                  </c:pt>
                  <c:pt idx="76">
                    <c:v>3.2918995157926721E-3</c:v>
                  </c:pt>
                  <c:pt idx="77">
                    <c:v>3.0473587025095488E-3</c:v>
                  </c:pt>
                  <c:pt idx="78">
                    <c:v>2.8514907349499168E-3</c:v>
                  </c:pt>
                  <c:pt idx="79">
                    <c:v>2.7170355582487333E-3</c:v>
                  </c:pt>
                  <c:pt idx="80">
                    <c:v>2.6530770849373672E-3</c:v>
                  </c:pt>
                  <c:pt idx="81">
                    <c:v>2.6913180288432562E-3</c:v>
                  </c:pt>
                  <c:pt idx="82">
                    <c:v>2.8885673051186117E-3</c:v>
                  </c:pt>
                  <c:pt idx="83">
                    <c:v>3.3330280071043467E-3</c:v>
                  </c:pt>
                  <c:pt idx="84">
                    <c:v>4.069769528615136E-3</c:v>
                  </c:pt>
                  <c:pt idx="85">
                    <c:v>4.9944485873235156E-3</c:v>
                  </c:pt>
                  <c:pt idx="86">
                    <c:v>5.9132765050304275E-3</c:v>
                  </c:pt>
                  <c:pt idx="87">
                    <c:v>6.6078693020104762E-3</c:v>
                  </c:pt>
                  <c:pt idx="88">
                    <c:v>6.9620945658092322E-3</c:v>
                  </c:pt>
                  <c:pt idx="89">
                    <c:v>6.9545278530212928E-3</c:v>
                  </c:pt>
                  <c:pt idx="90">
                    <c:v>6.6917058282558763E-3</c:v>
                  </c:pt>
                  <c:pt idx="91">
                    <c:v>6.2685908295146212E-3</c:v>
                  </c:pt>
                  <c:pt idx="92">
                    <c:v>5.7570659349728904E-3</c:v>
                  </c:pt>
                  <c:pt idx="93">
                    <c:v>5.1988232408438527E-3</c:v>
                  </c:pt>
                  <c:pt idx="94">
                    <c:v>4.6528428866159438E-3</c:v>
                  </c:pt>
                  <c:pt idx="95">
                    <c:v>4.1579714062479328E-3</c:v>
                  </c:pt>
                  <c:pt idx="96">
                    <c:v>3.7412147335508569E-3</c:v>
                  </c:pt>
                  <c:pt idx="97">
                    <c:v>3.4538735738552633E-3</c:v>
                  </c:pt>
                  <c:pt idx="98">
                    <c:v>3.3037254253490637E-3</c:v>
                  </c:pt>
                  <c:pt idx="99">
                    <c:v>3.2531820148315235E-3</c:v>
                  </c:pt>
                  <c:pt idx="100">
                    <c:v>3.261643310460631E-3</c:v>
                  </c:pt>
                  <c:pt idx="101">
                    <c:v>3.3047539089865983E-3</c:v>
                  </c:pt>
                  <c:pt idx="102">
                    <c:v>3.3629863660668046E-3</c:v>
                  </c:pt>
                  <c:pt idx="103">
                    <c:v>3.4152068509195593E-3</c:v>
                  </c:pt>
                  <c:pt idx="104">
                    <c:v>3.4283490629236453E-3</c:v>
                  </c:pt>
                  <c:pt idx="105">
                    <c:v>3.4441215745233673E-3</c:v>
                  </c:pt>
                  <c:pt idx="106">
                    <c:v>3.4490558433199819E-3</c:v>
                  </c:pt>
                  <c:pt idx="107">
                    <c:v>3.4611674337433102E-3</c:v>
                  </c:pt>
                  <c:pt idx="108">
                    <c:v>3.4262390159309417E-3</c:v>
                  </c:pt>
                  <c:pt idx="109">
                    <c:v>3.3880099606080714E-3</c:v>
                  </c:pt>
                  <c:pt idx="110">
                    <c:v>3.3375906620381236E-3</c:v>
                  </c:pt>
                  <c:pt idx="111">
                    <c:v>3.3230394408915571E-3</c:v>
                  </c:pt>
                  <c:pt idx="112">
                    <c:v>3.3303367056346008E-3</c:v>
                  </c:pt>
                  <c:pt idx="113">
                    <c:v>3.3493475954585192E-3</c:v>
                  </c:pt>
                  <c:pt idx="114">
                    <c:v>3.3338908460360502E-3</c:v>
                  </c:pt>
                  <c:pt idx="115">
                    <c:v>3.3255618099426077E-3</c:v>
                  </c:pt>
                  <c:pt idx="116">
                    <c:v>3.3389370396927926E-3</c:v>
                  </c:pt>
                  <c:pt idx="117">
                    <c:v>3.3450222597982276E-3</c:v>
                  </c:pt>
                  <c:pt idx="118">
                    <c:v>3.3184953064478344E-3</c:v>
                  </c:pt>
                  <c:pt idx="119">
                    <c:v>3.3696426057715227E-3</c:v>
                  </c:pt>
                  <c:pt idx="120">
                    <c:v>3.4583924343640814E-3</c:v>
                  </c:pt>
                  <c:pt idx="121">
                    <c:v>3.5324849383166221E-3</c:v>
                  </c:pt>
                  <c:pt idx="122">
                    <c:v>3.4643168778891271E-3</c:v>
                  </c:pt>
                  <c:pt idx="123">
                    <c:v>3.3872405843785834E-3</c:v>
                  </c:pt>
                  <c:pt idx="124">
                    <c:v>3.3409563140014819E-3</c:v>
                  </c:pt>
                  <c:pt idx="125">
                    <c:v>3.362330831137622E-3</c:v>
                  </c:pt>
                  <c:pt idx="126">
                    <c:v>3.354821404292301E-3</c:v>
                  </c:pt>
                  <c:pt idx="127">
                    <c:v>3.3650267647113955E-3</c:v>
                  </c:pt>
                  <c:pt idx="128">
                    <c:v>3.3925512707729671E-3</c:v>
                  </c:pt>
                  <c:pt idx="129">
                    <c:v>3.415141523050216E-3</c:v>
                  </c:pt>
                  <c:pt idx="130">
                    <c:v>3.43439323756543E-3</c:v>
                  </c:pt>
                  <c:pt idx="131">
                    <c:v>3.4848484758699446E-3</c:v>
                  </c:pt>
                  <c:pt idx="132">
                    <c:v>3.5589929924095863E-3</c:v>
                  </c:pt>
                  <c:pt idx="133">
                    <c:v>3.600659120940387E-3</c:v>
                  </c:pt>
                  <c:pt idx="134">
                    <c:v>3.6869802775773707E-3</c:v>
                  </c:pt>
                  <c:pt idx="135">
                    <c:v>3.7879045885766439E-3</c:v>
                  </c:pt>
                  <c:pt idx="136">
                    <c:v>3.9370328279599012E-3</c:v>
                  </c:pt>
                  <c:pt idx="137">
                    <c:v>4.0650063286065052E-3</c:v>
                  </c:pt>
                  <c:pt idx="138">
                    <c:v>4.1522874131416573E-3</c:v>
                  </c:pt>
                  <c:pt idx="139">
                    <c:v>4.1665814657733287E-3</c:v>
                  </c:pt>
                </c:numCache>
              </c:numRef>
            </c:plus>
            <c:minus>
              <c:numRef>
                <c:f>'AVG healthy'!$AX$5:$AX$144</c:f>
                <c:numCache>
                  <c:formatCode>General</c:formatCode>
                  <c:ptCount val="140"/>
                  <c:pt idx="0">
                    <c:v>1.4373510085115744E-3</c:v>
                  </c:pt>
                  <c:pt idx="1">
                    <c:v>1.4507419020865179E-3</c:v>
                  </c:pt>
                  <c:pt idx="2">
                    <c:v>1.4479252630357183E-3</c:v>
                  </c:pt>
                  <c:pt idx="3">
                    <c:v>1.4671731727277197E-3</c:v>
                  </c:pt>
                  <c:pt idx="4">
                    <c:v>1.4881607048615126E-3</c:v>
                  </c:pt>
                  <c:pt idx="5">
                    <c:v>1.5123369062377428E-3</c:v>
                  </c:pt>
                  <c:pt idx="6">
                    <c:v>1.5110967467174539E-3</c:v>
                  </c:pt>
                  <c:pt idx="7">
                    <c:v>1.5189243061296091E-3</c:v>
                  </c:pt>
                  <c:pt idx="8">
                    <c:v>1.5473590951656537E-3</c:v>
                  </c:pt>
                  <c:pt idx="9">
                    <c:v>1.5846464842266283E-3</c:v>
                  </c:pt>
                  <c:pt idx="10">
                    <c:v>1.6048907033228586E-3</c:v>
                  </c:pt>
                  <c:pt idx="11">
                    <c:v>1.6206148922576374E-3</c:v>
                  </c:pt>
                  <c:pt idx="12">
                    <c:v>1.6529647801344859E-3</c:v>
                  </c:pt>
                  <c:pt idx="13">
                    <c:v>1.7083143941385051E-3</c:v>
                  </c:pt>
                  <c:pt idx="14">
                    <c:v>1.7581095342329833E-3</c:v>
                  </c:pt>
                  <c:pt idx="15">
                    <c:v>1.8247648033271377E-3</c:v>
                  </c:pt>
                  <c:pt idx="16">
                    <c:v>1.9087360889559939E-3</c:v>
                  </c:pt>
                  <c:pt idx="17">
                    <c:v>2.0036042927492727E-3</c:v>
                  </c:pt>
                  <c:pt idx="18">
                    <c:v>2.102473009567592E-3</c:v>
                  </c:pt>
                  <c:pt idx="19">
                    <c:v>2.2147049553296128E-3</c:v>
                  </c:pt>
                  <c:pt idx="20">
                    <c:v>2.3512367050548548E-3</c:v>
                  </c:pt>
                  <c:pt idx="21">
                    <c:v>2.5379261680208748E-3</c:v>
                  </c:pt>
                  <c:pt idx="22">
                    <c:v>2.7652337010667253E-3</c:v>
                  </c:pt>
                  <c:pt idx="23">
                    <c:v>3.0129109172000084E-3</c:v>
                  </c:pt>
                  <c:pt idx="24">
                    <c:v>3.2442537631881753E-3</c:v>
                  </c:pt>
                  <c:pt idx="25">
                    <c:v>3.4658642049302003E-3</c:v>
                  </c:pt>
                  <c:pt idx="26">
                    <c:v>3.6684770510216572E-3</c:v>
                  </c:pt>
                  <c:pt idx="27">
                    <c:v>3.8410045290709731E-3</c:v>
                  </c:pt>
                  <c:pt idx="28">
                    <c:v>3.9765279950805177E-3</c:v>
                  </c:pt>
                  <c:pt idx="29">
                    <c:v>4.0944729148267231E-3</c:v>
                  </c:pt>
                  <c:pt idx="30">
                    <c:v>4.2029468473224006E-3</c:v>
                  </c:pt>
                  <c:pt idx="31">
                    <c:v>4.2904906800871881E-3</c:v>
                  </c:pt>
                  <c:pt idx="32">
                    <c:v>4.3603152735618034E-3</c:v>
                  </c:pt>
                  <c:pt idx="33">
                    <c:v>4.4264353125806214E-3</c:v>
                  </c:pt>
                  <c:pt idx="34">
                    <c:v>4.4857070684146422E-3</c:v>
                  </c:pt>
                  <c:pt idx="35">
                    <c:v>4.5337215939924517E-3</c:v>
                  </c:pt>
                  <c:pt idx="36">
                    <c:v>4.5798469215883337E-3</c:v>
                  </c:pt>
                  <c:pt idx="37">
                    <c:v>4.6319228312087755E-3</c:v>
                  </c:pt>
                  <c:pt idx="38">
                    <c:v>4.6744629615879853E-3</c:v>
                  </c:pt>
                  <c:pt idx="39">
                    <c:v>4.7182524091259727E-3</c:v>
                  </c:pt>
                  <c:pt idx="40">
                    <c:v>4.7785662574171004E-3</c:v>
                  </c:pt>
                  <c:pt idx="41">
                    <c:v>4.8534177211651524E-3</c:v>
                  </c:pt>
                  <c:pt idx="42">
                    <c:v>4.9226720448052657E-3</c:v>
                  </c:pt>
                  <c:pt idx="43">
                    <c:v>4.9851872555592919E-3</c:v>
                  </c:pt>
                  <c:pt idx="44">
                    <c:v>5.0464823857002111E-3</c:v>
                  </c:pt>
                  <c:pt idx="45">
                    <c:v>5.094724820173176E-3</c:v>
                  </c:pt>
                  <c:pt idx="46">
                    <c:v>5.1414268768277573E-3</c:v>
                  </c:pt>
                  <c:pt idx="47">
                    <c:v>5.1846754108284421E-3</c:v>
                  </c:pt>
                  <c:pt idx="48">
                    <c:v>5.2315314431236135E-3</c:v>
                  </c:pt>
                  <c:pt idx="49">
                    <c:v>5.2763515613912454E-3</c:v>
                  </c:pt>
                  <c:pt idx="50">
                    <c:v>5.3220030931088258E-3</c:v>
                  </c:pt>
                  <c:pt idx="51">
                    <c:v>5.3644292825990279E-3</c:v>
                  </c:pt>
                  <c:pt idx="52">
                    <c:v>5.4077256783148821E-3</c:v>
                  </c:pt>
                  <c:pt idx="53">
                    <c:v>5.4478605712847458E-3</c:v>
                  </c:pt>
                  <c:pt idx="54">
                    <c:v>5.4747167991371177E-3</c:v>
                  </c:pt>
                  <c:pt idx="55">
                    <c:v>5.483247716203116E-3</c:v>
                  </c:pt>
                  <c:pt idx="56">
                    <c:v>5.4682093609495124E-3</c:v>
                  </c:pt>
                  <c:pt idx="57">
                    <c:v>5.4385841788694555E-3</c:v>
                  </c:pt>
                  <c:pt idx="58">
                    <c:v>5.3972913493015792E-3</c:v>
                  </c:pt>
                  <c:pt idx="59">
                    <c:v>5.349748027389461E-3</c:v>
                  </c:pt>
                  <c:pt idx="60">
                    <c:v>5.2995457710061228E-3</c:v>
                  </c:pt>
                  <c:pt idx="61">
                    <c:v>5.2735801368551287E-3</c:v>
                  </c:pt>
                  <c:pt idx="62">
                    <c:v>5.2791591528436755E-3</c:v>
                  </c:pt>
                  <c:pt idx="63">
                    <c:v>5.300515377556869E-3</c:v>
                  </c:pt>
                  <c:pt idx="64">
                    <c:v>5.3128649845036145E-3</c:v>
                  </c:pt>
                  <c:pt idx="65">
                    <c:v>5.2995592959596844E-3</c:v>
                  </c:pt>
                  <c:pt idx="66">
                    <c:v>5.2371210713192595E-3</c:v>
                  </c:pt>
                  <c:pt idx="67">
                    <c:v>5.1152545056201548E-3</c:v>
                  </c:pt>
                  <c:pt idx="68">
                    <c:v>4.9452618566696357E-3</c:v>
                  </c:pt>
                  <c:pt idx="69">
                    <c:v>4.7570830156304636E-3</c:v>
                  </c:pt>
                  <c:pt idx="70">
                    <c:v>4.5821762194249759E-3</c:v>
                  </c:pt>
                  <c:pt idx="71">
                    <c:v>4.438348170310114E-3</c:v>
                  </c:pt>
                  <c:pt idx="72">
                    <c:v>4.2909944662104698E-3</c:v>
                  </c:pt>
                  <c:pt idx="73">
                    <c:v>4.1018130257661177E-3</c:v>
                  </c:pt>
                  <c:pt idx="74">
                    <c:v>3.8541177895304976E-3</c:v>
                  </c:pt>
                  <c:pt idx="75">
                    <c:v>3.5742074458389155E-3</c:v>
                  </c:pt>
                  <c:pt idx="76">
                    <c:v>3.2918995157926721E-3</c:v>
                  </c:pt>
                  <c:pt idx="77">
                    <c:v>3.0473587025095488E-3</c:v>
                  </c:pt>
                  <c:pt idx="78">
                    <c:v>2.8514907349499168E-3</c:v>
                  </c:pt>
                  <c:pt idx="79">
                    <c:v>2.7170355582487333E-3</c:v>
                  </c:pt>
                  <c:pt idx="80">
                    <c:v>2.6530770849373672E-3</c:v>
                  </c:pt>
                  <c:pt idx="81">
                    <c:v>2.6913180288432562E-3</c:v>
                  </c:pt>
                  <c:pt idx="82">
                    <c:v>2.8885673051186117E-3</c:v>
                  </c:pt>
                  <c:pt idx="83">
                    <c:v>3.3330280071043467E-3</c:v>
                  </c:pt>
                  <c:pt idx="84">
                    <c:v>4.069769528615136E-3</c:v>
                  </c:pt>
                  <c:pt idx="85">
                    <c:v>4.9944485873235156E-3</c:v>
                  </c:pt>
                  <c:pt idx="86">
                    <c:v>5.9132765050304275E-3</c:v>
                  </c:pt>
                  <c:pt idx="87">
                    <c:v>6.6078693020104762E-3</c:v>
                  </c:pt>
                  <c:pt idx="88">
                    <c:v>6.9620945658092322E-3</c:v>
                  </c:pt>
                  <c:pt idx="89">
                    <c:v>6.9545278530212928E-3</c:v>
                  </c:pt>
                  <c:pt idx="90">
                    <c:v>6.6917058282558763E-3</c:v>
                  </c:pt>
                  <c:pt idx="91">
                    <c:v>6.2685908295146212E-3</c:v>
                  </c:pt>
                  <c:pt idx="92">
                    <c:v>5.7570659349728904E-3</c:v>
                  </c:pt>
                  <c:pt idx="93">
                    <c:v>5.1988232408438527E-3</c:v>
                  </c:pt>
                  <c:pt idx="94">
                    <c:v>4.6528428866159438E-3</c:v>
                  </c:pt>
                  <c:pt idx="95">
                    <c:v>4.1579714062479328E-3</c:v>
                  </c:pt>
                  <c:pt idx="96">
                    <c:v>3.7412147335508569E-3</c:v>
                  </c:pt>
                  <c:pt idx="97">
                    <c:v>3.4538735738552633E-3</c:v>
                  </c:pt>
                  <c:pt idx="98">
                    <c:v>3.3037254253490637E-3</c:v>
                  </c:pt>
                  <c:pt idx="99">
                    <c:v>3.2531820148315235E-3</c:v>
                  </c:pt>
                  <c:pt idx="100">
                    <c:v>3.261643310460631E-3</c:v>
                  </c:pt>
                  <c:pt idx="101">
                    <c:v>3.3047539089865983E-3</c:v>
                  </c:pt>
                  <c:pt idx="102">
                    <c:v>3.3629863660668046E-3</c:v>
                  </c:pt>
                  <c:pt idx="103">
                    <c:v>3.4152068509195593E-3</c:v>
                  </c:pt>
                  <c:pt idx="104">
                    <c:v>3.4283490629236453E-3</c:v>
                  </c:pt>
                  <c:pt idx="105">
                    <c:v>3.4441215745233673E-3</c:v>
                  </c:pt>
                  <c:pt idx="106">
                    <c:v>3.4490558433199819E-3</c:v>
                  </c:pt>
                  <c:pt idx="107">
                    <c:v>3.4611674337433102E-3</c:v>
                  </c:pt>
                  <c:pt idx="108">
                    <c:v>3.4262390159309417E-3</c:v>
                  </c:pt>
                  <c:pt idx="109">
                    <c:v>3.3880099606080714E-3</c:v>
                  </c:pt>
                  <c:pt idx="110">
                    <c:v>3.3375906620381236E-3</c:v>
                  </c:pt>
                  <c:pt idx="111">
                    <c:v>3.3230394408915571E-3</c:v>
                  </c:pt>
                  <c:pt idx="112">
                    <c:v>3.3303367056346008E-3</c:v>
                  </c:pt>
                  <c:pt idx="113">
                    <c:v>3.3493475954585192E-3</c:v>
                  </c:pt>
                  <c:pt idx="114">
                    <c:v>3.3338908460360502E-3</c:v>
                  </c:pt>
                  <c:pt idx="115">
                    <c:v>3.3255618099426077E-3</c:v>
                  </c:pt>
                  <c:pt idx="116">
                    <c:v>3.3389370396927926E-3</c:v>
                  </c:pt>
                  <c:pt idx="117">
                    <c:v>3.3450222597982276E-3</c:v>
                  </c:pt>
                  <c:pt idx="118">
                    <c:v>3.3184953064478344E-3</c:v>
                  </c:pt>
                  <c:pt idx="119">
                    <c:v>3.3696426057715227E-3</c:v>
                  </c:pt>
                  <c:pt idx="120">
                    <c:v>3.4583924343640814E-3</c:v>
                  </c:pt>
                  <c:pt idx="121">
                    <c:v>3.5324849383166221E-3</c:v>
                  </c:pt>
                  <c:pt idx="122">
                    <c:v>3.4643168778891271E-3</c:v>
                  </c:pt>
                  <c:pt idx="123">
                    <c:v>3.3872405843785834E-3</c:v>
                  </c:pt>
                  <c:pt idx="124">
                    <c:v>3.3409563140014819E-3</c:v>
                  </c:pt>
                  <c:pt idx="125">
                    <c:v>3.362330831137622E-3</c:v>
                  </c:pt>
                  <c:pt idx="126">
                    <c:v>3.354821404292301E-3</c:v>
                  </c:pt>
                  <c:pt idx="127">
                    <c:v>3.3650267647113955E-3</c:v>
                  </c:pt>
                  <c:pt idx="128">
                    <c:v>3.3925512707729671E-3</c:v>
                  </c:pt>
                  <c:pt idx="129">
                    <c:v>3.415141523050216E-3</c:v>
                  </c:pt>
                  <c:pt idx="130">
                    <c:v>3.43439323756543E-3</c:v>
                  </c:pt>
                  <c:pt idx="131">
                    <c:v>3.4848484758699446E-3</c:v>
                  </c:pt>
                  <c:pt idx="132">
                    <c:v>3.5589929924095863E-3</c:v>
                  </c:pt>
                  <c:pt idx="133">
                    <c:v>3.600659120940387E-3</c:v>
                  </c:pt>
                  <c:pt idx="134">
                    <c:v>3.6869802775773707E-3</c:v>
                  </c:pt>
                  <c:pt idx="135">
                    <c:v>3.7879045885766439E-3</c:v>
                  </c:pt>
                  <c:pt idx="136">
                    <c:v>3.9370328279599012E-3</c:v>
                  </c:pt>
                  <c:pt idx="137">
                    <c:v>4.0650063286065052E-3</c:v>
                  </c:pt>
                  <c:pt idx="138">
                    <c:v>4.1522874131416573E-3</c:v>
                  </c:pt>
                  <c:pt idx="139">
                    <c:v>4.1665814657733287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x"/>
            <c:errBarType val="both"/>
            <c:errValType val="fixedVal"/>
            <c:noEndCap val="0"/>
            <c:val val="1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AVG healthy'!$AT$5:$AT$144</c:f>
              <c:numCache>
                <c:formatCode>General</c:formatCode>
                <c:ptCount val="140"/>
                <c:pt idx="0">
                  <c:v>451.25</c:v>
                </c:pt>
                <c:pt idx="1">
                  <c:v>454.040009</c:v>
                </c:pt>
                <c:pt idx="2">
                  <c:v>456.82000699999998</c:v>
                </c:pt>
                <c:pt idx="3">
                  <c:v>459.60998499999999</c:v>
                </c:pt>
                <c:pt idx="4">
                  <c:v>462.39999399999999</c:v>
                </c:pt>
                <c:pt idx="5">
                  <c:v>465.19000199999999</c:v>
                </c:pt>
                <c:pt idx="6">
                  <c:v>467.98001099999999</c:v>
                </c:pt>
                <c:pt idx="7">
                  <c:v>470.77999899999998</c:v>
                </c:pt>
                <c:pt idx="8">
                  <c:v>473.57000699999998</c:v>
                </c:pt>
                <c:pt idx="9">
                  <c:v>476.36999500000002</c:v>
                </c:pt>
                <c:pt idx="10">
                  <c:v>479.16000400000001</c:v>
                </c:pt>
                <c:pt idx="11">
                  <c:v>481.959991</c:v>
                </c:pt>
                <c:pt idx="12">
                  <c:v>484.76001000000002</c:v>
                </c:pt>
                <c:pt idx="13">
                  <c:v>487.55999800000001</c:v>
                </c:pt>
                <c:pt idx="14">
                  <c:v>490.35998499999999</c:v>
                </c:pt>
                <c:pt idx="15">
                  <c:v>493.16000400000001</c:v>
                </c:pt>
                <c:pt idx="16">
                  <c:v>495.97000100000002</c:v>
                </c:pt>
                <c:pt idx="17">
                  <c:v>498.76998900000001</c:v>
                </c:pt>
                <c:pt idx="18">
                  <c:v>501.57998700000002</c:v>
                </c:pt>
                <c:pt idx="19">
                  <c:v>504.39001500000001</c:v>
                </c:pt>
                <c:pt idx="20">
                  <c:v>507.19000199999999</c:v>
                </c:pt>
                <c:pt idx="21">
                  <c:v>510</c:v>
                </c:pt>
                <c:pt idx="22">
                  <c:v>512.80999799999995</c:v>
                </c:pt>
                <c:pt idx="23">
                  <c:v>515.63000499999998</c:v>
                </c:pt>
                <c:pt idx="24">
                  <c:v>518.44000200000005</c:v>
                </c:pt>
                <c:pt idx="25">
                  <c:v>521.25</c:v>
                </c:pt>
                <c:pt idx="26">
                  <c:v>524.07000700000003</c:v>
                </c:pt>
                <c:pt idx="27">
                  <c:v>526.88000499999998</c:v>
                </c:pt>
                <c:pt idx="28">
                  <c:v>529.70001200000002</c:v>
                </c:pt>
                <c:pt idx="29">
                  <c:v>532.52002000000005</c:v>
                </c:pt>
                <c:pt idx="30">
                  <c:v>535.34002699999996</c:v>
                </c:pt>
                <c:pt idx="31">
                  <c:v>538.15997300000004</c:v>
                </c:pt>
                <c:pt idx="32">
                  <c:v>540.98999000000003</c:v>
                </c:pt>
                <c:pt idx="33">
                  <c:v>543.80999799999995</c:v>
                </c:pt>
                <c:pt idx="34">
                  <c:v>546.63000499999998</c:v>
                </c:pt>
                <c:pt idx="35">
                  <c:v>549.46002199999998</c:v>
                </c:pt>
                <c:pt idx="36">
                  <c:v>552.28997800000002</c:v>
                </c:pt>
                <c:pt idx="37">
                  <c:v>555.11999500000002</c:v>
                </c:pt>
                <c:pt idx="38">
                  <c:v>557.94000200000005</c:v>
                </c:pt>
                <c:pt idx="39">
                  <c:v>560.78002900000001</c:v>
                </c:pt>
                <c:pt idx="40">
                  <c:v>563.60998500000005</c:v>
                </c:pt>
                <c:pt idx="41">
                  <c:v>566.44000200000005</c:v>
                </c:pt>
                <c:pt idx="42">
                  <c:v>569.27002000000005</c:v>
                </c:pt>
                <c:pt idx="43">
                  <c:v>572.10998500000005</c:v>
                </c:pt>
                <c:pt idx="44">
                  <c:v>574.95001200000002</c:v>
                </c:pt>
                <c:pt idx="45">
                  <c:v>577.78002900000001</c:v>
                </c:pt>
                <c:pt idx="46">
                  <c:v>580.61999500000002</c:v>
                </c:pt>
                <c:pt idx="47">
                  <c:v>583.46002199999998</c:v>
                </c:pt>
                <c:pt idx="48">
                  <c:v>586.29998799999998</c:v>
                </c:pt>
                <c:pt idx="49">
                  <c:v>589.15002400000003</c:v>
                </c:pt>
                <c:pt idx="50">
                  <c:v>591.98999000000003</c:v>
                </c:pt>
                <c:pt idx="51">
                  <c:v>594.84002699999996</c:v>
                </c:pt>
                <c:pt idx="52">
                  <c:v>597.67999299999997</c:v>
                </c:pt>
                <c:pt idx="53">
                  <c:v>600.53002900000001</c:v>
                </c:pt>
                <c:pt idx="54">
                  <c:v>603.38000499999998</c:v>
                </c:pt>
                <c:pt idx="55">
                  <c:v>606.22997999999995</c:v>
                </c:pt>
                <c:pt idx="56">
                  <c:v>609.080017</c:v>
                </c:pt>
                <c:pt idx="57">
                  <c:v>611.92999299999997</c:v>
                </c:pt>
                <c:pt idx="58">
                  <c:v>614.78002900000001</c:v>
                </c:pt>
                <c:pt idx="59">
                  <c:v>617.64001499999995</c:v>
                </c:pt>
                <c:pt idx="60">
                  <c:v>620.48999000000003</c:v>
                </c:pt>
                <c:pt idx="61">
                  <c:v>623.34997599999997</c:v>
                </c:pt>
                <c:pt idx="62">
                  <c:v>626.21002199999998</c:v>
                </c:pt>
                <c:pt idx="63">
                  <c:v>629.07000700000003</c:v>
                </c:pt>
                <c:pt idx="64">
                  <c:v>631.92999299999997</c:v>
                </c:pt>
                <c:pt idx="65">
                  <c:v>634.78997800000002</c:v>
                </c:pt>
                <c:pt idx="66">
                  <c:v>637.65002400000003</c:v>
                </c:pt>
                <c:pt idx="67">
                  <c:v>640.51000999999997</c:v>
                </c:pt>
                <c:pt idx="68">
                  <c:v>643.38000499999998</c:v>
                </c:pt>
                <c:pt idx="69">
                  <c:v>646.23999000000003</c:v>
                </c:pt>
                <c:pt idx="70">
                  <c:v>649.10998500000005</c:v>
                </c:pt>
                <c:pt idx="71">
                  <c:v>651.97997999999995</c:v>
                </c:pt>
                <c:pt idx="72">
                  <c:v>654.84997599999997</c:v>
                </c:pt>
                <c:pt idx="73">
                  <c:v>657.71997099999999</c:v>
                </c:pt>
                <c:pt idx="74">
                  <c:v>660.59002699999996</c:v>
                </c:pt>
                <c:pt idx="75">
                  <c:v>663.46997099999999</c:v>
                </c:pt>
                <c:pt idx="76">
                  <c:v>666.34002699999996</c:v>
                </c:pt>
                <c:pt idx="77">
                  <c:v>669.21997099999999</c:v>
                </c:pt>
                <c:pt idx="78">
                  <c:v>672.09002699999996</c:v>
                </c:pt>
                <c:pt idx="79">
                  <c:v>674.96997099999999</c:v>
                </c:pt>
                <c:pt idx="80">
                  <c:v>677.84997599999997</c:v>
                </c:pt>
                <c:pt idx="81">
                  <c:v>680.72997999999995</c:v>
                </c:pt>
                <c:pt idx="82">
                  <c:v>683.60998500000005</c:v>
                </c:pt>
                <c:pt idx="83">
                  <c:v>686.48999000000003</c:v>
                </c:pt>
                <c:pt idx="84">
                  <c:v>689.38000499999998</c:v>
                </c:pt>
                <c:pt idx="85">
                  <c:v>692.26000999999997</c:v>
                </c:pt>
                <c:pt idx="86">
                  <c:v>695.15002400000003</c:v>
                </c:pt>
                <c:pt idx="87">
                  <c:v>698.03002900000001</c:v>
                </c:pt>
                <c:pt idx="88">
                  <c:v>700.919983</c:v>
                </c:pt>
                <c:pt idx="89">
                  <c:v>703.80999799999995</c:v>
                </c:pt>
                <c:pt idx="90">
                  <c:v>706.70001200000002</c:v>
                </c:pt>
                <c:pt idx="91">
                  <c:v>709.59997599999997</c:v>
                </c:pt>
                <c:pt idx="92">
                  <c:v>712.48999000000003</c:v>
                </c:pt>
                <c:pt idx="93">
                  <c:v>715.38000499999998</c:v>
                </c:pt>
                <c:pt idx="94">
                  <c:v>718.28002900000001</c:v>
                </c:pt>
                <c:pt idx="95">
                  <c:v>721.17999299999997</c:v>
                </c:pt>
                <c:pt idx="96">
                  <c:v>724.07000700000003</c:v>
                </c:pt>
                <c:pt idx="97">
                  <c:v>726.96997099999999</c:v>
                </c:pt>
                <c:pt idx="98">
                  <c:v>729.86999500000002</c:v>
                </c:pt>
                <c:pt idx="99">
                  <c:v>732.77002000000005</c:v>
                </c:pt>
                <c:pt idx="100">
                  <c:v>735.67999299999997</c:v>
                </c:pt>
                <c:pt idx="101">
                  <c:v>738.580017</c:v>
                </c:pt>
                <c:pt idx="102">
                  <c:v>741.48999000000003</c:v>
                </c:pt>
                <c:pt idx="103">
                  <c:v>744.39001499999995</c:v>
                </c:pt>
                <c:pt idx="104">
                  <c:v>747.29998799999998</c:v>
                </c:pt>
                <c:pt idx="105">
                  <c:v>750.21002199999998</c:v>
                </c:pt>
                <c:pt idx="106">
                  <c:v>753.11999500000002</c:v>
                </c:pt>
                <c:pt idx="107">
                  <c:v>756.03002900000001</c:v>
                </c:pt>
                <c:pt idx="108">
                  <c:v>758.94000200000005</c:v>
                </c:pt>
                <c:pt idx="109">
                  <c:v>761.84997599999997</c:v>
                </c:pt>
                <c:pt idx="110">
                  <c:v>764.77002000000005</c:v>
                </c:pt>
                <c:pt idx="111">
                  <c:v>767.67999299999997</c:v>
                </c:pt>
                <c:pt idx="112">
                  <c:v>770.59997599999997</c:v>
                </c:pt>
                <c:pt idx="113">
                  <c:v>773.52002000000005</c:v>
                </c:pt>
                <c:pt idx="114">
                  <c:v>776.44000200000005</c:v>
                </c:pt>
                <c:pt idx="115">
                  <c:v>779.35998500000005</c:v>
                </c:pt>
                <c:pt idx="116">
                  <c:v>782.28002900000001</c:v>
                </c:pt>
                <c:pt idx="117">
                  <c:v>785.20001200000002</c:v>
                </c:pt>
                <c:pt idx="118">
                  <c:v>788.11999500000002</c:v>
                </c:pt>
                <c:pt idx="119">
                  <c:v>791.04998799999998</c:v>
                </c:pt>
                <c:pt idx="120">
                  <c:v>793.97997999999995</c:v>
                </c:pt>
                <c:pt idx="121">
                  <c:v>796.90002400000003</c:v>
                </c:pt>
                <c:pt idx="122">
                  <c:v>799.830017</c:v>
                </c:pt>
                <c:pt idx="123">
                  <c:v>802.76000999999997</c:v>
                </c:pt>
                <c:pt idx="124">
                  <c:v>805.69000200000005</c:v>
                </c:pt>
                <c:pt idx="125">
                  <c:v>808.61999500000002</c:v>
                </c:pt>
                <c:pt idx="126">
                  <c:v>811.55999799999995</c:v>
                </c:pt>
                <c:pt idx="127">
                  <c:v>814.48999000000003</c:v>
                </c:pt>
                <c:pt idx="128">
                  <c:v>817.42999299999997</c:v>
                </c:pt>
                <c:pt idx="129">
                  <c:v>820.35998500000005</c:v>
                </c:pt>
                <c:pt idx="130">
                  <c:v>823.29998799999998</c:v>
                </c:pt>
                <c:pt idx="131">
                  <c:v>826.23999000000003</c:v>
                </c:pt>
                <c:pt idx="132">
                  <c:v>829.17999299999997</c:v>
                </c:pt>
                <c:pt idx="133">
                  <c:v>832.11999500000002</c:v>
                </c:pt>
                <c:pt idx="134">
                  <c:v>835.07000700000003</c:v>
                </c:pt>
                <c:pt idx="135">
                  <c:v>838.01000999999997</c:v>
                </c:pt>
                <c:pt idx="136">
                  <c:v>840.95001200000002</c:v>
                </c:pt>
                <c:pt idx="137">
                  <c:v>843.90002400000003</c:v>
                </c:pt>
                <c:pt idx="138">
                  <c:v>846.84997599999997</c:v>
                </c:pt>
                <c:pt idx="139">
                  <c:v>849.79998799999998</c:v>
                </c:pt>
              </c:numCache>
            </c:numRef>
          </c:xVal>
          <c:yVal>
            <c:numRef>
              <c:f>'AVG healthy'!$AU$5:$AU$144</c:f>
              <c:numCache>
                <c:formatCode>General</c:formatCode>
                <c:ptCount val="140"/>
                <c:pt idx="0">
                  <c:v>4.8546187499999997E-2</c:v>
                </c:pt>
                <c:pt idx="1">
                  <c:v>4.8599937500000003E-2</c:v>
                </c:pt>
                <c:pt idx="2">
                  <c:v>4.8498562500000009E-2</c:v>
                </c:pt>
                <c:pt idx="3">
                  <c:v>4.8099937500000002E-2</c:v>
                </c:pt>
                <c:pt idx="4">
                  <c:v>4.7709624999999999E-2</c:v>
                </c:pt>
                <c:pt idx="5">
                  <c:v>4.7258250000000002E-2</c:v>
                </c:pt>
                <c:pt idx="6">
                  <c:v>4.6889750000000008E-2</c:v>
                </c:pt>
                <c:pt idx="7">
                  <c:v>4.6525625000000001E-2</c:v>
                </c:pt>
                <c:pt idx="8">
                  <c:v>4.6278812500000002E-2</c:v>
                </c:pt>
                <c:pt idx="9">
                  <c:v>4.6130687500000003E-2</c:v>
                </c:pt>
                <c:pt idx="10">
                  <c:v>4.6044687500000001E-2</c:v>
                </c:pt>
                <c:pt idx="11">
                  <c:v>4.5936375000000002E-2</c:v>
                </c:pt>
                <c:pt idx="12">
                  <c:v>4.5866187500000009E-2</c:v>
                </c:pt>
                <c:pt idx="13">
                  <c:v>4.6079687499999994E-2</c:v>
                </c:pt>
                <c:pt idx="14">
                  <c:v>4.6616375000000002E-2</c:v>
                </c:pt>
                <c:pt idx="15">
                  <c:v>4.7502937499999995E-2</c:v>
                </c:pt>
                <c:pt idx="16">
                  <c:v>4.8843062499999999E-2</c:v>
                </c:pt>
                <c:pt idx="17">
                  <c:v>5.0797437500000014E-2</c:v>
                </c:pt>
                <c:pt idx="18">
                  <c:v>5.3601625E-2</c:v>
                </c:pt>
                <c:pt idx="19">
                  <c:v>5.7348937500000002E-2</c:v>
                </c:pt>
                <c:pt idx="20">
                  <c:v>6.2294249999999995E-2</c:v>
                </c:pt>
                <c:pt idx="21">
                  <c:v>6.8427124999999991E-2</c:v>
                </c:pt>
                <c:pt idx="22">
                  <c:v>7.5907562499999998E-2</c:v>
                </c:pt>
                <c:pt idx="23">
                  <c:v>8.4601375000000006E-2</c:v>
                </c:pt>
                <c:pt idx="24">
                  <c:v>9.4360625000000004E-2</c:v>
                </c:pt>
                <c:pt idx="25">
                  <c:v>0.10469281250000001</c:v>
                </c:pt>
                <c:pt idx="26">
                  <c:v>0.1149528125</c:v>
                </c:pt>
                <c:pt idx="27">
                  <c:v>0.124286625</c:v>
                </c:pt>
                <c:pt idx="28">
                  <c:v>0.13210850000000002</c:v>
                </c:pt>
                <c:pt idx="29">
                  <c:v>0.13820793749999999</c:v>
                </c:pt>
                <c:pt idx="30">
                  <c:v>0.1428066875</c:v>
                </c:pt>
                <c:pt idx="31">
                  <c:v>0.14615181250000001</c:v>
                </c:pt>
                <c:pt idx="32">
                  <c:v>0.14861475000000002</c:v>
                </c:pt>
                <c:pt idx="33">
                  <c:v>0.150609625</c:v>
                </c:pt>
                <c:pt idx="34">
                  <c:v>0.15248700000000001</c:v>
                </c:pt>
                <c:pt idx="35">
                  <c:v>0.15420975000000001</c:v>
                </c:pt>
                <c:pt idx="36">
                  <c:v>0.1554168125</c:v>
                </c:pt>
                <c:pt idx="37">
                  <c:v>0.15562506249999999</c:v>
                </c:pt>
                <c:pt idx="38">
                  <c:v>0.15453718749999998</c:v>
                </c:pt>
                <c:pt idx="39">
                  <c:v>0.1522305625</c:v>
                </c:pt>
                <c:pt idx="40">
                  <c:v>0.14888368749999997</c:v>
                </c:pt>
                <c:pt idx="41">
                  <c:v>0.14454424999999999</c:v>
                </c:pt>
                <c:pt idx="42">
                  <c:v>0.1392543125</c:v>
                </c:pt>
                <c:pt idx="43">
                  <c:v>0.13340768750000001</c:v>
                </c:pt>
                <c:pt idx="44">
                  <c:v>0.12767581250000001</c:v>
                </c:pt>
                <c:pt idx="45">
                  <c:v>0.12259275</c:v>
                </c:pt>
                <c:pt idx="46">
                  <c:v>0.1183010625</c:v>
                </c:pt>
                <c:pt idx="47">
                  <c:v>0.11468031249999999</c:v>
                </c:pt>
                <c:pt idx="48">
                  <c:v>0.11164731250000001</c:v>
                </c:pt>
                <c:pt idx="49">
                  <c:v>0.10918712500000001</c:v>
                </c:pt>
                <c:pt idx="50">
                  <c:v>0.10729918749999999</c:v>
                </c:pt>
                <c:pt idx="51">
                  <c:v>0.10589374999999999</c:v>
                </c:pt>
                <c:pt idx="52">
                  <c:v>0.10479724999999999</c:v>
                </c:pt>
                <c:pt idx="53">
                  <c:v>0.10369231249999999</c:v>
                </c:pt>
                <c:pt idx="54">
                  <c:v>0.10219081249999999</c:v>
                </c:pt>
                <c:pt idx="55">
                  <c:v>9.9956937499999995E-2</c:v>
                </c:pt>
                <c:pt idx="56">
                  <c:v>9.698675000000001E-2</c:v>
                </c:pt>
                <c:pt idx="57">
                  <c:v>9.3560312500000006E-2</c:v>
                </c:pt>
                <c:pt idx="58">
                  <c:v>9.0099312500000014E-2</c:v>
                </c:pt>
                <c:pt idx="59">
                  <c:v>8.6965500000000001E-2</c:v>
                </c:pt>
                <c:pt idx="60">
                  <c:v>8.4443812499999993E-2</c:v>
                </c:pt>
                <c:pt idx="61">
                  <c:v>8.2700625E-2</c:v>
                </c:pt>
                <c:pt idx="62">
                  <c:v>8.1736625000000007E-2</c:v>
                </c:pt>
                <c:pt idx="63">
                  <c:v>8.1339124999999998E-2</c:v>
                </c:pt>
                <c:pt idx="64">
                  <c:v>8.09021875E-2</c:v>
                </c:pt>
                <c:pt idx="65">
                  <c:v>7.9730999999999996E-2</c:v>
                </c:pt>
                <c:pt idx="66">
                  <c:v>7.7444437499999991E-2</c:v>
                </c:pt>
                <c:pt idx="67">
                  <c:v>7.4267124999999989E-2</c:v>
                </c:pt>
                <c:pt idx="68">
                  <c:v>7.0577562499999996E-2</c:v>
                </c:pt>
                <c:pt idx="69">
                  <c:v>6.6853812499999998E-2</c:v>
                </c:pt>
                <c:pt idx="70">
                  <c:v>6.3629812500000008E-2</c:v>
                </c:pt>
                <c:pt idx="71">
                  <c:v>6.1075375000000001E-2</c:v>
                </c:pt>
                <c:pt idx="72">
                  <c:v>5.8662500000000006E-2</c:v>
                </c:pt>
                <c:pt idx="73">
                  <c:v>5.5800750000000003E-2</c:v>
                </c:pt>
                <c:pt idx="74">
                  <c:v>5.2473999999999993E-2</c:v>
                </c:pt>
                <c:pt idx="75">
                  <c:v>4.907475E-2</c:v>
                </c:pt>
                <c:pt idx="76">
                  <c:v>4.5956312499999999E-2</c:v>
                </c:pt>
                <c:pt idx="77">
                  <c:v>4.3436500000000003E-2</c:v>
                </c:pt>
                <c:pt idx="78">
                  <c:v>4.1704437499999997E-2</c:v>
                </c:pt>
                <c:pt idx="79">
                  <c:v>4.0870374999999994E-2</c:v>
                </c:pt>
                <c:pt idx="80">
                  <c:v>4.0920750000000006E-2</c:v>
                </c:pt>
                <c:pt idx="81">
                  <c:v>4.2009749999999998E-2</c:v>
                </c:pt>
                <c:pt idx="82">
                  <c:v>4.4627500000000001E-2</c:v>
                </c:pt>
                <c:pt idx="83">
                  <c:v>4.9967562500000007E-2</c:v>
                </c:pt>
                <c:pt idx="84">
                  <c:v>5.9804312499999998E-2</c:v>
                </c:pt>
                <c:pt idx="85">
                  <c:v>7.56605625E-2</c:v>
                </c:pt>
                <c:pt idx="86">
                  <c:v>9.7789312499999989E-2</c:v>
                </c:pt>
                <c:pt idx="87">
                  <c:v>0.124754875</c:v>
                </c:pt>
                <c:pt idx="88">
                  <c:v>0.15358287500000001</c:v>
                </c:pt>
                <c:pt idx="89">
                  <c:v>0.18110831249999998</c:v>
                </c:pt>
                <c:pt idx="90">
                  <c:v>0.20569587500000003</c:v>
                </c:pt>
                <c:pt idx="91">
                  <c:v>0.22743168749999998</c:v>
                </c:pt>
                <c:pt idx="92">
                  <c:v>0.24707425</c:v>
                </c:pt>
                <c:pt idx="93">
                  <c:v>0.265006625</c:v>
                </c:pt>
                <c:pt idx="94">
                  <c:v>0.28142299999999998</c:v>
                </c:pt>
                <c:pt idx="95">
                  <c:v>0.29629324999999995</c:v>
                </c:pt>
                <c:pt idx="96">
                  <c:v>0.30960981249999997</c:v>
                </c:pt>
                <c:pt idx="97">
                  <c:v>0.32149925000000001</c:v>
                </c:pt>
                <c:pt idx="98">
                  <c:v>0.3319085625</c:v>
                </c:pt>
                <c:pt idx="99">
                  <c:v>0.3408044375</c:v>
                </c:pt>
                <c:pt idx="100">
                  <c:v>0.34823725</c:v>
                </c:pt>
                <c:pt idx="101">
                  <c:v>0.35433487499999999</c:v>
                </c:pt>
                <c:pt idx="102">
                  <c:v>0.35906456249999996</c:v>
                </c:pt>
                <c:pt idx="103">
                  <c:v>0.36246462499999998</c:v>
                </c:pt>
                <c:pt idx="104">
                  <c:v>0.36502762499999997</c:v>
                </c:pt>
                <c:pt idx="105">
                  <c:v>0.36699025000000002</c:v>
                </c:pt>
                <c:pt idx="106">
                  <c:v>0.3685235</c:v>
                </c:pt>
                <c:pt idx="107">
                  <c:v>0.36987425000000002</c:v>
                </c:pt>
                <c:pt idx="108">
                  <c:v>0.37105637499999999</c:v>
                </c:pt>
                <c:pt idx="109">
                  <c:v>0.37194462499999997</c:v>
                </c:pt>
                <c:pt idx="110">
                  <c:v>0.37282124999999999</c:v>
                </c:pt>
                <c:pt idx="111">
                  <c:v>0.37376387500000002</c:v>
                </c:pt>
                <c:pt idx="112">
                  <c:v>0.374410625</c:v>
                </c:pt>
                <c:pt idx="113">
                  <c:v>0.37480312500000001</c:v>
                </c:pt>
                <c:pt idx="114">
                  <c:v>0.37510281249999999</c:v>
                </c:pt>
                <c:pt idx="115">
                  <c:v>0.37511762500000001</c:v>
                </c:pt>
                <c:pt idx="116">
                  <c:v>0.37473506249999999</c:v>
                </c:pt>
                <c:pt idx="117">
                  <c:v>0.37428549999999999</c:v>
                </c:pt>
                <c:pt idx="118">
                  <c:v>0.37372181250000003</c:v>
                </c:pt>
                <c:pt idx="119">
                  <c:v>0.37301643750000002</c:v>
                </c:pt>
                <c:pt idx="120">
                  <c:v>0.37214387500000001</c:v>
                </c:pt>
                <c:pt idx="121">
                  <c:v>0.37100262500000003</c:v>
                </c:pt>
                <c:pt idx="122">
                  <c:v>0.36974912500000001</c:v>
                </c:pt>
                <c:pt idx="123">
                  <c:v>0.36868406250000002</c:v>
                </c:pt>
                <c:pt idx="124">
                  <c:v>0.36807981249999999</c:v>
                </c:pt>
                <c:pt idx="125">
                  <c:v>0.36773543750000004</c:v>
                </c:pt>
                <c:pt idx="126">
                  <c:v>0.36736943750000001</c:v>
                </c:pt>
                <c:pt idx="127">
                  <c:v>0.36669062499999994</c:v>
                </c:pt>
                <c:pt idx="128">
                  <c:v>0.36604006249999999</c:v>
                </c:pt>
                <c:pt idx="129">
                  <c:v>0.3655858125</c:v>
                </c:pt>
                <c:pt idx="130">
                  <c:v>0.36527675000000004</c:v>
                </c:pt>
                <c:pt idx="131">
                  <c:v>0.36496856249999998</c:v>
                </c:pt>
                <c:pt idx="132">
                  <c:v>0.36491418749999999</c:v>
                </c:pt>
                <c:pt idx="133">
                  <c:v>0.36498956250000003</c:v>
                </c:pt>
                <c:pt idx="134">
                  <c:v>0.36524806249999997</c:v>
                </c:pt>
                <c:pt idx="135">
                  <c:v>0.36568968750000003</c:v>
                </c:pt>
                <c:pt idx="136">
                  <c:v>0.36645237500000005</c:v>
                </c:pt>
                <c:pt idx="137">
                  <c:v>0.3672764375</c:v>
                </c:pt>
                <c:pt idx="138">
                  <c:v>0.36835300000000004</c:v>
                </c:pt>
                <c:pt idx="139">
                  <c:v>0.3691271874999999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24B1-4701-9C3E-F738DACE2604}"/>
            </c:ext>
          </c:extLst>
        </c:ser>
        <c:ser>
          <c:idx val="1"/>
          <c:order val="1"/>
          <c:tx>
            <c:strRef>
              <c:f>'AVG healthy'!$AV$4</c:f>
              <c:strCache>
                <c:ptCount val="1"/>
                <c:pt idx="0">
                  <c:v>Nipponbare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1"/>
            <c:plus>
              <c:numRef>
                <c:f>'AVG healthy'!$AY$5:$AY$144</c:f>
                <c:numCache>
                  <c:formatCode>General</c:formatCode>
                  <c:ptCount val="140"/>
                  <c:pt idx="0">
                    <c:v>8.2413779793899977E-4</c:v>
                  </c:pt>
                  <c:pt idx="1">
                    <c:v>8.4445082544361782E-4</c:v>
                  </c:pt>
                  <c:pt idx="2">
                    <c:v>8.7016246799637089E-4</c:v>
                  </c:pt>
                  <c:pt idx="3">
                    <c:v>8.4137279495744542E-4</c:v>
                  </c:pt>
                  <c:pt idx="4">
                    <c:v>8.3323182431131509E-4</c:v>
                  </c:pt>
                  <c:pt idx="5">
                    <c:v>8.0818500288625146E-4</c:v>
                  </c:pt>
                  <c:pt idx="6">
                    <c:v>8.0189873045293631E-4</c:v>
                  </c:pt>
                  <c:pt idx="7">
                    <c:v>7.949612329431362E-4</c:v>
                  </c:pt>
                  <c:pt idx="8">
                    <c:v>7.9910163404556538E-4</c:v>
                  </c:pt>
                  <c:pt idx="9">
                    <c:v>7.9620597519853968E-4</c:v>
                  </c:pt>
                  <c:pt idx="10">
                    <c:v>7.7853842743670111E-4</c:v>
                  </c:pt>
                  <c:pt idx="11">
                    <c:v>7.8106918379913088E-4</c:v>
                  </c:pt>
                  <c:pt idx="12">
                    <c:v>7.8431503684662542E-4</c:v>
                  </c:pt>
                  <c:pt idx="13">
                    <c:v>7.7587014132938137E-4</c:v>
                  </c:pt>
                  <c:pt idx="14">
                    <c:v>7.5134836154403396E-4</c:v>
                  </c:pt>
                  <c:pt idx="15">
                    <c:v>7.4067915355620882E-4</c:v>
                  </c:pt>
                  <c:pt idx="16">
                    <c:v>7.1428587174526728E-4</c:v>
                  </c:pt>
                  <c:pt idx="17">
                    <c:v>6.8480954389453356E-4</c:v>
                  </c:pt>
                  <c:pt idx="18">
                    <c:v>6.5736664218270366E-4</c:v>
                  </c:pt>
                  <c:pt idx="19">
                    <c:v>6.9096276429593171E-4</c:v>
                  </c:pt>
                  <c:pt idx="20">
                    <c:v>7.9341184126258384E-4</c:v>
                  </c:pt>
                  <c:pt idx="21">
                    <c:v>9.0587846771994214E-4</c:v>
                  </c:pt>
                  <c:pt idx="22">
                    <c:v>1.0219720735716537E-3</c:v>
                  </c:pt>
                  <c:pt idx="23">
                    <c:v>1.1558702391841816E-3</c:v>
                  </c:pt>
                  <c:pt idx="24">
                    <c:v>1.2954179899148251E-3</c:v>
                  </c:pt>
                  <c:pt idx="25">
                    <c:v>1.4377140907500504E-3</c:v>
                  </c:pt>
                  <c:pt idx="26">
                    <c:v>1.5537292371206211E-3</c:v>
                  </c:pt>
                  <c:pt idx="27">
                    <c:v>1.6275298162873285E-3</c:v>
                  </c:pt>
                  <c:pt idx="28">
                    <c:v>1.671416019445305E-3</c:v>
                  </c:pt>
                  <c:pt idx="29">
                    <c:v>1.7120957119336534E-3</c:v>
                  </c:pt>
                  <c:pt idx="30">
                    <c:v>1.7747705171252441E-3</c:v>
                  </c:pt>
                  <c:pt idx="31">
                    <c:v>1.8441378281636802E-3</c:v>
                  </c:pt>
                  <c:pt idx="32">
                    <c:v>1.886608337486544E-3</c:v>
                  </c:pt>
                  <c:pt idx="33">
                    <c:v>1.9177695751568169E-3</c:v>
                  </c:pt>
                  <c:pt idx="34">
                    <c:v>1.9490232005842396E-3</c:v>
                  </c:pt>
                  <c:pt idx="35">
                    <c:v>1.9756030896743914E-3</c:v>
                  </c:pt>
                  <c:pt idx="36">
                    <c:v>1.9973668665917445E-3</c:v>
                  </c:pt>
                  <c:pt idx="37">
                    <c:v>2.0279997276714387E-3</c:v>
                  </c:pt>
                  <c:pt idx="38">
                    <c:v>2.0754520427508508E-3</c:v>
                  </c:pt>
                  <c:pt idx="39">
                    <c:v>2.1217949568763236E-3</c:v>
                  </c:pt>
                  <c:pt idx="40">
                    <c:v>2.1686285679071255E-3</c:v>
                  </c:pt>
                  <c:pt idx="41">
                    <c:v>2.2111789694262093E-3</c:v>
                  </c:pt>
                  <c:pt idx="42">
                    <c:v>2.2458092754251494E-3</c:v>
                  </c:pt>
                  <c:pt idx="43">
                    <c:v>2.2740881854851781E-3</c:v>
                  </c:pt>
                  <c:pt idx="44">
                    <c:v>2.2872769714607855E-3</c:v>
                  </c:pt>
                  <c:pt idx="45">
                    <c:v>2.2930024878899218E-3</c:v>
                  </c:pt>
                  <c:pt idx="46">
                    <c:v>2.2873122097198479E-3</c:v>
                  </c:pt>
                  <c:pt idx="47">
                    <c:v>2.2802772239651657E-3</c:v>
                  </c:pt>
                  <c:pt idx="48">
                    <c:v>2.261789131625596E-3</c:v>
                  </c:pt>
                  <c:pt idx="49">
                    <c:v>2.243675791773413E-3</c:v>
                  </c:pt>
                  <c:pt idx="50">
                    <c:v>2.228375384220326E-3</c:v>
                  </c:pt>
                  <c:pt idx="51">
                    <c:v>2.219629778481739E-3</c:v>
                  </c:pt>
                  <c:pt idx="52">
                    <c:v>2.2066695052126144E-3</c:v>
                  </c:pt>
                  <c:pt idx="53">
                    <c:v>2.201042217451688E-3</c:v>
                  </c:pt>
                  <c:pt idx="54">
                    <c:v>2.1972868094875132E-3</c:v>
                  </c:pt>
                  <c:pt idx="55">
                    <c:v>2.1821110839932412E-3</c:v>
                  </c:pt>
                  <c:pt idx="56">
                    <c:v>2.1476573009202773E-3</c:v>
                  </c:pt>
                  <c:pt idx="57">
                    <c:v>2.1121156095429226E-3</c:v>
                  </c:pt>
                  <c:pt idx="58">
                    <c:v>2.0756775721791397E-3</c:v>
                  </c:pt>
                  <c:pt idx="59">
                    <c:v>2.0325730081916481E-3</c:v>
                  </c:pt>
                  <c:pt idx="60">
                    <c:v>1.9908060894409476E-3</c:v>
                  </c:pt>
                  <c:pt idx="61">
                    <c:v>1.9673644333512365E-3</c:v>
                  </c:pt>
                  <c:pt idx="62">
                    <c:v>1.9558405324092958E-3</c:v>
                  </c:pt>
                  <c:pt idx="63">
                    <c:v>1.9511222212140241E-3</c:v>
                  </c:pt>
                  <c:pt idx="64">
                    <c:v>1.9438501831248957E-3</c:v>
                  </c:pt>
                  <c:pt idx="65">
                    <c:v>1.914902837737111E-3</c:v>
                  </c:pt>
                  <c:pt idx="66">
                    <c:v>1.8469867302586583E-3</c:v>
                  </c:pt>
                  <c:pt idx="67">
                    <c:v>1.7519922354824165E-3</c:v>
                  </c:pt>
                  <c:pt idx="68">
                    <c:v>1.6446741656390229E-3</c:v>
                  </c:pt>
                  <c:pt idx="69">
                    <c:v>1.5429438027192181E-3</c:v>
                  </c:pt>
                  <c:pt idx="70">
                    <c:v>1.4537903734483E-3</c:v>
                  </c:pt>
                  <c:pt idx="71">
                    <c:v>1.3930092518173213E-3</c:v>
                  </c:pt>
                  <c:pt idx="72">
                    <c:v>1.3366697095103454E-3</c:v>
                  </c:pt>
                  <c:pt idx="73">
                    <c:v>1.2696177643449493E-3</c:v>
                  </c:pt>
                  <c:pt idx="74">
                    <c:v>1.1781804452522596E-3</c:v>
                  </c:pt>
                  <c:pt idx="75">
                    <c:v>1.0789352437134249E-3</c:v>
                  </c:pt>
                  <c:pt idx="76">
                    <c:v>9.8703524487149552E-4</c:v>
                  </c:pt>
                  <c:pt idx="77">
                    <c:v>9.0765897869422895E-4</c:v>
                  </c:pt>
                  <c:pt idx="78">
                    <c:v>8.5676609774796122E-4</c:v>
                  </c:pt>
                  <c:pt idx="79">
                    <c:v>8.3079686983963149E-4</c:v>
                  </c:pt>
                  <c:pt idx="80">
                    <c:v>8.3059554495410349E-4</c:v>
                  </c:pt>
                  <c:pt idx="81">
                    <c:v>8.5559421606283873E-4</c:v>
                  </c:pt>
                  <c:pt idx="82">
                    <c:v>9.3139315900651995E-4</c:v>
                  </c:pt>
                  <c:pt idx="83">
                    <c:v>1.0976984990073908E-3</c:v>
                  </c:pt>
                  <c:pt idx="84">
                    <c:v>1.4029043757970393E-3</c:v>
                  </c:pt>
                  <c:pt idx="85">
                    <c:v>1.8447963606045635E-3</c:v>
                  </c:pt>
                  <c:pt idx="86">
                    <c:v>2.3261413818367552E-3</c:v>
                  </c:pt>
                  <c:pt idx="87">
                    <c:v>2.7584963649710335E-3</c:v>
                  </c:pt>
                  <c:pt idx="88">
                    <c:v>3.0540424852808401E-3</c:v>
                  </c:pt>
                  <c:pt idx="89">
                    <c:v>3.1760078537651794E-3</c:v>
                  </c:pt>
                  <c:pt idx="90">
                    <c:v>3.1016269811757853E-3</c:v>
                  </c:pt>
                  <c:pt idx="91">
                    <c:v>2.8975092517412641E-3</c:v>
                  </c:pt>
                  <c:pt idx="92">
                    <c:v>2.6105445242020154E-3</c:v>
                  </c:pt>
                  <c:pt idx="93">
                    <c:v>2.2825957403651374E-3</c:v>
                  </c:pt>
                  <c:pt idx="94">
                    <c:v>1.917963265387043E-3</c:v>
                  </c:pt>
                  <c:pt idx="95">
                    <c:v>1.5709310540569267E-3</c:v>
                  </c:pt>
                  <c:pt idx="96">
                    <c:v>1.2920313573343085E-3</c:v>
                  </c:pt>
                  <c:pt idx="97">
                    <c:v>1.1797658872011901E-3</c:v>
                  </c:pt>
                  <c:pt idx="98">
                    <c:v>1.2493542821316686E-3</c:v>
                  </c:pt>
                  <c:pt idx="99">
                    <c:v>1.4453869217788478E-3</c:v>
                  </c:pt>
                  <c:pt idx="100">
                    <c:v>1.6771122551635913E-3</c:v>
                  </c:pt>
                  <c:pt idx="101">
                    <c:v>1.9057647907025216E-3</c:v>
                  </c:pt>
                  <c:pt idx="102">
                    <c:v>2.1202069437960013E-3</c:v>
                  </c:pt>
                  <c:pt idx="103">
                    <c:v>2.3073913067558965E-3</c:v>
                  </c:pt>
                  <c:pt idx="104">
                    <c:v>2.4232275462852987E-3</c:v>
                  </c:pt>
                  <c:pt idx="105">
                    <c:v>2.508779187664692E-3</c:v>
                  </c:pt>
                  <c:pt idx="106">
                    <c:v>2.561748645318042E-3</c:v>
                  </c:pt>
                  <c:pt idx="107">
                    <c:v>2.6340114973517834E-3</c:v>
                  </c:pt>
                  <c:pt idx="108">
                    <c:v>2.669818792036881E-3</c:v>
                  </c:pt>
                  <c:pt idx="109">
                    <c:v>2.696433637766206E-3</c:v>
                  </c:pt>
                  <c:pt idx="110">
                    <c:v>2.6877179185476174E-3</c:v>
                  </c:pt>
                  <c:pt idx="111">
                    <c:v>2.7377922645985568E-3</c:v>
                  </c:pt>
                  <c:pt idx="112">
                    <c:v>2.7528037937562129E-3</c:v>
                  </c:pt>
                  <c:pt idx="113">
                    <c:v>2.7875199593933443E-3</c:v>
                  </c:pt>
                  <c:pt idx="114">
                    <c:v>2.7818433475279899E-3</c:v>
                  </c:pt>
                  <c:pt idx="115">
                    <c:v>2.8168675606841864E-3</c:v>
                  </c:pt>
                  <c:pt idx="116">
                    <c:v>2.86707099669028E-3</c:v>
                  </c:pt>
                  <c:pt idx="117">
                    <c:v>2.9494327113935648E-3</c:v>
                  </c:pt>
                  <c:pt idx="118">
                    <c:v>3.0265985527313782E-3</c:v>
                  </c:pt>
                  <c:pt idx="119">
                    <c:v>3.0959489352184065E-3</c:v>
                  </c:pt>
                  <c:pt idx="120">
                    <c:v>3.1744261796533401E-3</c:v>
                  </c:pt>
                  <c:pt idx="121">
                    <c:v>3.2345523968219346E-3</c:v>
                  </c:pt>
                  <c:pt idx="122">
                    <c:v>3.2490731087525477E-3</c:v>
                  </c:pt>
                  <c:pt idx="123">
                    <c:v>3.2480515770408305E-3</c:v>
                  </c:pt>
                  <c:pt idx="124">
                    <c:v>3.233114850796354E-3</c:v>
                  </c:pt>
                  <c:pt idx="125">
                    <c:v>3.2057919129029199E-3</c:v>
                  </c:pt>
                  <c:pt idx="126">
                    <c:v>3.2193322727209137E-3</c:v>
                  </c:pt>
                  <c:pt idx="127">
                    <c:v>3.3319667439918009E-3</c:v>
                  </c:pt>
                  <c:pt idx="128">
                    <c:v>3.4616390401656953E-3</c:v>
                  </c:pt>
                  <c:pt idx="129">
                    <c:v>3.5086442146631492E-3</c:v>
                  </c:pt>
                  <c:pt idx="130">
                    <c:v>3.5597274329818838E-3</c:v>
                  </c:pt>
                  <c:pt idx="131">
                    <c:v>3.7112585950950291E-3</c:v>
                  </c:pt>
                  <c:pt idx="132">
                    <c:v>3.8795894730203834E-3</c:v>
                  </c:pt>
                  <c:pt idx="133">
                    <c:v>4.0084105640136505E-3</c:v>
                  </c:pt>
                  <c:pt idx="134">
                    <c:v>4.1036204311629167E-3</c:v>
                  </c:pt>
                  <c:pt idx="135">
                    <c:v>4.227624364450993E-3</c:v>
                  </c:pt>
                  <c:pt idx="136">
                    <c:v>4.3251639377720223E-3</c:v>
                  </c:pt>
                  <c:pt idx="137">
                    <c:v>4.41653780607022E-3</c:v>
                  </c:pt>
                  <c:pt idx="138">
                    <c:v>4.4968050169737726E-3</c:v>
                  </c:pt>
                  <c:pt idx="139">
                    <c:v>4.5454580701338645E-3</c:v>
                  </c:pt>
                </c:numCache>
              </c:numRef>
            </c:plus>
            <c:minus>
              <c:numRef>
                <c:f>'AVG healthy'!$AY$5:$AY$144</c:f>
                <c:numCache>
                  <c:formatCode>General</c:formatCode>
                  <c:ptCount val="140"/>
                  <c:pt idx="0">
                    <c:v>8.2413779793899977E-4</c:v>
                  </c:pt>
                  <c:pt idx="1">
                    <c:v>8.4445082544361782E-4</c:v>
                  </c:pt>
                  <c:pt idx="2">
                    <c:v>8.7016246799637089E-4</c:v>
                  </c:pt>
                  <c:pt idx="3">
                    <c:v>8.4137279495744542E-4</c:v>
                  </c:pt>
                  <c:pt idx="4">
                    <c:v>8.3323182431131509E-4</c:v>
                  </c:pt>
                  <c:pt idx="5">
                    <c:v>8.0818500288625146E-4</c:v>
                  </c:pt>
                  <c:pt idx="6">
                    <c:v>8.0189873045293631E-4</c:v>
                  </c:pt>
                  <c:pt idx="7">
                    <c:v>7.949612329431362E-4</c:v>
                  </c:pt>
                  <c:pt idx="8">
                    <c:v>7.9910163404556538E-4</c:v>
                  </c:pt>
                  <c:pt idx="9">
                    <c:v>7.9620597519853968E-4</c:v>
                  </c:pt>
                  <c:pt idx="10">
                    <c:v>7.7853842743670111E-4</c:v>
                  </c:pt>
                  <c:pt idx="11">
                    <c:v>7.8106918379913088E-4</c:v>
                  </c:pt>
                  <c:pt idx="12">
                    <c:v>7.8431503684662542E-4</c:v>
                  </c:pt>
                  <c:pt idx="13">
                    <c:v>7.7587014132938137E-4</c:v>
                  </c:pt>
                  <c:pt idx="14">
                    <c:v>7.5134836154403396E-4</c:v>
                  </c:pt>
                  <c:pt idx="15">
                    <c:v>7.4067915355620882E-4</c:v>
                  </c:pt>
                  <c:pt idx="16">
                    <c:v>7.1428587174526728E-4</c:v>
                  </c:pt>
                  <c:pt idx="17">
                    <c:v>6.8480954389453356E-4</c:v>
                  </c:pt>
                  <c:pt idx="18">
                    <c:v>6.5736664218270366E-4</c:v>
                  </c:pt>
                  <c:pt idx="19">
                    <c:v>6.9096276429593171E-4</c:v>
                  </c:pt>
                  <c:pt idx="20">
                    <c:v>7.9341184126258384E-4</c:v>
                  </c:pt>
                  <c:pt idx="21">
                    <c:v>9.0587846771994214E-4</c:v>
                  </c:pt>
                  <c:pt idx="22">
                    <c:v>1.0219720735716537E-3</c:v>
                  </c:pt>
                  <c:pt idx="23">
                    <c:v>1.1558702391841816E-3</c:v>
                  </c:pt>
                  <c:pt idx="24">
                    <c:v>1.2954179899148251E-3</c:v>
                  </c:pt>
                  <c:pt idx="25">
                    <c:v>1.4377140907500504E-3</c:v>
                  </c:pt>
                  <c:pt idx="26">
                    <c:v>1.5537292371206211E-3</c:v>
                  </c:pt>
                  <c:pt idx="27">
                    <c:v>1.6275298162873285E-3</c:v>
                  </c:pt>
                  <c:pt idx="28">
                    <c:v>1.671416019445305E-3</c:v>
                  </c:pt>
                  <c:pt idx="29">
                    <c:v>1.7120957119336534E-3</c:v>
                  </c:pt>
                  <c:pt idx="30">
                    <c:v>1.7747705171252441E-3</c:v>
                  </c:pt>
                  <c:pt idx="31">
                    <c:v>1.8441378281636802E-3</c:v>
                  </c:pt>
                  <c:pt idx="32">
                    <c:v>1.886608337486544E-3</c:v>
                  </c:pt>
                  <c:pt idx="33">
                    <c:v>1.9177695751568169E-3</c:v>
                  </c:pt>
                  <c:pt idx="34">
                    <c:v>1.9490232005842396E-3</c:v>
                  </c:pt>
                  <c:pt idx="35">
                    <c:v>1.9756030896743914E-3</c:v>
                  </c:pt>
                  <c:pt idx="36">
                    <c:v>1.9973668665917445E-3</c:v>
                  </c:pt>
                  <c:pt idx="37">
                    <c:v>2.0279997276714387E-3</c:v>
                  </c:pt>
                  <c:pt idx="38">
                    <c:v>2.0754520427508508E-3</c:v>
                  </c:pt>
                  <c:pt idx="39">
                    <c:v>2.1217949568763236E-3</c:v>
                  </c:pt>
                  <c:pt idx="40">
                    <c:v>2.1686285679071255E-3</c:v>
                  </c:pt>
                  <c:pt idx="41">
                    <c:v>2.2111789694262093E-3</c:v>
                  </c:pt>
                  <c:pt idx="42">
                    <c:v>2.2458092754251494E-3</c:v>
                  </c:pt>
                  <c:pt idx="43">
                    <c:v>2.2740881854851781E-3</c:v>
                  </c:pt>
                  <c:pt idx="44">
                    <c:v>2.2872769714607855E-3</c:v>
                  </c:pt>
                  <c:pt idx="45">
                    <c:v>2.2930024878899218E-3</c:v>
                  </c:pt>
                  <c:pt idx="46">
                    <c:v>2.2873122097198479E-3</c:v>
                  </c:pt>
                  <c:pt idx="47">
                    <c:v>2.2802772239651657E-3</c:v>
                  </c:pt>
                  <c:pt idx="48">
                    <c:v>2.261789131625596E-3</c:v>
                  </c:pt>
                  <c:pt idx="49">
                    <c:v>2.243675791773413E-3</c:v>
                  </c:pt>
                  <c:pt idx="50">
                    <c:v>2.228375384220326E-3</c:v>
                  </c:pt>
                  <c:pt idx="51">
                    <c:v>2.219629778481739E-3</c:v>
                  </c:pt>
                  <c:pt idx="52">
                    <c:v>2.2066695052126144E-3</c:v>
                  </c:pt>
                  <c:pt idx="53">
                    <c:v>2.201042217451688E-3</c:v>
                  </c:pt>
                  <c:pt idx="54">
                    <c:v>2.1972868094875132E-3</c:v>
                  </c:pt>
                  <c:pt idx="55">
                    <c:v>2.1821110839932412E-3</c:v>
                  </c:pt>
                  <c:pt idx="56">
                    <c:v>2.1476573009202773E-3</c:v>
                  </c:pt>
                  <c:pt idx="57">
                    <c:v>2.1121156095429226E-3</c:v>
                  </c:pt>
                  <c:pt idx="58">
                    <c:v>2.0756775721791397E-3</c:v>
                  </c:pt>
                  <c:pt idx="59">
                    <c:v>2.0325730081916481E-3</c:v>
                  </c:pt>
                  <c:pt idx="60">
                    <c:v>1.9908060894409476E-3</c:v>
                  </c:pt>
                  <c:pt idx="61">
                    <c:v>1.9673644333512365E-3</c:v>
                  </c:pt>
                  <c:pt idx="62">
                    <c:v>1.9558405324092958E-3</c:v>
                  </c:pt>
                  <c:pt idx="63">
                    <c:v>1.9511222212140241E-3</c:v>
                  </c:pt>
                  <c:pt idx="64">
                    <c:v>1.9438501831248957E-3</c:v>
                  </c:pt>
                  <c:pt idx="65">
                    <c:v>1.914902837737111E-3</c:v>
                  </c:pt>
                  <c:pt idx="66">
                    <c:v>1.8469867302586583E-3</c:v>
                  </c:pt>
                  <c:pt idx="67">
                    <c:v>1.7519922354824165E-3</c:v>
                  </c:pt>
                  <c:pt idx="68">
                    <c:v>1.6446741656390229E-3</c:v>
                  </c:pt>
                  <c:pt idx="69">
                    <c:v>1.5429438027192181E-3</c:v>
                  </c:pt>
                  <c:pt idx="70">
                    <c:v>1.4537903734483E-3</c:v>
                  </c:pt>
                  <c:pt idx="71">
                    <c:v>1.3930092518173213E-3</c:v>
                  </c:pt>
                  <c:pt idx="72">
                    <c:v>1.3366697095103454E-3</c:v>
                  </c:pt>
                  <c:pt idx="73">
                    <c:v>1.2696177643449493E-3</c:v>
                  </c:pt>
                  <c:pt idx="74">
                    <c:v>1.1781804452522596E-3</c:v>
                  </c:pt>
                  <c:pt idx="75">
                    <c:v>1.0789352437134249E-3</c:v>
                  </c:pt>
                  <c:pt idx="76">
                    <c:v>9.8703524487149552E-4</c:v>
                  </c:pt>
                  <c:pt idx="77">
                    <c:v>9.0765897869422895E-4</c:v>
                  </c:pt>
                  <c:pt idx="78">
                    <c:v>8.5676609774796122E-4</c:v>
                  </c:pt>
                  <c:pt idx="79">
                    <c:v>8.3079686983963149E-4</c:v>
                  </c:pt>
                  <c:pt idx="80">
                    <c:v>8.3059554495410349E-4</c:v>
                  </c:pt>
                  <c:pt idx="81">
                    <c:v>8.5559421606283873E-4</c:v>
                  </c:pt>
                  <c:pt idx="82">
                    <c:v>9.3139315900651995E-4</c:v>
                  </c:pt>
                  <c:pt idx="83">
                    <c:v>1.0976984990073908E-3</c:v>
                  </c:pt>
                  <c:pt idx="84">
                    <c:v>1.4029043757970393E-3</c:v>
                  </c:pt>
                  <c:pt idx="85">
                    <c:v>1.8447963606045635E-3</c:v>
                  </c:pt>
                  <c:pt idx="86">
                    <c:v>2.3261413818367552E-3</c:v>
                  </c:pt>
                  <c:pt idx="87">
                    <c:v>2.7584963649710335E-3</c:v>
                  </c:pt>
                  <c:pt idx="88">
                    <c:v>3.0540424852808401E-3</c:v>
                  </c:pt>
                  <c:pt idx="89">
                    <c:v>3.1760078537651794E-3</c:v>
                  </c:pt>
                  <c:pt idx="90">
                    <c:v>3.1016269811757853E-3</c:v>
                  </c:pt>
                  <c:pt idx="91">
                    <c:v>2.8975092517412641E-3</c:v>
                  </c:pt>
                  <c:pt idx="92">
                    <c:v>2.6105445242020154E-3</c:v>
                  </c:pt>
                  <c:pt idx="93">
                    <c:v>2.2825957403651374E-3</c:v>
                  </c:pt>
                  <c:pt idx="94">
                    <c:v>1.917963265387043E-3</c:v>
                  </c:pt>
                  <c:pt idx="95">
                    <c:v>1.5709310540569267E-3</c:v>
                  </c:pt>
                  <c:pt idx="96">
                    <c:v>1.2920313573343085E-3</c:v>
                  </c:pt>
                  <c:pt idx="97">
                    <c:v>1.1797658872011901E-3</c:v>
                  </c:pt>
                  <c:pt idx="98">
                    <c:v>1.2493542821316686E-3</c:v>
                  </c:pt>
                  <c:pt idx="99">
                    <c:v>1.4453869217788478E-3</c:v>
                  </c:pt>
                  <c:pt idx="100">
                    <c:v>1.6771122551635913E-3</c:v>
                  </c:pt>
                  <c:pt idx="101">
                    <c:v>1.9057647907025216E-3</c:v>
                  </c:pt>
                  <c:pt idx="102">
                    <c:v>2.1202069437960013E-3</c:v>
                  </c:pt>
                  <c:pt idx="103">
                    <c:v>2.3073913067558965E-3</c:v>
                  </c:pt>
                  <c:pt idx="104">
                    <c:v>2.4232275462852987E-3</c:v>
                  </c:pt>
                  <c:pt idx="105">
                    <c:v>2.508779187664692E-3</c:v>
                  </c:pt>
                  <c:pt idx="106">
                    <c:v>2.561748645318042E-3</c:v>
                  </c:pt>
                  <c:pt idx="107">
                    <c:v>2.6340114973517834E-3</c:v>
                  </c:pt>
                  <c:pt idx="108">
                    <c:v>2.669818792036881E-3</c:v>
                  </c:pt>
                  <c:pt idx="109">
                    <c:v>2.696433637766206E-3</c:v>
                  </c:pt>
                  <c:pt idx="110">
                    <c:v>2.6877179185476174E-3</c:v>
                  </c:pt>
                  <c:pt idx="111">
                    <c:v>2.7377922645985568E-3</c:v>
                  </c:pt>
                  <c:pt idx="112">
                    <c:v>2.7528037937562129E-3</c:v>
                  </c:pt>
                  <c:pt idx="113">
                    <c:v>2.7875199593933443E-3</c:v>
                  </c:pt>
                  <c:pt idx="114">
                    <c:v>2.7818433475279899E-3</c:v>
                  </c:pt>
                  <c:pt idx="115">
                    <c:v>2.8168675606841864E-3</c:v>
                  </c:pt>
                  <c:pt idx="116">
                    <c:v>2.86707099669028E-3</c:v>
                  </c:pt>
                  <c:pt idx="117">
                    <c:v>2.9494327113935648E-3</c:v>
                  </c:pt>
                  <c:pt idx="118">
                    <c:v>3.0265985527313782E-3</c:v>
                  </c:pt>
                  <c:pt idx="119">
                    <c:v>3.0959489352184065E-3</c:v>
                  </c:pt>
                  <c:pt idx="120">
                    <c:v>3.1744261796533401E-3</c:v>
                  </c:pt>
                  <c:pt idx="121">
                    <c:v>3.2345523968219346E-3</c:v>
                  </c:pt>
                  <c:pt idx="122">
                    <c:v>3.2490731087525477E-3</c:v>
                  </c:pt>
                  <c:pt idx="123">
                    <c:v>3.2480515770408305E-3</c:v>
                  </c:pt>
                  <c:pt idx="124">
                    <c:v>3.233114850796354E-3</c:v>
                  </c:pt>
                  <c:pt idx="125">
                    <c:v>3.2057919129029199E-3</c:v>
                  </c:pt>
                  <c:pt idx="126">
                    <c:v>3.2193322727209137E-3</c:v>
                  </c:pt>
                  <c:pt idx="127">
                    <c:v>3.3319667439918009E-3</c:v>
                  </c:pt>
                  <c:pt idx="128">
                    <c:v>3.4616390401656953E-3</c:v>
                  </c:pt>
                  <c:pt idx="129">
                    <c:v>3.5086442146631492E-3</c:v>
                  </c:pt>
                  <c:pt idx="130">
                    <c:v>3.5597274329818838E-3</c:v>
                  </c:pt>
                  <c:pt idx="131">
                    <c:v>3.7112585950950291E-3</c:v>
                  </c:pt>
                  <c:pt idx="132">
                    <c:v>3.8795894730203834E-3</c:v>
                  </c:pt>
                  <c:pt idx="133">
                    <c:v>4.0084105640136505E-3</c:v>
                  </c:pt>
                  <c:pt idx="134">
                    <c:v>4.1036204311629167E-3</c:v>
                  </c:pt>
                  <c:pt idx="135">
                    <c:v>4.227624364450993E-3</c:v>
                  </c:pt>
                  <c:pt idx="136">
                    <c:v>4.3251639377720223E-3</c:v>
                  </c:pt>
                  <c:pt idx="137">
                    <c:v>4.41653780607022E-3</c:v>
                  </c:pt>
                  <c:pt idx="138">
                    <c:v>4.4968050169737726E-3</c:v>
                  </c:pt>
                  <c:pt idx="139">
                    <c:v>4.5454580701338645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x"/>
            <c:errBarType val="both"/>
            <c:errValType val="fixedVal"/>
            <c:noEndCap val="0"/>
            <c:val val="1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AVG healthy'!$AT$5:$AT$144</c:f>
              <c:numCache>
                <c:formatCode>General</c:formatCode>
                <c:ptCount val="140"/>
                <c:pt idx="0">
                  <c:v>451.25</c:v>
                </c:pt>
                <c:pt idx="1">
                  <c:v>454.040009</c:v>
                </c:pt>
                <c:pt idx="2">
                  <c:v>456.82000699999998</c:v>
                </c:pt>
                <c:pt idx="3">
                  <c:v>459.60998499999999</c:v>
                </c:pt>
                <c:pt idx="4">
                  <c:v>462.39999399999999</c:v>
                </c:pt>
                <c:pt idx="5">
                  <c:v>465.19000199999999</c:v>
                </c:pt>
                <c:pt idx="6">
                  <c:v>467.98001099999999</c:v>
                </c:pt>
                <c:pt idx="7">
                  <c:v>470.77999899999998</c:v>
                </c:pt>
                <c:pt idx="8">
                  <c:v>473.57000699999998</c:v>
                </c:pt>
                <c:pt idx="9">
                  <c:v>476.36999500000002</c:v>
                </c:pt>
                <c:pt idx="10">
                  <c:v>479.16000400000001</c:v>
                </c:pt>
                <c:pt idx="11">
                  <c:v>481.959991</c:v>
                </c:pt>
                <c:pt idx="12">
                  <c:v>484.76001000000002</c:v>
                </c:pt>
                <c:pt idx="13">
                  <c:v>487.55999800000001</c:v>
                </c:pt>
                <c:pt idx="14">
                  <c:v>490.35998499999999</c:v>
                </c:pt>
                <c:pt idx="15">
                  <c:v>493.16000400000001</c:v>
                </c:pt>
                <c:pt idx="16">
                  <c:v>495.97000100000002</c:v>
                </c:pt>
                <c:pt idx="17">
                  <c:v>498.76998900000001</c:v>
                </c:pt>
                <c:pt idx="18">
                  <c:v>501.57998700000002</c:v>
                </c:pt>
                <c:pt idx="19">
                  <c:v>504.39001500000001</c:v>
                </c:pt>
                <c:pt idx="20">
                  <c:v>507.19000199999999</c:v>
                </c:pt>
                <c:pt idx="21">
                  <c:v>510</c:v>
                </c:pt>
                <c:pt idx="22">
                  <c:v>512.80999799999995</c:v>
                </c:pt>
                <c:pt idx="23">
                  <c:v>515.63000499999998</c:v>
                </c:pt>
                <c:pt idx="24">
                  <c:v>518.44000200000005</c:v>
                </c:pt>
                <c:pt idx="25">
                  <c:v>521.25</c:v>
                </c:pt>
                <c:pt idx="26">
                  <c:v>524.07000700000003</c:v>
                </c:pt>
                <c:pt idx="27">
                  <c:v>526.88000499999998</c:v>
                </c:pt>
                <c:pt idx="28">
                  <c:v>529.70001200000002</c:v>
                </c:pt>
                <c:pt idx="29">
                  <c:v>532.52002000000005</c:v>
                </c:pt>
                <c:pt idx="30">
                  <c:v>535.34002699999996</c:v>
                </c:pt>
                <c:pt idx="31">
                  <c:v>538.15997300000004</c:v>
                </c:pt>
                <c:pt idx="32">
                  <c:v>540.98999000000003</c:v>
                </c:pt>
                <c:pt idx="33">
                  <c:v>543.80999799999995</c:v>
                </c:pt>
                <c:pt idx="34">
                  <c:v>546.63000499999998</c:v>
                </c:pt>
                <c:pt idx="35">
                  <c:v>549.46002199999998</c:v>
                </c:pt>
                <c:pt idx="36">
                  <c:v>552.28997800000002</c:v>
                </c:pt>
                <c:pt idx="37">
                  <c:v>555.11999500000002</c:v>
                </c:pt>
                <c:pt idx="38">
                  <c:v>557.94000200000005</c:v>
                </c:pt>
                <c:pt idx="39">
                  <c:v>560.78002900000001</c:v>
                </c:pt>
                <c:pt idx="40">
                  <c:v>563.60998500000005</c:v>
                </c:pt>
                <c:pt idx="41">
                  <c:v>566.44000200000005</c:v>
                </c:pt>
                <c:pt idx="42">
                  <c:v>569.27002000000005</c:v>
                </c:pt>
                <c:pt idx="43">
                  <c:v>572.10998500000005</c:v>
                </c:pt>
                <c:pt idx="44">
                  <c:v>574.95001200000002</c:v>
                </c:pt>
                <c:pt idx="45">
                  <c:v>577.78002900000001</c:v>
                </c:pt>
                <c:pt idx="46">
                  <c:v>580.61999500000002</c:v>
                </c:pt>
                <c:pt idx="47">
                  <c:v>583.46002199999998</c:v>
                </c:pt>
                <c:pt idx="48">
                  <c:v>586.29998799999998</c:v>
                </c:pt>
                <c:pt idx="49">
                  <c:v>589.15002400000003</c:v>
                </c:pt>
                <c:pt idx="50">
                  <c:v>591.98999000000003</c:v>
                </c:pt>
                <c:pt idx="51">
                  <c:v>594.84002699999996</c:v>
                </c:pt>
                <c:pt idx="52">
                  <c:v>597.67999299999997</c:v>
                </c:pt>
                <c:pt idx="53">
                  <c:v>600.53002900000001</c:v>
                </c:pt>
                <c:pt idx="54">
                  <c:v>603.38000499999998</c:v>
                </c:pt>
                <c:pt idx="55">
                  <c:v>606.22997999999995</c:v>
                </c:pt>
                <c:pt idx="56">
                  <c:v>609.080017</c:v>
                </c:pt>
                <c:pt idx="57">
                  <c:v>611.92999299999997</c:v>
                </c:pt>
                <c:pt idx="58">
                  <c:v>614.78002900000001</c:v>
                </c:pt>
                <c:pt idx="59">
                  <c:v>617.64001499999995</c:v>
                </c:pt>
                <c:pt idx="60">
                  <c:v>620.48999000000003</c:v>
                </c:pt>
                <c:pt idx="61">
                  <c:v>623.34997599999997</c:v>
                </c:pt>
                <c:pt idx="62">
                  <c:v>626.21002199999998</c:v>
                </c:pt>
                <c:pt idx="63">
                  <c:v>629.07000700000003</c:v>
                </c:pt>
                <c:pt idx="64">
                  <c:v>631.92999299999997</c:v>
                </c:pt>
                <c:pt idx="65">
                  <c:v>634.78997800000002</c:v>
                </c:pt>
                <c:pt idx="66">
                  <c:v>637.65002400000003</c:v>
                </c:pt>
                <c:pt idx="67">
                  <c:v>640.51000999999997</c:v>
                </c:pt>
                <c:pt idx="68">
                  <c:v>643.38000499999998</c:v>
                </c:pt>
                <c:pt idx="69">
                  <c:v>646.23999000000003</c:v>
                </c:pt>
                <c:pt idx="70">
                  <c:v>649.10998500000005</c:v>
                </c:pt>
                <c:pt idx="71">
                  <c:v>651.97997999999995</c:v>
                </c:pt>
                <c:pt idx="72">
                  <c:v>654.84997599999997</c:v>
                </c:pt>
                <c:pt idx="73">
                  <c:v>657.71997099999999</c:v>
                </c:pt>
                <c:pt idx="74">
                  <c:v>660.59002699999996</c:v>
                </c:pt>
                <c:pt idx="75">
                  <c:v>663.46997099999999</c:v>
                </c:pt>
                <c:pt idx="76">
                  <c:v>666.34002699999996</c:v>
                </c:pt>
                <c:pt idx="77">
                  <c:v>669.21997099999999</c:v>
                </c:pt>
                <c:pt idx="78">
                  <c:v>672.09002699999996</c:v>
                </c:pt>
                <c:pt idx="79">
                  <c:v>674.96997099999999</c:v>
                </c:pt>
                <c:pt idx="80">
                  <c:v>677.84997599999997</c:v>
                </c:pt>
                <c:pt idx="81">
                  <c:v>680.72997999999995</c:v>
                </c:pt>
                <c:pt idx="82">
                  <c:v>683.60998500000005</c:v>
                </c:pt>
                <c:pt idx="83">
                  <c:v>686.48999000000003</c:v>
                </c:pt>
                <c:pt idx="84">
                  <c:v>689.38000499999998</c:v>
                </c:pt>
                <c:pt idx="85">
                  <c:v>692.26000999999997</c:v>
                </c:pt>
                <c:pt idx="86">
                  <c:v>695.15002400000003</c:v>
                </c:pt>
                <c:pt idx="87">
                  <c:v>698.03002900000001</c:v>
                </c:pt>
                <c:pt idx="88">
                  <c:v>700.919983</c:v>
                </c:pt>
                <c:pt idx="89">
                  <c:v>703.80999799999995</c:v>
                </c:pt>
                <c:pt idx="90">
                  <c:v>706.70001200000002</c:v>
                </c:pt>
                <c:pt idx="91">
                  <c:v>709.59997599999997</c:v>
                </c:pt>
                <c:pt idx="92">
                  <c:v>712.48999000000003</c:v>
                </c:pt>
                <c:pt idx="93">
                  <c:v>715.38000499999998</c:v>
                </c:pt>
                <c:pt idx="94">
                  <c:v>718.28002900000001</c:v>
                </c:pt>
                <c:pt idx="95">
                  <c:v>721.17999299999997</c:v>
                </c:pt>
                <c:pt idx="96">
                  <c:v>724.07000700000003</c:v>
                </c:pt>
                <c:pt idx="97">
                  <c:v>726.96997099999999</c:v>
                </c:pt>
                <c:pt idx="98">
                  <c:v>729.86999500000002</c:v>
                </c:pt>
                <c:pt idx="99">
                  <c:v>732.77002000000005</c:v>
                </c:pt>
                <c:pt idx="100">
                  <c:v>735.67999299999997</c:v>
                </c:pt>
                <c:pt idx="101">
                  <c:v>738.580017</c:v>
                </c:pt>
                <c:pt idx="102">
                  <c:v>741.48999000000003</c:v>
                </c:pt>
                <c:pt idx="103">
                  <c:v>744.39001499999995</c:v>
                </c:pt>
                <c:pt idx="104">
                  <c:v>747.29998799999998</c:v>
                </c:pt>
                <c:pt idx="105">
                  <c:v>750.21002199999998</c:v>
                </c:pt>
                <c:pt idx="106">
                  <c:v>753.11999500000002</c:v>
                </c:pt>
                <c:pt idx="107">
                  <c:v>756.03002900000001</c:v>
                </c:pt>
                <c:pt idx="108">
                  <c:v>758.94000200000005</c:v>
                </c:pt>
                <c:pt idx="109">
                  <c:v>761.84997599999997</c:v>
                </c:pt>
                <c:pt idx="110">
                  <c:v>764.77002000000005</c:v>
                </c:pt>
                <c:pt idx="111">
                  <c:v>767.67999299999997</c:v>
                </c:pt>
                <c:pt idx="112">
                  <c:v>770.59997599999997</c:v>
                </c:pt>
                <c:pt idx="113">
                  <c:v>773.52002000000005</c:v>
                </c:pt>
                <c:pt idx="114">
                  <c:v>776.44000200000005</c:v>
                </c:pt>
                <c:pt idx="115">
                  <c:v>779.35998500000005</c:v>
                </c:pt>
                <c:pt idx="116">
                  <c:v>782.28002900000001</c:v>
                </c:pt>
                <c:pt idx="117">
                  <c:v>785.20001200000002</c:v>
                </c:pt>
                <c:pt idx="118">
                  <c:v>788.11999500000002</c:v>
                </c:pt>
                <c:pt idx="119">
                  <c:v>791.04998799999998</c:v>
                </c:pt>
                <c:pt idx="120">
                  <c:v>793.97997999999995</c:v>
                </c:pt>
                <c:pt idx="121">
                  <c:v>796.90002400000003</c:v>
                </c:pt>
                <c:pt idx="122">
                  <c:v>799.830017</c:v>
                </c:pt>
                <c:pt idx="123">
                  <c:v>802.76000999999997</c:v>
                </c:pt>
                <c:pt idx="124">
                  <c:v>805.69000200000005</c:v>
                </c:pt>
                <c:pt idx="125">
                  <c:v>808.61999500000002</c:v>
                </c:pt>
                <c:pt idx="126">
                  <c:v>811.55999799999995</c:v>
                </c:pt>
                <c:pt idx="127">
                  <c:v>814.48999000000003</c:v>
                </c:pt>
                <c:pt idx="128">
                  <c:v>817.42999299999997</c:v>
                </c:pt>
                <c:pt idx="129">
                  <c:v>820.35998500000005</c:v>
                </c:pt>
                <c:pt idx="130">
                  <c:v>823.29998799999998</c:v>
                </c:pt>
                <c:pt idx="131">
                  <c:v>826.23999000000003</c:v>
                </c:pt>
                <c:pt idx="132">
                  <c:v>829.17999299999997</c:v>
                </c:pt>
                <c:pt idx="133">
                  <c:v>832.11999500000002</c:v>
                </c:pt>
                <c:pt idx="134">
                  <c:v>835.07000700000003</c:v>
                </c:pt>
                <c:pt idx="135">
                  <c:v>838.01000999999997</c:v>
                </c:pt>
                <c:pt idx="136">
                  <c:v>840.95001200000002</c:v>
                </c:pt>
                <c:pt idx="137">
                  <c:v>843.90002400000003</c:v>
                </c:pt>
                <c:pt idx="138">
                  <c:v>846.84997599999997</c:v>
                </c:pt>
                <c:pt idx="139">
                  <c:v>849.79998799999998</c:v>
                </c:pt>
              </c:numCache>
            </c:numRef>
          </c:xVal>
          <c:yVal>
            <c:numRef>
              <c:f>'AVG healthy'!$AV$5:$AV$144</c:f>
              <c:numCache>
                <c:formatCode>General</c:formatCode>
                <c:ptCount val="140"/>
                <c:pt idx="0">
                  <c:v>4.7841624999999999E-2</c:v>
                </c:pt>
                <c:pt idx="1">
                  <c:v>4.7740187500000003E-2</c:v>
                </c:pt>
                <c:pt idx="2">
                  <c:v>4.7509999999999997E-2</c:v>
                </c:pt>
                <c:pt idx="3">
                  <c:v>4.7153874999999998E-2</c:v>
                </c:pt>
                <c:pt idx="4">
                  <c:v>4.6741999999999999E-2</c:v>
                </c:pt>
                <c:pt idx="5">
                  <c:v>4.6256437500000004E-2</c:v>
                </c:pt>
                <c:pt idx="6">
                  <c:v>4.5783250000000004E-2</c:v>
                </c:pt>
                <c:pt idx="7">
                  <c:v>4.5374750000000005E-2</c:v>
                </c:pt>
                <c:pt idx="8">
                  <c:v>4.5088875E-2</c:v>
                </c:pt>
                <c:pt idx="9">
                  <c:v>4.4899312499999997E-2</c:v>
                </c:pt>
                <c:pt idx="10">
                  <c:v>4.4745062500000002E-2</c:v>
                </c:pt>
                <c:pt idx="11">
                  <c:v>4.4590125000000001E-2</c:v>
                </c:pt>
                <c:pt idx="12">
                  <c:v>4.4410375000000002E-2</c:v>
                </c:pt>
                <c:pt idx="13">
                  <c:v>4.4377562500000009E-2</c:v>
                </c:pt>
                <c:pt idx="14">
                  <c:v>4.45628125E-2</c:v>
                </c:pt>
                <c:pt idx="15">
                  <c:v>4.4993125000000002E-2</c:v>
                </c:pt>
                <c:pt idx="16">
                  <c:v>4.5750937500000005E-2</c:v>
                </c:pt>
                <c:pt idx="17">
                  <c:v>4.6922562500000001E-2</c:v>
                </c:pt>
                <c:pt idx="18">
                  <c:v>4.87605625E-2</c:v>
                </c:pt>
                <c:pt idx="19">
                  <c:v>5.1343812500000002E-2</c:v>
                </c:pt>
                <c:pt idx="20">
                  <c:v>5.4952812499999996E-2</c:v>
                </c:pt>
                <c:pt idx="21">
                  <c:v>5.9626437500000004E-2</c:v>
                </c:pt>
                <c:pt idx="22">
                  <c:v>6.559174999999999E-2</c:v>
                </c:pt>
                <c:pt idx="23">
                  <c:v>7.2817437499999998E-2</c:v>
                </c:pt>
                <c:pt idx="24">
                  <c:v>8.1249875000000013E-2</c:v>
                </c:pt>
                <c:pt idx="25">
                  <c:v>9.0412812499999995E-2</c:v>
                </c:pt>
                <c:pt idx="26">
                  <c:v>9.9727750000000004E-2</c:v>
                </c:pt>
                <c:pt idx="27">
                  <c:v>0.1084014375</c:v>
                </c:pt>
                <c:pt idx="28">
                  <c:v>0.11579600000000001</c:v>
                </c:pt>
                <c:pt idx="29">
                  <c:v>0.12158706250000001</c:v>
                </c:pt>
                <c:pt idx="30">
                  <c:v>0.12588431249999998</c:v>
                </c:pt>
                <c:pt idx="31">
                  <c:v>0.12891425000000001</c:v>
                </c:pt>
                <c:pt idx="32">
                  <c:v>0.13102406250000001</c:v>
                </c:pt>
                <c:pt idx="33">
                  <c:v>0.13274</c:v>
                </c:pt>
                <c:pt idx="34">
                  <c:v>0.134385</c:v>
                </c:pt>
                <c:pt idx="35">
                  <c:v>0.13591112499999999</c:v>
                </c:pt>
                <c:pt idx="36">
                  <c:v>0.13694000000000001</c:v>
                </c:pt>
                <c:pt idx="37">
                  <c:v>0.136870625</c:v>
                </c:pt>
                <c:pt idx="38">
                  <c:v>0.13542531250000001</c:v>
                </c:pt>
                <c:pt idx="39">
                  <c:v>0.13267825</c:v>
                </c:pt>
                <c:pt idx="40">
                  <c:v>0.12894168749999999</c:v>
                </c:pt>
                <c:pt idx="41">
                  <c:v>0.1241854375</c:v>
                </c:pt>
                <c:pt idx="42">
                  <c:v>0.11850931249999999</c:v>
                </c:pt>
                <c:pt idx="43">
                  <c:v>0.1123075</c:v>
                </c:pt>
                <c:pt idx="44">
                  <c:v>0.10634431249999998</c:v>
                </c:pt>
                <c:pt idx="45">
                  <c:v>0.101122375</c:v>
                </c:pt>
                <c:pt idx="46">
                  <c:v>9.6738750000000012E-2</c:v>
                </c:pt>
                <c:pt idx="47">
                  <c:v>9.3076562500000015E-2</c:v>
                </c:pt>
                <c:pt idx="48">
                  <c:v>9.0020187500000015E-2</c:v>
                </c:pt>
                <c:pt idx="49">
                  <c:v>8.7536375E-2</c:v>
                </c:pt>
                <c:pt idx="50">
                  <c:v>8.5596375000000002E-2</c:v>
                </c:pt>
                <c:pt idx="51">
                  <c:v>8.4156937500000001E-2</c:v>
                </c:pt>
                <c:pt idx="52">
                  <c:v>8.30179375E-2</c:v>
                </c:pt>
                <c:pt idx="53">
                  <c:v>8.1898625000000003E-2</c:v>
                </c:pt>
                <c:pt idx="54">
                  <c:v>8.0399812500000001E-2</c:v>
                </c:pt>
                <c:pt idx="55">
                  <c:v>7.8256312499999994E-2</c:v>
                </c:pt>
                <c:pt idx="56">
                  <c:v>7.5468312499999995E-2</c:v>
                </c:pt>
                <c:pt idx="57">
                  <c:v>7.235431249999999E-2</c:v>
                </c:pt>
                <c:pt idx="58">
                  <c:v>6.9288687500000001E-2</c:v>
                </c:pt>
                <c:pt idx="59">
                  <c:v>6.6579562499999995E-2</c:v>
                </c:pt>
                <c:pt idx="60">
                  <c:v>6.4424937500000001E-2</c:v>
                </c:pt>
                <c:pt idx="61">
                  <c:v>6.2919687500000002E-2</c:v>
                </c:pt>
                <c:pt idx="62">
                  <c:v>6.2039812499999999E-2</c:v>
                </c:pt>
                <c:pt idx="63">
                  <c:v>6.1591187499999998E-2</c:v>
                </c:pt>
                <c:pt idx="64">
                  <c:v>6.1156812500000005E-2</c:v>
                </c:pt>
                <c:pt idx="65">
                  <c:v>6.0213624999999993E-2</c:v>
                </c:pt>
                <c:pt idx="66">
                  <c:v>5.8509750000000006E-2</c:v>
                </c:pt>
                <c:pt idx="67">
                  <c:v>5.6229312500000003E-2</c:v>
                </c:pt>
                <c:pt idx="68">
                  <c:v>5.3664375E-2</c:v>
                </c:pt>
                <c:pt idx="69">
                  <c:v>5.1109875000000006E-2</c:v>
                </c:pt>
                <c:pt idx="70">
                  <c:v>4.8881375000000005E-2</c:v>
                </c:pt>
                <c:pt idx="71">
                  <c:v>4.7101124999999994E-2</c:v>
                </c:pt>
                <c:pt idx="72">
                  <c:v>4.5393062499999998E-2</c:v>
                </c:pt>
                <c:pt idx="73">
                  <c:v>4.3439875000000003E-2</c:v>
                </c:pt>
                <c:pt idx="74">
                  <c:v>4.1275000000000006E-2</c:v>
                </c:pt>
                <c:pt idx="75">
                  <c:v>3.9177687500000002E-2</c:v>
                </c:pt>
                <c:pt idx="76">
                  <c:v>3.7335624999999997E-2</c:v>
                </c:pt>
                <c:pt idx="77">
                  <c:v>3.5921750000000002E-2</c:v>
                </c:pt>
                <c:pt idx="78">
                  <c:v>3.501725E-2</c:v>
                </c:pt>
                <c:pt idx="79">
                  <c:v>3.4653625E-2</c:v>
                </c:pt>
                <c:pt idx="80">
                  <c:v>3.4811374999999999E-2</c:v>
                </c:pt>
                <c:pt idx="81">
                  <c:v>3.5533062500000004E-2</c:v>
                </c:pt>
                <c:pt idx="82">
                  <c:v>3.7061562499999999E-2</c:v>
                </c:pt>
                <c:pt idx="83">
                  <c:v>4.0157249999999999E-2</c:v>
                </c:pt>
                <c:pt idx="84">
                  <c:v>4.6283375000000002E-2</c:v>
                </c:pt>
                <c:pt idx="85">
                  <c:v>5.724725E-2</c:v>
                </c:pt>
                <c:pt idx="86">
                  <c:v>7.4201437499999995E-2</c:v>
                </c:pt>
                <c:pt idx="87">
                  <c:v>9.6773749999999992E-2</c:v>
                </c:pt>
                <c:pt idx="88">
                  <c:v>0.12275443749999999</c:v>
                </c:pt>
                <c:pt idx="89">
                  <c:v>0.14923575</c:v>
                </c:pt>
                <c:pt idx="90">
                  <c:v>0.17427624999999997</c:v>
                </c:pt>
                <c:pt idx="91">
                  <c:v>0.19748012500000001</c:v>
                </c:pt>
                <c:pt idx="92">
                  <c:v>0.21922687499999999</c:v>
                </c:pt>
                <c:pt idx="93">
                  <c:v>0.23975600000000002</c:v>
                </c:pt>
                <c:pt idx="94">
                  <c:v>0.25907975</c:v>
                </c:pt>
                <c:pt idx="95">
                  <c:v>0.27702993749999999</c:v>
                </c:pt>
                <c:pt idx="96">
                  <c:v>0.2933865625</c:v>
                </c:pt>
                <c:pt idx="97">
                  <c:v>0.30823706249999994</c:v>
                </c:pt>
                <c:pt idx="98">
                  <c:v>0.32136212499999994</c:v>
                </c:pt>
                <c:pt idx="99">
                  <c:v>0.33265124999999995</c:v>
                </c:pt>
                <c:pt idx="100">
                  <c:v>0.34208618749999997</c:v>
                </c:pt>
                <c:pt idx="101">
                  <c:v>0.34990418750000002</c:v>
                </c:pt>
                <c:pt idx="102">
                  <c:v>0.35602393750000005</c:v>
                </c:pt>
                <c:pt idx="103">
                  <c:v>0.36050018750000001</c:v>
                </c:pt>
                <c:pt idx="104">
                  <c:v>0.3638313125</c:v>
                </c:pt>
                <c:pt idx="105">
                  <c:v>0.36649506249999997</c:v>
                </c:pt>
                <c:pt idx="106">
                  <c:v>0.36857143749999999</c:v>
                </c:pt>
                <c:pt idx="107">
                  <c:v>0.37024518750000002</c:v>
                </c:pt>
                <c:pt idx="108">
                  <c:v>0.37148199999999998</c:v>
                </c:pt>
                <c:pt idx="109">
                  <c:v>0.37239200000000006</c:v>
                </c:pt>
                <c:pt idx="110">
                  <c:v>0.37328768749999997</c:v>
                </c:pt>
                <c:pt idx="111">
                  <c:v>0.37418931249999998</c:v>
                </c:pt>
                <c:pt idx="112">
                  <c:v>0.37487300000000001</c:v>
                </c:pt>
                <c:pt idx="113">
                  <c:v>0.37527806250000001</c:v>
                </c:pt>
                <c:pt idx="114">
                  <c:v>0.37551087500000002</c:v>
                </c:pt>
                <c:pt idx="115">
                  <c:v>0.37524962500000003</c:v>
                </c:pt>
                <c:pt idx="116">
                  <c:v>0.37465293749999995</c:v>
                </c:pt>
                <c:pt idx="117">
                  <c:v>0.37399512500000004</c:v>
                </c:pt>
                <c:pt idx="118">
                  <c:v>0.37324518750000002</c:v>
                </c:pt>
                <c:pt idx="119">
                  <c:v>0.37229674999999995</c:v>
                </c:pt>
                <c:pt idx="120">
                  <c:v>0.37108868750000001</c:v>
                </c:pt>
                <c:pt idx="121">
                  <c:v>0.36955506249999998</c:v>
                </c:pt>
                <c:pt idx="122">
                  <c:v>0.36792874999999992</c:v>
                </c:pt>
                <c:pt idx="123">
                  <c:v>0.36679943749999999</c:v>
                </c:pt>
                <c:pt idx="124">
                  <c:v>0.36634824999999999</c:v>
                </c:pt>
                <c:pt idx="125">
                  <c:v>0.36609012500000004</c:v>
                </c:pt>
                <c:pt idx="126">
                  <c:v>0.36534074999999999</c:v>
                </c:pt>
                <c:pt idx="127">
                  <c:v>0.36438006249999999</c:v>
                </c:pt>
                <c:pt idx="128">
                  <c:v>0.36350412500000001</c:v>
                </c:pt>
                <c:pt idx="129">
                  <c:v>0.36280756249999996</c:v>
                </c:pt>
                <c:pt idx="130">
                  <c:v>0.36204462500000001</c:v>
                </c:pt>
                <c:pt idx="131">
                  <c:v>0.36135950000000006</c:v>
                </c:pt>
                <c:pt idx="132">
                  <c:v>0.36089956249999999</c:v>
                </c:pt>
                <c:pt idx="133">
                  <c:v>0.36049918749999998</c:v>
                </c:pt>
                <c:pt idx="134">
                  <c:v>0.3603893125</c:v>
                </c:pt>
                <c:pt idx="135">
                  <c:v>0.36046543750000004</c:v>
                </c:pt>
                <c:pt idx="136">
                  <c:v>0.36088193749999997</c:v>
                </c:pt>
                <c:pt idx="137">
                  <c:v>0.36121362499999998</c:v>
                </c:pt>
                <c:pt idx="138">
                  <c:v>0.36175437499999996</c:v>
                </c:pt>
                <c:pt idx="139">
                  <c:v>0.3621500625000000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24B1-4701-9C3E-F738DACE2604}"/>
            </c:ext>
          </c:extLst>
        </c:ser>
        <c:ser>
          <c:idx val="2"/>
          <c:order val="2"/>
          <c:tx>
            <c:strRef>
              <c:f>'AVG healthy'!$AW$4</c:f>
              <c:strCache>
                <c:ptCount val="1"/>
                <c:pt idx="0">
                  <c:v>IR64 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1"/>
            <c:plus>
              <c:numRef>
                <c:f>'AVG healthy'!$AZ$5:$AZ$144</c:f>
                <c:numCache>
                  <c:formatCode>General</c:formatCode>
                  <c:ptCount val="140"/>
                  <c:pt idx="0">
                    <c:v>5.0226415624744715E-4</c:v>
                  </c:pt>
                  <c:pt idx="1">
                    <c:v>5.0103318257050311E-4</c:v>
                  </c:pt>
                  <c:pt idx="2">
                    <c:v>5.1993113853465451E-4</c:v>
                  </c:pt>
                  <c:pt idx="3">
                    <c:v>5.5458553332966593E-4</c:v>
                  </c:pt>
                  <c:pt idx="4">
                    <c:v>5.647378759215233E-4</c:v>
                  </c:pt>
                  <c:pt idx="5">
                    <c:v>5.5207039834121482E-4</c:v>
                  </c:pt>
                  <c:pt idx="6">
                    <c:v>5.45177698500641E-4</c:v>
                  </c:pt>
                  <c:pt idx="7">
                    <c:v>5.5111289536160612E-4</c:v>
                  </c:pt>
                  <c:pt idx="8">
                    <c:v>5.6905468334910315E-4</c:v>
                  </c:pt>
                  <c:pt idx="9">
                    <c:v>5.891947849193085E-4</c:v>
                  </c:pt>
                  <c:pt idx="10">
                    <c:v>5.9916127583904601E-4</c:v>
                  </c:pt>
                  <c:pt idx="11">
                    <c:v>5.993500904680468E-4</c:v>
                  </c:pt>
                  <c:pt idx="12">
                    <c:v>6.1077536183201588E-4</c:v>
                  </c:pt>
                  <c:pt idx="13">
                    <c:v>6.2869398501759792E-4</c:v>
                  </c:pt>
                  <c:pt idx="14">
                    <c:v>6.3343898110499732E-4</c:v>
                  </c:pt>
                  <c:pt idx="15">
                    <c:v>6.3790704117978165E-4</c:v>
                  </c:pt>
                  <c:pt idx="16">
                    <c:v>6.6060547866777098E-4</c:v>
                  </c:pt>
                  <c:pt idx="17">
                    <c:v>7.2433361491952195E-4</c:v>
                  </c:pt>
                  <c:pt idx="18">
                    <c:v>8.0313542784610237E-4</c:v>
                  </c:pt>
                  <c:pt idx="19">
                    <c:v>8.9602213610371056E-4</c:v>
                  </c:pt>
                  <c:pt idx="20">
                    <c:v>1.0193664305946089E-3</c:v>
                  </c:pt>
                  <c:pt idx="21">
                    <c:v>1.1701844612498086E-3</c:v>
                  </c:pt>
                  <c:pt idx="22">
                    <c:v>1.3226906901814453E-3</c:v>
                  </c:pt>
                  <c:pt idx="23">
                    <c:v>1.487491642877351E-3</c:v>
                  </c:pt>
                  <c:pt idx="24">
                    <c:v>1.6542544050582753E-3</c:v>
                  </c:pt>
                  <c:pt idx="25">
                    <c:v>1.816796537806439E-3</c:v>
                  </c:pt>
                  <c:pt idx="26">
                    <c:v>1.9569604748541298E-3</c:v>
                  </c:pt>
                  <c:pt idx="27">
                    <c:v>2.0774035269831214E-3</c:v>
                  </c:pt>
                  <c:pt idx="28">
                    <c:v>2.1601204509457662E-3</c:v>
                  </c:pt>
                  <c:pt idx="29">
                    <c:v>2.2307350197459741E-3</c:v>
                  </c:pt>
                  <c:pt idx="30">
                    <c:v>2.2785125411271326E-3</c:v>
                  </c:pt>
                  <c:pt idx="31">
                    <c:v>2.3217404213121181E-3</c:v>
                  </c:pt>
                  <c:pt idx="32">
                    <c:v>2.3507697892863086E-3</c:v>
                  </c:pt>
                  <c:pt idx="33">
                    <c:v>2.3899360207937622E-3</c:v>
                  </c:pt>
                  <c:pt idx="34">
                    <c:v>2.4250840675247866E-3</c:v>
                  </c:pt>
                  <c:pt idx="35">
                    <c:v>2.4670636964565801E-3</c:v>
                  </c:pt>
                  <c:pt idx="36">
                    <c:v>2.4996076490791394E-3</c:v>
                  </c:pt>
                  <c:pt idx="37">
                    <c:v>2.5209738015164176E-3</c:v>
                  </c:pt>
                  <c:pt idx="38">
                    <c:v>2.5264610393581142E-3</c:v>
                  </c:pt>
                  <c:pt idx="39">
                    <c:v>2.519025389096945E-3</c:v>
                  </c:pt>
                  <c:pt idx="40">
                    <c:v>2.5082489738860589E-3</c:v>
                  </c:pt>
                  <c:pt idx="41">
                    <c:v>2.4884544098371397E-3</c:v>
                  </c:pt>
                  <c:pt idx="42">
                    <c:v>2.4487676433261212E-3</c:v>
                  </c:pt>
                  <c:pt idx="43">
                    <c:v>2.3855662816244117E-3</c:v>
                  </c:pt>
                  <c:pt idx="44">
                    <c:v>2.3169598668309659E-3</c:v>
                  </c:pt>
                  <c:pt idx="45">
                    <c:v>2.2518101889305491E-3</c:v>
                  </c:pt>
                  <c:pt idx="46">
                    <c:v>2.1886097303030986E-3</c:v>
                  </c:pt>
                  <c:pt idx="47">
                    <c:v>2.1350128395657086E-3</c:v>
                  </c:pt>
                  <c:pt idx="48">
                    <c:v>2.0905944251123675E-3</c:v>
                  </c:pt>
                  <c:pt idx="49">
                    <c:v>2.0606748218478395E-3</c:v>
                  </c:pt>
                  <c:pt idx="50">
                    <c:v>2.0340670057422921E-3</c:v>
                  </c:pt>
                  <c:pt idx="51">
                    <c:v>2.0201119209386463E-3</c:v>
                  </c:pt>
                  <c:pt idx="52">
                    <c:v>2.0046066083284205E-3</c:v>
                  </c:pt>
                  <c:pt idx="53">
                    <c:v>1.9891203165423393E-3</c:v>
                  </c:pt>
                  <c:pt idx="54">
                    <c:v>1.9555457009840719E-3</c:v>
                  </c:pt>
                  <c:pt idx="55">
                    <c:v>1.9067372923010958E-3</c:v>
                  </c:pt>
                  <c:pt idx="56">
                    <c:v>1.8364319538817068E-3</c:v>
                  </c:pt>
                  <c:pt idx="57">
                    <c:v>1.7590680992432186E-3</c:v>
                  </c:pt>
                  <c:pt idx="58">
                    <c:v>1.6795122563492916E-3</c:v>
                  </c:pt>
                  <c:pt idx="59">
                    <c:v>1.6100531814611826E-3</c:v>
                  </c:pt>
                  <c:pt idx="60">
                    <c:v>1.5513739392275863E-3</c:v>
                  </c:pt>
                  <c:pt idx="61">
                    <c:v>1.5141303897850853E-3</c:v>
                  </c:pt>
                  <c:pt idx="62">
                    <c:v>1.4939724527629464E-3</c:v>
                  </c:pt>
                  <c:pt idx="63">
                    <c:v>1.4878637487935734E-3</c:v>
                  </c:pt>
                  <c:pt idx="64">
                    <c:v>1.4882397077829131E-3</c:v>
                  </c:pt>
                  <c:pt idx="65">
                    <c:v>1.4823032606676545E-3</c:v>
                  </c:pt>
                  <c:pt idx="66">
                    <c:v>1.4543453758219557E-3</c:v>
                  </c:pt>
                  <c:pt idx="67">
                    <c:v>1.4001931080662533E-3</c:v>
                  </c:pt>
                  <c:pt idx="68">
                    <c:v>1.3298142547239114E-3</c:v>
                  </c:pt>
                  <c:pt idx="69">
                    <c:v>1.2493374650841894E-3</c:v>
                  </c:pt>
                  <c:pt idx="70">
                    <c:v>1.1658124496391452E-3</c:v>
                  </c:pt>
                  <c:pt idx="71">
                    <c:v>1.0882490380060728E-3</c:v>
                  </c:pt>
                  <c:pt idx="72">
                    <c:v>1.0076906976519947E-3</c:v>
                  </c:pt>
                  <c:pt idx="73">
                    <c:v>9.1487779752378153E-4</c:v>
                  </c:pt>
                  <c:pt idx="74">
                    <c:v>8.078231065648605E-4</c:v>
                  </c:pt>
                  <c:pt idx="75">
                    <c:v>7.065930333766099E-4</c:v>
                  </c:pt>
                  <c:pt idx="76">
                    <c:v>6.162922819212723E-4</c:v>
                  </c:pt>
                  <c:pt idx="77">
                    <c:v>5.5040793556495183E-4</c:v>
                  </c:pt>
                  <c:pt idx="78">
                    <c:v>5.1564796443567427E-4</c:v>
                  </c:pt>
                  <c:pt idx="79">
                    <c:v>5.0976850571401327E-4</c:v>
                  </c:pt>
                  <c:pt idx="80">
                    <c:v>5.2747634248564372E-4</c:v>
                  </c:pt>
                  <c:pt idx="81">
                    <c:v>5.6506725071476269E-4</c:v>
                  </c:pt>
                  <c:pt idx="82">
                    <c:v>6.1066015024440845E-4</c:v>
                  </c:pt>
                  <c:pt idx="83">
                    <c:v>6.5739651967257633E-4</c:v>
                  </c:pt>
                  <c:pt idx="84">
                    <c:v>7.7638694018404889E-4</c:v>
                  </c:pt>
                  <c:pt idx="85">
                    <c:v>1.0604867592737292E-3</c:v>
                  </c:pt>
                  <c:pt idx="86">
                    <c:v>1.4746646991011208E-3</c:v>
                  </c:pt>
                  <c:pt idx="87">
                    <c:v>1.9238592133802527E-3</c:v>
                  </c:pt>
                  <c:pt idx="88">
                    <c:v>2.3228965226951928E-3</c:v>
                  </c:pt>
                  <c:pt idx="89">
                    <c:v>2.6153091742573287E-3</c:v>
                  </c:pt>
                  <c:pt idx="90">
                    <c:v>2.7698907366986102E-3</c:v>
                  </c:pt>
                  <c:pt idx="91">
                    <c:v>2.8315120770388514E-3</c:v>
                  </c:pt>
                  <c:pt idx="92">
                    <c:v>2.8327318678594603E-3</c:v>
                  </c:pt>
                  <c:pt idx="93">
                    <c:v>2.7959102280479173E-3</c:v>
                  </c:pt>
                  <c:pt idx="94">
                    <c:v>2.7347535643933193E-3</c:v>
                  </c:pt>
                  <c:pt idx="95">
                    <c:v>2.6706842518788533E-3</c:v>
                  </c:pt>
                  <c:pt idx="96">
                    <c:v>2.5921322434778898E-3</c:v>
                  </c:pt>
                  <c:pt idx="97">
                    <c:v>2.5007863100573913E-3</c:v>
                  </c:pt>
                  <c:pt idx="98">
                    <c:v>2.4126127128444134E-3</c:v>
                  </c:pt>
                  <c:pt idx="99">
                    <c:v>2.3266468578942868E-3</c:v>
                  </c:pt>
                  <c:pt idx="100">
                    <c:v>2.2520513599165975E-3</c:v>
                  </c:pt>
                  <c:pt idx="101">
                    <c:v>2.1937228000458876E-3</c:v>
                  </c:pt>
                  <c:pt idx="102">
                    <c:v>2.1615838533216771E-3</c:v>
                  </c:pt>
                  <c:pt idx="103">
                    <c:v>2.139828138221409E-3</c:v>
                  </c:pt>
                  <c:pt idx="104">
                    <c:v>2.126180916562065E-3</c:v>
                  </c:pt>
                  <c:pt idx="105">
                    <c:v>2.1153228849461127E-3</c:v>
                  </c:pt>
                  <c:pt idx="106">
                    <c:v>2.0933246222277161E-3</c:v>
                  </c:pt>
                  <c:pt idx="107">
                    <c:v>2.0851234843558219E-3</c:v>
                  </c:pt>
                  <c:pt idx="108">
                    <c:v>2.0741172940989283E-3</c:v>
                  </c:pt>
                  <c:pt idx="109">
                    <c:v>2.0819868126554391E-3</c:v>
                  </c:pt>
                  <c:pt idx="110">
                    <c:v>2.0592526950114734E-3</c:v>
                  </c:pt>
                  <c:pt idx="111">
                    <c:v>2.043558742263554E-3</c:v>
                  </c:pt>
                  <c:pt idx="112">
                    <c:v>2.0468124422903496E-3</c:v>
                  </c:pt>
                  <c:pt idx="113">
                    <c:v>2.072219620525739E-3</c:v>
                  </c:pt>
                  <c:pt idx="114">
                    <c:v>2.1149300358979063E-3</c:v>
                  </c:pt>
                  <c:pt idx="115">
                    <c:v>2.1640608267919788E-3</c:v>
                  </c:pt>
                  <c:pt idx="116">
                    <c:v>2.2090505404282141E-3</c:v>
                  </c:pt>
                  <c:pt idx="117">
                    <c:v>2.2361486182730533E-3</c:v>
                  </c:pt>
                  <c:pt idx="118">
                    <c:v>2.2323692698386108E-3</c:v>
                  </c:pt>
                  <c:pt idx="119">
                    <c:v>2.266630137275902E-3</c:v>
                  </c:pt>
                  <c:pt idx="120">
                    <c:v>2.3351992405920658E-3</c:v>
                  </c:pt>
                  <c:pt idx="121">
                    <c:v>2.4049777189031687E-3</c:v>
                  </c:pt>
                  <c:pt idx="122">
                    <c:v>2.3896117667955956E-3</c:v>
                  </c:pt>
                  <c:pt idx="123">
                    <c:v>2.3523782416168502E-3</c:v>
                  </c:pt>
                  <c:pt idx="124">
                    <c:v>2.3240951943813075E-3</c:v>
                  </c:pt>
                  <c:pt idx="125">
                    <c:v>2.2876365560579237E-3</c:v>
                  </c:pt>
                  <c:pt idx="126">
                    <c:v>2.2990653959293877E-3</c:v>
                  </c:pt>
                  <c:pt idx="127">
                    <c:v>2.3824109216932236E-3</c:v>
                  </c:pt>
                  <c:pt idx="128">
                    <c:v>2.4787639428910128E-3</c:v>
                  </c:pt>
                  <c:pt idx="129">
                    <c:v>2.5227460742687485E-3</c:v>
                  </c:pt>
                  <c:pt idx="130">
                    <c:v>2.6108623162885329E-3</c:v>
                  </c:pt>
                  <c:pt idx="131">
                    <c:v>2.6621827142613293E-3</c:v>
                  </c:pt>
                  <c:pt idx="132">
                    <c:v>2.6782131797348022E-3</c:v>
                  </c:pt>
                  <c:pt idx="133">
                    <c:v>2.7719681481466639E-3</c:v>
                  </c:pt>
                  <c:pt idx="134">
                    <c:v>2.9097612944047795E-3</c:v>
                  </c:pt>
                  <c:pt idx="135">
                    <c:v>2.9947318085923281E-3</c:v>
                  </c:pt>
                  <c:pt idx="136">
                    <c:v>2.9947792189526663E-3</c:v>
                  </c:pt>
                  <c:pt idx="137">
                    <c:v>3.0560241805143154E-3</c:v>
                  </c:pt>
                  <c:pt idx="138">
                    <c:v>3.1400834873831496E-3</c:v>
                  </c:pt>
                  <c:pt idx="139">
                    <c:v>3.2246018006328748E-3</c:v>
                  </c:pt>
                </c:numCache>
              </c:numRef>
            </c:plus>
            <c:minus>
              <c:numRef>
                <c:f>'AVG healthy'!$AZ$5:$AZ$144</c:f>
                <c:numCache>
                  <c:formatCode>General</c:formatCode>
                  <c:ptCount val="140"/>
                  <c:pt idx="0">
                    <c:v>5.0226415624744715E-4</c:v>
                  </c:pt>
                  <c:pt idx="1">
                    <c:v>5.0103318257050311E-4</c:v>
                  </c:pt>
                  <c:pt idx="2">
                    <c:v>5.1993113853465451E-4</c:v>
                  </c:pt>
                  <c:pt idx="3">
                    <c:v>5.5458553332966593E-4</c:v>
                  </c:pt>
                  <c:pt idx="4">
                    <c:v>5.647378759215233E-4</c:v>
                  </c:pt>
                  <c:pt idx="5">
                    <c:v>5.5207039834121482E-4</c:v>
                  </c:pt>
                  <c:pt idx="6">
                    <c:v>5.45177698500641E-4</c:v>
                  </c:pt>
                  <c:pt idx="7">
                    <c:v>5.5111289536160612E-4</c:v>
                  </c:pt>
                  <c:pt idx="8">
                    <c:v>5.6905468334910315E-4</c:v>
                  </c:pt>
                  <c:pt idx="9">
                    <c:v>5.891947849193085E-4</c:v>
                  </c:pt>
                  <c:pt idx="10">
                    <c:v>5.9916127583904601E-4</c:v>
                  </c:pt>
                  <c:pt idx="11">
                    <c:v>5.993500904680468E-4</c:v>
                  </c:pt>
                  <c:pt idx="12">
                    <c:v>6.1077536183201588E-4</c:v>
                  </c:pt>
                  <c:pt idx="13">
                    <c:v>6.2869398501759792E-4</c:v>
                  </c:pt>
                  <c:pt idx="14">
                    <c:v>6.3343898110499732E-4</c:v>
                  </c:pt>
                  <c:pt idx="15">
                    <c:v>6.3790704117978165E-4</c:v>
                  </c:pt>
                  <c:pt idx="16">
                    <c:v>6.6060547866777098E-4</c:v>
                  </c:pt>
                  <c:pt idx="17">
                    <c:v>7.2433361491952195E-4</c:v>
                  </c:pt>
                  <c:pt idx="18">
                    <c:v>8.0313542784610237E-4</c:v>
                  </c:pt>
                  <c:pt idx="19">
                    <c:v>8.9602213610371056E-4</c:v>
                  </c:pt>
                  <c:pt idx="20">
                    <c:v>1.0193664305946089E-3</c:v>
                  </c:pt>
                  <c:pt idx="21">
                    <c:v>1.1701844612498086E-3</c:v>
                  </c:pt>
                  <c:pt idx="22">
                    <c:v>1.3226906901814453E-3</c:v>
                  </c:pt>
                  <c:pt idx="23">
                    <c:v>1.487491642877351E-3</c:v>
                  </c:pt>
                  <c:pt idx="24">
                    <c:v>1.6542544050582753E-3</c:v>
                  </c:pt>
                  <c:pt idx="25">
                    <c:v>1.816796537806439E-3</c:v>
                  </c:pt>
                  <c:pt idx="26">
                    <c:v>1.9569604748541298E-3</c:v>
                  </c:pt>
                  <c:pt idx="27">
                    <c:v>2.0774035269831214E-3</c:v>
                  </c:pt>
                  <c:pt idx="28">
                    <c:v>2.1601204509457662E-3</c:v>
                  </c:pt>
                  <c:pt idx="29">
                    <c:v>2.2307350197459741E-3</c:v>
                  </c:pt>
                  <c:pt idx="30">
                    <c:v>2.2785125411271326E-3</c:v>
                  </c:pt>
                  <c:pt idx="31">
                    <c:v>2.3217404213121181E-3</c:v>
                  </c:pt>
                  <c:pt idx="32">
                    <c:v>2.3507697892863086E-3</c:v>
                  </c:pt>
                  <c:pt idx="33">
                    <c:v>2.3899360207937622E-3</c:v>
                  </c:pt>
                  <c:pt idx="34">
                    <c:v>2.4250840675247866E-3</c:v>
                  </c:pt>
                  <c:pt idx="35">
                    <c:v>2.4670636964565801E-3</c:v>
                  </c:pt>
                  <c:pt idx="36">
                    <c:v>2.4996076490791394E-3</c:v>
                  </c:pt>
                  <c:pt idx="37">
                    <c:v>2.5209738015164176E-3</c:v>
                  </c:pt>
                  <c:pt idx="38">
                    <c:v>2.5264610393581142E-3</c:v>
                  </c:pt>
                  <c:pt idx="39">
                    <c:v>2.519025389096945E-3</c:v>
                  </c:pt>
                  <c:pt idx="40">
                    <c:v>2.5082489738860589E-3</c:v>
                  </c:pt>
                  <c:pt idx="41">
                    <c:v>2.4884544098371397E-3</c:v>
                  </c:pt>
                  <c:pt idx="42">
                    <c:v>2.4487676433261212E-3</c:v>
                  </c:pt>
                  <c:pt idx="43">
                    <c:v>2.3855662816244117E-3</c:v>
                  </c:pt>
                  <c:pt idx="44">
                    <c:v>2.3169598668309659E-3</c:v>
                  </c:pt>
                  <c:pt idx="45">
                    <c:v>2.2518101889305491E-3</c:v>
                  </c:pt>
                  <c:pt idx="46">
                    <c:v>2.1886097303030986E-3</c:v>
                  </c:pt>
                  <c:pt idx="47">
                    <c:v>2.1350128395657086E-3</c:v>
                  </c:pt>
                  <c:pt idx="48">
                    <c:v>2.0905944251123675E-3</c:v>
                  </c:pt>
                  <c:pt idx="49">
                    <c:v>2.0606748218478395E-3</c:v>
                  </c:pt>
                  <c:pt idx="50">
                    <c:v>2.0340670057422921E-3</c:v>
                  </c:pt>
                  <c:pt idx="51">
                    <c:v>2.0201119209386463E-3</c:v>
                  </c:pt>
                  <c:pt idx="52">
                    <c:v>2.0046066083284205E-3</c:v>
                  </c:pt>
                  <c:pt idx="53">
                    <c:v>1.9891203165423393E-3</c:v>
                  </c:pt>
                  <c:pt idx="54">
                    <c:v>1.9555457009840719E-3</c:v>
                  </c:pt>
                  <c:pt idx="55">
                    <c:v>1.9067372923010958E-3</c:v>
                  </c:pt>
                  <c:pt idx="56">
                    <c:v>1.8364319538817068E-3</c:v>
                  </c:pt>
                  <c:pt idx="57">
                    <c:v>1.7590680992432186E-3</c:v>
                  </c:pt>
                  <c:pt idx="58">
                    <c:v>1.6795122563492916E-3</c:v>
                  </c:pt>
                  <c:pt idx="59">
                    <c:v>1.6100531814611826E-3</c:v>
                  </c:pt>
                  <c:pt idx="60">
                    <c:v>1.5513739392275863E-3</c:v>
                  </c:pt>
                  <c:pt idx="61">
                    <c:v>1.5141303897850853E-3</c:v>
                  </c:pt>
                  <c:pt idx="62">
                    <c:v>1.4939724527629464E-3</c:v>
                  </c:pt>
                  <c:pt idx="63">
                    <c:v>1.4878637487935734E-3</c:v>
                  </c:pt>
                  <c:pt idx="64">
                    <c:v>1.4882397077829131E-3</c:v>
                  </c:pt>
                  <c:pt idx="65">
                    <c:v>1.4823032606676545E-3</c:v>
                  </c:pt>
                  <c:pt idx="66">
                    <c:v>1.4543453758219557E-3</c:v>
                  </c:pt>
                  <c:pt idx="67">
                    <c:v>1.4001931080662533E-3</c:v>
                  </c:pt>
                  <c:pt idx="68">
                    <c:v>1.3298142547239114E-3</c:v>
                  </c:pt>
                  <c:pt idx="69">
                    <c:v>1.2493374650841894E-3</c:v>
                  </c:pt>
                  <c:pt idx="70">
                    <c:v>1.1658124496391452E-3</c:v>
                  </c:pt>
                  <c:pt idx="71">
                    <c:v>1.0882490380060728E-3</c:v>
                  </c:pt>
                  <c:pt idx="72">
                    <c:v>1.0076906976519947E-3</c:v>
                  </c:pt>
                  <c:pt idx="73">
                    <c:v>9.1487779752378153E-4</c:v>
                  </c:pt>
                  <c:pt idx="74">
                    <c:v>8.078231065648605E-4</c:v>
                  </c:pt>
                  <c:pt idx="75">
                    <c:v>7.065930333766099E-4</c:v>
                  </c:pt>
                  <c:pt idx="76">
                    <c:v>6.162922819212723E-4</c:v>
                  </c:pt>
                  <c:pt idx="77">
                    <c:v>5.5040793556495183E-4</c:v>
                  </c:pt>
                  <c:pt idx="78">
                    <c:v>5.1564796443567427E-4</c:v>
                  </c:pt>
                  <c:pt idx="79">
                    <c:v>5.0976850571401327E-4</c:v>
                  </c:pt>
                  <c:pt idx="80">
                    <c:v>5.2747634248564372E-4</c:v>
                  </c:pt>
                  <c:pt idx="81">
                    <c:v>5.6506725071476269E-4</c:v>
                  </c:pt>
                  <c:pt idx="82">
                    <c:v>6.1066015024440845E-4</c:v>
                  </c:pt>
                  <c:pt idx="83">
                    <c:v>6.5739651967257633E-4</c:v>
                  </c:pt>
                  <c:pt idx="84">
                    <c:v>7.7638694018404889E-4</c:v>
                  </c:pt>
                  <c:pt idx="85">
                    <c:v>1.0604867592737292E-3</c:v>
                  </c:pt>
                  <c:pt idx="86">
                    <c:v>1.4746646991011208E-3</c:v>
                  </c:pt>
                  <c:pt idx="87">
                    <c:v>1.9238592133802527E-3</c:v>
                  </c:pt>
                  <c:pt idx="88">
                    <c:v>2.3228965226951928E-3</c:v>
                  </c:pt>
                  <c:pt idx="89">
                    <c:v>2.6153091742573287E-3</c:v>
                  </c:pt>
                  <c:pt idx="90">
                    <c:v>2.7698907366986102E-3</c:v>
                  </c:pt>
                  <c:pt idx="91">
                    <c:v>2.8315120770388514E-3</c:v>
                  </c:pt>
                  <c:pt idx="92">
                    <c:v>2.8327318678594603E-3</c:v>
                  </c:pt>
                  <c:pt idx="93">
                    <c:v>2.7959102280479173E-3</c:v>
                  </c:pt>
                  <c:pt idx="94">
                    <c:v>2.7347535643933193E-3</c:v>
                  </c:pt>
                  <c:pt idx="95">
                    <c:v>2.6706842518788533E-3</c:v>
                  </c:pt>
                  <c:pt idx="96">
                    <c:v>2.5921322434778898E-3</c:v>
                  </c:pt>
                  <c:pt idx="97">
                    <c:v>2.5007863100573913E-3</c:v>
                  </c:pt>
                  <c:pt idx="98">
                    <c:v>2.4126127128444134E-3</c:v>
                  </c:pt>
                  <c:pt idx="99">
                    <c:v>2.3266468578942868E-3</c:v>
                  </c:pt>
                  <c:pt idx="100">
                    <c:v>2.2520513599165975E-3</c:v>
                  </c:pt>
                  <c:pt idx="101">
                    <c:v>2.1937228000458876E-3</c:v>
                  </c:pt>
                  <c:pt idx="102">
                    <c:v>2.1615838533216771E-3</c:v>
                  </c:pt>
                  <c:pt idx="103">
                    <c:v>2.139828138221409E-3</c:v>
                  </c:pt>
                  <c:pt idx="104">
                    <c:v>2.126180916562065E-3</c:v>
                  </c:pt>
                  <c:pt idx="105">
                    <c:v>2.1153228849461127E-3</c:v>
                  </c:pt>
                  <c:pt idx="106">
                    <c:v>2.0933246222277161E-3</c:v>
                  </c:pt>
                  <c:pt idx="107">
                    <c:v>2.0851234843558219E-3</c:v>
                  </c:pt>
                  <c:pt idx="108">
                    <c:v>2.0741172940989283E-3</c:v>
                  </c:pt>
                  <c:pt idx="109">
                    <c:v>2.0819868126554391E-3</c:v>
                  </c:pt>
                  <c:pt idx="110">
                    <c:v>2.0592526950114734E-3</c:v>
                  </c:pt>
                  <c:pt idx="111">
                    <c:v>2.043558742263554E-3</c:v>
                  </c:pt>
                  <c:pt idx="112">
                    <c:v>2.0468124422903496E-3</c:v>
                  </c:pt>
                  <c:pt idx="113">
                    <c:v>2.072219620525739E-3</c:v>
                  </c:pt>
                  <c:pt idx="114">
                    <c:v>2.1149300358979063E-3</c:v>
                  </c:pt>
                  <c:pt idx="115">
                    <c:v>2.1640608267919788E-3</c:v>
                  </c:pt>
                  <c:pt idx="116">
                    <c:v>2.2090505404282141E-3</c:v>
                  </c:pt>
                  <c:pt idx="117">
                    <c:v>2.2361486182730533E-3</c:v>
                  </c:pt>
                  <c:pt idx="118">
                    <c:v>2.2323692698386108E-3</c:v>
                  </c:pt>
                  <c:pt idx="119">
                    <c:v>2.266630137275902E-3</c:v>
                  </c:pt>
                  <c:pt idx="120">
                    <c:v>2.3351992405920658E-3</c:v>
                  </c:pt>
                  <c:pt idx="121">
                    <c:v>2.4049777189031687E-3</c:v>
                  </c:pt>
                  <c:pt idx="122">
                    <c:v>2.3896117667955956E-3</c:v>
                  </c:pt>
                  <c:pt idx="123">
                    <c:v>2.3523782416168502E-3</c:v>
                  </c:pt>
                  <c:pt idx="124">
                    <c:v>2.3240951943813075E-3</c:v>
                  </c:pt>
                  <c:pt idx="125">
                    <c:v>2.2876365560579237E-3</c:v>
                  </c:pt>
                  <c:pt idx="126">
                    <c:v>2.2990653959293877E-3</c:v>
                  </c:pt>
                  <c:pt idx="127">
                    <c:v>2.3824109216932236E-3</c:v>
                  </c:pt>
                  <c:pt idx="128">
                    <c:v>2.4787639428910128E-3</c:v>
                  </c:pt>
                  <c:pt idx="129">
                    <c:v>2.5227460742687485E-3</c:v>
                  </c:pt>
                  <c:pt idx="130">
                    <c:v>2.6108623162885329E-3</c:v>
                  </c:pt>
                  <c:pt idx="131">
                    <c:v>2.6621827142613293E-3</c:v>
                  </c:pt>
                  <c:pt idx="132">
                    <c:v>2.6782131797348022E-3</c:v>
                  </c:pt>
                  <c:pt idx="133">
                    <c:v>2.7719681481466639E-3</c:v>
                  </c:pt>
                  <c:pt idx="134">
                    <c:v>2.9097612944047795E-3</c:v>
                  </c:pt>
                  <c:pt idx="135">
                    <c:v>2.9947318085923281E-3</c:v>
                  </c:pt>
                  <c:pt idx="136">
                    <c:v>2.9947792189526663E-3</c:v>
                  </c:pt>
                  <c:pt idx="137">
                    <c:v>3.0560241805143154E-3</c:v>
                  </c:pt>
                  <c:pt idx="138">
                    <c:v>3.1400834873831496E-3</c:v>
                  </c:pt>
                  <c:pt idx="139">
                    <c:v>3.2246018006328748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x"/>
            <c:errBarType val="both"/>
            <c:errValType val="fixedVal"/>
            <c:noEndCap val="0"/>
            <c:val val="1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AVG healthy'!$AT$5:$AT$144</c:f>
              <c:numCache>
                <c:formatCode>General</c:formatCode>
                <c:ptCount val="140"/>
                <c:pt idx="0">
                  <c:v>451.25</c:v>
                </c:pt>
                <c:pt idx="1">
                  <c:v>454.040009</c:v>
                </c:pt>
                <c:pt idx="2">
                  <c:v>456.82000699999998</c:v>
                </c:pt>
                <c:pt idx="3">
                  <c:v>459.60998499999999</c:v>
                </c:pt>
                <c:pt idx="4">
                  <c:v>462.39999399999999</c:v>
                </c:pt>
                <c:pt idx="5">
                  <c:v>465.19000199999999</c:v>
                </c:pt>
                <c:pt idx="6">
                  <c:v>467.98001099999999</c:v>
                </c:pt>
                <c:pt idx="7">
                  <c:v>470.77999899999998</c:v>
                </c:pt>
                <c:pt idx="8">
                  <c:v>473.57000699999998</c:v>
                </c:pt>
                <c:pt idx="9">
                  <c:v>476.36999500000002</c:v>
                </c:pt>
                <c:pt idx="10">
                  <c:v>479.16000400000001</c:v>
                </c:pt>
                <c:pt idx="11">
                  <c:v>481.959991</c:v>
                </c:pt>
                <c:pt idx="12">
                  <c:v>484.76001000000002</c:v>
                </c:pt>
                <c:pt idx="13">
                  <c:v>487.55999800000001</c:v>
                </c:pt>
                <c:pt idx="14">
                  <c:v>490.35998499999999</c:v>
                </c:pt>
                <c:pt idx="15">
                  <c:v>493.16000400000001</c:v>
                </c:pt>
                <c:pt idx="16">
                  <c:v>495.97000100000002</c:v>
                </c:pt>
                <c:pt idx="17">
                  <c:v>498.76998900000001</c:v>
                </c:pt>
                <c:pt idx="18">
                  <c:v>501.57998700000002</c:v>
                </c:pt>
                <c:pt idx="19">
                  <c:v>504.39001500000001</c:v>
                </c:pt>
                <c:pt idx="20">
                  <c:v>507.19000199999999</c:v>
                </c:pt>
                <c:pt idx="21">
                  <c:v>510</c:v>
                </c:pt>
                <c:pt idx="22">
                  <c:v>512.80999799999995</c:v>
                </c:pt>
                <c:pt idx="23">
                  <c:v>515.63000499999998</c:v>
                </c:pt>
                <c:pt idx="24">
                  <c:v>518.44000200000005</c:v>
                </c:pt>
                <c:pt idx="25">
                  <c:v>521.25</c:v>
                </c:pt>
                <c:pt idx="26">
                  <c:v>524.07000700000003</c:v>
                </c:pt>
                <c:pt idx="27">
                  <c:v>526.88000499999998</c:v>
                </c:pt>
                <c:pt idx="28">
                  <c:v>529.70001200000002</c:v>
                </c:pt>
                <c:pt idx="29">
                  <c:v>532.52002000000005</c:v>
                </c:pt>
                <c:pt idx="30">
                  <c:v>535.34002699999996</c:v>
                </c:pt>
                <c:pt idx="31">
                  <c:v>538.15997300000004</c:v>
                </c:pt>
                <c:pt idx="32">
                  <c:v>540.98999000000003</c:v>
                </c:pt>
                <c:pt idx="33">
                  <c:v>543.80999799999995</c:v>
                </c:pt>
                <c:pt idx="34">
                  <c:v>546.63000499999998</c:v>
                </c:pt>
                <c:pt idx="35">
                  <c:v>549.46002199999998</c:v>
                </c:pt>
                <c:pt idx="36">
                  <c:v>552.28997800000002</c:v>
                </c:pt>
                <c:pt idx="37">
                  <c:v>555.11999500000002</c:v>
                </c:pt>
                <c:pt idx="38">
                  <c:v>557.94000200000005</c:v>
                </c:pt>
                <c:pt idx="39">
                  <c:v>560.78002900000001</c:v>
                </c:pt>
                <c:pt idx="40">
                  <c:v>563.60998500000005</c:v>
                </c:pt>
                <c:pt idx="41">
                  <c:v>566.44000200000005</c:v>
                </c:pt>
                <c:pt idx="42">
                  <c:v>569.27002000000005</c:v>
                </c:pt>
                <c:pt idx="43">
                  <c:v>572.10998500000005</c:v>
                </c:pt>
                <c:pt idx="44">
                  <c:v>574.95001200000002</c:v>
                </c:pt>
                <c:pt idx="45">
                  <c:v>577.78002900000001</c:v>
                </c:pt>
                <c:pt idx="46">
                  <c:v>580.61999500000002</c:v>
                </c:pt>
                <c:pt idx="47">
                  <c:v>583.46002199999998</c:v>
                </c:pt>
                <c:pt idx="48">
                  <c:v>586.29998799999998</c:v>
                </c:pt>
                <c:pt idx="49">
                  <c:v>589.15002400000003</c:v>
                </c:pt>
                <c:pt idx="50">
                  <c:v>591.98999000000003</c:v>
                </c:pt>
                <c:pt idx="51">
                  <c:v>594.84002699999996</c:v>
                </c:pt>
                <c:pt idx="52">
                  <c:v>597.67999299999997</c:v>
                </c:pt>
                <c:pt idx="53">
                  <c:v>600.53002900000001</c:v>
                </c:pt>
                <c:pt idx="54">
                  <c:v>603.38000499999998</c:v>
                </c:pt>
                <c:pt idx="55">
                  <c:v>606.22997999999995</c:v>
                </c:pt>
                <c:pt idx="56">
                  <c:v>609.080017</c:v>
                </c:pt>
                <c:pt idx="57">
                  <c:v>611.92999299999997</c:v>
                </c:pt>
                <c:pt idx="58">
                  <c:v>614.78002900000001</c:v>
                </c:pt>
                <c:pt idx="59">
                  <c:v>617.64001499999995</c:v>
                </c:pt>
                <c:pt idx="60">
                  <c:v>620.48999000000003</c:v>
                </c:pt>
                <c:pt idx="61">
                  <c:v>623.34997599999997</c:v>
                </c:pt>
                <c:pt idx="62">
                  <c:v>626.21002199999998</c:v>
                </c:pt>
                <c:pt idx="63">
                  <c:v>629.07000700000003</c:v>
                </c:pt>
                <c:pt idx="64">
                  <c:v>631.92999299999997</c:v>
                </c:pt>
                <c:pt idx="65">
                  <c:v>634.78997800000002</c:v>
                </c:pt>
                <c:pt idx="66">
                  <c:v>637.65002400000003</c:v>
                </c:pt>
                <c:pt idx="67">
                  <c:v>640.51000999999997</c:v>
                </c:pt>
                <c:pt idx="68">
                  <c:v>643.38000499999998</c:v>
                </c:pt>
                <c:pt idx="69">
                  <c:v>646.23999000000003</c:v>
                </c:pt>
                <c:pt idx="70">
                  <c:v>649.10998500000005</c:v>
                </c:pt>
                <c:pt idx="71">
                  <c:v>651.97997999999995</c:v>
                </c:pt>
                <c:pt idx="72">
                  <c:v>654.84997599999997</c:v>
                </c:pt>
                <c:pt idx="73">
                  <c:v>657.71997099999999</c:v>
                </c:pt>
                <c:pt idx="74">
                  <c:v>660.59002699999996</c:v>
                </c:pt>
                <c:pt idx="75">
                  <c:v>663.46997099999999</c:v>
                </c:pt>
                <c:pt idx="76">
                  <c:v>666.34002699999996</c:v>
                </c:pt>
                <c:pt idx="77">
                  <c:v>669.21997099999999</c:v>
                </c:pt>
                <c:pt idx="78">
                  <c:v>672.09002699999996</c:v>
                </c:pt>
                <c:pt idx="79">
                  <c:v>674.96997099999999</c:v>
                </c:pt>
                <c:pt idx="80">
                  <c:v>677.84997599999997</c:v>
                </c:pt>
                <c:pt idx="81">
                  <c:v>680.72997999999995</c:v>
                </c:pt>
                <c:pt idx="82">
                  <c:v>683.60998500000005</c:v>
                </c:pt>
                <c:pt idx="83">
                  <c:v>686.48999000000003</c:v>
                </c:pt>
                <c:pt idx="84">
                  <c:v>689.38000499999998</c:v>
                </c:pt>
                <c:pt idx="85">
                  <c:v>692.26000999999997</c:v>
                </c:pt>
                <c:pt idx="86">
                  <c:v>695.15002400000003</c:v>
                </c:pt>
                <c:pt idx="87">
                  <c:v>698.03002900000001</c:v>
                </c:pt>
                <c:pt idx="88">
                  <c:v>700.919983</c:v>
                </c:pt>
                <c:pt idx="89">
                  <c:v>703.80999799999995</c:v>
                </c:pt>
                <c:pt idx="90">
                  <c:v>706.70001200000002</c:v>
                </c:pt>
                <c:pt idx="91">
                  <c:v>709.59997599999997</c:v>
                </c:pt>
                <c:pt idx="92">
                  <c:v>712.48999000000003</c:v>
                </c:pt>
                <c:pt idx="93">
                  <c:v>715.38000499999998</c:v>
                </c:pt>
                <c:pt idx="94">
                  <c:v>718.28002900000001</c:v>
                </c:pt>
                <c:pt idx="95">
                  <c:v>721.17999299999997</c:v>
                </c:pt>
                <c:pt idx="96">
                  <c:v>724.07000700000003</c:v>
                </c:pt>
                <c:pt idx="97">
                  <c:v>726.96997099999999</c:v>
                </c:pt>
                <c:pt idx="98">
                  <c:v>729.86999500000002</c:v>
                </c:pt>
                <c:pt idx="99">
                  <c:v>732.77002000000005</c:v>
                </c:pt>
                <c:pt idx="100">
                  <c:v>735.67999299999997</c:v>
                </c:pt>
                <c:pt idx="101">
                  <c:v>738.580017</c:v>
                </c:pt>
                <c:pt idx="102">
                  <c:v>741.48999000000003</c:v>
                </c:pt>
                <c:pt idx="103">
                  <c:v>744.39001499999995</c:v>
                </c:pt>
                <c:pt idx="104">
                  <c:v>747.29998799999998</c:v>
                </c:pt>
                <c:pt idx="105">
                  <c:v>750.21002199999998</c:v>
                </c:pt>
                <c:pt idx="106">
                  <c:v>753.11999500000002</c:v>
                </c:pt>
                <c:pt idx="107">
                  <c:v>756.03002900000001</c:v>
                </c:pt>
                <c:pt idx="108">
                  <c:v>758.94000200000005</c:v>
                </c:pt>
                <c:pt idx="109">
                  <c:v>761.84997599999997</c:v>
                </c:pt>
                <c:pt idx="110">
                  <c:v>764.77002000000005</c:v>
                </c:pt>
                <c:pt idx="111">
                  <c:v>767.67999299999997</c:v>
                </c:pt>
                <c:pt idx="112">
                  <c:v>770.59997599999997</c:v>
                </c:pt>
                <c:pt idx="113">
                  <c:v>773.52002000000005</c:v>
                </c:pt>
                <c:pt idx="114">
                  <c:v>776.44000200000005</c:v>
                </c:pt>
                <c:pt idx="115">
                  <c:v>779.35998500000005</c:v>
                </c:pt>
                <c:pt idx="116">
                  <c:v>782.28002900000001</c:v>
                </c:pt>
                <c:pt idx="117">
                  <c:v>785.20001200000002</c:v>
                </c:pt>
                <c:pt idx="118">
                  <c:v>788.11999500000002</c:v>
                </c:pt>
                <c:pt idx="119">
                  <c:v>791.04998799999998</c:v>
                </c:pt>
                <c:pt idx="120">
                  <c:v>793.97997999999995</c:v>
                </c:pt>
                <c:pt idx="121">
                  <c:v>796.90002400000003</c:v>
                </c:pt>
                <c:pt idx="122">
                  <c:v>799.830017</c:v>
                </c:pt>
                <c:pt idx="123">
                  <c:v>802.76000999999997</c:v>
                </c:pt>
                <c:pt idx="124">
                  <c:v>805.69000200000005</c:v>
                </c:pt>
                <c:pt idx="125">
                  <c:v>808.61999500000002</c:v>
                </c:pt>
                <c:pt idx="126">
                  <c:v>811.55999799999995</c:v>
                </c:pt>
                <c:pt idx="127">
                  <c:v>814.48999000000003</c:v>
                </c:pt>
                <c:pt idx="128">
                  <c:v>817.42999299999997</c:v>
                </c:pt>
                <c:pt idx="129">
                  <c:v>820.35998500000005</c:v>
                </c:pt>
                <c:pt idx="130">
                  <c:v>823.29998799999998</c:v>
                </c:pt>
                <c:pt idx="131">
                  <c:v>826.23999000000003</c:v>
                </c:pt>
                <c:pt idx="132">
                  <c:v>829.17999299999997</c:v>
                </c:pt>
                <c:pt idx="133">
                  <c:v>832.11999500000002</c:v>
                </c:pt>
                <c:pt idx="134">
                  <c:v>835.07000700000003</c:v>
                </c:pt>
                <c:pt idx="135">
                  <c:v>838.01000999999997</c:v>
                </c:pt>
                <c:pt idx="136">
                  <c:v>840.95001200000002</c:v>
                </c:pt>
                <c:pt idx="137">
                  <c:v>843.90002400000003</c:v>
                </c:pt>
                <c:pt idx="138">
                  <c:v>846.84997599999997</c:v>
                </c:pt>
                <c:pt idx="139">
                  <c:v>849.79998799999998</c:v>
                </c:pt>
              </c:numCache>
            </c:numRef>
          </c:xVal>
          <c:yVal>
            <c:numRef>
              <c:f>'AVG healthy'!$AW$5:$AW$144</c:f>
              <c:numCache>
                <c:formatCode>General</c:formatCode>
                <c:ptCount val="140"/>
                <c:pt idx="0">
                  <c:v>4.5824000000000004E-2</c:v>
                </c:pt>
                <c:pt idx="1">
                  <c:v>4.5757875000000003E-2</c:v>
                </c:pt>
                <c:pt idx="2">
                  <c:v>4.5566374999999999E-2</c:v>
                </c:pt>
                <c:pt idx="3">
                  <c:v>4.5259624999999998E-2</c:v>
                </c:pt>
                <c:pt idx="4">
                  <c:v>4.4776375E-2</c:v>
                </c:pt>
                <c:pt idx="5">
                  <c:v>4.4265249999999999E-2</c:v>
                </c:pt>
                <c:pt idx="6">
                  <c:v>4.3781374999999997E-2</c:v>
                </c:pt>
                <c:pt idx="7">
                  <c:v>4.3445750000000005E-2</c:v>
                </c:pt>
                <c:pt idx="8">
                  <c:v>4.3159249999999996E-2</c:v>
                </c:pt>
                <c:pt idx="9">
                  <c:v>4.2957250000000002E-2</c:v>
                </c:pt>
                <c:pt idx="10">
                  <c:v>4.2765750000000005E-2</c:v>
                </c:pt>
                <c:pt idx="11">
                  <c:v>4.2603874999999999E-2</c:v>
                </c:pt>
                <c:pt idx="12">
                  <c:v>4.2400750000000001E-2</c:v>
                </c:pt>
                <c:pt idx="13">
                  <c:v>4.2356375000000002E-2</c:v>
                </c:pt>
                <c:pt idx="14">
                  <c:v>4.2451625E-2</c:v>
                </c:pt>
                <c:pt idx="15">
                  <c:v>4.2778375E-2</c:v>
                </c:pt>
                <c:pt idx="16">
                  <c:v>4.3376875000000002E-2</c:v>
                </c:pt>
                <c:pt idx="17">
                  <c:v>4.4429625E-2</c:v>
                </c:pt>
                <c:pt idx="18">
                  <c:v>4.6097374999999996E-2</c:v>
                </c:pt>
                <c:pt idx="19">
                  <c:v>4.8599749999999997E-2</c:v>
                </c:pt>
                <c:pt idx="20">
                  <c:v>5.2138375000000001E-2</c:v>
                </c:pt>
                <c:pt idx="21">
                  <c:v>5.6767499999999999E-2</c:v>
                </c:pt>
                <c:pt idx="22">
                  <c:v>6.2567249999999991E-2</c:v>
                </c:pt>
                <c:pt idx="23">
                  <c:v>6.9576374999999996E-2</c:v>
                </c:pt>
                <c:pt idx="24">
                  <c:v>7.7815375000000006E-2</c:v>
                </c:pt>
                <c:pt idx="25">
                  <c:v>8.6943499999999993E-2</c:v>
                </c:pt>
                <c:pt idx="26">
                  <c:v>9.6225375000000002E-2</c:v>
                </c:pt>
                <c:pt idx="27">
                  <c:v>0.1048385</c:v>
                </c:pt>
                <c:pt idx="28">
                  <c:v>0.112164875</c:v>
                </c:pt>
                <c:pt idx="29">
                  <c:v>0.11789274999999999</c:v>
                </c:pt>
                <c:pt idx="30">
                  <c:v>0.12204974999999998</c:v>
                </c:pt>
                <c:pt idx="31">
                  <c:v>0.124883125</c:v>
                </c:pt>
                <c:pt idx="32">
                  <c:v>0.12677337499999999</c:v>
                </c:pt>
                <c:pt idx="33">
                  <c:v>0.12821725</c:v>
                </c:pt>
                <c:pt idx="34">
                  <c:v>0.12959075</c:v>
                </c:pt>
                <c:pt idx="35">
                  <c:v>0.13087037499999998</c:v>
                </c:pt>
                <c:pt idx="36">
                  <c:v>0.13164062500000001</c:v>
                </c:pt>
                <c:pt idx="37">
                  <c:v>0.131329375</c:v>
                </c:pt>
                <c:pt idx="38">
                  <c:v>0.12960975000000002</c:v>
                </c:pt>
                <c:pt idx="39">
                  <c:v>0.12660637499999999</c:v>
                </c:pt>
                <c:pt idx="40">
                  <c:v>0.12260225</c:v>
                </c:pt>
                <c:pt idx="41">
                  <c:v>0.11764887499999999</c:v>
                </c:pt>
                <c:pt idx="42">
                  <c:v>0.11182300000000001</c:v>
                </c:pt>
                <c:pt idx="43">
                  <c:v>0.10556037500000001</c:v>
                </c:pt>
                <c:pt idx="44">
                  <c:v>9.959937499999999E-2</c:v>
                </c:pt>
                <c:pt idx="45">
                  <c:v>9.4435750000000013E-2</c:v>
                </c:pt>
                <c:pt idx="46">
                  <c:v>9.0133000000000005E-2</c:v>
                </c:pt>
                <c:pt idx="47">
                  <c:v>8.6535250000000008E-2</c:v>
                </c:pt>
                <c:pt idx="48">
                  <c:v>8.3544375000000004E-2</c:v>
                </c:pt>
                <c:pt idx="49">
                  <c:v>8.1120500000000012E-2</c:v>
                </c:pt>
                <c:pt idx="50">
                  <c:v>7.9232125E-2</c:v>
                </c:pt>
                <c:pt idx="51">
                  <c:v>7.7830250000000017E-2</c:v>
                </c:pt>
                <c:pt idx="52">
                  <c:v>7.6722125000000002E-2</c:v>
                </c:pt>
                <c:pt idx="53">
                  <c:v>7.560349999999999E-2</c:v>
                </c:pt>
                <c:pt idx="54">
                  <c:v>7.4129875000000012E-2</c:v>
                </c:pt>
                <c:pt idx="55">
                  <c:v>7.2067249999999999E-2</c:v>
                </c:pt>
                <c:pt idx="56">
                  <c:v>6.9432999999999995E-2</c:v>
                </c:pt>
                <c:pt idx="57">
                  <c:v>6.6502499999999992E-2</c:v>
                </c:pt>
                <c:pt idx="58">
                  <c:v>6.3628374999999987E-2</c:v>
                </c:pt>
                <c:pt idx="59">
                  <c:v>6.10985E-2</c:v>
                </c:pt>
                <c:pt idx="60">
                  <c:v>5.9089500000000003E-2</c:v>
                </c:pt>
                <c:pt idx="61">
                  <c:v>5.7693500000000002E-2</c:v>
                </c:pt>
                <c:pt idx="62">
                  <c:v>5.6882624999999999E-2</c:v>
                </c:pt>
                <c:pt idx="63">
                  <c:v>5.6483124999999995E-2</c:v>
                </c:pt>
                <c:pt idx="64">
                  <c:v>5.6084250000000002E-2</c:v>
                </c:pt>
                <c:pt idx="65">
                  <c:v>5.5217000000000002E-2</c:v>
                </c:pt>
                <c:pt idx="66">
                  <c:v>5.3670374999999999E-2</c:v>
                </c:pt>
                <c:pt idx="67">
                  <c:v>5.1603125E-2</c:v>
                </c:pt>
                <c:pt idx="68">
                  <c:v>4.9282875000000004E-2</c:v>
                </c:pt>
                <c:pt idx="69">
                  <c:v>4.6997875000000001E-2</c:v>
                </c:pt>
                <c:pt idx="70">
                  <c:v>4.5036875000000004E-2</c:v>
                </c:pt>
                <c:pt idx="71">
                  <c:v>4.3471124999999999E-2</c:v>
                </c:pt>
                <c:pt idx="72">
                  <c:v>4.1989249999999999E-2</c:v>
                </c:pt>
                <c:pt idx="73">
                  <c:v>4.0322249999999997E-2</c:v>
                </c:pt>
                <c:pt idx="74">
                  <c:v>3.8520499999999999E-2</c:v>
                </c:pt>
                <c:pt idx="75">
                  <c:v>3.6819124999999994E-2</c:v>
                </c:pt>
                <c:pt idx="76">
                  <c:v>3.5375500000000004E-2</c:v>
                </c:pt>
                <c:pt idx="77">
                  <c:v>3.4324500000000001E-2</c:v>
                </c:pt>
                <c:pt idx="78">
                  <c:v>3.3754000000000006E-2</c:v>
                </c:pt>
                <c:pt idx="79">
                  <c:v>3.3659874999999999E-2</c:v>
                </c:pt>
                <c:pt idx="80">
                  <c:v>3.4016624999999995E-2</c:v>
                </c:pt>
                <c:pt idx="81">
                  <c:v>3.4827124999999994E-2</c:v>
                </c:pt>
                <c:pt idx="82">
                  <c:v>3.6230875000000003E-2</c:v>
                </c:pt>
                <c:pt idx="83">
                  <c:v>3.8822000000000002E-2</c:v>
                </c:pt>
                <c:pt idx="84">
                  <c:v>4.4035124999999994E-2</c:v>
                </c:pt>
                <c:pt idx="85">
                  <c:v>5.3714375000000002E-2</c:v>
                </c:pt>
                <c:pt idx="86">
                  <c:v>6.9155750000000002E-2</c:v>
                </c:pt>
                <c:pt idx="87">
                  <c:v>9.0137750000000003E-2</c:v>
                </c:pt>
                <c:pt idx="88">
                  <c:v>0.1146365</c:v>
                </c:pt>
                <c:pt idx="89">
                  <c:v>0.13993725000000001</c:v>
                </c:pt>
                <c:pt idx="90">
                  <c:v>0.16421512500000002</c:v>
                </c:pt>
                <c:pt idx="91">
                  <c:v>0.187096875</c:v>
                </c:pt>
                <c:pt idx="92">
                  <c:v>0.2089165</c:v>
                </c:pt>
                <c:pt idx="93">
                  <c:v>0.22982112500000001</c:v>
                </c:pt>
                <c:pt idx="94">
                  <c:v>0.24974412500000001</c:v>
                </c:pt>
                <c:pt idx="95">
                  <c:v>0.26846287499999999</c:v>
                </c:pt>
                <c:pt idx="96">
                  <c:v>0.28577762500000004</c:v>
                </c:pt>
                <c:pt idx="97">
                  <c:v>0.30161212500000001</c:v>
                </c:pt>
                <c:pt idx="98">
                  <c:v>0.315744625</c:v>
                </c:pt>
                <c:pt idx="99">
                  <c:v>0.32796924999999999</c:v>
                </c:pt>
                <c:pt idx="100">
                  <c:v>0.33831275</c:v>
                </c:pt>
                <c:pt idx="101">
                  <c:v>0.34691100000000002</c:v>
                </c:pt>
                <c:pt idx="102">
                  <c:v>0.35370950000000001</c:v>
                </c:pt>
                <c:pt idx="103">
                  <c:v>0.35876425000000001</c:v>
                </c:pt>
                <c:pt idx="104">
                  <c:v>0.36254249999999999</c:v>
                </c:pt>
                <c:pt idx="105">
                  <c:v>0.36540249999999996</c:v>
                </c:pt>
                <c:pt idx="106">
                  <c:v>0.36757724999999997</c:v>
                </c:pt>
                <c:pt idx="107">
                  <c:v>0.3693805</c:v>
                </c:pt>
                <c:pt idx="108">
                  <c:v>0.37081762499999998</c:v>
                </c:pt>
                <c:pt idx="109">
                  <c:v>0.37175737500000006</c:v>
                </c:pt>
                <c:pt idx="110">
                  <c:v>0.37255550000000004</c:v>
                </c:pt>
                <c:pt idx="111">
                  <c:v>0.37335912500000001</c:v>
                </c:pt>
                <c:pt idx="112">
                  <c:v>0.37395287500000002</c:v>
                </c:pt>
                <c:pt idx="113">
                  <c:v>0.37427549999999998</c:v>
                </c:pt>
                <c:pt idx="114">
                  <c:v>0.37444325000000001</c:v>
                </c:pt>
                <c:pt idx="115">
                  <c:v>0.37422925000000001</c:v>
                </c:pt>
                <c:pt idx="116">
                  <c:v>0.37361549999999999</c:v>
                </c:pt>
                <c:pt idx="117">
                  <c:v>0.37287950000000003</c:v>
                </c:pt>
                <c:pt idx="118">
                  <c:v>0.37206624999999999</c:v>
                </c:pt>
                <c:pt idx="119">
                  <c:v>0.37114987499999996</c:v>
                </c:pt>
                <c:pt idx="120">
                  <c:v>0.37009662499999996</c:v>
                </c:pt>
                <c:pt idx="121">
                  <c:v>0.36883862499999998</c:v>
                </c:pt>
                <c:pt idx="122">
                  <c:v>0.36746075</c:v>
                </c:pt>
                <c:pt idx="123">
                  <c:v>0.36637149999999996</c:v>
                </c:pt>
                <c:pt idx="124">
                  <c:v>0.36572312500000004</c:v>
                </c:pt>
                <c:pt idx="125">
                  <c:v>0.36535562500000002</c:v>
                </c:pt>
                <c:pt idx="126">
                  <c:v>0.36472949999999998</c:v>
                </c:pt>
                <c:pt idx="127">
                  <c:v>0.363895625</c:v>
                </c:pt>
                <c:pt idx="128">
                  <c:v>0.36310437500000003</c:v>
                </c:pt>
                <c:pt idx="129">
                  <c:v>0.36253974999999999</c:v>
                </c:pt>
                <c:pt idx="130">
                  <c:v>0.36198712499999997</c:v>
                </c:pt>
                <c:pt idx="131">
                  <c:v>0.36153562499999997</c:v>
                </c:pt>
                <c:pt idx="132">
                  <c:v>0.36130087499999997</c:v>
                </c:pt>
                <c:pt idx="133">
                  <c:v>0.36137762499999998</c:v>
                </c:pt>
                <c:pt idx="134">
                  <c:v>0.36151750000000005</c:v>
                </c:pt>
                <c:pt idx="135">
                  <c:v>0.36185287499999996</c:v>
                </c:pt>
                <c:pt idx="136">
                  <c:v>0.36232687500000005</c:v>
                </c:pt>
                <c:pt idx="137">
                  <c:v>0.36300250000000001</c:v>
                </c:pt>
                <c:pt idx="138">
                  <c:v>0.36376174999999999</c:v>
                </c:pt>
                <c:pt idx="139">
                  <c:v>0.3643438749999999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24B1-4701-9C3E-F738DACE260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59906399"/>
        <c:axId val="609355391"/>
      </c:scatterChart>
      <c:valAx>
        <c:axId val="1859906399"/>
        <c:scaling>
          <c:orientation val="minMax"/>
          <c:max val="850"/>
          <c:min val="45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Wavelength [nm]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09355391"/>
        <c:crosses val="autoZero"/>
        <c:crossBetween val="midCat"/>
      </c:valAx>
      <c:valAx>
        <c:axId val="609355391"/>
        <c:scaling>
          <c:orientation val="minMax"/>
          <c:max val="0.4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Reflectance [%/100]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59906399"/>
        <c:crosses val="autoZero"/>
        <c:crossBetween val="midCat"/>
        <c:majorUnit val="0.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880565604975054"/>
          <c:y val="5.2681992337164751E-2"/>
          <c:w val="0.72903218178808726"/>
          <c:h val="0.73557599481099345"/>
        </c:manualLayout>
      </c:layout>
      <c:scatterChart>
        <c:scatterStyle val="lineMarker"/>
        <c:varyColors val="0"/>
        <c:ser>
          <c:idx val="0"/>
          <c:order val="0"/>
          <c:tx>
            <c:strRef>
              <c:f>'Correlation per genotype'!$F$3</c:f>
              <c:strCache>
                <c:ptCount val="1"/>
                <c:pt idx="0">
                  <c:v>No. of conidia per lesion area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square"/>
            <c:size val="5"/>
            <c:spPr>
              <a:noFill/>
              <a:ln w="12700">
                <a:solidFill>
                  <a:schemeClr val="tx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5.0708779645787523E-2"/>
                  <c:y val="-2.9148942589072916E-2"/>
                </c:manualLayout>
              </c:layout>
              <c:numFmt formatCode="#,##0.000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200" b="0" i="0" u="none" strike="noStrike" kern="1200" baseline="0">
                      <a:solidFill>
                        <a:sysClr val="windowText" lastClr="000000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</c:trendlineLbl>
          </c:trendline>
          <c:xVal>
            <c:numRef>
              <c:f>'Correlation per genotype'!$D$4:$D$11</c:f>
              <c:numCache>
                <c:formatCode>General</c:formatCode>
                <c:ptCount val="8"/>
                <c:pt idx="0">
                  <c:v>9.9876570000000271</c:v>
                </c:pt>
                <c:pt idx="1">
                  <c:v>12.53045999999998</c:v>
                </c:pt>
                <c:pt idx="2">
                  <c:v>9.7414430000000003</c:v>
                </c:pt>
                <c:pt idx="3">
                  <c:v>11.620011000000005</c:v>
                </c:pt>
                <c:pt idx="4">
                  <c:v>12.457256999999998</c:v>
                </c:pt>
                <c:pt idx="5">
                  <c:v>13.585542</c:v>
                </c:pt>
                <c:pt idx="6">
                  <c:v>14.259430999999974</c:v>
                </c:pt>
                <c:pt idx="7">
                  <c:v>9.0177570000000102</c:v>
                </c:pt>
              </c:numCache>
            </c:numRef>
          </c:xVal>
          <c:yVal>
            <c:numRef>
              <c:f>'Correlation per genotype'!$F$4:$F$11</c:f>
              <c:numCache>
                <c:formatCode>General</c:formatCode>
                <c:ptCount val="8"/>
                <c:pt idx="0">
                  <c:v>2031.25</c:v>
                </c:pt>
                <c:pt idx="1">
                  <c:v>1875</c:v>
                </c:pt>
                <c:pt idx="2">
                  <c:v>1093.75</c:v>
                </c:pt>
                <c:pt idx="3">
                  <c:v>1750</c:v>
                </c:pt>
                <c:pt idx="4">
                  <c:v>1944.4444444444443</c:v>
                </c:pt>
                <c:pt idx="5">
                  <c:v>3035.7142857142858</c:v>
                </c:pt>
                <c:pt idx="6">
                  <c:v>1964.2857142857142</c:v>
                </c:pt>
                <c:pt idx="7">
                  <c:v>833.3333333333333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9580-4F54-852D-A0358725A4C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61465600"/>
        <c:axId val="261467520"/>
      </c:scatterChart>
      <c:valAx>
        <c:axId val="261465600"/>
        <c:scaling>
          <c:orientation val="minMax"/>
          <c:max val="25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/>
                  <a:t>Area under difference spectrum  [%/100 . nm]</a:t>
                </a:r>
                <a:endParaRPr lang="en-US"/>
              </a:p>
            </c:rich>
          </c:tx>
          <c:layout>
            <c:manualLayout>
              <c:xMode val="edge"/>
              <c:yMode val="edge"/>
              <c:x val="0.19003688728098178"/>
              <c:y val="0.882662835249042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61467520"/>
        <c:crosses val="autoZero"/>
        <c:crossBetween val="midCat"/>
        <c:majorUnit val="5"/>
      </c:valAx>
      <c:valAx>
        <c:axId val="261467520"/>
        <c:scaling>
          <c:orientation val="minMax"/>
          <c:max val="400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 dirty="0" err="1"/>
                  <a:t>No</a:t>
                </a:r>
                <a:r>
                  <a:rPr lang="de-DE" dirty="0"/>
                  <a:t>. </a:t>
                </a:r>
                <a:r>
                  <a:rPr lang="de-DE" dirty="0" err="1"/>
                  <a:t>conidia</a:t>
                </a:r>
                <a:r>
                  <a:rPr lang="de-DE" dirty="0"/>
                  <a:t> per </a:t>
                </a:r>
                <a:r>
                  <a:rPr lang="de-DE" dirty="0" err="1"/>
                  <a:t>lesion</a:t>
                </a:r>
                <a:r>
                  <a:rPr lang="de-DE" dirty="0"/>
                  <a:t> </a:t>
                </a:r>
                <a:r>
                  <a:rPr lang="de-DE" dirty="0" err="1"/>
                  <a:t>area</a:t>
                </a:r>
                <a:r>
                  <a:rPr lang="de-DE" dirty="0"/>
                  <a:t>  [mm-</a:t>
                </a:r>
                <a:r>
                  <a:rPr lang="de-DE" baseline="30000" dirty="0"/>
                  <a:t>2</a:t>
                </a:r>
                <a:r>
                  <a:rPr lang="de-DE" dirty="0"/>
                  <a:t>]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#,##0" sourceLinked="0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6146560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3175">
      <a:solidFill>
        <a:schemeClr val="tx1"/>
      </a:solidFill>
    </a:ln>
    <a:effectLst/>
  </c:spPr>
  <c:txPr>
    <a:bodyPr/>
    <a:lstStyle/>
    <a:p>
      <a:pPr>
        <a:defRPr sz="12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Correlation per genotype'!$F$20</c:f>
              <c:strCache>
                <c:ptCount val="1"/>
                <c:pt idx="0">
                  <c:v>No. of conidia per lesion area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square"/>
            <c:size val="5"/>
            <c:spPr>
              <a:noFill/>
              <a:ln w="12700">
                <a:solidFill>
                  <a:schemeClr val="tx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1.1438899529450711E-2"/>
                  <c:y val="-0.23104353335143452"/>
                </c:manualLayout>
              </c:layout>
              <c:numFmt formatCode="#,##0.000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200" b="0" i="0" u="none" strike="noStrike" kern="1200" baseline="0">
                      <a:solidFill>
                        <a:schemeClr val="tx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</c:trendlineLbl>
          </c:trendline>
          <c:trendline>
            <c:spPr>
              <a:ln w="19050" cap="rnd">
                <a:solidFill>
                  <a:schemeClr val="tx1"/>
                </a:solidFill>
                <a:prstDash val="sysDot"/>
              </a:ln>
              <a:effectLst/>
            </c:spPr>
            <c:trendlineType val="power"/>
            <c:dispRSqr val="1"/>
            <c:dispEq val="1"/>
            <c:trendlineLbl>
              <c:layout>
                <c:manualLayout>
                  <c:x val="0.29941635802469135"/>
                  <c:y val="0.12953321567562676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200" b="0" i="0" u="none" strike="noStrike" kern="1200" baseline="0">
                      <a:solidFill>
                        <a:schemeClr val="tx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</c:trendlineLbl>
          </c:trendline>
          <c:xVal>
            <c:numRef>
              <c:f>'Correlation per genotype'!$D$21:$D$28</c:f>
              <c:numCache>
                <c:formatCode>General</c:formatCode>
                <c:ptCount val="8"/>
                <c:pt idx="0">
                  <c:v>4.5667830000000151</c:v>
                </c:pt>
                <c:pt idx="1">
                  <c:v>6.1891310000000068</c:v>
                </c:pt>
                <c:pt idx="2">
                  <c:v>6.2370510000000046</c:v>
                </c:pt>
                <c:pt idx="3">
                  <c:v>14.777808000000014</c:v>
                </c:pt>
                <c:pt idx="4">
                  <c:v>12.467093000000002</c:v>
                </c:pt>
                <c:pt idx="5">
                  <c:v>2.1453170000000092</c:v>
                </c:pt>
                <c:pt idx="6">
                  <c:v>8.9180520000000136</c:v>
                </c:pt>
                <c:pt idx="7">
                  <c:v>8.8514039999999987</c:v>
                </c:pt>
              </c:numCache>
            </c:numRef>
          </c:xVal>
          <c:yVal>
            <c:numRef>
              <c:f>'Correlation per genotype'!$F$21:$F$28</c:f>
              <c:numCache>
                <c:formatCode>General</c:formatCode>
                <c:ptCount val="8"/>
                <c:pt idx="0">
                  <c:v>625</c:v>
                </c:pt>
                <c:pt idx="1">
                  <c:v>1250</c:v>
                </c:pt>
                <c:pt idx="2">
                  <c:v>833.33333333333337</c:v>
                </c:pt>
                <c:pt idx="3">
                  <c:v>1406.25</c:v>
                </c:pt>
                <c:pt idx="4">
                  <c:v>1145.8333333333333</c:v>
                </c:pt>
                <c:pt idx="5">
                  <c:v>625</c:v>
                </c:pt>
                <c:pt idx="6">
                  <c:v>1041.6666666666667</c:v>
                </c:pt>
                <c:pt idx="7">
                  <c:v>125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43AF-4E6A-81B3-D152BFD0ACF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61222784"/>
        <c:axId val="261224704"/>
      </c:scatterChart>
      <c:valAx>
        <c:axId val="261222784"/>
        <c:scaling>
          <c:orientation val="minMax"/>
          <c:max val="25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/>
                  <a:t>Area under difference spectrum  [%/100 . nm]</a:t>
                </a:r>
                <a:endParaRPr lang="en-US"/>
              </a:p>
            </c:rich>
          </c:tx>
          <c:layout>
            <c:manualLayout>
              <c:xMode val="edge"/>
              <c:yMode val="edge"/>
              <c:x val="0.20135135135135135"/>
              <c:y val="0.8821925815307567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61224704"/>
        <c:crosses val="autoZero"/>
        <c:crossBetween val="midCat"/>
      </c:valAx>
      <c:valAx>
        <c:axId val="261224704"/>
        <c:scaling>
          <c:orientation val="minMax"/>
          <c:max val="400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 dirty="0" err="1"/>
                  <a:t>No</a:t>
                </a:r>
                <a:r>
                  <a:rPr lang="de-DE" dirty="0"/>
                  <a:t>. </a:t>
                </a:r>
                <a:r>
                  <a:rPr lang="de-DE" dirty="0" err="1"/>
                  <a:t>conidia</a:t>
                </a:r>
                <a:r>
                  <a:rPr lang="de-DE" dirty="0"/>
                  <a:t> per </a:t>
                </a:r>
                <a:r>
                  <a:rPr lang="de-DE" dirty="0" err="1"/>
                  <a:t>lesion</a:t>
                </a:r>
                <a:r>
                  <a:rPr lang="de-DE" dirty="0"/>
                  <a:t> </a:t>
                </a:r>
                <a:r>
                  <a:rPr lang="de-DE" dirty="0" err="1"/>
                  <a:t>area</a:t>
                </a:r>
                <a:r>
                  <a:rPr lang="de-DE" dirty="0"/>
                  <a:t>  [mm-</a:t>
                </a:r>
                <a:r>
                  <a:rPr lang="de-DE" baseline="30000" dirty="0"/>
                  <a:t>2</a:t>
                </a:r>
                <a:r>
                  <a:rPr lang="de-DE" dirty="0"/>
                  <a:t>]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#,##0" sourceLinked="0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6122278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3175">
      <a:solidFill>
        <a:schemeClr val="tx1"/>
      </a:solidFill>
    </a:ln>
    <a:effectLst/>
  </c:spPr>
  <c:txPr>
    <a:bodyPr/>
    <a:lstStyle/>
    <a:p>
      <a:pPr>
        <a:defRPr sz="12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306365420538648"/>
          <c:y val="5.2681992337164751E-2"/>
          <c:w val="0.72685766475136548"/>
          <c:h val="0.76302681992337162"/>
        </c:manualLayout>
      </c:layout>
      <c:scatterChart>
        <c:scatterStyle val="lineMarker"/>
        <c:varyColors val="0"/>
        <c:ser>
          <c:idx val="0"/>
          <c:order val="0"/>
          <c:tx>
            <c:strRef>
              <c:f>'Correlation per genotype'!$F$38</c:f>
              <c:strCache>
                <c:ptCount val="1"/>
                <c:pt idx="0">
                  <c:v>No. of conidia per lesion area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square"/>
            <c:size val="5"/>
            <c:spPr>
              <a:noFill/>
              <a:ln w="12700">
                <a:solidFill>
                  <a:schemeClr val="tx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9050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24346935518195362"/>
                  <c:y val="0.10946050924668899"/>
                </c:manualLayout>
              </c:layout>
              <c:numFmt formatCode="#,##0.000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200" b="0" i="0" u="none" strike="noStrike" kern="1200" baseline="0">
                      <a:solidFill>
                        <a:sysClr val="windowText" lastClr="000000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</c:trendlineLbl>
          </c:trendline>
          <c:xVal>
            <c:numRef>
              <c:f>'Correlation per genotype'!$D$39:$D$46</c:f>
              <c:numCache>
                <c:formatCode>General</c:formatCode>
                <c:ptCount val="8"/>
                <c:pt idx="0">
                  <c:v>16.779368000000009</c:v>
                </c:pt>
                <c:pt idx="1">
                  <c:v>17.790261000000005</c:v>
                </c:pt>
                <c:pt idx="2">
                  <c:v>15.15408099999998</c:v>
                </c:pt>
                <c:pt idx="3">
                  <c:v>23.190562000000014</c:v>
                </c:pt>
                <c:pt idx="4">
                  <c:v>15.799911000000005</c:v>
                </c:pt>
                <c:pt idx="5">
                  <c:v>11.743462000000015</c:v>
                </c:pt>
                <c:pt idx="6">
                  <c:v>8.8528110000000133</c:v>
                </c:pt>
                <c:pt idx="7">
                  <c:v>19.803377000000001</c:v>
                </c:pt>
              </c:numCache>
            </c:numRef>
          </c:xVal>
          <c:yVal>
            <c:numRef>
              <c:f>'Correlation per genotype'!$F$39:$F$46</c:f>
              <c:numCache>
                <c:formatCode>General</c:formatCode>
                <c:ptCount val="8"/>
                <c:pt idx="0">
                  <c:v>2968.75</c:v>
                </c:pt>
                <c:pt idx="1">
                  <c:v>2500</c:v>
                </c:pt>
                <c:pt idx="2">
                  <c:v>2750</c:v>
                </c:pt>
                <c:pt idx="3">
                  <c:v>3541.6666666666665</c:v>
                </c:pt>
                <c:pt idx="4">
                  <c:v>1916.6666666666667</c:v>
                </c:pt>
                <c:pt idx="5">
                  <c:v>1130.952380952381</c:v>
                </c:pt>
                <c:pt idx="6">
                  <c:v>1562.5</c:v>
                </c:pt>
                <c:pt idx="7">
                  <c:v>2187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0BDD-4820-BD25-70ABC6E0C90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61374720"/>
        <c:axId val="261376640"/>
      </c:scatterChart>
      <c:valAx>
        <c:axId val="261374720"/>
        <c:scaling>
          <c:orientation val="minMax"/>
          <c:max val="25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/>
                  <a:t>Area under difference spectrum  [%/100 . nm]</a:t>
                </a:r>
                <a:endParaRPr lang="en-US"/>
              </a:p>
            </c:rich>
          </c:tx>
          <c:layout>
            <c:manualLayout>
              <c:xMode val="edge"/>
              <c:yMode val="edge"/>
              <c:x val="0.18770601309971388"/>
              <c:y val="0.9090038314176245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61376640"/>
        <c:crosses val="autoZero"/>
        <c:crossBetween val="midCat"/>
        <c:majorUnit val="5"/>
        <c:minorUnit val="1"/>
      </c:valAx>
      <c:valAx>
        <c:axId val="26137664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 dirty="0" err="1"/>
                  <a:t>No</a:t>
                </a:r>
                <a:r>
                  <a:rPr lang="de-DE" dirty="0"/>
                  <a:t>. </a:t>
                </a:r>
                <a:r>
                  <a:rPr lang="de-DE" dirty="0" err="1"/>
                  <a:t>conidia</a:t>
                </a:r>
                <a:r>
                  <a:rPr lang="de-DE" dirty="0"/>
                  <a:t> per </a:t>
                </a:r>
                <a:r>
                  <a:rPr lang="de-DE" dirty="0" err="1"/>
                  <a:t>lesion</a:t>
                </a:r>
                <a:r>
                  <a:rPr lang="de-DE" dirty="0"/>
                  <a:t> </a:t>
                </a:r>
                <a:r>
                  <a:rPr lang="de-DE" dirty="0" err="1"/>
                  <a:t>area</a:t>
                </a:r>
                <a:r>
                  <a:rPr lang="de-DE" dirty="0"/>
                  <a:t>  [mm-</a:t>
                </a:r>
                <a:r>
                  <a:rPr lang="de-DE" baseline="30000" dirty="0"/>
                  <a:t>2</a:t>
                </a:r>
                <a:r>
                  <a:rPr lang="de-DE" dirty="0"/>
                  <a:t>]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#,##0" sourceLinked="0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6137472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3175">
      <a:solidFill>
        <a:schemeClr val="tx1"/>
      </a:solidFill>
    </a:ln>
    <a:effectLst/>
  </c:spPr>
  <c:txPr>
    <a:bodyPr/>
    <a:lstStyle/>
    <a:p>
      <a:pPr>
        <a:defRPr sz="12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F0A4E-C752-47A4-9B23-FFB8ABCB429F}" type="datetimeFigureOut">
              <a:rPr lang="de-DE" smtClean="0"/>
              <a:t>20.05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786EFD-1E59-4AD0-A0DC-44B24892ADC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028712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F0A4E-C752-47A4-9B23-FFB8ABCB429F}" type="datetimeFigureOut">
              <a:rPr lang="de-DE" smtClean="0"/>
              <a:t>20.05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786EFD-1E59-4AD0-A0DC-44B24892ADC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211972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F0A4E-C752-47A4-9B23-FFB8ABCB429F}" type="datetimeFigureOut">
              <a:rPr lang="de-DE" smtClean="0"/>
              <a:t>20.05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786EFD-1E59-4AD0-A0DC-44B24892ADC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931298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F0A4E-C752-47A4-9B23-FFB8ABCB429F}" type="datetimeFigureOut">
              <a:rPr lang="de-DE" smtClean="0"/>
              <a:t>20.05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786EFD-1E59-4AD0-A0DC-44B24892ADC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615608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F0A4E-C752-47A4-9B23-FFB8ABCB429F}" type="datetimeFigureOut">
              <a:rPr lang="de-DE" smtClean="0"/>
              <a:t>20.05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786EFD-1E59-4AD0-A0DC-44B24892ADC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12046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F0A4E-C752-47A4-9B23-FFB8ABCB429F}" type="datetimeFigureOut">
              <a:rPr lang="de-DE" smtClean="0"/>
              <a:t>20.05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786EFD-1E59-4AD0-A0DC-44B24892ADC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539304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F0A4E-C752-47A4-9B23-FFB8ABCB429F}" type="datetimeFigureOut">
              <a:rPr lang="de-DE" smtClean="0"/>
              <a:t>20.05.2024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786EFD-1E59-4AD0-A0DC-44B24892ADC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473384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F0A4E-C752-47A4-9B23-FFB8ABCB429F}" type="datetimeFigureOut">
              <a:rPr lang="de-DE" smtClean="0"/>
              <a:t>20.05.2024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786EFD-1E59-4AD0-A0DC-44B24892ADC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0973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F0A4E-C752-47A4-9B23-FFB8ABCB429F}" type="datetimeFigureOut">
              <a:rPr lang="de-DE" smtClean="0"/>
              <a:t>20.05.2024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786EFD-1E59-4AD0-A0DC-44B24892ADC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63268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F0A4E-C752-47A4-9B23-FFB8ABCB429F}" type="datetimeFigureOut">
              <a:rPr lang="de-DE" smtClean="0"/>
              <a:t>20.05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786EFD-1E59-4AD0-A0DC-44B24892ADC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475812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F0A4E-C752-47A4-9B23-FFB8ABCB429F}" type="datetimeFigureOut">
              <a:rPr lang="de-DE" smtClean="0"/>
              <a:t>20.05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786EFD-1E59-4AD0-A0DC-44B24892ADC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008609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3F0A4E-C752-47A4-9B23-FFB8ABCB429F}" type="datetimeFigureOut">
              <a:rPr lang="de-DE" smtClean="0"/>
              <a:t>20.05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786EFD-1E59-4AD0-A0DC-44B24892ADC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454434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3.xml"/><Relationship Id="rId3" Type="http://schemas.openxmlformats.org/officeDocument/2006/relationships/chart" Target="../charts/chart8.xml"/><Relationship Id="rId7" Type="http://schemas.openxmlformats.org/officeDocument/2006/relationships/chart" Target="../charts/chart12.xml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11.xml"/><Relationship Id="rId5" Type="http://schemas.openxmlformats.org/officeDocument/2006/relationships/chart" Target="../charts/chart10.xml"/><Relationship Id="rId4" Type="http://schemas.openxmlformats.org/officeDocument/2006/relationships/chart" Target="../charts/chart9.xml"/><Relationship Id="rId9" Type="http://schemas.openxmlformats.org/officeDocument/2006/relationships/chart" Target="../charts/chart1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AC9DA5D3-5E9D-7106-A898-D7D6CC17B64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76138889"/>
              </p:ext>
            </p:extLst>
          </p:nvPr>
        </p:nvGraphicFramePr>
        <p:xfrm>
          <a:off x="932906" y="5009949"/>
          <a:ext cx="3840480" cy="29260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9632FDF5-EB87-0181-78FA-C1A9E199640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70844655"/>
              </p:ext>
            </p:extLst>
          </p:nvPr>
        </p:nvGraphicFramePr>
        <p:xfrm>
          <a:off x="4787566" y="5009949"/>
          <a:ext cx="3840480" cy="29260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8D8AED59-4406-5093-BA1D-09AAFD3EE77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16039534"/>
              </p:ext>
            </p:extLst>
          </p:nvPr>
        </p:nvGraphicFramePr>
        <p:xfrm>
          <a:off x="932906" y="2205668"/>
          <a:ext cx="3840480" cy="29260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id="{6D3E2990-3380-360C-B377-B7E1CC8A389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29355034"/>
              </p:ext>
            </p:extLst>
          </p:nvPr>
        </p:nvGraphicFramePr>
        <p:xfrm>
          <a:off x="4787566" y="2205668"/>
          <a:ext cx="3840480" cy="29260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02441DB9-0DDB-CDFF-E2C4-B0545F3CA239}"/>
              </a:ext>
            </a:extLst>
          </p:cNvPr>
          <p:cNvSpPr txBox="1"/>
          <p:nvPr/>
        </p:nvSpPr>
        <p:spPr>
          <a:xfrm>
            <a:off x="407864" y="3329440"/>
            <a:ext cx="7680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Guy 11 </a:t>
            </a:r>
            <a:endParaRPr lang="en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0940062-722C-062F-3A21-CAE6D73C6F4C}"/>
              </a:ext>
            </a:extLst>
          </p:cNvPr>
          <p:cNvSpPr txBox="1"/>
          <p:nvPr/>
        </p:nvSpPr>
        <p:spPr>
          <a:xfrm>
            <a:off x="407864" y="6143660"/>
            <a:ext cx="7680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Li1497</a:t>
            </a:r>
            <a:endParaRPr lang="en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80BCF65-6281-6DA9-ACA7-BFBAB0905D97}"/>
              </a:ext>
            </a:extLst>
          </p:cNvPr>
          <p:cNvSpPr txBox="1"/>
          <p:nvPr/>
        </p:nvSpPr>
        <p:spPr>
          <a:xfrm>
            <a:off x="1580528" y="2007425"/>
            <a:ext cx="25452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7 days post inoculation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FD01786-3F8C-CACE-8719-565F4014FAD0}"/>
              </a:ext>
            </a:extLst>
          </p:cNvPr>
          <p:cNvSpPr txBox="1"/>
          <p:nvPr/>
        </p:nvSpPr>
        <p:spPr>
          <a:xfrm>
            <a:off x="5435188" y="2007425"/>
            <a:ext cx="25452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9 days post inoculation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419A6EB-BC4F-A024-5F4B-2ED7B3E71D8E}"/>
              </a:ext>
            </a:extLst>
          </p:cNvPr>
          <p:cNvSpPr txBox="1"/>
          <p:nvPr/>
        </p:nvSpPr>
        <p:spPr>
          <a:xfrm>
            <a:off x="1577872" y="8013554"/>
            <a:ext cx="1993026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just" defTabSz="914400" rtl="0" eaLnBrk="1" fontAlgn="base" latinLnBrk="0" hangingPunct="1"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1793875" algn="r"/>
                <a:tab pos="1881188" algn="r"/>
              </a:tabLst>
            </a:pPr>
            <a:r>
              <a:rPr lang="en-US" altLang="en-US" sz="1400" dirty="0">
                <a:solidFill>
                  <a:srgbClr val="000000"/>
                </a:solidFill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H</a:t>
            </a:r>
            <a:r>
              <a:rPr kumimoji="0" lang="en-US" altLang="en-US" sz="14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ealthy (green) tissue         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52CB6CF7-957C-6C0E-1A54-E034909E6DF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09924" y="8141711"/>
            <a:ext cx="180000" cy="36000"/>
          </a:xfrm>
          <a:prstGeom prst="rect">
            <a:avLst/>
          </a:prstGeom>
          <a:solidFill>
            <a:srgbClr val="01E106"/>
          </a:solidFill>
          <a:ln>
            <a:solidFill>
              <a:srgbClr val="00FF00"/>
            </a:solidFill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algn="just"/>
            <a:endParaRPr lang="en-US" sz="1400" dirty="0">
              <a:ln>
                <a:solidFill>
                  <a:schemeClr val="bg1"/>
                </a:solidFill>
              </a:ln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D6F91132-9BA0-9380-C853-06270780D8C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31969" y="8141063"/>
            <a:ext cx="180000" cy="36000"/>
          </a:xfrm>
          <a:prstGeom prst="rec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algn="just"/>
            <a:endParaRPr lang="en-US" sz="1400" dirty="0">
              <a:ln>
                <a:solidFill>
                  <a:schemeClr val="bg1"/>
                </a:solidFill>
              </a:ln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55193619-C2DB-EF17-A3D5-24B4099C4078}"/>
              </a:ext>
            </a:extLst>
          </p:cNvPr>
          <p:cNvSpPr txBox="1"/>
          <p:nvPr/>
        </p:nvSpPr>
        <p:spPr>
          <a:xfrm>
            <a:off x="3811969" y="8020563"/>
            <a:ext cx="166001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ark brown tissue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D16406A0-3626-5877-B37F-238A9849D727}"/>
              </a:ext>
            </a:extLst>
          </p:cNvPr>
          <p:cNvSpPr txBox="1"/>
          <p:nvPr/>
        </p:nvSpPr>
        <p:spPr>
          <a:xfrm>
            <a:off x="671379" y="995513"/>
            <a:ext cx="48006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kern="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Times New Roman" panose="02020603050405020304" pitchFamily="18" charset="0"/>
                <a:ea typeface="Calibri" panose="020F0502020204030204" pitchFamily="34" charset="0"/>
              </a:rPr>
              <a:t>Additional file 1: Fig A1</a:t>
            </a:r>
            <a:endParaRPr lang="en-US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2DA13D9B-CA5B-FB12-6A5F-701291EEB465}"/>
              </a:ext>
            </a:extLst>
          </p:cNvPr>
          <p:cNvSpPr txBox="1"/>
          <p:nvPr/>
        </p:nvSpPr>
        <p:spPr>
          <a:xfrm>
            <a:off x="452846" y="125590"/>
            <a:ext cx="4800600" cy="5672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200000"/>
              </a:lnSpc>
              <a:spcBef>
                <a:spcPts val="120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Information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490612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59B3497A-0843-99BA-DFBB-6150F0F5DF6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4871993"/>
              </p:ext>
            </p:extLst>
          </p:nvPr>
        </p:nvGraphicFramePr>
        <p:xfrm>
          <a:off x="4752975" y="2943225"/>
          <a:ext cx="4572000" cy="3657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3" name="TextBox 12">
            <a:extLst>
              <a:ext uri="{FF2B5EF4-FFF2-40B4-BE49-F238E27FC236}">
                <a16:creationId xmlns:a16="http://schemas.microsoft.com/office/drawing/2014/main" id="{8C44714B-BA64-FC70-A66E-55E4EFB03CCE}"/>
              </a:ext>
            </a:extLst>
          </p:cNvPr>
          <p:cNvSpPr txBox="1"/>
          <p:nvPr/>
        </p:nvSpPr>
        <p:spPr>
          <a:xfrm>
            <a:off x="1528972" y="2666226"/>
            <a:ext cx="25452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7 days post inoculation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EF65B5C-EC2E-E21D-6365-F2CE53706049}"/>
              </a:ext>
            </a:extLst>
          </p:cNvPr>
          <p:cNvSpPr txBox="1"/>
          <p:nvPr/>
        </p:nvSpPr>
        <p:spPr>
          <a:xfrm>
            <a:off x="5983527" y="2666226"/>
            <a:ext cx="25452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9 days post inoculation</a:t>
            </a:r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153E375E-D1FB-E691-BA52-6437EFBFE3AB}"/>
              </a:ext>
            </a:extLst>
          </p:cNvPr>
          <p:cNvCxnSpPr>
            <a:cxnSpLocks/>
          </p:cNvCxnSpPr>
          <p:nvPr/>
        </p:nvCxnSpPr>
        <p:spPr>
          <a:xfrm>
            <a:off x="967319" y="6819235"/>
            <a:ext cx="340025" cy="0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496449B4-7F4C-06B4-0526-97A2362858CB}"/>
              </a:ext>
            </a:extLst>
          </p:cNvPr>
          <p:cNvCxnSpPr>
            <a:cxnSpLocks/>
          </p:cNvCxnSpPr>
          <p:nvPr/>
        </p:nvCxnSpPr>
        <p:spPr>
          <a:xfrm>
            <a:off x="2045355" y="6819235"/>
            <a:ext cx="340025" cy="0"/>
          </a:xfrm>
          <a:prstGeom prst="line">
            <a:avLst/>
          </a:prstGeom>
          <a:ln w="38100">
            <a:solidFill>
              <a:schemeClr val="accent2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F586A5ED-64F0-8C7C-C8A2-AF62135F8774}"/>
              </a:ext>
            </a:extLst>
          </p:cNvPr>
          <p:cNvSpPr txBox="1"/>
          <p:nvPr/>
        </p:nvSpPr>
        <p:spPr>
          <a:xfrm>
            <a:off x="1240805" y="6668099"/>
            <a:ext cx="7018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O 39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1E5C896-EB6E-016B-DE22-571388C64CBA}"/>
              </a:ext>
            </a:extLst>
          </p:cNvPr>
          <p:cNvSpPr txBox="1"/>
          <p:nvPr/>
        </p:nvSpPr>
        <p:spPr>
          <a:xfrm>
            <a:off x="2325211" y="6668102"/>
            <a:ext cx="11901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Nipponbare</a:t>
            </a: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1809FB7F-EC69-ACB6-7CCB-BB060D94B08C}"/>
              </a:ext>
            </a:extLst>
          </p:cNvPr>
          <p:cNvCxnSpPr>
            <a:cxnSpLocks/>
          </p:cNvCxnSpPr>
          <p:nvPr/>
        </p:nvCxnSpPr>
        <p:spPr>
          <a:xfrm>
            <a:off x="3565394" y="6819235"/>
            <a:ext cx="340025" cy="0"/>
          </a:xfrm>
          <a:prstGeom prst="line">
            <a:avLst/>
          </a:prstGeom>
          <a:ln w="38100">
            <a:solidFill>
              <a:schemeClr val="bg1">
                <a:lumMod val="6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F66DB75C-CA0D-5F4E-13AA-CEE249A18559}"/>
              </a:ext>
            </a:extLst>
          </p:cNvPr>
          <p:cNvSpPr txBox="1"/>
          <p:nvPr/>
        </p:nvSpPr>
        <p:spPr>
          <a:xfrm>
            <a:off x="3847085" y="6668099"/>
            <a:ext cx="10446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R64</a:t>
            </a:r>
          </a:p>
        </p:txBody>
      </p:sp>
      <p:graphicFrame>
        <p:nvGraphicFramePr>
          <p:cNvPr id="21" name="Chart 20">
            <a:extLst>
              <a:ext uri="{FF2B5EF4-FFF2-40B4-BE49-F238E27FC236}">
                <a16:creationId xmlns:a16="http://schemas.microsoft.com/office/drawing/2014/main" id="{C35CBD8B-DCF2-C0ED-63DD-AAC21B99E09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67839179"/>
              </p:ext>
            </p:extLst>
          </p:nvPr>
        </p:nvGraphicFramePr>
        <p:xfrm>
          <a:off x="242516" y="2943225"/>
          <a:ext cx="4572000" cy="3657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6" name="TextBox 25">
            <a:extLst>
              <a:ext uri="{FF2B5EF4-FFF2-40B4-BE49-F238E27FC236}">
                <a16:creationId xmlns:a16="http://schemas.microsoft.com/office/drawing/2014/main" id="{B19EF197-D24A-E005-7E6C-4FB3C09B3D26}"/>
              </a:ext>
            </a:extLst>
          </p:cNvPr>
          <p:cNvSpPr txBox="1"/>
          <p:nvPr/>
        </p:nvSpPr>
        <p:spPr>
          <a:xfrm>
            <a:off x="467965" y="1587801"/>
            <a:ext cx="48006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kern="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Times New Roman" panose="02020603050405020304" pitchFamily="18" charset="0"/>
                <a:ea typeface="Calibri" panose="020F0502020204030204" pitchFamily="34" charset="0"/>
              </a:rPr>
              <a:t>Additional file 2 : Fig A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2505195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>
            <a:extLst>
              <a:ext uri="{FF2B5EF4-FFF2-40B4-BE49-F238E27FC236}">
                <a16:creationId xmlns:a16="http://schemas.microsoft.com/office/drawing/2014/main" id="{5E5B6E7E-5E77-8669-9A93-29C80F0A674B}"/>
              </a:ext>
            </a:extLst>
          </p:cNvPr>
          <p:cNvGrpSpPr/>
          <p:nvPr/>
        </p:nvGrpSpPr>
        <p:grpSpPr>
          <a:xfrm>
            <a:off x="810645" y="286284"/>
            <a:ext cx="8047166" cy="12314024"/>
            <a:chOff x="810645" y="286284"/>
            <a:chExt cx="8047166" cy="12314024"/>
          </a:xfrm>
        </p:grpSpPr>
        <p:graphicFrame>
          <p:nvGraphicFramePr>
            <p:cNvPr id="2" name="Chart 2">
              <a:extLst>
                <a:ext uri="{FF2B5EF4-FFF2-40B4-BE49-F238E27FC236}">
                  <a16:creationId xmlns:a16="http://schemas.microsoft.com/office/drawing/2014/main" id="{E65E675B-DC40-E7FD-D312-749C2FC1CC59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353642340"/>
                </p:ext>
              </p:extLst>
            </p:nvPr>
          </p:nvGraphicFramePr>
          <p:xfrm>
            <a:off x="810645" y="6388822"/>
            <a:ext cx="4023360" cy="310896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3" name="Chart 2">
              <a:extLst>
                <a:ext uri="{FF2B5EF4-FFF2-40B4-BE49-F238E27FC236}">
                  <a16:creationId xmlns:a16="http://schemas.microsoft.com/office/drawing/2014/main" id="{1BE42169-4356-D738-BEFA-9F59ECCAB8FC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423086501"/>
                </p:ext>
              </p:extLst>
            </p:nvPr>
          </p:nvGraphicFramePr>
          <p:xfrm>
            <a:off x="4834451" y="6388822"/>
            <a:ext cx="4023360" cy="310896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4" name="Chart 6">
              <a:extLst>
                <a:ext uri="{FF2B5EF4-FFF2-40B4-BE49-F238E27FC236}">
                  <a16:creationId xmlns:a16="http://schemas.microsoft.com/office/drawing/2014/main" id="{86FE980E-53F2-1373-81A5-4249CB9A06B9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227394669"/>
                </p:ext>
              </p:extLst>
            </p:nvPr>
          </p:nvGraphicFramePr>
          <p:xfrm>
            <a:off x="810645" y="9491348"/>
            <a:ext cx="4023360" cy="310896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5" name="Chart 8">
              <a:extLst>
                <a:ext uri="{FF2B5EF4-FFF2-40B4-BE49-F238E27FC236}">
                  <a16:creationId xmlns:a16="http://schemas.microsoft.com/office/drawing/2014/main" id="{11E08C50-FCF4-6295-568E-4C3CE4AC0E33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83042831"/>
                </p:ext>
              </p:extLst>
            </p:nvPr>
          </p:nvGraphicFramePr>
          <p:xfrm>
            <a:off x="4834451" y="9491348"/>
            <a:ext cx="4023360" cy="310896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6" name="Textfeld 7">
              <a:extLst>
                <a:ext uri="{FF2B5EF4-FFF2-40B4-BE49-F238E27FC236}">
                  <a16:creationId xmlns:a16="http://schemas.microsoft.com/office/drawing/2014/main" id="{2592AA12-B997-1AEA-2EB2-AE7844C70798}"/>
                </a:ext>
              </a:extLst>
            </p:cNvPr>
            <p:cNvSpPr txBox="1"/>
            <p:nvPr/>
          </p:nvSpPr>
          <p:spPr>
            <a:xfrm>
              <a:off x="3481865" y="6453425"/>
              <a:ext cx="12662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CO 39 × Guy11</a:t>
              </a:r>
              <a:endParaRPr lang="en-GB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feld 8">
              <a:extLst>
                <a:ext uri="{FF2B5EF4-FFF2-40B4-BE49-F238E27FC236}">
                  <a16:creationId xmlns:a16="http://schemas.microsoft.com/office/drawing/2014/main" id="{2622D895-C616-F1B5-44D9-4E416C222CF6}"/>
                </a:ext>
              </a:extLst>
            </p:cNvPr>
            <p:cNvSpPr txBox="1"/>
            <p:nvPr/>
          </p:nvSpPr>
          <p:spPr>
            <a:xfrm>
              <a:off x="7175475" y="6453425"/>
              <a:ext cx="159191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Nipponbare × Guy11</a:t>
              </a:r>
              <a:endParaRPr lang="en-GB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feld 9">
              <a:extLst>
                <a:ext uri="{FF2B5EF4-FFF2-40B4-BE49-F238E27FC236}">
                  <a16:creationId xmlns:a16="http://schemas.microsoft.com/office/drawing/2014/main" id="{7E77BFB3-6253-D41E-7364-E7C567CFD144}"/>
                </a:ext>
              </a:extLst>
            </p:cNvPr>
            <p:cNvSpPr txBox="1"/>
            <p:nvPr/>
          </p:nvSpPr>
          <p:spPr>
            <a:xfrm>
              <a:off x="3360057" y="11645254"/>
              <a:ext cx="128272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CO 39 × Li1497</a:t>
              </a:r>
              <a:endParaRPr lang="en-GB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feld 10">
              <a:extLst>
                <a:ext uri="{FF2B5EF4-FFF2-40B4-BE49-F238E27FC236}">
                  <a16:creationId xmlns:a16="http://schemas.microsoft.com/office/drawing/2014/main" id="{FB4F1655-2429-414E-4688-9C6E37F37469}"/>
                </a:ext>
              </a:extLst>
            </p:cNvPr>
            <p:cNvSpPr txBox="1"/>
            <p:nvPr/>
          </p:nvSpPr>
          <p:spPr>
            <a:xfrm>
              <a:off x="7191148" y="9534207"/>
              <a:ext cx="160973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Nipponbare × Li1497</a:t>
              </a:r>
              <a:endParaRPr lang="en-GB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10" name="Diagramm 11">
              <a:extLst>
                <a:ext uri="{FF2B5EF4-FFF2-40B4-BE49-F238E27FC236}">
                  <a16:creationId xmlns:a16="http://schemas.microsoft.com/office/drawing/2014/main" id="{4FE5E1AC-AA17-F677-C7C6-E9289931CFE4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911030406"/>
                </p:ext>
              </p:extLst>
            </p:nvPr>
          </p:nvGraphicFramePr>
          <p:xfrm>
            <a:off x="810645" y="286284"/>
            <a:ext cx="4023360" cy="301752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11" name="Diagramm 12">
              <a:extLst>
                <a:ext uri="{FF2B5EF4-FFF2-40B4-BE49-F238E27FC236}">
                  <a16:creationId xmlns:a16="http://schemas.microsoft.com/office/drawing/2014/main" id="{A047DECB-7853-7F8B-2C77-4F327CBF8519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389497630"/>
                </p:ext>
              </p:extLst>
            </p:nvPr>
          </p:nvGraphicFramePr>
          <p:xfrm>
            <a:off x="4834451" y="286284"/>
            <a:ext cx="4023360" cy="301752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graphicFrame>
          <p:nvGraphicFramePr>
            <p:cNvPr id="12" name="Diagramm 13">
              <a:extLst>
                <a:ext uri="{FF2B5EF4-FFF2-40B4-BE49-F238E27FC236}">
                  <a16:creationId xmlns:a16="http://schemas.microsoft.com/office/drawing/2014/main" id="{E301806D-5626-26FD-B244-73DCEE97D2E7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621195101"/>
                </p:ext>
              </p:extLst>
            </p:nvPr>
          </p:nvGraphicFramePr>
          <p:xfrm>
            <a:off x="810645" y="3307484"/>
            <a:ext cx="4023360" cy="301752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graphicFrame>
          <p:nvGraphicFramePr>
            <p:cNvPr id="13" name="Diagramm 14">
              <a:extLst>
                <a:ext uri="{FF2B5EF4-FFF2-40B4-BE49-F238E27FC236}">
                  <a16:creationId xmlns:a16="http://schemas.microsoft.com/office/drawing/2014/main" id="{8043B1EC-594D-B3BD-F282-B32F4B2C639A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335870519"/>
                </p:ext>
              </p:extLst>
            </p:nvPr>
          </p:nvGraphicFramePr>
          <p:xfrm>
            <a:off x="4834451" y="3307484"/>
            <a:ext cx="4023360" cy="301752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sp>
          <p:nvSpPr>
            <p:cNvPr id="14" name="Textfeld 7">
              <a:extLst>
                <a:ext uri="{FF2B5EF4-FFF2-40B4-BE49-F238E27FC236}">
                  <a16:creationId xmlns:a16="http://schemas.microsoft.com/office/drawing/2014/main" id="{2AEE38E8-9F44-B740-3AB6-D6930E5EDD44}"/>
                </a:ext>
              </a:extLst>
            </p:cNvPr>
            <p:cNvSpPr txBox="1"/>
            <p:nvPr/>
          </p:nvSpPr>
          <p:spPr>
            <a:xfrm>
              <a:off x="4057585" y="2377857"/>
              <a:ext cx="6286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CO 39</a:t>
              </a:r>
              <a:endParaRPr lang="en-GB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feld 8">
              <a:extLst>
                <a:ext uri="{FF2B5EF4-FFF2-40B4-BE49-F238E27FC236}">
                  <a16:creationId xmlns:a16="http://schemas.microsoft.com/office/drawing/2014/main" id="{1D05B119-7A13-40EE-B037-FF5D45FF5E5D}"/>
                </a:ext>
              </a:extLst>
            </p:cNvPr>
            <p:cNvSpPr txBox="1"/>
            <p:nvPr/>
          </p:nvSpPr>
          <p:spPr>
            <a:xfrm>
              <a:off x="7847000" y="330733"/>
              <a:ext cx="97494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Nipponbare</a:t>
              </a:r>
              <a:endParaRPr lang="en-GB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feld 9">
              <a:extLst>
                <a:ext uri="{FF2B5EF4-FFF2-40B4-BE49-F238E27FC236}">
                  <a16:creationId xmlns:a16="http://schemas.microsoft.com/office/drawing/2014/main" id="{7AC6C0D4-23C9-5A23-EDF4-52D88095D107}"/>
                </a:ext>
              </a:extLst>
            </p:cNvPr>
            <p:cNvSpPr txBox="1"/>
            <p:nvPr/>
          </p:nvSpPr>
          <p:spPr>
            <a:xfrm>
              <a:off x="4129156" y="3376334"/>
              <a:ext cx="6458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Guy11</a:t>
              </a:r>
              <a:endParaRPr lang="en-GB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feld 10">
              <a:extLst>
                <a:ext uri="{FF2B5EF4-FFF2-40B4-BE49-F238E27FC236}">
                  <a16:creationId xmlns:a16="http://schemas.microsoft.com/office/drawing/2014/main" id="{E74E6066-66AB-2978-9F3A-6BA69D4AE048}"/>
                </a:ext>
              </a:extLst>
            </p:cNvPr>
            <p:cNvSpPr txBox="1"/>
            <p:nvPr/>
          </p:nvSpPr>
          <p:spPr>
            <a:xfrm>
              <a:off x="7929403" y="5353342"/>
              <a:ext cx="66236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Li1497</a:t>
              </a:r>
              <a:endParaRPr lang="en-GB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0" name="TextBox 19">
            <a:extLst>
              <a:ext uri="{FF2B5EF4-FFF2-40B4-BE49-F238E27FC236}">
                <a16:creationId xmlns:a16="http://schemas.microsoft.com/office/drawing/2014/main" id="{866BF610-48E8-5A66-79DE-F98548B09240}"/>
              </a:ext>
            </a:extLst>
          </p:cNvPr>
          <p:cNvSpPr txBox="1"/>
          <p:nvPr/>
        </p:nvSpPr>
        <p:spPr>
          <a:xfrm>
            <a:off x="33628" y="-48124"/>
            <a:ext cx="48006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kern="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Times New Roman" panose="02020603050405020304" pitchFamily="18" charset="0"/>
                <a:ea typeface="Calibri" panose="020F0502020204030204" pitchFamily="34" charset="0"/>
              </a:rPr>
              <a:t>Additional file 3 : Fig A3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603425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Theme">
  <a:themeElements>
    <a:clrScheme name="Office 2013 - 2022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0</TotalTime>
  <Words>262</Words>
  <Application>Microsoft Office PowerPoint</Application>
  <PresentationFormat>A3 Paper (297x420 mm)</PresentationFormat>
  <Paragraphs>51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2013 - 2022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Admin</dc:creator>
  <cp:lastModifiedBy>Angeline Wanjiku Maina</cp:lastModifiedBy>
  <cp:revision>103</cp:revision>
  <dcterms:created xsi:type="dcterms:W3CDTF">2022-03-24T12:14:38Z</dcterms:created>
  <dcterms:modified xsi:type="dcterms:W3CDTF">2024-05-20T19:38:14Z</dcterms:modified>
</cp:coreProperties>
</file>